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87" r:id="rId2"/>
    <p:sldId id="290" r:id="rId3"/>
  </p:sldIdLst>
  <p:sldSz cx="12192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u Fangfei" initials="LF" lastIdx="1" clrIdx="0">
    <p:extLst>
      <p:ext uri="{19B8F6BF-5375-455C-9EA6-DF929625EA0E}">
        <p15:presenceInfo xmlns:p15="http://schemas.microsoft.com/office/powerpoint/2012/main" userId="ae67101c3aa1a1b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66"/>
    <a:srgbClr val="FC7368"/>
    <a:srgbClr val="FDABA5"/>
    <a:srgbClr val="FF8F8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533" autoAdjust="0"/>
    <p:restoredTop sz="95439" autoAdjust="0"/>
  </p:normalViewPr>
  <p:slideViewPr>
    <p:cSldViewPr snapToGrid="0">
      <p:cViewPr>
        <p:scale>
          <a:sx n="100" d="100"/>
          <a:sy n="100" d="100"/>
        </p:scale>
        <p:origin x="522" y="-17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5" d="100"/>
        <a:sy n="95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5931A2-A52F-40EF-9D6E-9A6E14403691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DB6BB0-094A-45D5-9CA2-A075A8049B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82984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DB6BB0-094A-45D5-9CA2-A075A8049B36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15469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DB6BB0-094A-45D5-9CA2-A075A8049B36}" type="slidenum">
              <a:rPr lang="en-GB" smtClean="0"/>
              <a:pPr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16925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8526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1492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4778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6181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2629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6596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4749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7612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890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7117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2034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7F360-48B2-4082-B078-BE41404BB0F0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CE5FD2-6FE7-427B-97F8-643A4965C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4261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4" name="Line 895">
            <a:extLst>
              <a:ext uri="{FF2B5EF4-FFF2-40B4-BE49-F238E27FC236}">
                <a16:creationId xmlns:a16="http://schemas.microsoft.com/office/drawing/2014/main" id="{D265A5C2-1388-4727-B0BE-54B5E6E2827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66775" y="10229850"/>
            <a:ext cx="39688" cy="22225"/>
          </a:xfrm>
          <a:prstGeom prst="line">
            <a:avLst/>
          </a:prstGeom>
          <a:noFill/>
          <a:ln w="0">
            <a:solidFill>
              <a:srgbClr val="46B446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6" name="TextBox 115"/>
          <p:cNvSpPr txBox="1"/>
          <p:nvPr/>
        </p:nvSpPr>
        <p:spPr>
          <a:xfrm>
            <a:off x="2620600" y="2074283"/>
            <a:ext cx="7025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419" name="Rectangle 292"/>
          <p:cNvSpPr>
            <a:spLocks noChangeArrowheads="1"/>
          </p:cNvSpPr>
          <p:nvPr/>
        </p:nvSpPr>
        <p:spPr bwMode="auto">
          <a:xfrm>
            <a:off x="4189158" y="2249714"/>
            <a:ext cx="22718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28" name="Rectangle 301"/>
          <p:cNvSpPr>
            <a:spLocks noChangeArrowheads="1"/>
          </p:cNvSpPr>
          <p:nvPr/>
        </p:nvSpPr>
        <p:spPr bwMode="auto">
          <a:xfrm>
            <a:off x="3242570" y="2284744"/>
            <a:ext cx="73203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F: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29" name="Rectangle 302"/>
          <p:cNvSpPr>
            <a:spLocks noChangeArrowheads="1"/>
          </p:cNvSpPr>
          <p:nvPr/>
        </p:nvSpPr>
        <p:spPr bwMode="auto">
          <a:xfrm>
            <a:off x="3353636" y="2277738"/>
            <a:ext cx="1382019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80000"/>
                </a:solidFill>
                <a:effectLst/>
                <a:cs typeface="Arial" panose="020B0604020202020204" pitchFamily="34" charset="0"/>
              </a:rPr>
              <a:t>FTMS - p ESI Full 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C80000"/>
                </a:solidFill>
                <a:effectLst/>
                <a:cs typeface="Arial" panose="020B0604020202020204" pitchFamily="34" charset="0"/>
              </a:rPr>
              <a:t>ms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80000"/>
                </a:solidFill>
                <a:effectLst/>
                <a:cs typeface="Arial" panose="020B0604020202020204" pitchFamily="34" charset="0"/>
              </a:rPr>
              <a:t> [50.00-1000.00]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30" name="Line 303"/>
          <p:cNvSpPr>
            <a:spLocks noChangeShapeType="1"/>
          </p:cNvSpPr>
          <p:nvPr/>
        </p:nvSpPr>
        <p:spPr bwMode="auto">
          <a:xfrm>
            <a:off x="3309462" y="5920913"/>
            <a:ext cx="587894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1" name="Line 304"/>
          <p:cNvSpPr>
            <a:spLocks noChangeShapeType="1"/>
          </p:cNvSpPr>
          <p:nvPr/>
        </p:nvSpPr>
        <p:spPr bwMode="auto">
          <a:xfrm>
            <a:off x="3371306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2" name="Line 305"/>
          <p:cNvSpPr>
            <a:spLocks noChangeShapeType="1"/>
          </p:cNvSpPr>
          <p:nvPr/>
        </p:nvSpPr>
        <p:spPr bwMode="auto">
          <a:xfrm>
            <a:off x="3433149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3" name="Line 306"/>
          <p:cNvSpPr>
            <a:spLocks noChangeShapeType="1"/>
          </p:cNvSpPr>
          <p:nvPr/>
        </p:nvSpPr>
        <p:spPr bwMode="auto">
          <a:xfrm>
            <a:off x="3494993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4" name="Line 307"/>
          <p:cNvSpPr>
            <a:spLocks noChangeShapeType="1"/>
          </p:cNvSpPr>
          <p:nvPr/>
        </p:nvSpPr>
        <p:spPr bwMode="auto">
          <a:xfrm>
            <a:off x="3556837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5" name="Line 308"/>
          <p:cNvSpPr>
            <a:spLocks noChangeShapeType="1"/>
          </p:cNvSpPr>
          <p:nvPr/>
        </p:nvSpPr>
        <p:spPr bwMode="auto">
          <a:xfrm>
            <a:off x="3680524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6" name="Line 309"/>
          <p:cNvSpPr>
            <a:spLocks noChangeShapeType="1"/>
          </p:cNvSpPr>
          <p:nvPr/>
        </p:nvSpPr>
        <p:spPr bwMode="auto">
          <a:xfrm>
            <a:off x="3741106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7" name="Line 310"/>
          <p:cNvSpPr>
            <a:spLocks noChangeShapeType="1"/>
          </p:cNvSpPr>
          <p:nvPr/>
        </p:nvSpPr>
        <p:spPr bwMode="auto">
          <a:xfrm>
            <a:off x="3802950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8" name="Line 311"/>
          <p:cNvSpPr>
            <a:spLocks noChangeShapeType="1"/>
          </p:cNvSpPr>
          <p:nvPr/>
        </p:nvSpPr>
        <p:spPr bwMode="auto">
          <a:xfrm>
            <a:off x="3864794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9" name="Line 312"/>
          <p:cNvSpPr>
            <a:spLocks noChangeShapeType="1"/>
          </p:cNvSpPr>
          <p:nvPr/>
        </p:nvSpPr>
        <p:spPr bwMode="auto">
          <a:xfrm>
            <a:off x="3988481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0" name="Line 313"/>
          <p:cNvSpPr>
            <a:spLocks noChangeShapeType="1"/>
          </p:cNvSpPr>
          <p:nvPr/>
        </p:nvSpPr>
        <p:spPr bwMode="auto">
          <a:xfrm>
            <a:off x="4050325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1" name="Line 314"/>
          <p:cNvSpPr>
            <a:spLocks noChangeShapeType="1"/>
          </p:cNvSpPr>
          <p:nvPr/>
        </p:nvSpPr>
        <p:spPr bwMode="auto">
          <a:xfrm>
            <a:off x="4112169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2" name="Line 315"/>
          <p:cNvSpPr>
            <a:spLocks noChangeShapeType="1"/>
          </p:cNvSpPr>
          <p:nvPr/>
        </p:nvSpPr>
        <p:spPr bwMode="auto">
          <a:xfrm>
            <a:off x="4172750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3" name="Line 316"/>
          <p:cNvSpPr>
            <a:spLocks noChangeShapeType="1"/>
          </p:cNvSpPr>
          <p:nvPr/>
        </p:nvSpPr>
        <p:spPr bwMode="auto">
          <a:xfrm>
            <a:off x="4296438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4" name="Line 317"/>
          <p:cNvSpPr>
            <a:spLocks noChangeShapeType="1"/>
          </p:cNvSpPr>
          <p:nvPr/>
        </p:nvSpPr>
        <p:spPr bwMode="auto">
          <a:xfrm>
            <a:off x="4358282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5" name="Line 318"/>
          <p:cNvSpPr>
            <a:spLocks noChangeShapeType="1"/>
          </p:cNvSpPr>
          <p:nvPr/>
        </p:nvSpPr>
        <p:spPr bwMode="auto">
          <a:xfrm>
            <a:off x="4420126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6" name="Line 319"/>
          <p:cNvSpPr>
            <a:spLocks noChangeShapeType="1"/>
          </p:cNvSpPr>
          <p:nvPr/>
        </p:nvSpPr>
        <p:spPr bwMode="auto">
          <a:xfrm>
            <a:off x="4485756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7" name="Line 320"/>
          <p:cNvSpPr>
            <a:spLocks noChangeShapeType="1"/>
          </p:cNvSpPr>
          <p:nvPr/>
        </p:nvSpPr>
        <p:spPr bwMode="auto">
          <a:xfrm>
            <a:off x="4609443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8" name="Line 321"/>
          <p:cNvSpPr>
            <a:spLocks noChangeShapeType="1"/>
          </p:cNvSpPr>
          <p:nvPr/>
        </p:nvSpPr>
        <p:spPr bwMode="auto">
          <a:xfrm>
            <a:off x="4670025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9" name="Line 322"/>
          <p:cNvSpPr>
            <a:spLocks noChangeShapeType="1"/>
          </p:cNvSpPr>
          <p:nvPr/>
        </p:nvSpPr>
        <p:spPr bwMode="auto">
          <a:xfrm>
            <a:off x="4731869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0" name="Line 323"/>
          <p:cNvSpPr>
            <a:spLocks noChangeShapeType="1"/>
          </p:cNvSpPr>
          <p:nvPr/>
        </p:nvSpPr>
        <p:spPr bwMode="auto">
          <a:xfrm>
            <a:off x="4793712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1" name="Line 324"/>
          <p:cNvSpPr>
            <a:spLocks noChangeShapeType="1"/>
          </p:cNvSpPr>
          <p:nvPr/>
        </p:nvSpPr>
        <p:spPr bwMode="auto">
          <a:xfrm>
            <a:off x="4917400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2" name="Line 325"/>
          <p:cNvSpPr>
            <a:spLocks noChangeShapeType="1"/>
          </p:cNvSpPr>
          <p:nvPr/>
        </p:nvSpPr>
        <p:spPr bwMode="auto">
          <a:xfrm>
            <a:off x="4979244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3" name="Line 326"/>
          <p:cNvSpPr>
            <a:spLocks noChangeShapeType="1"/>
          </p:cNvSpPr>
          <p:nvPr/>
        </p:nvSpPr>
        <p:spPr bwMode="auto">
          <a:xfrm>
            <a:off x="5041088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4" name="Line 327"/>
          <p:cNvSpPr>
            <a:spLocks noChangeShapeType="1"/>
          </p:cNvSpPr>
          <p:nvPr/>
        </p:nvSpPr>
        <p:spPr bwMode="auto">
          <a:xfrm>
            <a:off x="5101669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5" name="Line 328"/>
          <p:cNvSpPr>
            <a:spLocks noChangeShapeType="1"/>
          </p:cNvSpPr>
          <p:nvPr/>
        </p:nvSpPr>
        <p:spPr bwMode="auto">
          <a:xfrm>
            <a:off x="5225357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6" name="Line 329"/>
          <p:cNvSpPr>
            <a:spLocks noChangeShapeType="1"/>
          </p:cNvSpPr>
          <p:nvPr/>
        </p:nvSpPr>
        <p:spPr bwMode="auto">
          <a:xfrm>
            <a:off x="5287200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7" name="Line 330"/>
          <p:cNvSpPr>
            <a:spLocks noChangeShapeType="1"/>
          </p:cNvSpPr>
          <p:nvPr/>
        </p:nvSpPr>
        <p:spPr bwMode="auto">
          <a:xfrm>
            <a:off x="5349044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8" name="Line 331"/>
          <p:cNvSpPr>
            <a:spLocks noChangeShapeType="1"/>
          </p:cNvSpPr>
          <p:nvPr/>
        </p:nvSpPr>
        <p:spPr bwMode="auto">
          <a:xfrm>
            <a:off x="5410888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9" name="Line 332"/>
          <p:cNvSpPr>
            <a:spLocks noChangeShapeType="1"/>
          </p:cNvSpPr>
          <p:nvPr/>
        </p:nvSpPr>
        <p:spPr bwMode="auto">
          <a:xfrm>
            <a:off x="5534576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0" name="Line 333"/>
          <p:cNvSpPr>
            <a:spLocks noChangeShapeType="1"/>
          </p:cNvSpPr>
          <p:nvPr/>
        </p:nvSpPr>
        <p:spPr bwMode="auto">
          <a:xfrm>
            <a:off x="5595157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1" name="Line 334"/>
          <p:cNvSpPr>
            <a:spLocks noChangeShapeType="1"/>
          </p:cNvSpPr>
          <p:nvPr/>
        </p:nvSpPr>
        <p:spPr bwMode="auto">
          <a:xfrm>
            <a:off x="5660787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2" name="Line 335"/>
          <p:cNvSpPr>
            <a:spLocks noChangeShapeType="1"/>
          </p:cNvSpPr>
          <p:nvPr/>
        </p:nvSpPr>
        <p:spPr bwMode="auto">
          <a:xfrm>
            <a:off x="5722631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3" name="Line 336"/>
          <p:cNvSpPr>
            <a:spLocks noChangeShapeType="1"/>
          </p:cNvSpPr>
          <p:nvPr/>
        </p:nvSpPr>
        <p:spPr bwMode="auto">
          <a:xfrm>
            <a:off x="5846319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4" name="Line 337"/>
          <p:cNvSpPr>
            <a:spLocks noChangeShapeType="1"/>
          </p:cNvSpPr>
          <p:nvPr/>
        </p:nvSpPr>
        <p:spPr bwMode="auto">
          <a:xfrm>
            <a:off x="5908162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5" name="Line 338"/>
          <p:cNvSpPr>
            <a:spLocks noChangeShapeType="1"/>
          </p:cNvSpPr>
          <p:nvPr/>
        </p:nvSpPr>
        <p:spPr bwMode="auto">
          <a:xfrm>
            <a:off x="5970006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6" name="Line 339"/>
          <p:cNvSpPr>
            <a:spLocks noChangeShapeType="1"/>
          </p:cNvSpPr>
          <p:nvPr/>
        </p:nvSpPr>
        <p:spPr bwMode="auto">
          <a:xfrm>
            <a:off x="6030588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7" name="Line 340"/>
          <p:cNvSpPr>
            <a:spLocks noChangeShapeType="1"/>
          </p:cNvSpPr>
          <p:nvPr/>
        </p:nvSpPr>
        <p:spPr bwMode="auto">
          <a:xfrm>
            <a:off x="6154275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8" name="Line 341"/>
          <p:cNvSpPr>
            <a:spLocks noChangeShapeType="1"/>
          </p:cNvSpPr>
          <p:nvPr/>
        </p:nvSpPr>
        <p:spPr bwMode="auto">
          <a:xfrm>
            <a:off x="6216119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9" name="Line 342"/>
          <p:cNvSpPr>
            <a:spLocks noChangeShapeType="1"/>
          </p:cNvSpPr>
          <p:nvPr/>
        </p:nvSpPr>
        <p:spPr bwMode="auto">
          <a:xfrm>
            <a:off x="6277963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0" name="Line 343"/>
          <p:cNvSpPr>
            <a:spLocks noChangeShapeType="1"/>
          </p:cNvSpPr>
          <p:nvPr/>
        </p:nvSpPr>
        <p:spPr bwMode="auto">
          <a:xfrm>
            <a:off x="6339807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1" name="Line 344"/>
          <p:cNvSpPr>
            <a:spLocks noChangeShapeType="1"/>
          </p:cNvSpPr>
          <p:nvPr/>
        </p:nvSpPr>
        <p:spPr bwMode="auto">
          <a:xfrm>
            <a:off x="6463494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2" name="Line 345"/>
          <p:cNvSpPr>
            <a:spLocks noChangeShapeType="1"/>
          </p:cNvSpPr>
          <p:nvPr/>
        </p:nvSpPr>
        <p:spPr bwMode="auto">
          <a:xfrm>
            <a:off x="6524076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3" name="Line 346"/>
          <p:cNvSpPr>
            <a:spLocks noChangeShapeType="1"/>
          </p:cNvSpPr>
          <p:nvPr/>
        </p:nvSpPr>
        <p:spPr bwMode="auto">
          <a:xfrm>
            <a:off x="6585920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4" name="Line 347"/>
          <p:cNvSpPr>
            <a:spLocks noChangeShapeType="1"/>
          </p:cNvSpPr>
          <p:nvPr/>
        </p:nvSpPr>
        <p:spPr bwMode="auto">
          <a:xfrm>
            <a:off x="6647764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5" name="Line 348"/>
          <p:cNvSpPr>
            <a:spLocks noChangeShapeType="1"/>
          </p:cNvSpPr>
          <p:nvPr/>
        </p:nvSpPr>
        <p:spPr bwMode="auto">
          <a:xfrm>
            <a:off x="6771451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6" name="Line 349"/>
          <p:cNvSpPr>
            <a:spLocks noChangeShapeType="1"/>
          </p:cNvSpPr>
          <p:nvPr/>
        </p:nvSpPr>
        <p:spPr bwMode="auto">
          <a:xfrm>
            <a:off x="6837081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7" name="Line 350"/>
          <p:cNvSpPr>
            <a:spLocks noChangeShapeType="1"/>
          </p:cNvSpPr>
          <p:nvPr/>
        </p:nvSpPr>
        <p:spPr bwMode="auto">
          <a:xfrm>
            <a:off x="6898925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8" name="Line 351"/>
          <p:cNvSpPr>
            <a:spLocks noChangeShapeType="1"/>
          </p:cNvSpPr>
          <p:nvPr/>
        </p:nvSpPr>
        <p:spPr bwMode="auto">
          <a:xfrm>
            <a:off x="6959507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9" name="Line 352"/>
          <p:cNvSpPr>
            <a:spLocks noChangeShapeType="1"/>
          </p:cNvSpPr>
          <p:nvPr/>
        </p:nvSpPr>
        <p:spPr bwMode="auto">
          <a:xfrm>
            <a:off x="7083194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0" name="Line 353"/>
          <p:cNvSpPr>
            <a:spLocks noChangeShapeType="1"/>
          </p:cNvSpPr>
          <p:nvPr/>
        </p:nvSpPr>
        <p:spPr bwMode="auto">
          <a:xfrm>
            <a:off x="7145038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1" name="Line 354"/>
          <p:cNvSpPr>
            <a:spLocks noChangeShapeType="1"/>
          </p:cNvSpPr>
          <p:nvPr/>
        </p:nvSpPr>
        <p:spPr bwMode="auto">
          <a:xfrm>
            <a:off x="7206882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2" name="Line 355"/>
          <p:cNvSpPr>
            <a:spLocks noChangeShapeType="1"/>
          </p:cNvSpPr>
          <p:nvPr/>
        </p:nvSpPr>
        <p:spPr bwMode="auto">
          <a:xfrm>
            <a:off x="7268726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3" name="Line 356"/>
          <p:cNvSpPr>
            <a:spLocks noChangeShapeType="1"/>
          </p:cNvSpPr>
          <p:nvPr/>
        </p:nvSpPr>
        <p:spPr bwMode="auto">
          <a:xfrm>
            <a:off x="7391151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4" name="Line 357"/>
          <p:cNvSpPr>
            <a:spLocks noChangeShapeType="1"/>
          </p:cNvSpPr>
          <p:nvPr/>
        </p:nvSpPr>
        <p:spPr bwMode="auto">
          <a:xfrm>
            <a:off x="7452995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5" name="Line 358"/>
          <p:cNvSpPr>
            <a:spLocks noChangeShapeType="1"/>
          </p:cNvSpPr>
          <p:nvPr/>
        </p:nvSpPr>
        <p:spPr bwMode="auto">
          <a:xfrm>
            <a:off x="7514838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6" name="Line 359"/>
          <p:cNvSpPr>
            <a:spLocks noChangeShapeType="1"/>
          </p:cNvSpPr>
          <p:nvPr/>
        </p:nvSpPr>
        <p:spPr bwMode="auto">
          <a:xfrm>
            <a:off x="7576682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7" name="Line 360"/>
          <p:cNvSpPr>
            <a:spLocks noChangeShapeType="1"/>
          </p:cNvSpPr>
          <p:nvPr/>
        </p:nvSpPr>
        <p:spPr bwMode="auto">
          <a:xfrm>
            <a:off x="7700370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8" name="Line 361"/>
          <p:cNvSpPr>
            <a:spLocks noChangeShapeType="1"/>
          </p:cNvSpPr>
          <p:nvPr/>
        </p:nvSpPr>
        <p:spPr bwMode="auto">
          <a:xfrm>
            <a:off x="7762214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Line 362"/>
          <p:cNvSpPr>
            <a:spLocks noChangeShapeType="1"/>
          </p:cNvSpPr>
          <p:nvPr/>
        </p:nvSpPr>
        <p:spPr bwMode="auto">
          <a:xfrm>
            <a:off x="7824057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Line 363"/>
          <p:cNvSpPr>
            <a:spLocks noChangeShapeType="1"/>
          </p:cNvSpPr>
          <p:nvPr/>
        </p:nvSpPr>
        <p:spPr bwMode="auto">
          <a:xfrm>
            <a:off x="7884639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1" name="Line 364"/>
          <p:cNvSpPr>
            <a:spLocks noChangeShapeType="1"/>
          </p:cNvSpPr>
          <p:nvPr/>
        </p:nvSpPr>
        <p:spPr bwMode="auto">
          <a:xfrm>
            <a:off x="8012113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2" name="Line 365"/>
          <p:cNvSpPr>
            <a:spLocks noChangeShapeType="1"/>
          </p:cNvSpPr>
          <p:nvPr/>
        </p:nvSpPr>
        <p:spPr bwMode="auto">
          <a:xfrm>
            <a:off x="8073957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3" name="Line 366"/>
          <p:cNvSpPr>
            <a:spLocks noChangeShapeType="1"/>
          </p:cNvSpPr>
          <p:nvPr/>
        </p:nvSpPr>
        <p:spPr bwMode="auto">
          <a:xfrm>
            <a:off x="8135800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Line 367"/>
          <p:cNvSpPr>
            <a:spLocks noChangeShapeType="1"/>
          </p:cNvSpPr>
          <p:nvPr/>
        </p:nvSpPr>
        <p:spPr bwMode="auto">
          <a:xfrm>
            <a:off x="8197644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5" name="Line 368"/>
          <p:cNvSpPr>
            <a:spLocks noChangeShapeType="1"/>
          </p:cNvSpPr>
          <p:nvPr/>
        </p:nvSpPr>
        <p:spPr bwMode="auto">
          <a:xfrm>
            <a:off x="8320070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6" name="Line 369"/>
          <p:cNvSpPr>
            <a:spLocks noChangeShapeType="1"/>
          </p:cNvSpPr>
          <p:nvPr/>
        </p:nvSpPr>
        <p:spPr bwMode="auto">
          <a:xfrm>
            <a:off x="8381913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7" name="Line 370"/>
          <p:cNvSpPr>
            <a:spLocks noChangeShapeType="1"/>
          </p:cNvSpPr>
          <p:nvPr/>
        </p:nvSpPr>
        <p:spPr bwMode="auto">
          <a:xfrm>
            <a:off x="8443757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8" name="Line 371"/>
          <p:cNvSpPr>
            <a:spLocks noChangeShapeType="1"/>
          </p:cNvSpPr>
          <p:nvPr/>
        </p:nvSpPr>
        <p:spPr bwMode="auto">
          <a:xfrm>
            <a:off x="8505601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9" name="Line 372"/>
          <p:cNvSpPr>
            <a:spLocks noChangeShapeType="1"/>
          </p:cNvSpPr>
          <p:nvPr/>
        </p:nvSpPr>
        <p:spPr bwMode="auto">
          <a:xfrm>
            <a:off x="8629289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0" name="Line 373"/>
          <p:cNvSpPr>
            <a:spLocks noChangeShapeType="1"/>
          </p:cNvSpPr>
          <p:nvPr/>
        </p:nvSpPr>
        <p:spPr bwMode="auto">
          <a:xfrm>
            <a:off x="8691132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1" name="Line 374"/>
          <p:cNvSpPr>
            <a:spLocks noChangeShapeType="1"/>
          </p:cNvSpPr>
          <p:nvPr/>
        </p:nvSpPr>
        <p:spPr bwMode="auto">
          <a:xfrm>
            <a:off x="8752976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2" name="Line 375"/>
          <p:cNvSpPr>
            <a:spLocks noChangeShapeType="1"/>
          </p:cNvSpPr>
          <p:nvPr/>
        </p:nvSpPr>
        <p:spPr bwMode="auto">
          <a:xfrm>
            <a:off x="8813558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3" name="Line 376"/>
          <p:cNvSpPr>
            <a:spLocks noChangeShapeType="1"/>
          </p:cNvSpPr>
          <p:nvPr/>
        </p:nvSpPr>
        <p:spPr bwMode="auto">
          <a:xfrm>
            <a:off x="8937245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4" name="Line 377"/>
          <p:cNvSpPr>
            <a:spLocks noChangeShapeType="1"/>
          </p:cNvSpPr>
          <p:nvPr/>
        </p:nvSpPr>
        <p:spPr bwMode="auto">
          <a:xfrm>
            <a:off x="8999089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5" name="Line 378"/>
          <p:cNvSpPr>
            <a:spLocks noChangeShapeType="1"/>
          </p:cNvSpPr>
          <p:nvPr/>
        </p:nvSpPr>
        <p:spPr bwMode="auto">
          <a:xfrm>
            <a:off x="9060933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6" name="Line 379"/>
          <p:cNvSpPr>
            <a:spLocks noChangeShapeType="1"/>
          </p:cNvSpPr>
          <p:nvPr/>
        </p:nvSpPr>
        <p:spPr bwMode="auto">
          <a:xfrm>
            <a:off x="9122777" y="5920913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7" name="Line 380"/>
          <p:cNvSpPr>
            <a:spLocks noChangeShapeType="1"/>
          </p:cNvSpPr>
          <p:nvPr/>
        </p:nvSpPr>
        <p:spPr bwMode="auto">
          <a:xfrm>
            <a:off x="3309462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8" name="Rectangle 381"/>
          <p:cNvSpPr>
            <a:spLocks noChangeArrowheads="1"/>
          </p:cNvSpPr>
          <p:nvPr/>
        </p:nvSpPr>
        <p:spPr bwMode="auto">
          <a:xfrm>
            <a:off x="3255191" y="5962949"/>
            <a:ext cx="0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09" name="Line 382"/>
          <p:cNvSpPr>
            <a:spLocks noChangeShapeType="1"/>
          </p:cNvSpPr>
          <p:nvPr/>
        </p:nvSpPr>
        <p:spPr bwMode="auto">
          <a:xfrm>
            <a:off x="3618681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0" name="Rectangle 383"/>
          <p:cNvSpPr>
            <a:spLocks noChangeArrowheads="1"/>
          </p:cNvSpPr>
          <p:nvPr/>
        </p:nvSpPr>
        <p:spPr bwMode="auto">
          <a:xfrm>
            <a:off x="3545478" y="5962949"/>
            <a:ext cx="137571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11" name="Line 384"/>
          <p:cNvSpPr>
            <a:spLocks noChangeShapeType="1"/>
          </p:cNvSpPr>
          <p:nvPr/>
        </p:nvSpPr>
        <p:spPr bwMode="auto">
          <a:xfrm>
            <a:off x="3926637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3" name="Line 386"/>
          <p:cNvSpPr>
            <a:spLocks noChangeShapeType="1"/>
          </p:cNvSpPr>
          <p:nvPr/>
        </p:nvSpPr>
        <p:spPr bwMode="auto">
          <a:xfrm>
            <a:off x="4234594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4" name="Rectangle 387"/>
          <p:cNvSpPr>
            <a:spLocks noChangeArrowheads="1"/>
          </p:cNvSpPr>
          <p:nvPr/>
        </p:nvSpPr>
        <p:spPr bwMode="auto">
          <a:xfrm>
            <a:off x="4161391" y="5962949"/>
            <a:ext cx="137571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15" name="Line 388"/>
          <p:cNvSpPr>
            <a:spLocks noChangeShapeType="1"/>
          </p:cNvSpPr>
          <p:nvPr/>
        </p:nvSpPr>
        <p:spPr bwMode="auto">
          <a:xfrm>
            <a:off x="4547599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7" name="Line 390"/>
          <p:cNvSpPr>
            <a:spLocks noChangeShapeType="1"/>
          </p:cNvSpPr>
          <p:nvPr/>
        </p:nvSpPr>
        <p:spPr bwMode="auto">
          <a:xfrm>
            <a:off x="4855556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8" name="Rectangle 391"/>
          <p:cNvSpPr>
            <a:spLocks noChangeArrowheads="1"/>
          </p:cNvSpPr>
          <p:nvPr/>
        </p:nvSpPr>
        <p:spPr bwMode="auto">
          <a:xfrm>
            <a:off x="4782353" y="5962949"/>
            <a:ext cx="137571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0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19" name="Line 392"/>
          <p:cNvSpPr>
            <a:spLocks noChangeShapeType="1"/>
          </p:cNvSpPr>
          <p:nvPr/>
        </p:nvSpPr>
        <p:spPr bwMode="auto">
          <a:xfrm>
            <a:off x="5163513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1" name="Line 394"/>
          <p:cNvSpPr>
            <a:spLocks noChangeShapeType="1"/>
          </p:cNvSpPr>
          <p:nvPr/>
        </p:nvSpPr>
        <p:spPr bwMode="auto">
          <a:xfrm>
            <a:off x="5472732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2" name="Rectangle 395"/>
          <p:cNvSpPr>
            <a:spLocks noChangeArrowheads="1"/>
          </p:cNvSpPr>
          <p:nvPr/>
        </p:nvSpPr>
        <p:spPr bwMode="auto">
          <a:xfrm>
            <a:off x="5399529" y="5962949"/>
            <a:ext cx="137571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0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23" name="Line 396"/>
          <p:cNvSpPr>
            <a:spLocks noChangeShapeType="1"/>
          </p:cNvSpPr>
          <p:nvPr/>
        </p:nvSpPr>
        <p:spPr bwMode="auto">
          <a:xfrm>
            <a:off x="5784475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5" name="Line 398"/>
          <p:cNvSpPr>
            <a:spLocks noChangeShapeType="1"/>
          </p:cNvSpPr>
          <p:nvPr/>
        </p:nvSpPr>
        <p:spPr bwMode="auto">
          <a:xfrm>
            <a:off x="6092432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6" name="Rectangle 399"/>
          <p:cNvSpPr>
            <a:spLocks noChangeArrowheads="1"/>
          </p:cNvSpPr>
          <p:nvPr/>
        </p:nvSpPr>
        <p:spPr bwMode="auto">
          <a:xfrm>
            <a:off x="6019229" y="5962949"/>
            <a:ext cx="137571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0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27" name="Line 400"/>
          <p:cNvSpPr>
            <a:spLocks noChangeShapeType="1"/>
          </p:cNvSpPr>
          <p:nvPr/>
        </p:nvSpPr>
        <p:spPr bwMode="auto">
          <a:xfrm>
            <a:off x="6401651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9" name="Line 402"/>
          <p:cNvSpPr>
            <a:spLocks noChangeShapeType="1"/>
          </p:cNvSpPr>
          <p:nvPr/>
        </p:nvSpPr>
        <p:spPr bwMode="auto">
          <a:xfrm>
            <a:off x="6709607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0" name="Rectangle 403"/>
          <p:cNvSpPr>
            <a:spLocks noChangeArrowheads="1"/>
          </p:cNvSpPr>
          <p:nvPr/>
        </p:nvSpPr>
        <p:spPr bwMode="auto">
          <a:xfrm>
            <a:off x="6636404" y="5962949"/>
            <a:ext cx="137571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00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31" name="Line 404"/>
          <p:cNvSpPr>
            <a:spLocks noChangeShapeType="1"/>
          </p:cNvSpPr>
          <p:nvPr/>
        </p:nvSpPr>
        <p:spPr bwMode="auto">
          <a:xfrm>
            <a:off x="7021350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3" name="Line 406"/>
          <p:cNvSpPr>
            <a:spLocks noChangeShapeType="1"/>
          </p:cNvSpPr>
          <p:nvPr/>
        </p:nvSpPr>
        <p:spPr bwMode="auto">
          <a:xfrm>
            <a:off x="7330569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4" name="Rectangle 407"/>
          <p:cNvSpPr>
            <a:spLocks noChangeArrowheads="1"/>
          </p:cNvSpPr>
          <p:nvPr/>
        </p:nvSpPr>
        <p:spPr bwMode="auto">
          <a:xfrm>
            <a:off x="7257366" y="5962949"/>
            <a:ext cx="137571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0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35" name="Line 408"/>
          <p:cNvSpPr>
            <a:spLocks noChangeShapeType="1"/>
          </p:cNvSpPr>
          <p:nvPr/>
        </p:nvSpPr>
        <p:spPr bwMode="auto">
          <a:xfrm>
            <a:off x="7638526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7" name="Line 410"/>
          <p:cNvSpPr>
            <a:spLocks noChangeShapeType="1"/>
          </p:cNvSpPr>
          <p:nvPr/>
        </p:nvSpPr>
        <p:spPr bwMode="auto">
          <a:xfrm>
            <a:off x="7946483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8" name="Rectangle 411"/>
          <p:cNvSpPr>
            <a:spLocks noChangeArrowheads="1"/>
          </p:cNvSpPr>
          <p:nvPr/>
        </p:nvSpPr>
        <p:spPr bwMode="auto">
          <a:xfrm>
            <a:off x="7873280" y="5962949"/>
            <a:ext cx="137571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0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39" name="Line 412"/>
          <p:cNvSpPr>
            <a:spLocks noChangeShapeType="1"/>
          </p:cNvSpPr>
          <p:nvPr/>
        </p:nvSpPr>
        <p:spPr bwMode="auto">
          <a:xfrm>
            <a:off x="8259488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1" name="Line 414"/>
          <p:cNvSpPr>
            <a:spLocks noChangeShapeType="1"/>
          </p:cNvSpPr>
          <p:nvPr/>
        </p:nvSpPr>
        <p:spPr bwMode="auto">
          <a:xfrm>
            <a:off x="8567445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2" name="Rectangle 415"/>
          <p:cNvSpPr>
            <a:spLocks noChangeArrowheads="1"/>
          </p:cNvSpPr>
          <p:nvPr/>
        </p:nvSpPr>
        <p:spPr bwMode="auto">
          <a:xfrm>
            <a:off x="8494242" y="5962949"/>
            <a:ext cx="137571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0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43" name="Line 416"/>
          <p:cNvSpPr>
            <a:spLocks noChangeShapeType="1"/>
          </p:cNvSpPr>
          <p:nvPr/>
        </p:nvSpPr>
        <p:spPr bwMode="auto">
          <a:xfrm>
            <a:off x="8875402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5" name="Line 418"/>
          <p:cNvSpPr>
            <a:spLocks noChangeShapeType="1"/>
          </p:cNvSpPr>
          <p:nvPr/>
        </p:nvSpPr>
        <p:spPr bwMode="auto">
          <a:xfrm>
            <a:off x="9188407" y="5920913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6" name="Rectangle 419"/>
          <p:cNvSpPr>
            <a:spLocks noChangeArrowheads="1"/>
          </p:cNvSpPr>
          <p:nvPr/>
        </p:nvSpPr>
        <p:spPr bwMode="auto">
          <a:xfrm>
            <a:off x="9093748" y="5962949"/>
            <a:ext cx="183007" cy="109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47" name="Rectangle 420"/>
          <p:cNvSpPr>
            <a:spLocks noChangeArrowheads="1"/>
          </p:cNvSpPr>
          <p:nvPr/>
        </p:nvSpPr>
        <p:spPr bwMode="auto">
          <a:xfrm>
            <a:off x="6175731" y="6130229"/>
            <a:ext cx="20678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/z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48" name="Line 421"/>
          <p:cNvSpPr>
            <a:spLocks noChangeShapeType="1"/>
          </p:cNvSpPr>
          <p:nvPr/>
        </p:nvSpPr>
        <p:spPr bwMode="auto">
          <a:xfrm flipV="1">
            <a:off x="3309462" y="2485119"/>
            <a:ext cx="0" cy="343159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9" name="Line 422"/>
          <p:cNvSpPr>
            <a:spLocks noChangeShapeType="1"/>
          </p:cNvSpPr>
          <p:nvPr/>
        </p:nvSpPr>
        <p:spPr bwMode="auto">
          <a:xfrm flipH="1">
            <a:off x="3282957" y="588167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0" name="Line 423"/>
          <p:cNvSpPr>
            <a:spLocks noChangeShapeType="1"/>
          </p:cNvSpPr>
          <p:nvPr/>
        </p:nvSpPr>
        <p:spPr bwMode="auto">
          <a:xfrm flipH="1">
            <a:off x="3282957" y="584804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1" name="Line 424"/>
          <p:cNvSpPr>
            <a:spLocks noChangeShapeType="1"/>
          </p:cNvSpPr>
          <p:nvPr/>
        </p:nvSpPr>
        <p:spPr bwMode="auto">
          <a:xfrm flipH="1">
            <a:off x="3282957" y="581301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2" name="Line 425"/>
          <p:cNvSpPr>
            <a:spLocks noChangeShapeType="1"/>
          </p:cNvSpPr>
          <p:nvPr/>
        </p:nvSpPr>
        <p:spPr bwMode="auto">
          <a:xfrm flipH="1">
            <a:off x="3282957" y="577938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3" name="Line 426"/>
          <p:cNvSpPr>
            <a:spLocks noChangeShapeType="1"/>
          </p:cNvSpPr>
          <p:nvPr/>
        </p:nvSpPr>
        <p:spPr bwMode="auto">
          <a:xfrm flipH="1">
            <a:off x="3282957" y="571073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4" name="Line 427"/>
          <p:cNvSpPr>
            <a:spLocks noChangeShapeType="1"/>
          </p:cNvSpPr>
          <p:nvPr/>
        </p:nvSpPr>
        <p:spPr bwMode="auto">
          <a:xfrm flipH="1">
            <a:off x="3282957" y="567710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5" name="Line 428"/>
          <p:cNvSpPr>
            <a:spLocks noChangeShapeType="1"/>
          </p:cNvSpPr>
          <p:nvPr/>
        </p:nvSpPr>
        <p:spPr bwMode="auto">
          <a:xfrm flipH="1">
            <a:off x="3282957" y="564207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6" name="Line 429"/>
          <p:cNvSpPr>
            <a:spLocks noChangeShapeType="1"/>
          </p:cNvSpPr>
          <p:nvPr/>
        </p:nvSpPr>
        <p:spPr bwMode="auto">
          <a:xfrm flipH="1">
            <a:off x="3282957" y="560844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7" name="Line 430"/>
          <p:cNvSpPr>
            <a:spLocks noChangeShapeType="1"/>
          </p:cNvSpPr>
          <p:nvPr/>
        </p:nvSpPr>
        <p:spPr bwMode="auto">
          <a:xfrm flipH="1">
            <a:off x="3282957" y="553978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8" name="Line 431"/>
          <p:cNvSpPr>
            <a:spLocks noChangeShapeType="1"/>
          </p:cNvSpPr>
          <p:nvPr/>
        </p:nvSpPr>
        <p:spPr bwMode="auto">
          <a:xfrm flipH="1">
            <a:off x="3282957" y="550475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9" name="Line 432"/>
          <p:cNvSpPr>
            <a:spLocks noChangeShapeType="1"/>
          </p:cNvSpPr>
          <p:nvPr/>
        </p:nvSpPr>
        <p:spPr bwMode="auto">
          <a:xfrm flipH="1">
            <a:off x="3282957" y="547112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0" name="Line 433"/>
          <p:cNvSpPr>
            <a:spLocks noChangeShapeType="1"/>
          </p:cNvSpPr>
          <p:nvPr/>
        </p:nvSpPr>
        <p:spPr bwMode="auto">
          <a:xfrm flipH="1">
            <a:off x="3282957" y="543609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1" name="Line 434"/>
          <p:cNvSpPr>
            <a:spLocks noChangeShapeType="1"/>
          </p:cNvSpPr>
          <p:nvPr/>
        </p:nvSpPr>
        <p:spPr bwMode="auto">
          <a:xfrm flipH="1">
            <a:off x="3282957" y="536743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2" name="Line 435"/>
          <p:cNvSpPr>
            <a:spLocks noChangeShapeType="1"/>
          </p:cNvSpPr>
          <p:nvPr/>
        </p:nvSpPr>
        <p:spPr bwMode="auto">
          <a:xfrm flipH="1">
            <a:off x="3282957" y="533380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3" name="Line 436"/>
          <p:cNvSpPr>
            <a:spLocks noChangeShapeType="1"/>
          </p:cNvSpPr>
          <p:nvPr/>
        </p:nvSpPr>
        <p:spPr bwMode="auto">
          <a:xfrm flipH="1">
            <a:off x="3282957" y="530017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4" name="Line 437"/>
          <p:cNvSpPr>
            <a:spLocks noChangeShapeType="1"/>
          </p:cNvSpPr>
          <p:nvPr/>
        </p:nvSpPr>
        <p:spPr bwMode="auto">
          <a:xfrm flipH="1">
            <a:off x="3282957" y="526514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5" name="Line 438"/>
          <p:cNvSpPr>
            <a:spLocks noChangeShapeType="1"/>
          </p:cNvSpPr>
          <p:nvPr/>
        </p:nvSpPr>
        <p:spPr bwMode="auto">
          <a:xfrm flipH="1">
            <a:off x="3282957" y="519648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6" name="Line 439"/>
          <p:cNvSpPr>
            <a:spLocks noChangeShapeType="1"/>
          </p:cNvSpPr>
          <p:nvPr/>
        </p:nvSpPr>
        <p:spPr bwMode="auto">
          <a:xfrm flipH="1">
            <a:off x="3282957" y="516285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7" name="Line 440"/>
          <p:cNvSpPr>
            <a:spLocks noChangeShapeType="1"/>
          </p:cNvSpPr>
          <p:nvPr/>
        </p:nvSpPr>
        <p:spPr bwMode="auto">
          <a:xfrm flipH="1">
            <a:off x="3282957" y="512782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8" name="Line 441"/>
          <p:cNvSpPr>
            <a:spLocks noChangeShapeType="1"/>
          </p:cNvSpPr>
          <p:nvPr/>
        </p:nvSpPr>
        <p:spPr bwMode="auto">
          <a:xfrm flipH="1">
            <a:off x="3282957" y="509419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9" name="Line 442"/>
          <p:cNvSpPr>
            <a:spLocks noChangeShapeType="1"/>
          </p:cNvSpPr>
          <p:nvPr/>
        </p:nvSpPr>
        <p:spPr bwMode="auto">
          <a:xfrm flipH="1">
            <a:off x="3282957" y="502553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0" name="Line 443"/>
          <p:cNvSpPr>
            <a:spLocks noChangeShapeType="1"/>
          </p:cNvSpPr>
          <p:nvPr/>
        </p:nvSpPr>
        <p:spPr bwMode="auto">
          <a:xfrm flipH="1">
            <a:off x="3282957" y="499050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1" name="Line 444"/>
          <p:cNvSpPr>
            <a:spLocks noChangeShapeType="1"/>
          </p:cNvSpPr>
          <p:nvPr/>
        </p:nvSpPr>
        <p:spPr bwMode="auto">
          <a:xfrm flipH="1">
            <a:off x="3282957" y="4956873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2" name="Line 445"/>
          <p:cNvSpPr>
            <a:spLocks noChangeShapeType="1"/>
          </p:cNvSpPr>
          <p:nvPr/>
        </p:nvSpPr>
        <p:spPr bwMode="auto">
          <a:xfrm flipH="1">
            <a:off x="3282957" y="4923243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3" name="Line 446"/>
          <p:cNvSpPr>
            <a:spLocks noChangeShapeType="1"/>
          </p:cNvSpPr>
          <p:nvPr/>
        </p:nvSpPr>
        <p:spPr bwMode="auto">
          <a:xfrm flipH="1">
            <a:off x="3282957" y="485458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4" name="Line 447"/>
          <p:cNvSpPr>
            <a:spLocks noChangeShapeType="1"/>
          </p:cNvSpPr>
          <p:nvPr/>
        </p:nvSpPr>
        <p:spPr bwMode="auto">
          <a:xfrm flipH="1">
            <a:off x="3282957" y="4819553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5" name="Line 448"/>
          <p:cNvSpPr>
            <a:spLocks noChangeShapeType="1"/>
          </p:cNvSpPr>
          <p:nvPr/>
        </p:nvSpPr>
        <p:spPr bwMode="auto">
          <a:xfrm flipH="1">
            <a:off x="3282957" y="478592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6" name="Line 449"/>
          <p:cNvSpPr>
            <a:spLocks noChangeShapeType="1"/>
          </p:cNvSpPr>
          <p:nvPr/>
        </p:nvSpPr>
        <p:spPr bwMode="auto">
          <a:xfrm flipH="1">
            <a:off x="3282957" y="4750893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7" name="Line 450"/>
          <p:cNvSpPr>
            <a:spLocks noChangeShapeType="1"/>
          </p:cNvSpPr>
          <p:nvPr/>
        </p:nvSpPr>
        <p:spPr bwMode="auto">
          <a:xfrm flipH="1">
            <a:off x="3282957" y="4682233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8" name="Line 451"/>
          <p:cNvSpPr>
            <a:spLocks noChangeShapeType="1"/>
          </p:cNvSpPr>
          <p:nvPr/>
        </p:nvSpPr>
        <p:spPr bwMode="auto">
          <a:xfrm flipH="1">
            <a:off x="3282957" y="464860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9" name="Line 452"/>
          <p:cNvSpPr>
            <a:spLocks noChangeShapeType="1"/>
          </p:cNvSpPr>
          <p:nvPr/>
        </p:nvSpPr>
        <p:spPr bwMode="auto">
          <a:xfrm flipH="1">
            <a:off x="3282957" y="461357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0" name="Line 453"/>
          <p:cNvSpPr>
            <a:spLocks noChangeShapeType="1"/>
          </p:cNvSpPr>
          <p:nvPr/>
        </p:nvSpPr>
        <p:spPr bwMode="auto">
          <a:xfrm flipH="1">
            <a:off x="3282957" y="457994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1" name="Line 454"/>
          <p:cNvSpPr>
            <a:spLocks noChangeShapeType="1"/>
          </p:cNvSpPr>
          <p:nvPr/>
        </p:nvSpPr>
        <p:spPr bwMode="auto">
          <a:xfrm flipH="1">
            <a:off x="3282957" y="451128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2" name="Line 455"/>
          <p:cNvSpPr>
            <a:spLocks noChangeShapeType="1"/>
          </p:cNvSpPr>
          <p:nvPr/>
        </p:nvSpPr>
        <p:spPr bwMode="auto">
          <a:xfrm flipH="1">
            <a:off x="3282957" y="447765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3" name="Line 456"/>
          <p:cNvSpPr>
            <a:spLocks noChangeShapeType="1"/>
          </p:cNvSpPr>
          <p:nvPr/>
        </p:nvSpPr>
        <p:spPr bwMode="auto">
          <a:xfrm flipH="1">
            <a:off x="3282957" y="444262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4" name="Line 457"/>
          <p:cNvSpPr>
            <a:spLocks noChangeShapeType="1"/>
          </p:cNvSpPr>
          <p:nvPr/>
        </p:nvSpPr>
        <p:spPr bwMode="auto">
          <a:xfrm flipH="1">
            <a:off x="3282957" y="440899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5" name="Line 458"/>
          <p:cNvSpPr>
            <a:spLocks noChangeShapeType="1"/>
          </p:cNvSpPr>
          <p:nvPr/>
        </p:nvSpPr>
        <p:spPr bwMode="auto">
          <a:xfrm flipH="1">
            <a:off x="3282957" y="434033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6" name="Line 459"/>
          <p:cNvSpPr>
            <a:spLocks noChangeShapeType="1"/>
          </p:cNvSpPr>
          <p:nvPr/>
        </p:nvSpPr>
        <p:spPr bwMode="auto">
          <a:xfrm flipH="1">
            <a:off x="3282957" y="430530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7" name="Line 460"/>
          <p:cNvSpPr>
            <a:spLocks noChangeShapeType="1"/>
          </p:cNvSpPr>
          <p:nvPr/>
        </p:nvSpPr>
        <p:spPr bwMode="auto">
          <a:xfrm flipH="1">
            <a:off x="3282957" y="427167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8" name="Line 461"/>
          <p:cNvSpPr>
            <a:spLocks noChangeShapeType="1"/>
          </p:cNvSpPr>
          <p:nvPr/>
        </p:nvSpPr>
        <p:spPr bwMode="auto">
          <a:xfrm flipH="1">
            <a:off x="3282957" y="423664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9" name="Line 462"/>
          <p:cNvSpPr>
            <a:spLocks noChangeShapeType="1"/>
          </p:cNvSpPr>
          <p:nvPr/>
        </p:nvSpPr>
        <p:spPr bwMode="auto">
          <a:xfrm flipH="1">
            <a:off x="3282957" y="416938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0" name="Line 463"/>
          <p:cNvSpPr>
            <a:spLocks noChangeShapeType="1"/>
          </p:cNvSpPr>
          <p:nvPr/>
        </p:nvSpPr>
        <p:spPr bwMode="auto">
          <a:xfrm flipH="1">
            <a:off x="3282957" y="413435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1" name="Line 464"/>
          <p:cNvSpPr>
            <a:spLocks noChangeShapeType="1"/>
          </p:cNvSpPr>
          <p:nvPr/>
        </p:nvSpPr>
        <p:spPr bwMode="auto">
          <a:xfrm flipH="1">
            <a:off x="3282957" y="410072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2" name="Line 465"/>
          <p:cNvSpPr>
            <a:spLocks noChangeShapeType="1"/>
          </p:cNvSpPr>
          <p:nvPr/>
        </p:nvSpPr>
        <p:spPr bwMode="auto">
          <a:xfrm flipH="1">
            <a:off x="3282957" y="406569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3" name="Line 466"/>
          <p:cNvSpPr>
            <a:spLocks noChangeShapeType="1"/>
          </p:cNvSpPr>
          <p:nvPr/>
        </p:nvSpPr>
        <p:spPr bwMode="auto">
          <a:xfrm flipH="1">
            <a:off x="3282957" y="399703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4" name="Line 467"/>
          <p:cNvSpPr>
            <a:spLocks noChangeShapeType="1"/>
          </p:cNvSpPr>
          <p:nvPr/>
        </p:nvSpPr>
        <p:spPr bwMode="auto">
          <a:xfrm flipH="1">
            <a:off x="3282957" y="396340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5" name="Line 468"/>
          <p:cNvSpPr>
            <a:spLocks noChangeShapeType="1"/>
          </p:cNvSpPr>
          <p:nvPr/>
        </p:nvSpPr>
        <p:spPr bwMode="auto">
          <a:xfrm flipH="1">
            <a:off x="3282957" y="392837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6" name="Line 469"/>
          <p:cNvSpPr>
            <a:spLocks noChangeShapeType="1"/>
          </p:cNvSpPr>
          <p:nvPr/>
        </p:nvSpPr>
        <p:spPr bwMode="auto">
          <a:xfrm flipH="1">
            <a:off x="3282957" y="389474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7" name="Line 470"/>
          <p:cNvSpPr>
            <a:spLocks noChangeShapeType="1"/>
          </p:cNvSpPr>
          <p:nvPr/>
        </p:nvSpPr>
        <p:spPr bwMode="auto">
          <a:xfrm flipH="1">
            <a:off x="3282957" y="382608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8" name="Line 471"/>
          <p:cNvSpPr>
            <a:spLocks noChangeShapeType="1"/>
          </p:cNvSpPr>
          <p:nvPr/>
        </p:nvSpPr>
        <p:spPr bwMode="auto">
          <a:xfrm flipH="1">
            <a:off x="3282957" y="379245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9" name="Line 472"/>
          <p:cNvSpPr>
            <a:spLocks noChangeShapeType="1"/>
          </p:cNvSpPr>
          <p:nvPr/>
        </p:nvSpPr>
        <p:spPr bwMode="auto">
          <a:xfrm flipH="1">
            <a:off x="3282957" y="375742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0" name="Line 473"/>
          <p:cNvSpPr>
            <a:spLocks noChangeShapeType="1"/>
          </p:cNvSpPr>
          <p:nvPr/>
        </p:nvSpPr>
        <p:spPr bwMode="auto">
          <a:xfrm flipH="1">
            <a:off x="3282957" y="372379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1" name="Line 474"/>
          <p:cNvSpPr>
            <a:spLocks noChangeShapeType="1"/>
          </p:cNvSpPr>
          <p:nvPr/>
        </p:nvSpPr>
        <p:spPr bwMode="auto">
          <a:xfrm flipH="1">
            <a:off x="3282957" y="365513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2" name="Line 475"/>
          <p:cNvSpPr>
            <a:spLocks noChangeShapeType="1"/>
          </p:cNvSpPr>
          <p:nvPr/>
        </p:nvSpPr>
        <p:spPr bwMode="auto">
          <a:xfrm flipH="1">
            <a:off x="3282957" y="362010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3" name="Line 476"/>
          <p:cNvSpPr>
            <a:spLocks noChangeShapeType="1"/>
          </p:cNvSpPr>
          <p:nvPr/>
        </p:nvSpPr>
        <p:spPr bwMode="auto">
          <a:xfrm flipH="1">
            <a:off x="3282957" y="358647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4" name="Line 477"/>
          <p:cNvSpPr>
            <a:spLocks noChangeShapeType="1"/>
          </p:cNvSpPr>
          <p:nvPr/>
        </p:nvSpPr>
        <p:spPr bwMode="auto">
          <a:xfrm flipH="1">
            <a:off x="3282957" y="355144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5" name="Line 478"/>
          <p:cNvSpPr>
            <a:spLocks noChangeShapeType="1"/>
          </p:cNvSpPr>
          <p:nvPr/>
        </p:nvSpPr>
        <p:spPr bwMode="auto">
          <a:xfrm flipH="1">
            <a:off x="3282957" y="348278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6" name="Line 479"/>
          <p:cNvSpPr>
            <a:spLocks noChangeShapeType="1"/>
          </p:cNvSpPr>
          <p:nvPr/>
        </p:nvSpPr>
        <p:spPr bwMode="auto">
          <a:xfrm flipH="1">
            <a:off x="3282957" y="344915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7" name="Line 480"/>
          <p:cNvSpPr>
            <a:spLocks noChangeShapeType="1"/>
          </p:cNvSpPr>
          <p:nvPr/>
        </p:nvSpPr>
        <p:spPr bwMode="auto">
          <a:xfrm flipH="1">
            <a:off x="3282957" y="341552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8" name="Line 481"/>
          <p:cNvSpPr>
            <a:spLocks noChangeShapeType="1"/>
          </p:cNvSpPr>
          <p:nvPr/>
        </p:nvSpPr>
        <p:spPr bwMode="auto">
          <a:xfrm flipH="1">
            <a:off x="3282957" y="338049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9" name="Line 482"/>
          <p:cNvSpPr>
            <a:spLocks noChangeShapeType="1"/>
          </p:cNvSpPr>
          <p:nvPr/>
        </p:nvSpPr>
        <p:spPr bwMode="auto">
          <a:xfrm flipH="1">
            <a:off x="3282957" y="331183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0" name="Line 483"/>
          <p:cNvSpPr>
            <a:spLocks noChangeShapeType="1"/>
          </p:cNvSpPr>
          <p:nvPr/>
        </p:nvSpPr>
        <p:spPr bwMode="auto">
          <a:xfrm flipH="1">
            <a:off x="3282957" y="327821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1" name="Line 484"/>
          <p:cNvSpPr>
            <a:spLocks noChangeShapeType="1"/>
          </p:cNvSpPr>
          <p:nvPr/>
        </p:nvSpPr>
        <p:spPr bwMode="auto">
          <a:xfrm flipH="1">
            <a:off x="3282957" y="324317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2" name="Line 485"/>
          <p:cNvSpPr>
            <a:spLocks noChangeShapeType="1"/>
          </p:cNvSpPr>
          <p:nvPr/>
        </p:nvSpPr>
        <p:spPr bwMode="auto">
          <a:xfrm flipH="1">
            <a:off x="3282957" y="320955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3" name="Line 486"/>
          <p:cNvSpPr>
            <a:spLocks noChangeShapeType="1"/>
          </p:cNvSpPr>
          <p:nvPr/>
        </p:nvSpPr>
        <p:spPr bwMode="auto">
          <a:xfrm flipH="1">
            <a:off x="3282957" y="314089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4" name="Line 487"/>
          <p:cNvSpPr>
            <a:spLocks noChangeShapeType="1"/>
          </p:cNvSpPr>
          <p:nvPr/>
        </p:nvSpPr>
        <p:spPr bwMode="auto">
          <a:xfrm flipH="1">
            <a:off x="3282957" y="310586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5" name="Line 488"/>
          <p:cNvSpPr>
            <a:spLocks noChangeShapeType="1"/>
          </p:cNvSpPr>
          <p:nvPr/>
        </p:nvSpPr>
        <p:spPr bwMode="auto">
          <a:xfrm flipH="1">
            <a:off x="3282957" y="307223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" name="Line 489"/>
          <p:cNvSpPr>
            <a:spLocks noChangeShapeType="1"/>
          </p:cNvSpPr>
          <p:nvPr/>
        </p:nvSpPr>
        <p:spPr bwMode="auto">
          <a:xfrm flipH="1">
            <a:off x="3282957" y="303860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" name="Line 490"/>
          <p:cNvSpPr>
            <a:spLocks noChangeShapeType="1"/>
          </p:cNvSpPr>
          <p:nvPr/>
        </p:nvSpPr>
        <p:spPr bwMode="auto">
          <a:xfrm flipH="1">
            <a:off x="3282957" y="296994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Line 492"/>
          <p:cNvSpPr>
            <a:spLocks noChangeShapeType="1"/>
          </p:cNvSpPr>
          <p:nvPr/>
        </p:nvSpPr>
        <p:spPr bwMode="auto">
          <a:xfrm flipH="1">
            <a:off x="3282957" y="293491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8" name="Line 493"/>
          <p:cNvSpPr>
            <a:spLocks noChangeShapeType="1"/>
          </p:cNvSpPr>
          <p:nvPr/>
        </p:nvSpPr>
        <p:spPr bwMode="auto">
          <a:xfrm flipH="1">
            <a:off x="3282957" y="290128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Line 494"/>
          <p:cNvSpPr>
            <a:spLocks noChangeShapeType="1"/>
          </p:cNvSpPr>
          <p:nvPr/>
        </p:nvSpPr>
        <p:spPr bwMode="auto">
          <a:xfrm flipH="1">
            <a:off x="3282957" y="286625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Line 495"/>
          <p:cNvSpPr>
            <a:spLocks noChangeShapeType="1"/>
          </p:cNvSpPr>
          <p:nvPr/>
        </p:nvSpPr>
        <p:spPr bwMode="auto">
          <a:xfrm flipH="1">
            <a:off x="3282957" y="279759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Line 496"/>
          <p:cNvSpPr>
            <a:spLocks noChangeShapeType="1"/>
          </p:cNvSpPr>
          <p:nvPr/>
        </p:nvSpPr>
        <p:spPr bwMode="auto">
          <a:xfrm flipH="1">
            <a:off x="3282957" y="276396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Line 497"/>
          <p:cNvSpPr>
            <a:spLocks noChangeShapeType="1"/>
          </p:cNvSpPr>
          <p:nvPr/>
        </p:nvSpPr>
        <p:spPr bwMode="auto">
          <a:xfrm flipH="1">
            <a:off x="3282957" y="272893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Line 498"/>
          <p:cNvSpPr>
            <a:spLocks noChangeShapeType="1"/>
          </p:cNvSpPr>
          <p:nvPr/>
        </p:nvSpPr>
        <p:spPr bwMode="auto">
          <a:xfrm flipH="1">
            <a:off x="3282957" y="269530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4" name="Line 499"/>
          <p:cNvSpPr>
            <a:spLocks noChangeShapeType="1"/>
          </p:cNvSpPr>
          <p:nvPr/>
        </p:nvSpPr>
        <p:spPr bwMode="auto">
          <a:xfrm flipH="1">
            <a:off x="3282957" y="262664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Line 500"/>
          <p:cNvSpPr>
            <a:spLocks noChangeShapeType="1"/>
          </p:cNvSpPr>
          <p:nvPr/>
        </p:nvSpPr>
        <p:spPr bwMode="auto">
          <a:xfrm flipH="1">
            <a:off x="3282957" y="259301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Line 501"/>
          <p:cNvSpPr>
            <a:spLocks noChangeShapeType="1"/>
          </p:cNvSpPr>
          <p:nvPr/>
        </p:nvSpPr>
        <p:spPr bwMode="auto">
          <a:xfrm flipH="1">
            <a:off x="3282957" y="255798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7" name="Line 502"/>
          <p:cNvSpPr>
            <a:spLocks noChangeShapeType="1"/>
          </p:cNvSpPr>
          <p:nvPr/>
        </p:nvSpPr>
        <p:spPr bwMode="auto">
          <a:xfrm flipH="1">
            <a:off x="3282957" y="252435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Line 503"/>
          <p:cNvSpPr>
            <a:spLocks noChangeShapeType="1"/>
          </p:cNvSpPr>
          <p:nvPr/>
        </p:nvSpPr>
        <p:spPr bwMode="auto">
          <a:xfrm flipH="1">
            <a:off x="3271598" y="5916718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9" name="Rectangle 504"/>
          <p:cNvSpPr>
            <a:spLocks noChangeArrowheads="1"/>
          </p:cNvSpPr>
          <p:nvPr/>
        </p:nvSpPr>
        <p:spPr bwMode="auto">
          <a:xfrm>
            <a:off x="3202182" y="5877483"/>
            <a:ext cx="45880" cy="10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70" name="Line 505"/>
          <p:cNvSpPr>
            <a:spLocks noChangeShapeType="1"/>
          </p:cNvSpPr>
          <p:nvPr/>
        </p:nvSpPr>
        <p:spPr bwMode="auto">
          <a:xfrm flipH="1">
            <a:off x="3271598" y="5745768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Line 507"/>
          <p:cNvSpPr>
            <a:spLocks noChangeShapeType="1"/>
          </p:cNvSpPr>
          <p:nvPr/>
        </p:nvSpPr>
        <p:spPr bwMode="auto">
          <a:xfrm flipH="1">
            <a:off x="3271598" y="5573418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Rectangle 508"/>
          <p:cNvSpPr>
            <a:spLocks noChangeArrowheads="1"/>
          </p:cNvSpPr>
          <p:nvPr/>
        </p:nvSpPr>
        <p:spPr bwMode="auto">
          <a:xfrm>
            <a:off x="3163056" y="5535585"/>
            <a:ext cx="91760" cy="10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74" name="Line 509"/>
          <p:cNvSpPr>
            <a:spLocks noChangeShapeType="1"/>
          </p:cNvSpPr>
          <p:nvPr/>
        </p:nvSpPr>
        <p:spPr bwMode="auto">
          <a:xfrm flipH="1">
            <a:off x="3271598" y="5402469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6" name="Line 511"/>
          <p:cNvSpPr>
            <a:spLocks noChangeShapeType="1"/>
          </p:cNvSpPr>
          <p:nvPr/>
        </p:nvSpPr>
        <p:spPr bwMode="auto">
          <a:xfrm flipH="1">
            <a:off x="3271598" y="5231520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Rectangle 512"/>
          <p:cNvSpPr>
            <a:spLocks noChangeArrowheads="1"/>
          </p:cNvSpPr>
          <p:nvPr/>
        </p:nvSpPr>
        <p:spPr bwMode="auto">
          <a:xfrm>
            <a:off x="3163056" y="5192286"/>
            <a:ext cx="91760" cy="10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78" name="Line 513"/>
          <p:cNvSpPr>
            <a:spLocks noChangeShapeType="1"/>
          </p:cNvSpPr>
          <p:nvPr/>
        </p:nvSpPr>
        <p:spPr bwMode="auto">
          <a:xfrm flipH="1">
            <a:off x="3271598" y="5059169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0" name="Line 515"/>
          <p:cNvSpPr>
            <a:spLocks noChangeShapeType="1"/>
          </p:cNvSpPr>
          <p:nvPr/>
        </p:nvSpPr>
        <p:spPr bwMode="auto">
          <a:xfrm flipH="1">
            <a:off x="3271598" y="4888220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1" name="Rectangle 516"/>
          <p:cNvSpPr>
            <a:spLocks noChangeArrowheads="1"/>
          </p:cNvSpPr>
          <p:nvPr/>
        </p:nvSpPr>
        <p:spPr bwMode="auto">
          <a:xfrm>
            <a:off x="3163056" y="4848986"/>
            <a:ext cx="91760" cy="10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82" name="Line 517"/>
          <p:cNvSpPr>
            <a:spLocks noChangeShapeType="1"/>
          </p:cNvSpPr>
          <p:nvPr/>
        </p:nvSpPr>
        <p:spPr bwMode="auto">
          <a:xfrm flipH="1">
            <a:off x="3271598" y="4717271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4" name="Line 519"/>
          <p:cNvSpPr>
            <a:spLocks noChangeShapeType="1"/>
          </p:cNvSpPr>
          <p:nvPr/>
        </p:nvSpPr>
        <p:spPr bwMode="auto">
          <a:xfrm flipH="1">
            <a:off x="3271598" y="4546322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Rectangle 520"/>
          <p:cNvSpPr>
            <a:spLocks noChangeArrowheads="1"/>
          </p:cNvSpPr>
          <p:nvPr/>
        </p:nvSpPr>
        <p:spPr bwMode="auto">
          <a:xfrm>
            <a:off x="3163056" y="4507088"/>
            <a:ext cx="91760" cy="10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86" name="Line 521"/>
          <p:cNvSpPr>
            <a:spLocks noChangeShapeType="1"/>
          </p:cNvSpPr>
          <p:nvPr/>
        </p:nvSpPr>
        <p:spPr bwMode="auto">
          <a:xfrm flipH="1">
            <a:off x="3271598" y="4373972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8" name="Line 523"/>
          <p:cNvSpPr>
            <a:spLocks noChangeShapeType="1"/>
          </p:cNvSpPr>
          <p:nvPr/>
        </p:nvSpPr>
        <p:spPr bwMode="auto">
          <a:xfrm flipH="1">
            <a:off x="3271598" y="4203023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9" name="Rectangle 524"/>
          <p:cNvSpPr>
            <a:spLocks noChangeArrowheads="1"/>
          </p:cNvSpPr>
          <p:nvPr/>
        </p:nvSpPr>
        <p:spPr bwMode="auto">
          <a:xfrm>
            <a:off x="3163056" y="4163788"/>
            <a:ext cx="91760" cy="10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90" name="Line 525"/>
          <p:cNvSpPr>
            <a:spLocks noChangeShapeType="1"/>
          </p:cNvSpPr>
          <p:nvPr/>
        </p:nvSpPr>
        <p:spPr bwMode="auto">
          <a:xfrm flipH="1">
            <a:off x="3271598" y="4032073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2" name="Line 527"/>
          <p:cNvSpPr>
            <a:spLocks noChangeShapeType="1"/>
          </p:cNvSpPr>
          <p:nvPr/>
        </p:nvSpPr>
        <p:spPr bwMode="auto">
          <a:xfrm flipH="1">
            <a:off x="3271598" y="3859723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3" name="Rectangle 528"/>
          <p:cNvSpPr>
            <a:spLocks noChangeArrowheads="1"/>
          </p:cNvSpPr>
          <p:nvPr/>
        </p:nvSpPr>
        <p:spPr bwMode="auto">
          <a:xfrm>
            <a:off x="3163056" y="3821890"/>
            <a:ext cx="91760" cy="10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94" name="Line 529"/>
          <p:cNvSpPr>
            <a:spLocks noChangeShapeType="1"/>
          </p:cNvSpPr>
          <p:nvPr/>
        </p:nvSpPr>
        <p:spPr bwMode="auto">
          <a:xfrm flipH="1">
            <a:off x="3271598" y="3688773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6" name="Line 531"/>
          <p:cNvSpPr>
            <a:spLocks noChangeShapeType="1"/>
          </p:cNvSpPr>
          <p:nvPr/>
        </p:nvSpPr>
        <p:spPr bwMode="auto">
          <a:xfrm flipH="1">
            <a:off x="3271598" y="3517824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7" name="Rectangle 532"/>
          <p:cNvSpPr>
            <a:spLocks noChangeArrowheads="1"/>
          </p:cNvSpPr>
          <p:nvPr/>
        </p:nvSpPr>
        <p:spPr bwMode="auto">
          <a:xfrm>
            <a:off x="3163056" y="3478590"/>
            <a:ext cx="91760" cy="10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0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98" name="Line 533"/>
          <p:cNvSpPr>
            <a:spLocks noChangeShapeType="1"/>
          </p:cNvSpPr>
          <p:nvPr/>
        </p:nvSpPr>
        <p:spPr bwMode="auto">
          <a:xfrm flipH="1">
            <a:off x="3271598" y="3346875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0" name="Line 535"/>
          <p:cNvSpPr>
            <a:spLocks noChangeShapeType="1"/>
          </p:cNvSpPr>
          <p:nvPr/>
        </p:nvSpPr>
        <p:spPr bwMode="auto">
          <a:xfrm flipH="1">
            <a:off x="3271598" y="3174525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1" name="Rectangle 536"/>
          <p:cNvSpPr>
            <a:spLocks noChangeArrowheads="1"/>
          </p:cNvSpPr>
          <p:nvPr/>
        </p:nvSpPr>
        <p:spPr bwMode="auto">
          <a:xfrm>
            <a:off x="3163056" y="3136692"/>
            <a:ext cx="91760" cy="10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0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02" name="Line 537"/>
          <p:cNvSpPr>
            <a:spLocks noChangeShapeType="1"/>
          </p:cNvSpPr>
          <p:nvPr/>
        </p:nvSpPr>
        <p:spPr bwMode="auto">
          <a:xfrm flipH="1">
            <a:off x="3271598" y="3003576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4" name="Line 539"/>
          <p:cNvSpPr>
            <a:spLocks noChangeShapeType="1"/>
          </p:cNvSpPr>
          <p:nvPr/>
        </p:nvSpPr>
        <p:spPr bwMode="auto">
          <a:xfrm flipH="1">
            <a:off x="3271598" y="2832627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5" name="Rectangle 540"/>
          <p:cNvSpPr>
            <a:spLocks noChangeArrowheads="1"/>
          </p:cNvSpPr>
          <p:nvPr/>
        </p:nvSpPr>
        <p:spPr bwMode="auto">
          <a:xfrm>
            <a:off x="3163056" y="2793393"/>
            <a:ext cx="91760" cy="10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0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06" name="Line 541"/>
          <p:cNvSpPr>
            <a:spLocks noChangeShapeType="1"/>
          </p:cNvSpPr>
          <p:nvPr/>
        </p:nvSpPr>
        <p:spPr bwMode="auto">
          <a:xfrm flipH="1">
            <a:off x="3271598" y="2661678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8" name="Line 543"/>
          <p:cNvSpPr>
            <a:spLocks noChangeShapeType="1"/>
          </p:cNvSpPr>
          <p:nvPr/>
        </p:nvSpPr>
        <p:spPr bwMode="auto">
          <a:xfrm flipH="1">
            <a:off x="3271598" y="2485124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9" name="Rectangle 544"/>
          <p:cNvSpPr>
            <a:spLocks noChangeArrowheads="1"/>
          </p:cNvSpPr>
          <p:nvPr/>
        </p:nvSpPr>
        <p:spPr bwMode="auto">
          <a:xfrm>
            <a:off x="3103145" y="2434015"/>
            <a:ext cx="137640" cy="10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10" name="Rectangle 545"/>
          <p:cNvSpPr>
            <a:spLocks noChangeArrowheads="1"/>
          </p:cNvSpPr>
          <p:nvPr/>
        </p:nvSpPr>
        <p:spPr bwMode="auto">
          <a:xfrm rot="16200000">
            <a:off x="2591224" y="4169181"/>
            <a:ext cx="816401" cy="978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elative Abundance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11" name="Freeform 546"/>
          <p:cNvSpPr>
            <a:spLocks/>
          </p:cNvSpPr>
          <p:nvPr/>
        </p:nvSpPr>
        <p:spPr bwMode="auto">
          <a:xfrm>
            <a:off x="3309462" y="2485124"/>
            <a:ext cx="5878945" cy="3431594"/>
          </a:xfrm>
          <a:custGeom>
            <a:avLst/>
            <a:gdLst>
              <a:gd name="T0" fmla="*/ 10 w 1525"/>
              <a:gd name="T1" fmla="*/ 801 h 801"/>
              <a:gd name="T2" fmla="*/ 20 w 1525"/>
              <a:gd name="T3" fmla="*/ 801 h 801"/>
              <a:gd name="T4" fmla="*/ 30 w 1525"/>
              <a:gd name="T5" fmla="*/ 801 h 801"/>
              <a:gd name="T6" fmla="*/ 41 w 1525"/>
              <a:gd name="T7" fmla="*/ 801 h 801"/>
              <a:gd name="T8" fmla="*/ 51 w 1525"/>
              <a:gd name="T9" fmla="*/ 801 h 801"/>
              <a:gd name="T10" fmla="*/ 62 w 1525"/>
              <a:gd name="T11" fmla="*/ 801 h 801"/>
              <a:gd name="T12" fmla="*/ 75 w 1525"/>
              <a:gd name="T13" fmla="*/ 801 h 801"/>
              <a:gd name="T14" fmla="*/ 87 w 1525"/>
              <a:gd name="T15" fmla="*/ 801 h 801"/>
              <a:gd name="T16" fmla="*/ 98 w 1525"/>
              <a:gd name="T17" fmla="*/ 801 h 801"/>
              <a:gd name="T18" fmla="*/ 108 w 1525"/>
              <a:gd name="T19" fmla="*/ 801 h 801"/>
              <a:gd name="T20" fmla="*/ 120 w 1525"/>
              <a:gd name="T21" fmla="*/ 801 h 801"/>
              <a:gd name="T22" fmla="*/ 134 w 1525"/>
              <a:gd name="T23" fmla="*/ 801 h 801"/>
              <a:gd name="T24" fmla="*/ 145 w 1525"/>
              <a:gd name="T25" fmla="*/ 801 h 801"/>
              <a:gd name="T26" fmla="*/ 156 w 1525"/>
              <a:gd name="T27" fmla="*/ 801 h 801"/>
              <a:gd name="T28" fmla="*/ 168 w 1525"/>
              <a:gd name="T29" fmla="*/ 801 h 801"/>
              <a:gd name="T30" fmla="*/ 179 w 1525"/>
              <a:gd name="T31" fmla="*/ 801 h 801"/>
              <a:gd name="T32" fmla="*/ 191 w 1525"/>
              <a:gd name="T33" fmla="*/ 801 h 801"/>
              <a:gd name="T34" fmla="*/ 206 w 1525"/>
              <a:gd name="T35" fmla="*/ 801 h 801"/>
              <a:gd name="T36" fmla="*/ 219 w 1525"/>
              <a:gd name="T37" fmla="*/ 768 h 801"/>
              <a:gd name="T38" fmla="*/ 229 w 1525"/>
              <a:gd name="T39" fmla="*/ 801 h 801"/>
              <a:gd name="T40" fmla="*/ 240 w 1525"/>
              <a:gd name="T41" fmla="*/ 801 h 801"/>
              <a:gd name="T42" fmla="*/ 251 w 1525"/>
              <a:gd name="T43" fmla="*/ 801 h 801"/>
              <a:gd name="T44" fmla="*/ 271 w 1525"/>
              <a:gd name="T45" fmla="*/ 801 h 801"/>
              <a:gd name="T46" fmla="*/ 285 w 1525"/>
              <a:gd name="T47" fmla="*/ 801 h 801"/>
              <a:gd name="T48" fmla="*/ 303 w 1525"/>
              <a:gd name="T49" fmla="*/ 801 h 801"/>
              <a:gd name="T50" fmla="*/ 317 w 1525"/>
              <a:gd name="T51" fmla="*/ 801 h 801"/>
              <a:gd name="T52" fmla="*/ 330 w 1525"/>
              <a:gd name="T53" fmla="*/ 801 h 801"/>
              <a:gd name="T54" fmla="*/ 349 w 1525"/>
              <a:gd name="T55" fmla="*/ 801 h 801"/>
              <a:gd name="T56" fmla="*/ 364 w 1525"/>
              <a:gd name="T57" fmla="*/ 798 h 801"/>
              <a:gd name="T58" fmla="*/ 384 w 1525"/>
              <a:gd name="T59" fmla="*/ 801 h 801"/>
              <a:gd name="T60" fmla="*/ 399 w 1525"/>
              <a:gd name="T61" fmla="*/ 781 h 801"/>
              <a:gd name="T62" fmla="*/ 413 w 1525"/>
              <a:gd name="T63" fmla="*/ 801 h 801"/>
              <a:gd name="T64" fmla="*/ 430 w 1525"/>
              <a:gd name="T65" fmla="*/ 801 h 801"/>
              <a:gd name="T66" fmla="*/ 449 w 1525"/>
              <a:gd name="T67" fmla="*/ 800 h 801"/>
              <a:gd name="T68" fmla="*/ 463 w 1525"/>
              <a:gd name="T69" fmla="*/ 801 h 801"/>
              <a:gd name="T70" fmla="*/ 478 w 1525"/>
              <a:gd name="T71" fmla="*/ 801 h 801"/>
              <a:gd name="T72" fmla="*/ 496 w 1525"/>
              <a:gd name="T73" fmla="*/ 800 h 801"/>
              <a:gd name="T74" fmla="*/ 510 w 1525"/>
              <a:gd name="T75" fmla="*/ 801 h 801"/>
              <a:gd name="T76" fmla="*/ 531 w 1525"/>
              <a:gd name="T77" fmla="*/ 799 h 801"/>
              <a:gd name="T78" fmla="*/ 557 w 1525"/>
              <a:gd name="T79" fmla="*/ 801 h 801"/>
              <a:gd name="T80" fmla="*/ 582 w 1525"/>
              <a:gd name="T81" fmla="*/ 801 h 801"/>
              <a:gd name="T82" fmla="*/ 608 w 1525"/>
              <a:gd name="T83" fmla="*/ 801 h 801"/>
              <a:gd name="T84" fmla="*/ 630 w 1525"/>
              <a:gd name="T85" fmla="*/ 801 h 801"/>
              <a:gd name="T86" fmla="*/ 662 w 1525"/>
              <a:gd name="T87" fmla="*/ 801 h 801"/>
              <a:gd name="T88" fmla="*/ 704 w 1525"/>
              <a:gd name="T89" fmla="*/ 801 h 801"/>
              <a:gd name="T90" fmla="*/ 724 w 1525"/>
              <a:gd name="T91" fmla="*/ 801 h 801"/>
              <a:gd name="T92" fmla="*/ 736 w 1525"/>
              <a:gd name="T93" fmla="*/ 801 h 801"/>
              <a:gd name="T94" fmla="*/ 754 w 1525"/>
              <a:gd name="T95" fmla="*/ 801 h 801"/>
              <a:gd name="T96" fmla="*/ 800 w 1525"/>
              <a:gd name="T97" fmla="*/ 801 h 801"/>
              <a:gd name="T98" fmla="*/ 871 w 1525"/>
              <a:gd name="T99" fmla="*/ 801 h 801"/>
              <a:gd name="T100" fmla="*/ 910 w 1525"/>
              <a:gd name="T101" fmla="*/ 801 h 801"/>
              <a:gd name="T102" fmla="*/ 952 w 1525"/>
              <a:gd name="T103" fmla="*/ 801 h 801"/>
              <a:gd name="T104" fmla="*/ 983 w 1525"/>
              <a:gd name="T105" fmla="*/ 801 h 801"/>
              <a:gd name="T106" fmla="*/ 1028 w 1525"/>
              <a:gd name="T107" fmla="*/ 801 h 801"/>
              <a:gd name="T108" fmla="*/ 1081 w 1525"/>
              <a:gd name="T109" fmla="*/ 801 h 801"/>
              <a:gd name="T110" fmla="*/ 1136 w 1525"/>
              <a:gd name="T111" fmla="*/ 801 h 801"/>
              <a:gd name="T112" fmla="*/ 1209 w 1525"/>
              <a:gd name="T113" fmla="*/ 801 h 801"/>
              <a:gd name="T114" fmla="*/ 1291 w 1525"/>
              <a:gd name="T115" fmla="*/ 801 h 801"/>
              <a:gd name="T116" fmla="*/ 1342 w 1525"/>
              <a:gd name="T117" fmla="*/ 801 h 801"/>
              <a:gd name="T118" fmla="*/ 1436 w 1525"/>
              <a:gd name="T119" fmla="*/ 801 h 801"/>
              <a:gd name="T120" fmla="*/ 1500 w 1525"/>
              <a:gd name="T121" fmla="*/ 801 h 8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1525" h="801">
                <a:moveTo>
                  <a:pt x="0" y="801"/>
                </a:moveTo>
                <a:lnTo>
                  <a:pt x="0" y="801"/>
                </a:lnTo>
                <a:lnTo>
                  <a:pt x="1" y="801"/>
                </a:lnTo>
                <a:lnTo>
                  <a:pt x="1" y="801"/>
                </a:lnTo>
                <a:lnTo>
                  <a:pt x="3" y="801"/>
                </a:lnTo>
                <a:lnTo>
                  <a:pt x="3" y="801"/>
                </a:lnTo>
                <a:lnTo>
                  <a:pt x="3" y="801"/>
                </a:lnTo>
                <a:lnTo>
                  <a:pt x="4" y="801"/>
                </a:lnTo>
                <a:lnTo>
                  <a:pt x="4" y="801"/>
                </a:lnTo>
                <a:lnTo>
                  <a:pt x="5" y="801"/>
                </a:lnTo>
                <a:lnTo>
                  <a:pt x="5" y="801"/>
                </a:lnTo>
                <a:lnTo>
                  <a:pt x="6" y="801"/>
                </a:lnTo>
                <a:lnTo>
                  <a:pt x="6" y="801"/>
                </a:lnTo>
                <a:lnTo>
                  <a:pt x="7" y="801"/>
                </a:lnTo>
                <a:lnTo>
                  <a:pt x="7" y="801"/>
                </a:lnTo>
                <a:lnTo>
                  <a:pt x="8" y="801"/>
                </a:lnTo>
                <a:lnTo>
                  <a:pt x="8" y="801"/>
                </a:lnTo>
                <a:lnTo>
                  <a:pt x="9" y="800"/>
                </a:lnTo>
                <a:lnTo>
                  <a:pt x="9" y="801"/>
                </a:lnTo>
                <a:lnTo>
                  <a:pt x="10" y="801"/>
                </a:lnTo>
                <a:lnTo>
                  <a:pt x="10" y="801"/>
                </a:lnTo>
                <a:lnTo>
                  <a:pt x="11" y="801"/>
                </a:lnTo>
                <a:lnTo>
                  <a:pt x="11" y="801"/>
                </a:lnTo>
                <a:lnTo>
                  <a:pt x="12" y="801"/>
                </a:lnTo>
                <a:lnTo>
                  <a:pt x="12" y="801"/>
                </a:lnTo>
                <a:lnTo>
                  <a:pt x="13" y="801"/>
                </a:lnTo>
                <a:lnTo>
                  <a:pt x="13" y="801"/>
                </a:lnTo>
                <a:lnTo>
                  <a:pt x="14" y="796"/>
                </a:lnTo>
                <a:lnTo>
                  <a:pt x="14" y="801"/>
                </a:lnTo>
                <a:lnTo>
                  <a:pt x="15" y="801"/>
                </a:lnTo>
                <a:lnTo>
                  <a:pt x="15" y="801"/>
                </a:lnTo>
                <a:lnTo>
                  <a:pt x="16" y="801"/>
                </a:lnTo>
                <a:lnTo>
                  <a:pt x="16" y="801"/>
                </a:lnTo>
                <a:lnTo>
                  <a:pt x="18" y="801"/>
                </a:lnTo>
                <a:lnTo>
                  <a:pt x="18" y="801"/>
                </a:lnTo>
                <a:lnTo>
                  <a:pt x="18" y="801"/>
                </a:lnTo>
                <a:lnTo>
                  <a:pt x="19" y="801"/>
                </a:lnTo>
                <a:lnTo>
                  <a:pt x="19" y="801"/>
                </a:lnTo>
                <a:lnTo>
                  <a:pt x="20" y="801"/>
                </a:lnTo>
                <a:lnTo>
                  <a:pt x="20" y="801"/>
                </a:lnTo>
                <a:lnTo>
                  <a:pt x="21" y="801"/>
                </a:lnTo>
                <a:lnTo>
                  <a:pt x="21" y="801"/>
                </a:lnTo>
                <a:lnTo>
                  <a:pt x="22" y="801"/>
                </a:lnTo>
                <a:lnTo>
                  <a:pt x="22" y="801"/>
                </a:lnTo>
                <a:lnTo>
                  <a:pt x="23" y="801"/>
                </a:lnTo>
                <a:lnTo>
                  <a:pt x="23" y="801"/>
                </a:lnTo>
                <a:lnTo>
                  <a:pt x="24" y="801"/>
                </a:lnTo>
                <a:lnTo>
                  <a:pt x="24" y="801"/>
                </a:lnTo>
                <a:lnTo>
                  <a:pt x="25" y="801"/>
                </a:lnTo>
                <a:lnTo>
                  <a:pt x="25" y="801"/>
                </a:lnTo>
                <a:lnTo>
                  <a:pt x="26" y="801"/>
                </a:lnTo>
                <a:lnTo>
                  <a:pt x="26" y="801"/>
                </a:lnTo>
                <a:lnTo>
                  <a:pt x="27" y="801"/>
                </a:lnTo>
                <a:lnTo>
                  <a:pt x="27" y="801"/>
                </a:lnTo>
                <a:lnTo>
                  <a:pt x="28" y="801"/>
                </a:lnTo>
                <a:lnTo>
                  <a:pt x="28" y="801"/>
                </a:lnTo>
                <a:lnTo>
                  <a:pt x="29" y="801"/>
                </a:lnTo>
                <a:lnTo>
                  <a:pt x="29" y="801"/>
                </a:lnTo>
                <a:lnTo>
                  <a:pt x="30" y="801"/>
                </a:lnTo>
                <a:lnTo>
                  <a:pt x="30" y="801"/>
                </a:lnTo>
                <a:lnTo>
                  <a:pt x="31" y="801"/>
                </a:lnTo>
                <a:lnTo>
                  <a:pt x="31" y="801"/>
                </a:lnTo>
                <a:lnTo>
                  <a:pt x="33" y="801"/>
                </a:lnTo>
                <a:lnTo>
                  <a:pt x="33" y="801"/>
                </a:lnTo>
                <a:lnTo>
                  <a:pt x="33" y="801"/>
                </a:lnTo>
                <a:lnTo>
                  <a:pt x="34" y="801"/>
                </a:lnTo>
                <a:lnTo>
                  <a:pt x="34" y="801"/>
                </a:lnTo>
                <a:lnTo>
                  <a:pt x="35" y="801"/>
                </a:lnTo>
                <a:lnTo>
                  <a:pt x="35" y="801"/>
                </a:lnTo>
                <a:lnTo>
                  <a:pt x="36" y="801"/>
                </a:lnTo>
                <a:lnTo>
                  <a:pt x="36" y="801"/>
                </a:lnTo>
                <a:lnTo>
                  <a:pt x="37" y="801"/>
                </a:lnTo>
                <a:lnTo>
                  <a:pt x="37" y="801"/>
                </a:lnTo>
                <a:lnTo>
                  <a:pt x="38" y="801"/>
                </a:lnTo>
                <a:lnTo>
                  <a:pt x="38" y="801"/>
                </a:lnTo>
                <a:lnTo>
                  <a:pt x="39" y="801"/>
                </a:lnTo>
                <a:lnTo>
                  <a:pt x="39" y="801"/>
                </a:lnTo>
                <a:lnTo>
                  <a:pt x="40" y="801"/>
                </a:lnTo>
                <a:lnTo>
                  <a:pt x="40" y="801"/>
                </a:lnTo>
                <a:lnTo>
                  <a:pt x="41" y="801"/>
                </a:lnTo>
                <a:lnTo>
                  <a:pt x="41" y="801"/>
                </a:lnTo>
                <a:lnTo>
                  <a:pt x="42" y="801"/>
                </a:lnTo>
                <a:lnTo>
                  <a:pt x="42" y="801"/>
                </a:lnTo>
                <a:lnTo>
                  <a:pt x="43" y="801"/>
                </a:lnTo>
                <a:lnTo>
                  <a:pt x="43" y="801"/>
                </a:lnTo>
                <a:lnTo>
                  <a:pt x="44" y="801"/>
                </a:lnTo>
                <a:lnTo>
                  <a:pt x="44" y="801"/>
                </a:lnTo>
                <a:lnTo>
                  <a:pt x="45" y="801"/>
                </a:lnTo>
                <a:lnTo>
                  <a:pt x="45" y="801"/>
                </a:lnTo>
                <a:lnTo>
                  <a:pt x="46" y="801"/>
                </a:lnTo>
                <a:lnTo>
                  <a:pt x="46" y="801"/>
                </a:lnTo>
                <a:lnTo>
                  <a:pt x="48" y="801"/>
                </a:lnTo>
                <a:lnTo>
                  <a:pt x="48" y="801"/>
                </a:lnTo>
                <a:lnTo>
                  <a:pt x="48" y="801"/>
                </a:lnTo>
                <a:lnTo>
                  <a:pt x="49" y="801"/>
                </a:lnTo>
                <a:lnTo>
                  <a:pt x="49" y="801"/>
                </a:lnTo>
                <a:lnTo>
                  <a:pt x="50" y="801"/>
                </a:lnTo>
                <a:lnTo>
                  <a:pt x="50" y="801"/>
                </a:lnTo>
                <a:lnTo>
                  <a:pt x="51" y="801"/>
                </a:lnTo>
                <a:lnTo>
                  <a:pt x="51" y="801"/>
                </a:lnTo>
                <a:lnTo>
                  <a:pt x="52" y="801"/>
                </a:lnTo>
                <a:lnTo>
                  <a:pt x="52" y="801"/>
                </a:lnTo>
                <a:lnTo>
                  <a:pt x="53" y="801"/>
                </a:lnTo>
                <a:lnTo>
                  <a:pt x="53" y="801"/>
                </a:lnTo>
                <a:lnTo>
                  <a:pt x="54" y="801"/>
                </a:lnTo>
                <a:lnTo>
                  <a:pt x="54" y="801"/>
                </a:lnTo>
                <a:lnTo>
                  <a:pt x="55" y="801"/>
                </a:lnTo>
                <a:lnTo>
                  <a:pt x="55" y="801"/>
                </a:lnTo>
                <a:lnTo>
                  <a:pt x="57" y="801"/>
                </a:lnTo>
                <a:lnTo>
                  <a:pt x="57" y="801"/>
                </a:lnTo>
                <a:lnTo>
                  <a:pt x="57" y="801"/>
                </a:lnTo>
                <a:lnTo>
                  <a:pt x="58" y="801"/>
                </a:lnTo>
                <a:lnTo>
                  <a:pt x="58" y="801"/>
                </a:lnTo>
                <a:lnTo>
                  <a:pt x="59" y="801"/>
                </a:lnTo>
                <a:lnTo>
                  <a:pt x="59" y="801"/>
                </a:lnTo>
                <a:lnTo>
                  <a:pt x="60" y="801"/>
                </a:lnTo>
                <a:lnTo>
                  <a:pt x="60" y="801"/>
                </a:lnTo>
                <a:lnTo>
                  <a:pt x="61" y="801"/>
                </a:lnTo>
                <a:lnTo>
                  <a:pt x="61" y="801"/>
                </a:lnTo>
                <a:lnTo>
                  <a:pt x="62" y="801"/>
                </a:lnTo>
                <a:lnTo>
                  <a:pt x="62" y="801"/>
                </a:lnTo>
                <a:lnTo>
                  <a:pt x="66" y="801"/>
                </a:lnTo>
                <a:lnTo>
                  <a:pt x="66" y="801"/>
                </a:lnTo>
                <a:lnTo>
                  <a:pt x="66" y="801"/>
                </a:lnTo>
                <a:lnTo>
                  <a:pt x="67" y="801"/>
                </a:lnTo>
                <a:lnTo>
                  <a:pt x="67" y="801"/>
                </a:lnTo>
                <a:lnTo>
                  <a:pt x="68" y="801"/>
                </a:lnTo>
                <a:lnTo>
                  <a:pt x="68" y="801"/>
                </a:lnTo>
                <a:lnTo>
                  <a:pt x="69" y="801"/>
                </a:lnTo>
                <a:lnTo>
                  <a:pt x="69" y="801"/>
                </a:lnTo>
                <a:lnTo>
                  <a:pt x="71" y="801"/>
                </a:lnTo>
                <a:lnTo>
                  <a:pt x="71" y="801"/>
                </a:lnTo>
                <a:lnTo>
                  <a:pt x="71" y="801"/>
                </a:lnTo>
                <a:lnTo>
                  <a:pt x="72" y="801"/>
                </a:lnTo>
                <a:lnTo>
                  <a:pt x="72" y="801"/>
                </a:lnTo>
                <a:lnTo>
                  <a:pt x="73" y="801"/>
                </a:lnTo>
                <a:lnTo>
                  <a:pt x="73" y="801"/>
                </a:lnTo>
                <a:lnTo>
                  <a:pt x="74" y="801"/>
                </a:lnTo>
                <a:lnTo>
                  <a:pt x="74" y="801"/>
                </a:lnTo>
                <a:lnTo>
                  <a:pt x="75" y="801"/>
                </a:lnTo>
                <a:lnTo>
                  <a:pt x="75" y="801"/>
                </a:lnTo>
                <a:lnTo>
                  <a:pt x="76" y="801"/>
                </a:lnTo>
                <a:lnTo>
                  <a:pt x="76" y="801"/>
                </a:lnTo>
                <a:lnTo>
                  <a:pt x="77" y="801"/>
                </a:lnTo>
                <a:lnTo>
                  <a:pt x="77" y="801"/>
                </a:lnTo>
                <a:lnTo>
                  <a:pt x="79" y="801"/>
                </a:lnTo>
                <a:lnTo>
                  <a:pt x="79" y="801"/>
                </a:lnTo>
                <a:lnTo>
                  <a:pt x="79" y="801"/>
                </a:lnTo>
                <a:lnTo>
                  <a:pt x="80" y="801"/>
                </a:lnTo>
                <a:lnTo>
                  <a:pt x="80" y="801"/>
                </a:lnTo>
                <a:lnTo>
                  <a:pt x="81" y="801"/>
                </a:lnTo>
                <a:lnTo>
                  <a:pt x="81" y="801"/>
                </a:lnTo>
                <a:lnTo>
                  <a:pt x="82" y="801"/>
                </a:lnTo>
                <a:lnTo>
                  <a:pt x="82" y="801"/>
                </a:lnTo>
                <a:lnTo>
                  <a:pt x="83" y="801"/>
                </a:lnTo>
                <a:lnTo>
                  <a:pt x="83" y="801"/>
                </a:lnTo>
                <a:lnTo>
                  <a:pt x="86" y="801"/>
                </a:lnTo>
                <a:lnTo>
                  <a:pt x="86" y="801"/>
                </a:lnTo>
                <a:lnTo>
                  <a:pt x="86" y="801"/>
                </a:lnTo>
                <a:lnTo>
                  <a:pt x="87" y="801"/>
                </a:lnTo>
                <a:lnTo>
                  <a:pt x="87" y="801"/>
                </a:lnTo>
                <a:lnTo>
                  <a:pt x="89" y="801"/>
                </a:lnTo>
                <a:lnTo>
                  <a:pt x="89" y="801"/>
                </a:lnTo>
                <a:lnTo>
                  <a:pt x="89" y="801"/>
                </a:lnTo>
                <a:lnTo>
                  <a:pt x="90" y="801"/>
                </a:lnTo>
                <a:lnTo>
                  <a:pt x="90" y="801"/>
                </a:lnTo>
                <a:lnTo>
                  <a:pt x="92" y="801"/>
                </a:lnTo>
                <a:lnTo>
                  <a:pt x="92" y="801"/>
                </a:lnTo>
                <a:lnTo>
                  <a:pt x="92" y="801"/>
                </a:lnTo>
                <a:lnTo>
                  <a:pt x="93" y="801"/>
                </a:lnTo>
                <a:lnTo>
                  <a:pt x="93" y="801"/>
                </a:lnTo>
                <a:lnTo>
                  <a:pt x="94" y="801"/>
                </a:lnTo>
                <a:lnTo>
                  <a:pt x="94" y="801"/>
                </a:lnTo>
                <a:lnTo>
                  <a:pt x="95" y="801"/>
                </a:lnTo>
                <a:lnTo>
                  <a:pt x="95" y="801"/>
                </a:lnTo>
                <a:lnTo>
                  <a:pt x="96" y="801"/>
                </a:lnTo>
                <a:lnTo>
                  <a:pt x="96" y="801"/>
                </a:lnTo>
                <a:lnTo>
                  <a:pt x="97" y="801"/>
                </a:lnTo>
                <a:lnTo>
                  <a:pt x="97" y="801"/>
                </a:lnTo>
                <a:lnTo>
                  <a:pt x="98" y="801"/>
                </a:lnTo>
                <a:lnTo>
                  <a:pt x="98" y="801"/>
                </a:lnTo>
                <a:lnTo>
                  <a:pt x="99" y="801"/>
                </a:lnTo>
                <a:lnTo>
                  <a:pt x="99" y="801"/>
                </a:lnTo>
                <a:lnTo>
                  <a:pt x="100" y="801"/>
                </a:lnTo>
                <a:lnTo>
                  <a:pt x="100" y="801"/>
                </a:lnTo>
                <a:lnTo>
                  <a:pt x="101" y="798"/>
                </a:lnTo>
                <a:lnTo>
                  <a:pt x="101" y="801"/>
                </a:lnTo>
                <a:lnTo>
                  <a:pt x="103" y="801"/>
                </a:lnTo>
                <a:lnTo>
                  <a:pt x="103" y="801"/>
                </a:lnTo>
                <a:lnTo>
                  <a:pt x="103" y="801"/>
                </a:lnTo>
                <a:lnTo>
                  <a:pt x="104" y="801"/>
                </a:lnTo>
                <a:lnTo>
                  <a:pt x="104" y="801"/>
                </a:lnTo>
                <a:lnTo>
                  <a:pt x="105" y="801"/>
                </a:lnTo>
                <a:lnTo>
                  <a:pt x="105" y="801"/>
                </a:lnTo>
                <a:lnTo>
                  <a:pt x="106" y="801"/>
                </a:lnTo>
                <a:lnTo>
                  <a:pt x="106" y="801"/>
                </a:lnTo>
                <a:lnTo>
                  <a:pt x="107" y="801"/>
                </a:lnTo>
                <a:lnTo>
                  <a:pt x="107" y="801"/>
                </a:lnTo>
                <a:lnTo>
                  <a:pt x="108" y="801"/>
                </a:lnTo>
                <a:lnTo>
                  <a:pt x="108" y="801"/>
                </a:lnTo>
                <a:lnTo>
                  <a:pt x="109" y="801"/>
                </a:lnTo>
                <a:lnTo>
                  <a:pt x="109" y="801"/>
                </a:lnTo>
                <a:lnTo>
                  <a:pt x="110" y="798"/>
                </a:lnTo>
                <a:lnTo>
                  <a:pt x="110" y="801"/>
                </a:lnTo>
                <a:lnTo>
                  <a:pt x="111" y="801"/>
                </a:lnTo>
                <a:lnTo>
                  <a:pt x="111" y="801"/>
                </a:lnTo>
                <a:lnTo>
                  <a:pt x="112" y="801"/>
                </a:lnTo>
                <a:lnTo>
                  <a:pt x="112" y="801"/>
                </a:lnTo>
                <a:lnTo>
                  <a:pt x="114" y="801"/>
                </a:lnTo>
                <a:lnTo>
                  <a:pt x="114" y="801"/>
                </a:lnTo>
                <a:lnTo>
                  <a:pt x="114" y="801"/>
                </a:lnTo>
                <a:lnTo>
                  <a:pt x="115" y="795"/>
                </a:lnTo>
                <a:lnTo>
                  <a:pt x="115" y="801"/>
                </a:lnTo>
                <a:lnTo>
                  <a:pt x="117" y="801"/>
                </a:lnTo>
                <a:lnTo>
                  <a:pt x="117" y="801"/>
                </a:lnTo>
                <a:lnTo>
                  <a:pt x="117" y="801"/>
                </a:lnTo>
                <a:lnTo>
                  <a:pt x="118" y="801"/>
                </a:lnTo>
                <a:lnTo>
                  <a:pt x="118" y="801"/>
                </a:lnTo>
                <a:lnTo>
                  <a:pt x="120" y="801"/>
                </a:lnTo>
                <a:lnTo>
                  <a:pt x="120" y="801"/>
                </a:lnTo>
                <a:lnTo>
                  <a:pt x="120" y="801"/>
                </a:lnTo>
                <a:lnTo>
                  <a:pt x="121" y="799"/>
                </a:lnTo>
                <a:lnTo>
                  <a:pt x="121" y="801"/>
                </a:lnTo>
                <a:lnTo>
                  <a:pt x="122" y="801"/>
                </a:lnTo>
                <a:lnTo>
                  <a:pt x="122" y="801"/>
                </a:lnTo>
                <a:lnTo>
                  <a:pt x="123" y="770"/>
                </a:lnTo>
                <a:lnTo>
                  <a:pt x="123" y="801"/>
                </a:lnTo>
                <a:lnTo>
                  <a:pt x="124" y="801"/>
                </a:lnTo>
                <a:lnTo>
                  <a:pt x="124" y="801"/>
                </a:lnTo>
                <a:lnTo>
                  <a:pt x="125" y="801"/>
                </a:lnTo>
                <a:lnTo>
                  <a:pt x="125" y="801"/>
                </a:lnTo>
                <a:lnTo>
                  <a:pt x="126" y="801"/>
                </a:lnTo>
                <a:lnTo>
                  <a:pt x="126" y="801"/>
                </a:lnTo>
                <a:lnTo>
                  <a:pt x="127" y="801"/>
                </a:lnTo>
                <a:lnTo>
                  <a:pt x="127" y="801"/>
                </a:lnTo>
                <a:lnTo>
                  <a:pt x="128" y="801"/>
                </a:lnTo>
                <a:lnTo>
                  <a:pt x="128" y="801"/>
                </a:lnTo>
                <a:lnTo>
                  <a:pt x="134" y="801"/>
                </a:lnTo>
                <a:lnTo>
                  <a:pt x="134" y="801"/>
                </a:lnTo>
                <a:lnTo>
                  <a:pt x="134" y="801"/>
                </a:lnTo>
                <a:lnTo>
                  <a:pt x="135" y="801"/>
                </a:lnTo>
                <a:lnTo>
                  <a:pt x="135" y="801"/>
                </a:lnTo>
                <a:lnTo>
                  <a:pt x="136" y="801"/>
                </a:lnTo>
                <a:lnTo>
                  <a:pt x="136" y="801"/>
                </a:lnTo>
                <a:lnTo>
                  <a:pt x="137" y="801"/>
                </a:lnTo>
                <a:lnTo>
                  <a:pt x="137" y="801"/>
                </a:lnTo>
                <a:lnTo>
                  <a:pt x="138" y="801"/>
                </a:lnTo>
                <a:lnTo>
                  <a:pt x="138" y="801"/>
                </a:lnTo>
                <a:lnTo>
                  <a:pt x="139" y="801"/>
                </a:lnTo>
                <a:lnTo>
                  <a:pt x="139" y="801"/>
                </a:lnTo>
                <a:lnTo>
                  <a:pt x="140" y="801"/>
                </a:lnTo>
                <a:lnTo>
                  <a:pt x="140" y="801"/>
                </a:lnTo>
                <a:lnTo>
                  <a:pt x="141" y="801"/>
                </a:lnTo>
                <a:lnTo>
                  <a:pt x="141" y="801"/>
                </a:lnTo>
                <a:lnTo>
                  <a:pt x="142" y="801"/>
                </a:lnTo>
                <a:lnTo>
                  <a:pt x="142" y="801"/>
                </a:lnTo>
                <a:lnTo>
                  <a:pt x="143" y="801"/>
                </a:lnTo>
                <a:lnTo>
                  <a:pt x="143" y="801"/>
                </a:lnTo>
                <a:lnTo>
                  <a:pt x="145" y="801"/>
                </a:lnTo>
                <a:lnTo>
                  <a:pt x="145" y="801"/>
                </a:lnTo>
                <a:lnTo>
                  <a:pt x="145" y="801"/>
                </a:lnTo>
                <a:lnTo>
                  <a:pt x="146" y="760"/>
                </a:lnTo>
                <a:lnTo>
                  <a:pt x="146" y="801"/>
                </a:lnTo>
                <a:lnTo>
                  <a:pt x="147" y="800"/>
                </a:lnTo>
                <a:lnTo>
                  <a:pt x="147" y="801"/>
                </a:lnTo>
                <a:lnTo>
                  <a:pt x="148" y="801"/>
                </a:lnTo>
                <a:lnTo>
                  <a:pt x="148" y="801"/>
                </a:lnTo>
                <a:lnTo>
                  <a:pt x="149" y="797"/>
                </a:lnTo>
                <a:lnTo>
                  <a:pt x="149" y="801"/>
                </a:lnTo>
                <a:lnTo>
                  <a:pt x="150" y="801"/>
                </a:lnTo>
                <a:lnTo>
                  <a:pt x="150" y="801"/>
                </a:lnTo>
                <a:lnTo>
                  <a:pt x="151" y="801"/>
                </a:lnTo>
                <a:lnTo>
                  <a:pt x="151" y="801"/>
                </a:lnTo>
                <a:lnTo>
                  <a:pt x="153" y="801"/>
                </a:lnTo>
                <a:lnTo>
                  <a:pt x="153" y="801"/>
                </a:lnTo>
                <a:lnTo>
                  <a:pt x="153" y="801"/>
                </a:lnTo>
                <a:lnTo>
                  <a:pt x="155" y="801"/>
                </a:lnTo>
                <a:lnTo>
                  <a:pt x="155" y="801"/>
                </a:lnTo>
                <a:lnTo>
                  <a:pt x="155" y="801"/>
                </a:lnTo>
                <a:lnTo>
                  <a:pt x="156" y="801"/>
                </a:lnTo>
                <a:lnTo>
                  <a:pt x="156" y="801"/>
                </a:lnTo>
                <a:lnTo>
                  <a:pt x="157" y="801"/>
                </a:lnTo>
                <a:lnTo>
                  <a:pt x="157" y="801"/>
                </a:lnTo>
                <a:lnTo>
                  <a:pt x="158" y="801"/>
                </a:lnTo>
                <a:lnTo>
                  <a:pt x="158" y="801"/>
                </a:lnTo>
                <a:lnTo>
                  <a:pt x="159" y="801"/>
                </a:lnTo>
                <a:lnTo>
                  <a:pt x="159" y="801"/>
                </a:lnTo>
                <a:lnTo>
                  <a:pt x="160" y="612"/>
                </a:lnTo>
                <a:lnTo>
                  <a:pt x="160" y="801"/>
                </a:lnTo>
                <a:lnTo>
                  <a:pt x="161" y="801"/>
                </a:lnTo>
                <a:lnTo>
                  <a:pt x="161" y="801"/>
                </a:lnTo>
                <a:lnTo>
                  <a:pt x="162" y="785"/>
                </a:lnTo>
                <a:lnTo>
                  <a:pt x="162" y="801"/>
                </a:lnTo>
                <a:lnTo>
                  <a:pt x="163" y="801"/>
                </a:lnTo>
                <a:lnTo>
                  <a:pt x="163" y="801"/>
                </a:lnTo>
                <a:lnTo>
                  <a:pt x="164" y="801"/>
                </a:lnTo>
                <a:lnTo>
                  <a:pt x="164" y="801"/>
                </a:lnTo>
                <a:lnTo>
                  <a:pt x="165" y="801"/>
                </a:lnTo>
                <a:lnTo>
                  <a:pt x="165" y="801"/>
                </a:lnTo>
                <a:lnTo>
                  <a:pt x="168" y="801"/>
                </a:lnTo>
                <a:lnTo>
                  <a:pt x="168" y="779"/>
                </a:lnTo>
                <a:lnTo>
                  <a:pt x="168" y="801"/>
                </a:lnTo>
                <a:lnTo>
                  <a:pt x="170" y="801"/>
                </a:lnTo>
                <a:lnTo>
                  <a:pt x="170" y="801"/>
                </a:lnTo>
                <a:lnTo>
                  <a:pt x="170" y="801"/>
                </a:lnTo>
                <a:lnTo>
                  <a:pt x="171" y="801"/>
                </a:lnTo>
                <a:lnTo>
                  <a:pt x="171" y="801"/>
                </a:lnTo>
                <a:lnTo>
                  <a:pt x="172" y="801"/>
                </a:lnTo>
                <a:lnTo>
                  <a:pt x="172" y="801"/>
                </a:lnTo>
                <a:lnTo>
                  <a:pt x="173" y="801"/>
                </a:lnTo>
                <a:lnTo>
                  <a:pt x="173" y="801"/>
                </a:lnTo>
                <a:lnTo>
                  <a:pt x="174" y="800"/>
                </a:lnTo>
                <a:lnTo>
                  <a:pt x="174" y="801"/>
                </a:lnTo>
                <a:lnTo>
                  <a:pt x="176" y="801"/>
                </a:lnTo>
                <a:lnTo>
                  <a:pt x="176" y="801"/>
                </a:lnTo>
                <a:lnTo>
                  <a:pt x="176" y="801"/>
                </a:lnTo>
                <a:lnTo>
                  <a:pt x="178" y="801"/>
                </a:lnTo>
                <a:lnTo>
                  <a:pt x="178" y="799"/>
                </a:lnTo>
                <a:lnTo>
                  <a:pt x="178" y="801"/>
                </a:lnTo>
                <a:lnTo>
                  <a:pt x="179" y="801"/>
                </a:lnTo>
                <a:lnTo>
                  <a:pt x="179" y="801"/>
                </a:lnTo>
                <a:lnTo>
                  <a:pt x="180" y="801"/>
                </a:lnTo>
                <a:lnTo>
                  <a:pt x="180" y="801"/>
                </a:lnTo>
                <a:lnTo>
                  <a:pt x="182" y="801"/>
                </a:lnTo>
                <a:lnTo>
                  <a:pt x="182" y="801"/>
                </a:lnTo>
                <a:lnTo>
                  <a:pt x="182" y="801"/>
                </a:lnTo>
                <a:lnTo>
                  <a:pt x="183" y="801"/>
                </a:lnTo>
                <a:lnTo>
                  <a:pt x="183" y="801"/>
                </a:lnTo>
                <a:lnTo>
                  <a:pt x="184" y="0"/>
                </a:lnTo>
                <a:lnTo>
                  <a:pt x="184" y="801"/>
                </a:lnTo>
                <a:lnTo>
                  <a:pt x="186" y="801"/>
                </a:lnTo>
                <a:lnTo>
                  <a:pt x="186" y="710"/>
                </a:lnTo>
                <a:lnTo>
                  <a:pt x="186" y="801"/>
                </a:lnTo>
                <a:lnTo>
                  <a:pt x="187" y="798"/>
                </a:lnTo>
                <a:lnTo>
                  <a:pt x="187" y="801"/>
                </a:lnTo>
                <a:lnTo>
                  <a:pt x="190" y="801"/>
                </a:lnTo>
                <a:lnTo>
                  <a:pt x="190" y="801"/>
                </a:lnTo>
                <a:lnTo>
                  <a:pt x="190" y="801"/>
                </a:lnTo>
                <a:lnTo>
                  <a:pt x="191" y="801"/>
                </a:lnTo>
                <a:lnTo>
                  <a:pt x="191" y="801"/>
                </a:lnTo>
                <a:lnTo>
                  <a:pt x="192" y="801"/>
                </a:lnTo>
                <a:lnTo>
                  <a:pt x="192" y="801"/>
                </a:lnTo>
                <a:lnTo>
                  <a:pt x="194" y="801"/>
                </a:lnTo>
                <a:lnTo>
                  <a:pt x="194" y="798"/>
                </a:lnTo>
                <a:lnTo>
                  <a:pt x="194" y="801"/>
                </a:lnTo>
                <a:lnTo>
                  <a:pt x="195" y="801"/>
                </a:lnTo>
                <a:lnTo>
                  <a:pt x="195" y="801"/>
                </a:lnTo>
                <a:lnTo>
                  <a:pt x="197" y="801"/>
                </a:lnTo>
                <a:lnTo>
                  <a:pt x="197" y="792"/>
                </a:lnTo>
                <a:lnTo>
                  <a:pt x="197" y="801"/>
                </a:lnTo>
                <a:lnTo>
                  <a:pt x="199" y="801"/>
                </a:lnTo>
                <a:lnTo>
                  <a:pt x="199" y="801"/>
                </a:lnTo>
                <a:lnTo>
                  <a:pt x="199" y="801"/>
                </a:lnTo>
                <a:lnTo>
                  <a:pt x="200" y="788"/>
                </a:lnTo>
                <a:lnTo>
                  <a:pt x="200" y="801"/>
                </a:lnTo>
                <a:lnTo>
                  <a:pt x="201" y="801"/>
                </a:lnTo>
                <a:lnTo>
                  <a:pt x="201" y="801"/>
                </a:lnTo>
                <a:lnTo>
                  <a:pt x="202" y="801"/>
                </a:lnTo>
                <a:lnTo>
                  <a:pt x="202" y="801"/>
                </a:lnTo>
                <a:lnTo>
                  <a:pt x="206" y="801"/>
                </a:lnTo>
                <a:lnTo>
                  <a:pt x="206" y="801"/>
                </a:lnTo>
                <a:lnTo>
                  <a:pt x="206" y="801"/>
                </a:lnTo>
                <a:lnTo>
                  <a:pt x="209" y="801"/>
                </a:lnTo>
                <a:lnTo>
                  <a:pt x="209" y="801"/>
                </a:lnTo>
                <a:lnTo>
                  <a:pt x="209" y="801"/>
                </a:lnTo>
                <a:lnTo>
                  <a:pt x="210" y="801"/>
                </a:lnTo>
                <a:lnTo>
                  <a:pt x="210" y="801"/>
                </a:lnTo>
                <a:lnTo>
                  <a:pt x="213" y="801"/>
                </a:lnTo>
                <a:lnTo>
                  <a:pt x="213" y="801"/>
                </a:lnTo>
                <a:lnTo>
                  <a:pt x="213" y="801"/>
                </a:lnTo>
                <a:lnTo>
                  <a:pt x="214" y="801"/>
                </a:lnTo>
                <a:lnTo>
                  <a:pt x="214" y="801"/>
                </a:lnTo>
                <a:lnTo>
                  <a:pt x="215" y="801"/>
                </a:lnTo>
                <a:lnTo>
                  <a:pt x="215" y="801"/>
                </a:lnTo>
                <a:lnTo>
                  <a:pt x="216" y="801"/>
                </a:lnTo>
                <a:lnTo>
                  <a:pt x="216" y="801"/>
                </a:lnTo>
                <a:lnTo>
                  <a:pt x="217" y="801"/>
                </a:lnTo>
                <a:lnTo>
                  <a:pt x="217" y="801"/>
                </a:lnTo>
                <a:lnTo>
                  <a:pt x="219" y="801"/>
                </a:lnTo>
                <a:lnTo>
                  <a:pt x="219" y="768"/>
                </a:lnTo>
                <a:lnTo>
                  <a:pt x="219" y="801"/>
                </a:lnTo>
                <a:lnTo>
                  <a:pt x="221" y="801"/>
                </a:lnTo>
                <a:lnTo>
                  <a:pt x="221" y="799"/>
                </a:lnTo>
                <a:lnTo>
                  <a:pt x="221" y="801"/>
                </a:lnTo>
                <a:lnTo>
                  <a:pt x="222" y="801"/>
                </a:lnTo>
                <a:lnTo>
                  <a:pt x="222" y="801"/>
                </a:lnTo>
                <a:lnTo>
                  <a:pt x="223" y="751"/>
                </a:lnTo>
                <a:lnTo>
                  <a:pt x="223" y="801"/>
                </a:lnTo>
                <a:lnTo>
                  <a:pt x="224" y="801"/>
                </a:lnTo>
                <a:lnTo>
                  <a:pt x="224" y="801"/>
                </a:lnTo>
                <a:lnTo>
                  <a:pt x="225" y="801"/>
                </a:lnTo>
                <a:lnTo>
                  <a:pt x="225" y="801"/>
                </a:lnTo>
                <a:lnTo>
                  <a:pt x="226" y="801"/>
                </a:lnTo>
                <a:lnTo>
                  <a:pt x="226" y="801"/>
                </a:lnTo>
                <a:lnTo>
                  <a:pt x="227" y="801"/>
                </a:lnTo>
                <a:lnTo>
                  <a:pt x="227" y="801"/>
                </a:lnTo>
                <a:lnTo>
                  <a:pt x="228" y="801"/>
                </a:lnTo>
                <a:lnTo>
                  <a:pt x="228" y="801"/>
                </a:lnTo>
                <a:lnTo>
                  <a:pt x="229" y="801"/>
                </a:lnTo>
                <a:lnTo>
                  <a:pt x="229" y="801"/>
                </a:lnTo>
                <a:lnTo>
                  <a:pt x="230" y="801"/>
                </a:lnTo>
                <a:lnTo>
                  <a:pt x="230" y="801"/>
                </a:lnTo>
                <a:lnTo>
                  <a:pt x="231" y="801"/>
                </a:lnTo>
                <a:lnTo>
                  <a:pt x="231" y="801"/>
                </a:lnTo>
                <a:lnTo>
                  <a:pt x="232" y="792"/>
                </a:lnTo>
                <a:lnTo>
                  <a:pt x="232" y="801"/>
                </a:lnTo>
                <a:lnTo>
                  <a:pt x="234" y="801"/>
                </a:lnTo>
                <a:lnTo>
                  <a:pt x="234" y="801"/>
                </a:lnTo>
                <a:lnTo>
                  <a:pt x="234" y="801"/>
                </a:lnTo>
                <a:lnTo>
                  <a:pt x="236" y="801"/>
                </a:lnTo>
                <a:lnTo>
                  <a:pt x="236" y="800"/>
                </a:lnTo>
                <a:lnTo>
                  <a:pt x="236" y="801"/>
                </a:lnTo>
                <a:lnTo>
                  <a:pt x="237" y="801"/>
                </a:lnTo>
                <a:lnTo>
                  <a:pt x="237" y="801"/>
                </a:lnTo>
                <a:lnTo>
                  <a:pt x="238" y="801"/>
                </a:lnTo>
                <a:lnTo>
                  <a:pt x="238" y="801"/>
                </a:lnTo>
                <a:lnTo>
                  <a:pt x="239" y="801"/>
                </a:lnTo>
                <a:lnTo>
                  <a:pt x="239" y="801"/>
                </a:lnTo>
                <a:lnTo>
                  <a:pt x="240" y="801"/>
                </a:lnTo>
                <a:lnTo>
                  <a:pt x="240" y="801"/>
                </a:lnTo>
                <a:lnTo>
                  <a:pt x="241" y="801"/>
                </a:lnTo>
                <a:lnTo>
                  <a:pt x="241" y="801"/>
                </a:lnTo>
                <a:lnTo>
                  <a:pt x="242" y="765"/>
                </a:lnTo>
                <a:lnTo>
                  <a:pt x="242" y="801"/>
                </a:lnTo>
                <a:lnTo>
                  <a:pt x="244" y="801"/>
                </a:lnTo>
                <a:lnTo>
                  <a:pt x="244" y="800"/>
                </a:lnTo>
                <a:lnTo>
                  <a:pt x="244" y="801"/>
                </a:lnTo>
                <a:lnTo>
                  <a:pt x="245" y="635"/>
                </a:lnTo>
                <a:lnTo>
                  <a:pt x="245" y="801"/>
                </a:lnTo>
                <a:lnTo>
                  <a:pt x="247" y="801"/>
                </a:lnTo>
                <a:lnTo>
                  <a:pt x="247" y="797"/>
                </a:lnTo>
                <a:lnTo>
                  <a:pt x="247" y="801"/>
                </a:lnTo>
                <a:lnTo>
                  <a:pt x="248" y="801"/>
                </a:lnTo>
                <a:lnTo>
                  <a:pt x="248" y="801"/>
                </a:lnTo>
                <a:lnTo>
                  <a:pt x="249" y="801"/>
                </a:lnTo>
                <a:lnTo>
                  <a:pt x="249" y="801"/>
                </a:lnTo>
                <a:lnTo>
                  <a:pt x="250" y="801"/>
                </a:lnTo>
                <a:lnTo>
                  <a:pt x="250" y="801"/>
                </a:lnTo>
                <a:lnTo>
                  <a:pt x="251" y="800"/>
                </a:lnTo>
                <a:lnTo>
                  <a:pt x="251" y="801"/>
                </a:lnTo>
                <a:lnTo>
                  <a:pt x="255" y="801"/>
                </a:lnTo>
                <a:lnTo>
                  <a:pt x="255" y="783"/>
                </a:lnTo>
                <a:lnTo>
                  <a:pt x="255" y="801"/>
                </a:lnTo>
                <a:lnTo>
                  <a:pt x="258" y="801"/>
                </a:lnTo>
                <a:lnTo>
                  <a:pt x="258" y="801"/>
                </a:lnTo>
                <a:lnTo>
                  <a:pt x="258" y="801"/>
                </a:lnTo>
                <a:lnTo>
                  <a:pt x="260" y="801"/>
                </a:lnTo>
                <a:lnTo>
                  <a:pt x="260" y="794"/>
                </a:lnTo>
                <a:lnTo>
                  <a:pt x="260" y="801"/>
                </a:lnTo>
                <a:lnTo>
                  <a:pt x="261" y="801"/>
                </a:lnTo>
                <a:lnTo>
                  <a:pt x="261" y="801"/>
                </a:lnTo>
                <a:lnTo>
                  <a:pt x="265" y="801"/>
                </a:lnTo>
                <a:lnTo>
                  <a:pt x="265" y="801"/>
                </a:lnTo>
                <a:lnTo>
                  <a:pt x="265" y="801"/>
                </a:lnTo>
                <a:lnTo>
                  <a:pt x="268" y="801"/>
                </a:lnTo>
                <a:lnTo>
                  <a:pt x="268" y="614"/>
                </a:lnTo>
                <a:lnTo>
                  <a:pt x="268" y="801"/>
                </a:lnTo>
                <a:lnTo>
                  <a:pt x="269" y="798"/>
                </a:lnTo>
                <a:lnTo>
                  <a:pt x="269" y="801"/>
                </a:lnTo>
                <a:lnTo>
                  <a:pt x="271" y="801"/>
                </a:lnTo>
                <a:lnTo>
                  <a:pt x="271" y="801"/>
                </a:lnTo>
                <a:lnTo>
                  <a:pt x="271" y="801"/>
                </a:lnTo>
                <a:lnTo>
                  <a:pt x="272" y="801"/>
                </a:lnTo>
                <a:lnTo>
                  <a:pt x="272" y="801"/>
                </a:lnTo>
                <a:lnTo>
                  <a:pt x="273" y="801"/>
                </a:lnTo>
                <a:lnTo>
                  <a:pt x="273" y="801"/>
                </a:lnTo>
                <a:lnTo>
                  <a:pt x="274" y="800"/>
                </a:lnTo>
                <a:lnTo>
                  <a:pt x="274" y="801"/>
                </a:lnTo>
                <a:lnTo>
                  <a:pt x="276" y="801"/>
                </a:lnTo>
                <a:lnTo>
                  <a:pt x="276" y="801"/>
                </a:lnTo>
                <a:lnTo>
                  <a:pt x="276" y="801"/>
                </a:lnTo>
                <a:lnTo>
                  <a:pt x="277" y="793"/>
                </a:lnTo>
                <a:lnTo>
                  <a:pt x="277" y="801"/>
                </a:lnTo>
                <a:lnTo>
                  <a:pt x="278" y="801"/>
                </a:lnTo>
                <a:lnTo>
                  <a:pt x="278" y="801"/>
                </a:lnTo>
                <a:lnTo>
                  <a:pt x="284" y="801"/>
                </a:lnTo>
                <a:lnTo>
                  <a:pt x="284" y="801"/>
                </a:lnTo>
                <a:lnTo>
                  <a:pt x="284" y="801"/>
                </a:lnTo>
                <a:lnTo>
                  <a:pt x="285" y="801"/>
                </a:lnTo>
                <a:lnTo>
                  <a:pt x="285" y="801"/>
                </a:lnTo>
                <a:lnTo>
                  <a:pt x="289" y="801"/>
                </a:lnTo>
                <a:lnTo>
                  <a:pt x="289" y="801"/>
                </a:lnTo>
                <a:lnTo>
                  <a:pt x="289" y="801"/>
                </a:lnTo>
                <a:lnTo>
                  <a:pt x="293" y="801"/>
                </a:lnTo>
                <a:lnTo>
                  <a:pt x="293" y="801"/>
                </a:lnTo>
                <a:lnTo>
                  <a:pt x="293" y="801"/>
                </a:lnTo>
                <a:lnTo>
                  <a:pt x="294" y="801"/>
                </a:lnTo>
                <a:lnTo>
                  <a:pt x="294" y="801"/>
                </a:lnTo>
                <a:lnTo>
                  <a:pt x="297" y="801"/>
                </a:lnTo>
                <a:lnTo>
                  <a:pt x="297" y="801"/>
                </a:lnTo>
                <a:lnTo>
                  <a:pt x="297" y="801"/>
                </a:lnTo>
                <a:lnTo>
                  <a:pt x="299" y="801"/>
                </a:lnTo>
                <a:lnTo>
                  <a:pt x="299" y="801"/>
                </a:lnTo>
                <a:lnTo>
                  <a:pt x="299" y="801"/>
                </a:lnTo>
                <a:lnTo>
                  <a:pt x="300" y="800"/>
                </a:lnTo>
                <a:lnTo>
                  <a:pt x="300" y="801"/>
                </a:lnTo>
                <a:lnTo>
                  <a:pt x="302" y="801"/>
                </a:lnTo>
                <a:lnTo>
                  <a:pt x="302" y="801"/>
                </a:lnTo>
                <a:lnTo>
                  <a:pt x="302" y="801"/>
                </a:lnTo>
                <a:lnTo>
                  <a:pt x="303" y="801"/>
                </a:lnTo>
                <a:lnTo>
                  <a:pt x="303" y="801"/>
                </a:lnTo>
                <a:lnTo>
                  <a:pt x="304" y="801"/>
                </a:lnTo>
                <a:lnTo>
                  <a:pt x="304" y="801"/>
                </a:lnTo>
                <a:lnTo>
                  <a:pt x="306" y="801"/>
                </a:lnTo>
                <a:lnTo>
                  <a:pt x="306" y="801"/>
                </a:lnTo>
                <a:lnTo>
                  <a:pt x="306" y="801"/>
                </a:lnTo>
                <a:lnTo>
                  <a:pt x="310" y="801"/>
                </a:lnTo>
                <a:lnTo>
                  <a:pt x="310" y="801"/>
                </a:lnTo>
                <a:lnTo>
                  <a:pt x="310" y="801"/>
                </a:lnTo>
                <a:lnTo>
                  <a:pt x="311" y="801"/>
                </a:lnTo>
                <a:lnTo>
                  <a:pt x="311" y="801"/>
                </a:lnTo>
                <a:lnTo>
                  <a:pt x="313" y="801"/>
                </a:lnTo>
                <a:lnTo>
                  <a:pt x="313" y="801"/>
                </a:lnTo>
                <a:lnTo>
                  <a:pt x="313" y="801"/>
                </a:lnTo>
                <a:lnTo>
                  <a:pt x="315" y="801"/>
                </a:lnTo>
                <a:lnTo>
                  <a:pt x="315" y="801"/>
                </a:lnTo>
                <a:lnTo>
                  <a:pt x="315" y="801"/>
                </a:lnTo>
                <a:lnTo>
                  <a:pt x="316" y="801"/>
                </a:lnTo>
                <a:lnTo>
                  <a:pt x="316" y="801"/>
                </a:lnTo>
                <a:lnTo>
                  <a:pt x="317" y="801"/>
                </a:lnTo>
                <a:lnTo>
                  <a:pt x="317" y="801"/>
                </a:lnTo>
                <a:lnTo>
                  <a:pt x="319" y="801"/>
                </a:lnTo>
                <a:lnTo>
                  <a:pt x="319" y="801"/>
                </a:lnTo>
                <a:lnTo>
                  <a:pt x="319" y="801"/>
                </a:lnTo>
                <a:lnTo>
                  <a:pt x="321" y="801"/>
                </a:lnTo>
                <a:lnTo>
                  <a:pt x="321" y="801"/>
                </a:lnTo>
                <a:lnTo>
                  <a:pt x="321" y="801"/>
                </a:lnTo>
                <a:lnTo>
                  <a:pt x="323" y="801"/>
                </a:lnTo>
                <a:lnTo>
                  <a:pt x="323" y="801"/>
                </a:lnTo>
                <a:lnTo>
                  <a:pt x="323" y="801"/>
                </a:lnTo>
                <a:lnTo>
                  <a:pt x="324" y="801"/>
                </a:lnTo>
                <a:lnTo>
                  <a:pt x="324" y="801"/>
                </a:lnTo>
                <a:lnTo>
                  <a:pt x="325" y="801"/>
                </a:lnTo>
                <a:lnTo>
                  <a:pt x="325" y="801"/>
                </a:lnTo>
                <a:lnTo>
                  <a:pt x="328" y="801"/>
                </a:lnTo>
                <a:lnTo>
                  <a:pt x="328" y="801"/>
                </a:lnTo>
                <a:lnTo>
                  <a:pt x="328" y="801"/>
                </a:lnTo>
                <a:lnTo>
                  <a:pt x="329" y="800"/>
                </a:lnTo>
                <a:lnTo>
                  <a:pt x="329" y="801"/>
                </a:lnTo>
                <a:lnTo>
                  <a:pt x="330" y="801"/>
                </a:lnTo>
                <a:lnTo>
                  <a:pt x="330" y="801"/>
                </a:lnTo>
                <a:lnTo>
                  <a:pt x="331" y="801"/>
                </a:lnTo>
                <a:lnTo>
                  <a:pt x="331" y="801"/>
                </a:lnTo>
                <a:lnTo>
                  <a:pt x="332" y="799"/>
                </a:lnTo>
                <a:lnTo>
                  <a:pt x="332" y="801"/>
                </a:lnTo>
                <a:lnTo>
                  <a:pt x="333" y="801"/>
                </a:lnTo>
                <a:lnTo>
                  <a:pt x="333" y="801"/>
                </a:lnTo>
                <a:lnTo>
                  <a:pt x="334" y="801"/>
                </a:lnTo>
                <a:lnTo>
                  <a:pt x="334" y="801"/>
                </a:lnTo>
                <a:lnTo>
                  <a:pt x="339" y="801"/>
                </a:lnTo>
                <a:lnTo>
                  <a:pt x="339" y="801"/>
                </a:lnTo>
                <a:lnTo>
                  <a:pt x="339" y="801"/>
                </a:lnTo>
                <a:lnTo>
                  <a:pt x="340" y="801"/>
                </a:lnTo>
                <a:lnTo>
                  <a:pt x="340" y="801"/>
                </a:lnTo>
                <a:lnTo>
                  <a:pt x="341" y="800"/>
                </a:lnTo>
                <a:lnTo>
                  <a:pt x="341" y="801"/>
                </a:lnTo>
                <a:lnTo>
                  <a:pt x="348" y="801"/>
                </a:lnTo>
                <a:lnTo>
                  <a:pt x="348" y="801"/>
                </a:lnTo>
                <a:lnTo>
                  <a:pt x="348" y="801"/>
                </a:lnTo>
                <a:lnTo>
                  <a:pt x="349" y="801"/>
                </a:lnTo>
                <a:lnTo>
                  <a:pt x="349" y="801"/>
                </a:lnTo>
                <a:lnTo>
                  <a:pt x="350" y="801"/>
                </a:lnTo>
                <a:lnTo>
                  <a:pt x="350" y="801"/>
                </a:lnTo>
                <a:lnTo>
                  <a:pt x="351" y="798"/>
                </a:lnTo>
                <a:lnTo>
                  <a:pt x="351" y="801"/>
                </a:lnTo>
                <a:lnTo>
                  <a:pt x="352" y="801"/>
                </a:lnTo>
                <a:lnTo>
                  <a:pt x="352" y="801"/>
                </a:lnTo>
                <a:lnTo>
                  <a:pt x="354" y="801"/>
                </a:lnTo>
                <a:lnTo>
                  <a:pt x="354" y="789"/>
                </a:lnTo>
                <a:lnTo>
                  <a:pt x="354" y="801"/>
                </a:lnTo>
                <a:lnTo>
                  <a:pt x="357" y="801"/>
                </a:lnTo>
                <a:lnTo>
                  <a:pt x="357" y="801"/>
                </a:lnTo>
                <a:lnTo>
                  <a:pt x="357" y="801"/>
                </a:lnTo>
                <a:lnTo>
                  <a:pt x="360" y="801"/>
                </a:lnTo>
                <a:lnTo>
                  <a:pt x="360" y="801"/>
                </a:lnTo>
                <a:lnTo>
                  <a:pt x="360" y="801"/>
                </a:lnTo>
                <a:lnTo>
                  <a:pt x="363" y="801"/>
                </a:lnTo>
                <a:lnTo>
                  <a:pt x="363" y="801"/>
                </a:lnTo>
                <a:lnTo>
                  <a:pt x="363" y="801"/>
                </a:lnTo>
                <a:lnTo>
                  <a:pt x="364" y="798"/>
                </a:lnTo>
                <a:lnTo>
                  <a:pt x="364" y="801"/>
                </a:lnTo>
                <a:lnTo>
                  <a:pt x="367" y="801"/>
                </a:lnTo>
                <a:lnTo>
                  <a:pt x="367" y="801"/>
                </a:lnTo>
                <a:lnTo>
                  <a:pt x="367" y="801"/>
                </a:lnTo>
                <a:lnTo>
                  <a:pt x="370" y="801"/>
                </a:lnTo>
                <a:lnTo>
                  <a:pt x="370" y="801"/>
                </a:lnTo>
                <a:lnTo>
                  <a:pt x="370" y="801"/>
                </a:lnTo>
                <a:lnTo>
                  <a:pt x="374" y="801"/>
                </a:lnTo>
                <a:lnTo>
                  <a:pt x="374" y="799"/>
                </a:lnTo>
                <a:lnTo>
                  <a:pt x="374" y="801"/>
                </a:lnTo>
                <a:lnTo>
                  <a:pt x="377" y="801"/>
                </a:lnTo>
                <a:lnTo>
                  <a:pt x="377" y="763"/>
                </a:lnTo>
                <a:lnTo>
                  <a:pt x="377" y="801"/>
                </a:lnTo>
                <a:lnTo>
                  <a:pt x="378" y="800"/>
                </a:lnTo>
                <a:lnTo>
                  <a:pt x="378" y="801"/>
                </a:lnTo>
                <a:lnTo>
                  <a:pt x="379" y="801"/>
                </a:lnTo>
                <a:lnTo>
                  <a:pt x="379" y="801"/>
                </a:lnTo>
                <a:lnTo>
                  <a:pt x="380" y="801"/>
                </a:lnTo>
                <a:lnTo>
                  <a:pt x="380" y="801"/>
                </a:lnTo>
                <a:lnTo>
                  <a:pt x="384" y="801"/>
                </a:lnTo>
                <a:lnTo>
                  <a:pt x="384" y="801"/>
                </a:lnTo>
                <a:lnTo>
                  <a:pt x="384" y="801"/>
                </a:lnTo>
                <a:lnTo>
                  <a:pt x="386" y="801"/>
                </a:lnTo>
                <a:lnTo>
                  <a:pt x="386" y="799"/>
                </a:lnTo>
                <a:lnTo>
                  <a:pt x="386" y="801"/>
                </a:lnTo>
                <a:lnTo>
                  <a:pt x="389" y="801"/>
                </a:lnTo>
                <a:lnTo>
                  <a:pt x="389" y="801"/>
                </a:lnTo>
                <a:lnTo>
                  <a:pt x="389" y="801"/>
                </a:lnTo>
                <a:lnTo>
                  <a:pt x="390" y="801"/>
                </a:lnTo>
                <a:lnTo>
                  <a:pt x="390" y="801"/>
                </a:lnTo>
                <a:lnTo>
                  <a:pt x="391" y="801"/>
                </a:lnTo>
                <a:lnTo>
                  <a:pt x="391" y="801"/>
                </a:lnTo>
                <a:lnTo>
                  <a:pt x="394" y="801"/>
                </a:lnTo>
                <a:lnTo>
                  <a:pt x="394" y="801"/>
                </a:lnTo>
                <a:lnTo>
                  <a:pt x="394" y="801"/>
                </a:lnTo>
                <a:lnTo>
                  <a:pt x="396" y="801"/>
                </a:lnTo>
                <a:lnTo>
                  <a:pt x="396" y="801"/>
                </a:lnTo>
                <a:lnTo>
                  <a:pt x="396" y="801"/>
                </a:lnTo>
                <a:lnTo>
                  <a:pt x="399" y="801"/>
                </a:lnTo>
                <a:lnTo>
                  <a:pt x="399" y="781"/>
                </a:lnTo>
                <a:lnTo>
                  <a:pt x="399" y="801"/>
                </a:lnTo>
                <a:lnTo>
                  <a:pt x="401" y="801"/>
                </a:lnTo>
                <a:lnTo>
                  <a:pt x="401" y="801"/>
                </a:lnTo>
                <a:lnTo>
                  <a:pt x="401" y="801"/>
                </a:lnTo>
                <a:lnTo>
                  <a:pt x="402" y="801"/>
                </a:lnTo>
                <a:lnTo>
                  <a:pt x="402" y="801"/>
                </a:lnTo>
                <a:lnTo>
                  <a:pt x="406" y="801"/>
                </a:lnTo>
                <a:lnTo>
                  <a:pt x="406" y="801"/>
                </a:lnTo>
                <a:lnTo>
                  <a:pt x="406" y="801"/>
                </a:lnTo>
                <a:lnTo>
                  <a:pt x="407" y="801"/>
                </a:lnTo>
                <a:lnTo>
                  <a:pt x="407" y="801"/>
                </a:lnTo>
                <a:lnTo>
                  <a:pt x="408" y="801"/>
                </a:lnTo>
                <a:lnTo>
                  <a:pt x="408" y="801"/>
                </a:lnTo>
                <a:lnTo>
                  <a:pt x="409" y="800"/>
                </a:lnTo>
                <a:lnTo>
                  <a:pt x="409" y="801"/>
                </a:lnTo>
                <a:lnTo>
                  <a:pt x="412" y="801"/>
                </a:lnTo>
                <a:lnTo>
                  <a:pt x="412" y="801"/>
                </a:lnTo>
                <a:lnTo>
                  <a:pt x="412" y="801"/>
                </a:lnTo>
                <a:lnTo>
                  <a:pt x="413" y="801"/>
                </a:lnTo>
                <a:lnTo>
                  <a:pt x="413" y="801"/>
                </a:lnTo>
                <a:lnTo>
                  <a:pt x="415" y="801"/>
                </a:lnTo>
                <a:lnTo>
                  <a:pt x="415" y="801"/>
                </a:lnTo>
                <a:lnTo>
                  <a:pt x="415" y="801"/>
                </a:lnTo>
                <a:lnTo>
                  <a:pt x="419" y="801"/>
                </a:lnTo>
                <a:lnTo>
                  <a:pt x="419" y="801"/>
                </a:lnTo>
                <a:lnTo>
                  <a:pt x="419" y="801"/>
                </a:lnTo>
                <a:lnTo>
                  <a:pt x="421" y="801"/>
                </a:lnTo>
                <a:lnTo>
                  <a:pt x="421" y="801"/>
                </a:lnTo>
                <a:lnTo>
                  <a:pt x="421" y="801"/>
                </a:lnTo>
                <a:lnTo>
                  <a:pt x="422" y="801"/>
                </a:lnTo>
                <a:lnTo>
                  <a:pt x="422" y="801"/>
                </a:lnTo>
                <a:lnTo>
                  <a:pt x="423" y="801"/>
                </a:lnTo>
                <a:lnTo>
                  <a:pt x="423" y="801"/>
                </a:lnTo>
                <a:lnTo>
                  <a:pt x="426" y="801"/>
                </a:lnTo>
                <a:lnTo>
                  <a:pt x="426" y="801"/>
                </a:lnTo>
                <a:lnTo>
                  <a:pt x="426" y="801"/>
                </a:lnTo>
                <a:lnTo>
                  <a:pt x="428" y="801"/>
                </a:lnTo>
                <a:lnTo>
                  <a:pt x="428" y="801"/>
                </a:lnTo>
                <a:lnTo>
                  <a:pt x="428" y="801"/>
                </a:lnTo>
                <a:lnTo>
                  <a:pt x="430" y="801"/>
                </a:lnTo>
                <a:lnTo>
                  <a:pt x="430" y="801"/>
                </a:lnTo>
                <a:lnTo>
                  <a:pt x="430" y="801"/>
                </a:lnTo>
                <a:lnTo>
                  <a:pt x="434" y="801"/>
                </a:lnTo>
                <a:lnTo>
                  <a:pt x="434" y="801"/>
                </a:lnTo>
                <a:lnTo>
                  <a:pt x="434" y="801"/>
                </a:lnTo>
                <a:lnTo>
                  <a:pt x="438" y="801"/>
                </a:lnTo>
                <a:lnTo>
                  <a:pt x="438" y="801"/>
                </a:lnTo>
                <a:lnTo>
                  <a:pt x="438" y="801"/>
                </a:lnTo>
                <a:lnTo>
                  <a:pt x="441" y="801"/>
                </a:lnTo>
                <a:lnTo>
                  <a:pt x="441" y="801"/>
                </a:lnTo>
                <a:lnTo>
                  <a:pt x="441" y="801"/>
                </a:lnTo>
                <a:lnTo>
                  <a:pt x="444" y="801"/>
                </a:lnTo>
                <a:lnTo>
                  <a:pt x="444" y="801"/>
                </a:lnTo>
                <a:lnTo>
                  <a:pt x="444" y="801"/>
                </a:lnTo>
                <a:lnTo>
                  <a:pt x="445" y="801"/>
                </a:lnTo>
                <a:lnTo>
                  <a:pt x="445" y="801"/>
                </a:lnTo>
                <a:lnTo>
                  <a:pt x="448" y="801"/>
                </a:lnTo>
                <a:lnTo>
                  <a:pt x="448" y="788"/>
                </a:lnTo>
                <a:lnTo>
                  <a:pt x="448" y="801"/>
                </a:lnTo>
                <a:lnTo>
                  <a:pt x="449" y="800"/>
                </a:lnTo>
                <a:lnTo>
                  <a:pt x="449" y="801"/>
                </a:lnTo>
                <a:lnTo>
                  <a:pt x="451" y="801"/>
                </a:lnTo>
                <a:lnTo>
                  <a:pt x="451" y="801"/>
                </a:lnTo>
                <a:lnTo>
                  <a:pt x="451" y="801"/>
                </a:lnTo>
                <a:lnTo>
                  <a:pt x="452" y="801"/>
                </a:lnTo>
                <a:lnTo>
                  <a:pt x="452" y="801"/>
                </a:lnTo>
                <a:lnTo>
                  <a:pt x="453" y="801"/>
                </a:lnTo>
                <a:lnTo>
                  <a:pt x="453" y="801"/>
                </a:lnTo>
                <a:lnTo>
                  <a:pt x="454" y="801"/>
                </a:lnTo>
                <a:lnTo>
                  <a:pt x="454" y="801"/>
                </a:lnTo>
                <a:lnTo>
                  <a:pt x="458" y="801"/>
                </a:lnTo>
                <a:lnTo>
                  <a:pt x="458" y="801"/>
                </a:lnTo>
                <a:lnTo>
                  <a:pt x="458" y="801"/>
                </a:lnTo>
                <a:lnTo>
                  <a:pt x="459" y="801"/>
                </a:lnTo>
                <a:lnTo>
                  <a:pt x="459" y="801"/>
                </a:lnTo>
                <a:lnTo>
                  <a:pt x="462" y="801"/>
                </a:lnTo>
                <a:lnTo>
                  <a:pt x="462" y="801"/>
                </a:lnTo>
                <a:lnTo>
                  <a:pt x="462" y="801"/>
                </a:lnTo>
                <a:lnTo>
                  <a:pt x="463" y="800"/>
                </a:lnTo>
                <a:lnTo>
                  <a:pt x="463" y="801"/>
                </a:lnTo>
                <a:lnTo>
                  <a:pt x="464" y="801"/>
                </a:lnTo>
                <a:lnTo>
                  <a:pt x="464" y="801"/>
                </a:lnTo>
                <a:lnTo>
                  <a:pt x="468" y="801"/>
                </a:lnTo>
                <a:lnTo>
                  <a:pt x="468" y="801"/>
                </a:lnTo>
                <a:lnTo>
                  <a:pt x="468" y="801"/>
                </a:lnTo>
                <a:lnTo>
                  <a:pt x="470" y="801"/>
                </a:lnTo>
                <a:lnTo>
                  <a:pt x="470" y="801"/>
                </a:lnTo>
                <a:lnTo>
                  <a:pt x="470" y="801"/>
                </a:lnTo>
                <a:lnTo>
                  <a:pt x="473" y="801"/>
                </a:lnTo>
                <a:lnTo>
                  <a:pt x="473" y="799"/>
                </a:lnTo>
                <a:lnTo>
                  <a:pt x="473" y="801"/>
                </a:lnTo>
                <a:lnTo>
                  <a:pt x="475" y="801"/>
                </a:lnTo>
                <a:lnTo>
                  <a:pt x="475" y="801"/>
                </a:lnTo>
                <a:lnTo>
                  <a:pt x="475" y="801"/>
                </a:lnTo>
                <a:lnTo>
                  <a:pt x="476" y="799"/>
                </a:lnTo>
                <a:lnTo>
                  <a:pt x="476" y="801"/>
                </a:lnTo>
                <a:lnTo>
                  <a:pt x="477" y="801"/>
                </a:lnTo>
                <a:lnTo>
                  <a:pt x="477" y="801"/>
                </a:lnTo>
                <a:lnTo>
                  <a:pt x="478" y="801"/>
                </a:lnTo>
                <a:lnTo>
                  <a:pt x="478" y="801"/>
                </a:lnTo>
                <a:lnTo>
                  <a:pt x="480" y="801"/>
                </a:lnTo>
                <a:lnTo>
                  <a:pt x="480" y="801"/>
                </a:lnTo>
                <a:lnTo>
                  <a:pt x="480" y="801"/>
                </a:lnTo>
                <a:lnTo>
                  <a:pt x="483" y="801"/>
                </a:lnTo>
                <a:lnTo>
                  <a:pt x="483" y="800"/>
                </a:lnTo>
                <a:lnTo>
                  <a:pt x="483" y="801"/>
                </a:lnTo>
                <a:lnTo>
                  <a:pt x="484" y="801"/>
                </a:lnTo>
                <a:lnTo>
                  <a:pt x="484" y="801"/>
                </a:lnTo>
                <a:lnTo>
                  <a:pt x="486" y="801"/>
                </a:lnTo>
                <a:lnTo>
                  <a:pt x="486" y="796"/>
                </a:lnTo>
                <a:lnTo>
                  <a:pt x="486" y="801"/>
                </a:lnTo>
                <a:lnTo>
                  <a:pt x="487" y="801"/>
                </a:lnTo>
                <a:lnTo>
                  <a:pt x="487" y="801"/>
                </a:lnTo>
                <a:lnTo>
                  <a:pt x="490" y="801"/>
                </a:lnTo>
                <a:lnTo>
                  <a:pt x="490" y="801"/>
                </a:lnTo>
                <a:lnTo>
                  <a:pt x="490" y="801"/>
                </a:lnTo>
                <a:lnTo>
                  <a:pt x="491" y="801"/>
                </a:lnTo>
                <a:lnTo>
                  <a:pt x="491" y="801"/>
                </a:lnTo>
                <a:lnTo>
                  <a:pt x="496" y="801"/>
                </a:lnTo>
                <a:lnTo>
                  <a:pt x="496" y="800"/>
                </a:lnTo>
                <a:lnTo>
                  <a:pt x="496" y="801"/>
                </a:lnTo>
                <a:lnTo>
                  <a:pt x="498" y="801"/>
                </a:lnTo>
                <a:lnTo>
                  <a:pt x="498" y="801"/>
                </a:lnTo>
                <a:lnTo>
                  <a:pt x="498" y="801"/>
                </a:lnTo>
                <a:lnTo>
                  <a:pt x="499" y="798"/>
                </a:lnTo>
                <a:lnTo>
                  <a:pt x="499" y="801"/>
                </a:lnTo>
                <a:lnTo>
                  <a:pt x="500" y="801"/>
                </a:lnTo>
                <a:lnTo>
                  <a:pt x="500" y="801"/>
                </a:lnTo>
                <a:lnTo>
                  <a:pt x="501" y="801"/>
                </a:lnTo>
                <a:lnTo>
                  <a:pt x="501" y="801"/>
                </a:lnTo>
                <a:lnTo>
                  <a:pt x="505" y="801"/>
                </a:lnTo>
                <a:lnTo>
                  <a:pt x="505" y="801"/>
                </a:lnTo>
                <a:lnTo>
                  <a:pt x="505" y="801"/>
                </a:lnTo>
                <a:lnTo>
                  <a:pt x="507" y="801"/>
                </a:lnTo>
                <a:lnTo>
                  <a:pt x="507" y="801"/>
                </a:lnTo>
                <a:lnTo>
                  <a:pt x="507" y="801"/>
                </a:lnTo>
                <a:lnTo>
                  <a:pt x="508" y="796"/>
                </a:lnTo>
                <a:lnTo>
                  <a:pt x="508" y="801"/>
                </a:lnTo>
                <a:lnTo>
                  <a:pt x="510" y="801"/>
                </a:lnTo>
                <a:lnTo>
                  <a:pt x="510" y="801"/>
                </a:lnTo>
                <a:lnTo>
                  <a:pt x="510" y="801"/>
                </a:lnTo>
                <a:lnTo>
                  <a:pt x="515" y="801"/>
                </a:lnTo>
                <a:lnTo>
                  <a:pt x="515" y="801"/>
                </a:lnTo>
                <a:lnTo>
                  <a:pt x="515" y="801"/>
                </a:lnTo>
                <a:lnTo>
                  <a:pt x="518" y="801"/>
                </a:lnTo>
                <a:lnTo>
                  <a:pt x="518" y="800"/>
                </a:lnTo>
                <a:lnTo>
                  <a:pt x="518" y="801"/>
                </a:lnTo>
                <a:lnTo>
                  <a:pt x="519" y="801"/>
                </a:lnTo>
                <a:lnTo>
                  <a:pt x="519" y="801"/>
                </a:lnTo>
                <a:lnTo>
                  <a:pt x="521" y="801"/>
                </a:lnTo>
                <a:lnTo>
                  <a:pt x="521" y="797"/>
                </a:lnTo>
                <a:lnTo>
                  <a:pt x="521" y="801"/>
                </a:lnTo>
                <a:lnTo>
                  <a:pt x="523" y="801"/>
                </a:lnTo>
                <a:lnTo>
                  <a:pt x="523" y="801"/>
                </a:lnTo>
                <a:lnTo>
                  <a:pt x="523" y="801"/>
                </a:lnTo>
                <a:lnTo>
                  <a:pt x="528" y="801"/>
                </a:lnTo>
                <a:lnTo>
                  <a:pt x="528" y="801"/>
                </a:lnTo>
                <a:lnTo>
                  <a:pt x="528" y="801"/>
                </a:lnTo>
                <a:lnTo>
                  <a:pt x="531" y="801"/>
                </a:lnTo>
                <a:lnTo>
                  <a:pt x="531" y="799"/>
                </a:lnTo>
                <a:lnTo>
                  <a:pt x="531" y="801"/>
                </a:lnTo>
                <a:lnTo>
                  <a:pt x="533" y="801"/>
                </a:lnTo>
                <a:lnTo>
                  <a:pt x="533" y="801"/>
                </a:lnTo>
                <a:lnTo>
                  <a:pt x="533" y="801"/>
                </a:lnTo>
                <a:lnTo>
                  <a:pt x="534" y="801"/>
                </a:lnTo>
                <a:lnTo>
                  <a:pt x="534" y="801"/>
                </a:lnTo>
                <a:lnTo>
                  <a:pt x="535" y="801"/>
                </a:lnTo>
                <a:lnTo>
                  <a:pt x="535" y="801"/>
                </a:lnTo>
                <a:lnTo>
                  <a:pt x="539" y="801"/>
                </a:lnTo>
                <a:lnTo>
                  <a:pt x="539" y="801"/>
                </a:lnTo>
                <a:lnTo>
                  <a:pt x="539" y="801"/>
                </a:lnTo>
                <a:lnTo>
                  <a:pt x="541" y="801"/>
                </a:lnTo>
                <a:lnTo>
                  <a:pt x="541" y="801"/>
                </a:lnTo>
                <a:lnTo>
                  <a:pt x="541" y="801"/>
                </a:lnTo>
                <a:lnTo>
                  <a:pt x="542" y="801"/>
                </a:lnTo>
                <a:lnTo>
                  <a:pt x="542" y="801"/>
                </a:lnTo>
                <a:lnTo>
                  <a:pt x="556" y="801"/>
                </a:lnTo>
                <a:lnTo>
                  <a:pt x="556" y="801"/>
                </a:lnTo>
                <a:lnTo>
                  <a:pt x="556" y="801"/>
                </a:lnTo>
                <a:lnTo>
                  <a:pt x="557" y="801"/>
                </a:lnTo>
                <a:lnTo>
                  <a:pt x="557" y="801"/>
                </a:lnTo>
                <a:lnTo>
                  <a:pt x="560" y="801"/>
                </a:lnTo>
                <a:lnTo>
                  <a:pt x="560" y="801"/>
                </a:lnTo>
                <a:lnTo>
                  <a:pt x="560" y="801"/>
                </a:lnTo>
                <a:lnTo>
                  <a:pt x="567" y="801"/>
                </a:lnTo>
                <a:lnTo>
                  <a:pt x="567" y="801"/>
                </a:lnTo>
                <a:lnTo>
                  <a:pt x="567" y="801"/>
                </a:lnTo>
                <a:lnTo>
                  <a:pt x="568" y="801"/>
                </a:lnTo>
                <a:lnTo>
                  <a:pt x="568" y="801"/>
                </a:lnTo>
                <a:lnTo>
                  <a:pt x="575" y="801"/>
                </a:lnTo>
                <a:lnTo>
                  <a:pt x="575" y="801"/>
                </a:lnTo>
                <a:lnTo>
                  <a:pt x="575" y="801"/>
                </a:lnTo>
                <a:lnTo>
                  <a:pt x="576" y="801"/>
                </a:lnTo>
                <a:lnTo>
                  <a:pt x="576" y="801"/>
                </a:lnTo>
                <a:lnTo>
                  <a:pt x="580" y="801"/>
                </a:lnTo>
                <a:lnTo>
                  <a:pt x="580" y="801"/>
                </a:lnTo>
                <a:lnTo>
                  <a:pt x="580" y="801"/>
                </a:lnTo>
                <a:lnTo>
                  <a:pt x="582" y="801"/>
                </a:lnTo>
                <a:lnTo>
                  <a:pt x="582" y="801"/>
                </a:lnTo>
                <a:lnTo>
                  <a:pt x="582" y="801"/>
                </a:lnTo>
                <a:lnTo>
                  <a:pt x="587" y="801"/>
                </a:lnTo>
                <a:lnTo>
                  <a:pt x="587" y="801"/>
                </a:lnTo>
                <a:lnTo>
                  <a:pt x="587" y="801"/>
                </a:lnTo>
                <a:lnTo>
                  <a:pt x="588" y="801"/>
                </a:lnTo>
                <a:lnTo>
                  <a:pt x="588" y="801"/>
                </a:lnTo>
                <a:lnTo>
                  <a:pt x="595" y="801"/>
                </a:lnTo>
                <a:lnTo>
                  <a:pt x="595" y="800"/>
                </a:lnTo>
                <a:lnTo>
                  <a:pt x="595" y="801"/>
                </a:lnTo>
                <a:lnTo>
                  <a:pt x="599" y="801"/>
                </a:lnTo>
                <a:lnTo>
                  <a:pt x="599" y="801"/>
                </a:lnTo>
                <a:lnTo>
                  <a:pt x="599" y="801"/>
                </a:lnTo>
                <a:lnTo>
                  <a:pt x="605" y="801"/>
                </a:lnTo>
                <a:lnTo>
                  <a:pt x="605" y="800"/>
                </a:lnTo>
                <a:lnTo>
                  <a:pt x="605" y="801"/>
                </a:lnTo>
                <a:lnTo>
                  <a:pt x="606" y="801"/>
                </a:lnTo>
                <a:lnTo>
                  <a:pt x="606" y="801"/>
                </a:lnTo>
                <a:lnTo>
                  <a:pt x="607" y="801"/>
                </a:lnTo>
                <a:lnTo>
                  <a:pt x="607" y="801"/>
                </a:lnTo>
                <a:lnTo>
                  <a:pt x="608" y="800"/>
                </a:lnTo>
                <a:lnTo>
                  <a:pt x="608" y="801"/>
                </a:lnTo>
                <a:lnTo>
                  <a:pt x="611" y="801"/>
                </a:lnTo>
                <a:lnTo>
                  <a:pt x="611" y="801"/>
                </a:lnTo>
                <a:lnTo>
                  <a:pt x="611" y="801"/>
                </a:lnTo>
                <a:lnTo>
                  <a:pt x="617" y="801"/>
                </a:lnTo>
                <a:lnTo>
                  <a:pt x="617" y="800"/>
                </a:lnTo>
                <a:lnTo>
                  <a:pt x="617" y="801"/>
                </a:lnTo>
                <a:lnTo>
                  <a:pt x="618" y="801"/>
                </a:lnTo>
                <a:lnTo>
                  <a:pt x="618" y="801"/>
                </a:lnTo>
                <a:lnTo>
                  <a:pt x="621" y="801"/>
                </a:lnTo>
                <a:lnTo>
                  <a:pt x="621" y="801"/>
                </a:lnTo>
                <a:lnTo>
                  <a:pt x="621" y="801"/>
                </a:lnTo>
                <a:lnTo>
                  <a:pt x="625" y="801"/>
                </a:lnTo>
                <a:lnTo>
                  <a:pt x="625" y="801"/>
                </a:lnTo>
                <a:lnTo>
                  <a:pt x="625" y="801"/>
                </a:lnTo>
                <a:lnTo>
                  <a:pt x="627" y="801"/>
                </a:lnTo>
                <a:lnTo>
                  <a:pt x="627" y="801"/>
                </a:lnTo>
                <a:lnTo>
                  <a:pt x="627" y="801"/>
                </a:lnTo>
                <a:lnTo>
                  <a:pt x="630" y="801"/>
                </a:lnTo>
                <a:lnTo>
                  <a:pt x="630" y="800"/>
                </a:lnTo>
                <a:lnTo>
                  <a:pt x="630" y="801"/>
                </a:lnTo>
                <a:lnTo>
                  <a:pt x="631" y="801"/>
                </a:lnTo>
                <a:lnTo>
                  <a:pt x="631" y="801"/>
                </a:lnTo>
                <a:lnTo>
                  <a:pt x="640" y="801"/>
                </a:lnTo>
                <a:lnTo>
                  <a:pt x="640" y="799"/>
                </a:lnTo>
                <a:lnTo>
                  <a:pt x="640" y="801"/>
                </a:lnTo>
                <a:lnTo>
                  <a:pt x="649" y="801"/>
                </a:lnTo>
                <a:lnTo>
                  <a:pt x="649" y="801"/>
                </a:lnTo>
                <a:lnTo>
                  <a:pt x="649" y="801"/>
                </a:lnTo>
                <a:lnTo>
                  <a:pt x="652" y="801"/>
                </a:lnTo>
                <a:lnTo>
                  <a:pt x="652" y="801"/>
                </a:lnTo>
                <a:lnTo>
                  <a:pt x="652" y="801"/>
                </a:lnTo>
                <a:lnTo>
                  <a:pt x="653" y="800"/>
                </a:lnTo>
                <a:lnTo>
                  <a:pt x="653" y="801"/>
                </a:lnTo>
                <a:lnTo>
                  <a:pt x="658" y="801"/>
                </a:lnTo>
                <a:lnTo>
                  <a:pt x="658" y="801"/>
                </a:lnTo>
                <a:lnTo>
                  <a:pt x="658" y="801"/>
                </a:lnTo>
                <a:lnTo>
                  <a:pt x="661" y="801"/>
                </a:lnTo>
                <a:lnTo>
                  <a:pt x="661" y="801"/>
                </a:lnTo>
                <a:lnTo>
                  <a:pt x="661" y="801"/>
                </a:lnTo>
                <a:lnTo>
                  <a:pt x="662" y="801"/>
                </a:lnTo>
                <a:lnTo>
                  <a:pt x="662" y="801"/>
                </a:lnTo>
                <a:lnTo>
                  <a:pt x="667" y="801"/>
                </a:lnTo>
                <a:lnTo>
                  <a:pt x="667" y="801"/>
                </a:lnTo>
                <a:lnTo>
                  <a:pt x="667" y="801"/>
                </a:lnTo>
                <a:lnTo>
                  <a:pt x="679" y="801"/>
                </a:lnTo>
                <a:lnTo>
                  <a:pt x="679" y="801"/>
                </a:lnTo>
                <a:lnTo>
                  <a:pt x="679" y="801"/>
                </a:lnTo>
                <a:lnTo>
                  <a:pt x="685" y="801"/>
                </a:lnTo>
                <a:lnTo>
                  <a:pt x="685" y="801"/>
                </a:lnTo>
                <a:lnTo>
                  <a:pt x="685" y="801"/>
                </a:lnTo>
                <a:lnTo>
                  <a:pt x="696" y="801"/>
                </a:lnTo>
                <a:lnTo>
                  <a:pt x="696" y="801"/>
                </a:lnTo>
                <a:lnTo>
                  <a:pt x="696" y="801"/>
                </a:lnTo>
                <a:lnTo>
                  <a:pt x="698" y="801"/>
                </a:lnTo>
                <a:lnTo>
                  <a:pt x="698" y="801"/>
                </a:lnTo>
                <a:lnTo>
                  <a:pt x="698" y="801"/>
                </a:lnTo>
                <a:lnTo>
                  <a:pt x="701" y="801"/>
                </a:lnTo>
                <a:lnTo>
                  <a:pt x="701" y="801"/>
                </a:lnTo>
                <a:lnTo>
                  <a:pt x="701" y="801"/>
                </a:lnTo>
                <a:lnTo>
                  <a:pt x="704" y="801"/>
                </a:lnTo>
                <a:lnTo>
                  <a:pt x="704" y="801"/>
                </a:lnTo>
                <a:lnTo>
                  <a:pt x="704" y="801"/>
                </a:lnTo>
                <a:lnTo>
                  <a:pt x="711" y="801"/>
                </a:lnTo>
                <a:lnTo>
                  <a:pt x="711" y="801"/>
                </a:lnTo>
                <a:lnTo>
                  <a:pt x="711" y="801"/>
                </a:lnTo>
                <a:lnTo>
                  <a:pt x="715" y="801"/>
                </a:lnTo>
                <a:lnTo>
                  <a:pt x="715" y="801"/>
                </a:lnTo>
                <a:lnTo>
                  <a:pt x="715" y="801"/>
                </a:lnTo>
                <a:lnTo>
                  <a:pt x="716" y="801"/>
                </a:lnTo>
                <a:lnTo>
                  <a:pt x="716" y="801"/>
                </a:lnTo>
                <a:lnTo>
                  <a:pt x="719" y="801"/>
                </a:lnTo>
                <a:lnTo>
                  <a:pt x="719" y="801"/>
                </a:lnTo>
                <a:lnTo>
                  <a:pt x="719" y="801"/>
                </a:lnTo>
                <a:lnTo>
                  <a:pt x="722" y="801"/>
                </a:lnTo>
                <a:lnTo>
                  <a:pt x="722" y="801"/>
                </a:lnTo>
                <a:lnTo>
                  <a:pt x="722" y="801"/>
                </a:lnTo>
                <a:lnTo>
                  <a:pt x="723" y="801"/>
                </a:lnTo>
                <a:lnTo>
                  <a:pt x="723" y="801"/>
                </a:lnTo>
                <a:lnTo>
                  <a:pt x="724" y="801"/>
                </a:lnTo>
                <a:lnTo>
                  <a:pt x="724" y="801"/>
                </a:lnTo>
                <a:lnTo>
                  <a:pt x="725" y="801"/>
                </a:lnTo>
                <a:lnTo>
                  <a:pt x="725" y="796"/>
                </a:lnTo>
                <a:lnTo>
                  <a:pt x="726" y="799"/>
                </a:lnTo>
                <a:lnTo>
                  <a:pt x="726" y="801"/>
                </a:lnTo>
                <a:lnTo>
                  <a:pt x="727" y="801"/>
                </a:lnTo>
                <a:lnTo>
                  <a:pt x="727" y="801"/>
                </a:lnTo>
                <a:lnTo>
                  <a:pt x="728" y="801"/>
                </a:lnTo>
                <a:lnTo>
                  <a:pt x="728" y="801"/>
                </a:lnTo>
                <a:lnTo>
                  <a:pt x="729" y="801"/>
                </a:lnTo>
                <a:lnTo>
                  <a:pt x="729" y="801"/>
                </a:lnTo>
                <a:lnTo>
                  <a:pt x="730" y="801"/>
                </a:lnTo>
                <a:lnTo>
                  <a:pt x="730" y="801"/>
                </a:lnTo>
                <a:lnTo>
                  <a:pt x="731" y="801"/>
                </a:lnTo>
                <a:lnTo>
                  <a:pt x="731" y="801"/>
                </a:lnTo>
                <a:lnTo>
                  <a:pt x="733" y="801"/>
                </a:lnTo>
                <a:lnTo>
                  <a:pt x="733" y="801"/>
                </a:lnTo>
                <a:lnTo>
                  <a:pt x="733" y="801"/>
                </a:lnTo>
                <a:lnTo>
                  <a:pt x="734" y="801"/>
                </a:lnTo>
                <a:lnTo>
                  <a:pt x="734" y="801"/>
                </a:lnTo>
                <a:lnTo>
                  <a:pt x="736" y="801"/>
                </a:lnTo>
                <a:lnTo>
                  <a:pt x="736" y="801"/>
                </a:lnTo>
                <a:lnTo>
                  <a:pt x="736" y="801"/>
                </a:lnTo>
                <a:lnTo>
                  <a:pt x="737" y="801"/>
                </a:lnTo>
                <a:lnTo>
                  <a:pt x="737" y="801"/>
                </a:lnTo>
                <a:lnTo>
                  <a:pt x="739" y="801"/>
                </a:lnTo>
                <a:lnTo>
                  <a:pt x="739" y="801"/>
                </a:lnTo>
                <a:lnTo>
                  <a:pt x="739" y="801"/>
                </a:lnTo>
                <a:lnTo>
                  <a:pt x="747" y="801"/>
                </a:lnTo>
                <a:lnTo>
                  <a:pt x="747" y="801"/>
                </a:lnTo>
                <a:lnTo>
                  <a:pt x="747" y="801"/>
                </a:lnTo>
                <a:lnTo>
                  <a:pt x="748" y="801"/>
                </a:lnTo>
                <a:lnTo>
                  <a:pt x="748" y="801"/>
                </a:lnTo>
                <a:lnTo>
                  <a:pt x="751" y="801"/>
                </a:lnTo>
                <a:lnTo>
                  <a:pt x="751" y="801"/>
                </a:lnTo>
                <a:lnTo>
                  <a:pt x="751" y="801"/>
                </a:lnTo>
                <a:lnTo>
                  <a:pt x="753" y="801"/>
                </a:lnTo>
                <a:lnTo>
                  <a:pt x="753" y="801"/>
                </a:lnTo>
                <a:lnTo>
                  <a:pt x="753" y="801"/>
                </a:lnTo>
                <a:lnTo>
                  <a:pt x="754" y="801"/>
                </a:lnTo>
                <a:lnTo>
                  <a:pt x="754" y="801"/>
                </a:lnTo>
                <a:lnTo>
                  <a:pt x="758" y="801"/>
                </a:lnTo>
                <a:lnTo>
                  <a:pt x="758" y="801"/>
                </a:lnTo>
                <a:lnTo>
                  <a:pt x="758" y="801"/>
                </a:lnTo>
                <a:lnTo>
                  <a:pt x="762" y="801"/>
                </a:lnTo>
                <a:lnTo>
                  <a:pt x="762" y="801"/>
                </a:lnTo>
                <a:lnTo>
                  <a:pt x="762" y="801"/>
                </a:lnTo>
                <a:lnTo>
                  <a:pt x="768" y="801"/>
                </a:lnTo>
                <a:lnTo>
                  <a:pt x="768" y="801"/>
                </a:lnTo>
                <a:lnTo>
                  <a:pt x="768" y="801"/>
                </a:lnTo>
                <a:lnTo>
                  <a:pt x="784" y="801"/>
                </a:lnTo>
                <a:lnTo>
                  <a:pt x="784" y="801"/>
                </a:lnTo>
                <a:lnTo>
                  <a:pt x="784" y="801"/>
                </a:lnTo>
                <a:lnTo>
                  <a:pt x="786" y="801"/>
                </a:lnTo>
                <a:lnTo>
                  <a:pt x="786" y="801"/>
                </a:lnTo>
                <a:lnTo>
                  <a:pt x="786" y="801"/>
                </a:lnTo>
                <a:lnTo>
                  <a:pt x="794" y="801"/>
                </a:lnTo>
                <a:lnTo>
                  <a:pt x="794" y="801"/>
                </a:lnTo>
                <a:lnTo>
                  <a:pt x="794" y="801"/>
                </a:lnTo>
                <a:lnTo>
                  <a:pt x="800" y="801"/>
                </a:lnTo>
                <a:lnTo>
                  <a:pt x="800" y="801"/>
                </a:lnTo>
                <a:lnTo>
                  <a:pt x="800" y="801"/>
                </a:lnTo>
                <a:lnTo>
                  <a:pt x="811" y="801"/>
                </a:lnTo>
                <a:lnTo>
                  <a:pt x="811" y="801"/>
                </a:lnTo>
                <a:lnTo>
                  <a:pt x="811" y="801"/>
                </a:lnTo>
                <a:lnTo>
                  <a:pt x="824" y="801"/>
                </a:lnTo>
                <a:lnTo>
                  <a:pt x="824" y="801"/>
                </a:lnTo>
                <a:lnTo>
                  <a:pt x="824" y="801"/>
                </a:lnTo>
                <a:lnTo>
                  <a:pt x="825" y="801"/>
                </a:lnTo>
                <a:lnTo>
                  <a:pt x="825" y="801"/>
                </a:lnTo>
                <a:lnTo>
                  <a:pt x="850" y="801"/>
                </a:lnTo>
                <a:lnTo>
                  <a:pt x="850" y="801"/>
                </a:lnTo>
                <a:lnTo>
                  <a:pt x="850" y="801"/>
                </a:lnTo>
                <a:lnTo>
                  <a:pt x="856" y="801"/>
                </a:lnTo>
                <a:lnTo>
                  <a:pt x="856" y="801"/>
                </a:lnTo>
                <a:lnTo>
                  <a:pt x="856" y="801"/>
                </a:lnTo>
                <a:lnTo>
                  <a:pt x="866" y="801"/>
                </a:lnTo>
                <a:lnTo>
                  <a:pt x="866" y="801"/>
                </a:lnTo>
                <a:lnTo>
                  <a:pt x="866" y="801"/>
                </a:lnTo>
                <a:lnTo>
                  <a:pt x="871" y="801"/>
                </a:lnTo>
                <a:lnTo>
                  <a:pt x="871" y="801"/>
                </a:lnTo>
                <a:lnTo>
                  <a:pt x="871" y="801"/>
                </a:lnTo>
                <a:lnTo>
                  <a:pt x="874" y="801"/>
                </a:lnTo>
                <a:lnTo>
                  <a:pt x="874" y="801"/>
                </a:lnTo>
                <a:lnTo>
                  <a:pt x="874" y="801"/>
                </a:lnTo>
                <a:lnTo>
                  <a:pt x="877" y="801"/>
                </a:lnTo>
                <a:lnTo>
                  <a:pt x="877" y="801"/>
                </a:lnTo>
                <a:lnTo>
                  <a:pt x="877" y="801"/>
                </a:lnTo>
                <a:lnTo>
                  <a:pt x="883" y="801"/>
                </a:lnTo>
                <a:lnTo>
                  <a:pt x="883" y="801"/>
                </a:lnTo>
                <a:lnTo>
                  <a:pt x="883" y="801"/>
                </a:lnTo>
                <a:lnTo>
                  <a:pt x="894" y="801"/>
                </a:lnTo>
                <a:lnTo>
                  <a:pt x="894" y="801"/>
                </a:lnTo>
                <a:lnTo>
                  <a:pt x="894" y="801"/>
                </a:lnTo>
                <a:lnTo>
                  <a:pt x="900" y="801"/>
                </a:lnTo>
                <a:lnTo>
                  <a:pt x="900" y="801"/>
                </a:lnTo>
                <a:lnTo>
                  <a:pt x="900" y="801"/>
                </a:lnTo>
                <a:lnTo>
                  <a:pt x="903" y="801"/>
                </a:lnTo>
                <a:lnTo>
                  <a:pt x="903" y="801"/>
                </a:lnTo>
                <a:lnTo>
                  <a:pt x="903" y="801"/>
                </a:lnTo>
                <a:lnTo>
                  <a:pt x="910" y="801"/>
                </a:lnTo>
                <a:lnTo>
                  <a:pt x="910" y="801"/>
                </a:lnTo>
                <a:lnTo>
                  <a:pt x="910" y="801"/>
                </a:lnTo>
                <a:lnTo>
                  <a:pt x="911" y="801"/>
                </a:lnTo>
                <a:lnTo>
                  <a:pt x="911" y="801"/>
                </a:lnTo>
                <a:lnTo>
                  <a:pt x="920" y="801"/>
                </a:lnTo>
                <a:lnTo>
                  <a:pt x="920" y="801"/>
                </a:lnTo>
                <a:lnTo>
                  <a:pt x="920" y="801"/>
                </a:lnTo>
                <a:lnTo>
                  <a:pt x="924" y="801"/>
                </a:lnTo>
                <a:lnTo>
                  <a:pt x="924" y="801"/>
                </a:lnTo>
                <a:lnTo>
                  <a:pt x="924" y="801"/>
                </a:lnTo>
                <a:lnTo>
                  <a:pt x="934" y="801"/>
                </a:lnTo>
                <a:lnTo>
                  <a:pt x="934" y="801"/>
                </a:lnTo>
                <a:lnTo>
                  <a:pt x="934" y="801"/>
                </a:lnTo>
                <a:lnTo>
                  <a:pt x="936" y="801"/>
                </a:lnTo>
                <a:lnTo>
                  <a:pt x="936" y="801"/>
                </a:lnTo>
                <a:lnTo>
                  <a:pt x="936" y="801"/>
                </a:lnTo>
                <a:lnTo>
                  <a:pt x="944" y="801"/>
                </a:lnTo>
                <a:lnTo>
                  <a:pt x="944" y="801"/>
                </a:lnTo>
                <a:lnTo>
                  <a:pt x="944" y="801"/>
                </a:lnTo>
                <a:lnTo>
                  <a:pt x="952" y="801"/>
                </a:lnTo>
                <a:lnTo>
                  <a:pt x="952" y="801"/>
                </a:lnTo>
                <a:lnTo>
                  <a:pt x="952" y="801"/>
                </a:lnTo>
                <a:lnTo>
                  <a:pt x="956" y="801"/>
                </a:lnTo>
                <a:lnTo>
                  <a:pt x="956" y="801"/>
                </a:lnTo>
                <a:lnTo>
                  <a:pt x="956" y="801"/>
                </a:lnTo>
                <a:lnTo>
                  <a:pt x="957" y="801"/>
                </a:lnTo>
                <a:lnTo>
                  <a:pt x="957" y="801"/>
                </a:lnTo>
                <a:lnTo>
                  <a:pt x="960" y="801"/>
                </a:lnTo>
                <a:lnTo>
                  <a:pt x="960" y="801"/>
                </a:lnTo>
                <a:lnTo>
                  <a:pt x="960" y="801"/>
                </a:lnTo>
                <a:lnTo>
                  <a:pt x="970" y="801"/>
                </a:lnTo>
                <a:lnTo>
                  <a:pt x="970" y="801"/>
                </a:lnTo>
                <a:lnTo>
                  <a:pt x="970" y="801"/>
                </a:lnTo>
                <a:lnTo>
                  <a:pt x="975" y="801"/>
                </a:lnTo>
                <a:lnTo>
                  <a:pt x="975" y="801"/>
                </a:lnTo>
                <a:lnTo>
                  <a:pt x="975" y="801"/>
                </a:lnTo>
                <a:lnTo>
                  <a:pt x="976" y="801"/>
                </a:lnTo>
                <a:lnTo>
                  <a:pt x="976" y="801"/>
                </a:lnTo>
                <a:lnTo>
                  <a:pt x="983" y="801"/>
                </a:lnTo>
                <a:lnTo>
                  <a:pt x="983" y="801"/>
                </a:lnTo>
                <a:lnTo>
                  <a:pt x="983" y="801"/>
                </a:lnTo>
                <a:lnTo>
                  <a:pt x="989" y="801"/>
                </a:lnTo>
                <a:lnTo>
                  <a:pt x="989" y="801"/>
                </a:lnTo>
                <a:lnTo>
                  <a:pt x="989" y="801"/>
                </a:lnTo>
                <a:lnTo>
                  <a:pt x="991" y="801"/>
                </a:lnTo>
                <a:lnTo>
                  <a:pt x="991" y="801"/>
                </a:lnTo>
                <a:lnTo>
                  <a:pt x="991" y="801"/>
                </a:lnTo>
                <a:lnTo>
                  <a:pt x="992" y="801"/>
                </a:lnTo>
                <a:lnTo>
                  <a:pt x="992" y="801"/>
                </a:lnTo>
                <a:lnTo>
                  <a:pt x="999" y="801"/>
                </a:lnTo>
                <a:lnTo>
                  <a:pt x="999" y="801"/>
                </a:lnTo>
                <a:lnTo>
                  <a:pt x="999" y="801"/>
                </a:lnTo>
                <a:lnTo>
                  <a:pt x="1005" y="801"/>
                </a:lnTo>
                <a:lnTo>
                  <a:pt x="1005" y="801"/>
                </a:lnTo>
                <a:lnTo>
                  <a:pt x="1005" y="801"/>
                </a:lnTo>
                <a:lnTo>
                  <a:pt x="1014" y="801"/>
                </a:lnTo>
                <a:lnTo>
                  <a:pt x="1014" y="801"/>
                </a:lnTo>
                <a:lnTo>
                  <a:pt x="1014" y="801"/>
                </a:lnTo>
                <a:lnTo>
                  <a:pt x="1028" y="801"/>
                </a:lnTo>
                <a:lnTo>
                  <a:pt x="1028" y="801"/>
                </a:lnTo>
                <a:lnTo>
                  <a:pt x="1028" y="801"/>
                </a:lnTo>
                <a:lnTo>
                  <a:pt x="1030" y="801"/>
                </a:lnTo>
                <a:lnTo>
                  <a:pt x="1030" y="801"/>
                </a:lnTo>
                <a:lnTo>
                  <a:pt x="1030" y="801"/>
                </a:lnTo>
                <a:lnTo>
                  <a:pt x="1039" y="801"/>
                </a:lnTo>
                <a:lnTo>
                  <a:pt x="1039" y="801"/>
                </a:lnTo>
                <a:lnTo>
                  <a:pt x="1039" y="801"/>
                </a:lnTo>
                <a:lnTo>
                  <a:pt x="1050" y="801"/>
                </a:lnTo>
                <a:lnTo>
                  <a:pt x="1050" y="801"/>
                </a:lnTo>
                <a:lnTo>
                  <a:pt x="1050" y="801"/>
                </a:lnTo>
                <a:lnTo>
                  <a:pt x="1062" y="801"/>
                </a:lnTo>
                <a:lnTo>
                  <a:pt x="1062" y="801"/>
                </a:lnTo>
                <a:lnTo>
                  <a:pt x="1062" y="801"/>
                </a:lnTo>
                <a:lnTo>
                  <a:pt x="1073" y="801"/>
                </a:lnTo>
                <a:lnTo>
                  <a:pt x="1073" y="801"/>
                </a:lnTo>
                <a:lnTo>
                  <a:pt x="1073" y="801"/>
                </a:lnTo>
                <a:lnTo>
                  <a:pt x="1079" y="801"/>
                </a:lnTo>
                <a:lnTo>
                  <a:pt x="1079" y="801"/>
                </a:lnTo>
                <a:lnTo>
                  <a:pt x="1079" y="801"/>
                </a:lnTo>
                <a:lnTo>
                  <a:pt x="1081" y="801"/>
                </a:lnTo>
                <a:lnTo>
                  <a:pt x="1081" y="801"/>
                </a:lnTo>
                <a:lnTo>
                  <a:pt x="1081" y="801"/>
                </a:lnTo>
                <a:lnTo>
                  <a:pt x="1085" y="801"/>
                </a:lnTo>
                <a:lnTo>
                  <a:pt x="1085" y="801"/>
                </a:lnTo>
                <a:lnTo>
                  <a:pt x="1085" y="801"/>
                </a:lnTo>
                <a:lnTo>
                  <a:pt x="1091" y="801"/>
                </a:lnTo>
                <a:lnTo>
                  <a:pt x="1091" y="801"/>
                </a:lnTo>
                <a:lnTo>
                  <a:pt x="1091" y="801"/>
                </a:lnTo>
                <a:lnTo>
                  <a:pt x="1106" y="801"/>
                </a:lnTo>
                <a:lnTo>
                  <a:pt x="1106" y="801"/>
                </a:lnTo>
                <a:lnTo>
                  <a:pt x="1106" y="801"/>
                </a:lnTo>
                <a:lnTo>
                  <a:pt x="1108" y="801"/>
                </a:lnTo>
                <a:lnTo>
                  <a:pt x="1108" y="801"/>
                </a:lnTo>
                <a:lnTo>
                  <a:pt x="1108" y="801"/>
                </a:lnTo>
                <a:lnTo>
                  <a:pt x="1125" y="801"/>
                </a:lnTo>
                <a:lnTo>
                  <a:pt x="1125" y="801"/>
                </a:lnTo>
                <a:lnTo>
                  <a:pt x="1125" y="801"/>
                </a:lnTo>
                <a:lnTo>
                  <a:pt x="1126" y="801"/>
                </a:lnTo>
                <a:lnTo>
                  <a:pt x="1126" y="801"/>
                </a:lnTo>
                <a:lnTo>
                  <a:pt x="1136" y="801"/>
                </a:lnTo>
                <a:lnTo>
                  <a:pt x="1136" y="801"/>
                </a:lnTo>
                <a:lnTo>
                  <a:pt x="1136" y="801"/>
                </a:lnTo>
                <a:lnTo>
                  <a:pt x="1144" y="801"/>
                </a:lnTo>
                <a:lnTo>
                  <a:pt x="1144" y="801"/>
                </a:lnTo>
                <a:lnTo>
                  <a:pt x="1144" y="801"/>
                </a:lnTo>
                <a:lnTo>
                  <a:pt x="1152" y="801"/>
                </a:lnTo>
                <a:lnTo>
                  <a:pt x="1152" y="801"/>
                </a:lnTo>
                <a:lnTo>
                  <a:pt x="1152" y="801"/>
                </a:lnTo>
                <a:lnTo>
                  <a:pt x="1154" y="801"/>
                </a:lnTo>
                <a:lnTo>
                  <a:pt x="1154" y="801"/>
                </a:lnTo>
                <a:lnTo>
                  <a:pt x="1154" y="801"/>
                </a:lnTo>
                <a:lnTo>
                  <a:pt x="1170" y="801"/>
                </a:lnTo>
                <a:lnTo>
                  <a:pt x="1170" y="801"/>
                </a:lnTo>
                <a:lnTo>
                  <a:pt x="1170" y="801"/>
                </a:lnTo>
                <a:lnTo>
                  <a:pt x="1201" y="801"/>
                </a:lnTo>
                <a:lnTo>
                  <a:pt x="1201" y="801"/>
                </a:lnTo>
                <a:lnTo>
                  <a:pt x="1201" y="801"/>
                </a:lnTo>
                <a:lnTo>
                  <a:pt x="1209" y="801"/>
                </a:lnTo>
                <a:lnTo>
                  <a:pt x="1209" y="801"/>
                </a:lnTo>
                <a:lnTo>
                  <a:pt x="1209" y="801"/>
                </a:lnTo>
                <a:lnTo>
                  <a:pt x="1213" y="801"/>
                </a:lnTo>
                <a:lnTo>
                  <a:pt x="1213" y="801"/>
                </a:lnTo>
                <a:lnTo>
                  <a:pt x="1213" y="801"/>
                </a:lnTo>
                <a:lnTo>
                  <a:pt x="1242" y="801"/>
                </a:lnTo>
                <a:lnTo>
                  <a:pt x="1242" y="801"/>
                </a:lnTo>
                <a:lnTo>
                  <a:pt x="1242" y="801"/>
                </a:lnTo>
                <a:lnTo>
                  <a:pt x="1252" y="801"/>
                </a:lnTo>
                <a:lnTo>
                  <a:pt x="1252" y="801"/>
                </a:lnTo>
                <a:lnTo>
                  <a:pt x="1252" y="801"/>
                </a:lnTo>
                <a:lnTo>
                  <a:pt x="1257" y="801"/>
                </a:lnTo>
                <a:lnTo>
                  <a:pt x="1257" y="801"/>
                </a:lnTo>
                <a:lnTo>
                  <a:pt x="1257" y="801"/>
                </a:lnTo>
                <a:lnTo>
                  <a:pt x="1275" y="801"/>
                </a:lnTo>
                <a:lnTo>
                  <a:pt x="1275" y="801"/>
                </a:lnTo>
                <a:lnTo>
                  <a:pt x="1275" y="801"/>
                </a:lnTo>
                <a:lnTo>
                  <a:pt x="1276" y="801"/>
                </a:lnTo>
                <a:lnTo>
                  <a:pt x="1276" y="801"/>
                </a:lnTo>
                <a:lnTo>
                  <a:pt x="1291" y="801"/>
                </a:lnTo>
                <a:lnTo>
                  <a:pt x="1291" y="801"/>
                </a:lnTo>
                <a:lnTo>
                  <a:pt x="1291" y="801"/>
                </a:lnTo>
                <a:lnTo>
                  <a:pt x="1299" y="801"/>
                </a:lnTo>
                <a:lnTo>
                  <a:pt x="1299" y="801"/>
                </a:lnTo>
                <a:lnTo>
                  <a:pt x="1299" y="801"/>
                </a:lnTo>
                <a:lnTo>
                  <a:pt x="1308" y="801"/>
                </a:lnTo>
                <a:lnTo>
                  <a:pt x="1308" y="801"/>
                </a:lnTo>
                <a:lnTo>
                  <a:pt x="1308" y="801"/>
                </a:lnTo>
                <a:lnTo>
                  <a:pt x="1320" y="801"/>
                </a:lnTo>
                <a:lnTo>
                  <a:pt x="1320" y="801"/>
                </a:lnTo>
                <a:lnTo>
                  <a:pt x="1320" y="801"/>
                </a:lnTo>
                <a:lnTo>
                  <a:pt x="1324" y="801"/>
                </a:lnTo>
                <a:lnTo>
                  <a:pt x="1324" y="801"/>
                </a:lnTo>
                <a:lnTo>
                  <a:pt x="1324" y="801"/>
                </a:lnTo>
                <a:lnTo>
                  <a:pt x="1329" y="801"/>
                </a:lnTo>
                <a:lnTo>
                  <a:pt x="1329" y="801"/>
                </a:lnTo>
                <a:lnTo>
                  <a:pt x="1329" y="801"/>
                </a:lnTo>
                <a:lnTo>
                  <a:pt x="1341" y="801"/>
                </a:lnTo>
                <a:lnTo>
                  <a:pt x="1341" y="801"/>
                </a:lnTo>
                <a:lnTo>
                  <a:pt x="1341" y="801"/>
                </a:lnTo>
                <a:lnTo>
                  <a:pt x="1342" y="801"/>
                </a:lnTo>
                <a:lnTo>
                  <a:pt x="1342" y="801"/>
                </a:lnTo>
                <a:lnTo>
                  <a:pt x="1349" y="801"/>
                </a:lnTo>
                <a:lnTo>
                  <a:pt x="1349" y="801"/>
                </a:lnTo>
                <a:lnTo>
                  <a:pt x="1349" y="801"/>
                </a:lnTo>
                <a:lnTo>
                  <a:pt x="1351" y="801"/>
                </a:lnTo>
                <a:lnTo>
                  <a:pt x="1351" y="801"/>
                </a:lnTo>
                <a:lnTo>
                  <a:pt x="1351" y="801"/>
                </a:lnTo>
                <a:lnTo>
                  <a:pt x="1367" y="801"/>
                </a:lnTo>
                <a:lnTo>
                  <a:pt x="1367" y="801"/>
                </a:lnTo>
                <a:lnTo>
                  <a:pt x="1367" y="801"/>
                </a:lnTo>
                <a:lnTo>
                  <a:pt x="1381" y="801"/>
                </a:lnTo>
                <a:lnTo>
                  <a:pt x="1381" y="801"/>
                </a:lnTo>
                <a:lnTo>
                  <a:pt x="1381" y="801"/>
                </a:lnTo>
                <a:lnTo>
                  <a:pt x="1415" y="801"/>
                </a:lnTo>
                <a:lnTo>
                  <a:pt x="1415" y="801"/>
                </a:lnTo>
                <a:lnTo>
                  <a:pt x="1415" y="801"/>
                </a:lnTo>
                <a:lnTo>
                  <a:pt x="1431" y="801"/>
                </a:lnTo>
                <a:lnTo>
                  <a:pt x="1431" y="801"/>
                </a:lnTo>
                <a:lnTo>
                  <a:pt x="1431" y="801"/>
                </a:lnTo>
                <a:lnTo>
                  <a:pt x="1436" y="801"/>
                </a:lnTo>
                <a:lnTo>
                  <a:pt x="1436" y="801"/>
                </a:lnTo>
                <a:lnTo>
                  <a:pt x="1436" y="801"/>
                </a:lnTo>
                <a:lnTo>
                  <a:pt x="1446" y="801"/>
                </a:lnTo>
                <a:lnTo>
                  <a:pt x="1446" y="801"/>
                </a:lnTo>
                <a:lnTo>
                  <a:pt x="1446" y="801"/>
                </a:lnTo>
                <a:lnTo>
                  <a:pt x="1449" y="801"/>
                </a:lnTo>
                <a:lnTo>
                  <a:pt x="1449" y="801"/>
                </a:lnTo>
                <a:lnTo>
                  <a:pt x="1449" y="801"/>
                </a:lnTo>
                <a:lnTo>
                  <a:pt x="1461" y="801"/>
                </a:lnTo>
                <a:lnTo>
                  <a:pt x="1461" y="801"/>
                </a:lnTo>
                <a:lnTo>
                  <a:pt x="1461" y="801"/>
                </a:lnTo>
                <a:lnTo>
                  <a:pt x="1471" y="801"/>
                </a:lnTo>
                <a:lnTo>
                  <a:pt x="1471" y="801"/>
                </a:lnTo>
                <a:lnTo>
                  <a:pt x="1471" y="801"/>
                </a:lnTo>
                <a:lnTo>
                  <a:pt x="1486" y="801"/>
                </a:lnTo>
                <a:lnTo>
                  <a:pt x="1486" y="801"/>
                </a:lnTo>
                <a:lnTo>
                  <a:pt x="1486" y="801"/>
                </a:lnTo>
                <a:lnTo>
                  <a:pt x="1499" y="801"/>
                </a:lnTo>
                <a:lnTo>
                  <a:pt x="1499" y="801"/>
                </a:lnTo>
                <a:lnTo>
                  <a:pt x="1499" y="801"/>
                </a:lnTo>
                <a:lnTo>
                  <a:pt x="1500" y="801"/>
                </a:lnTo>
                <a:lnTo>
                  <a:pt x="1500" y="801"/>
                </a:lnTo>
                <a:lnTo>
                  <a:pt x="1504" y="801"/>
                </a:lnTo>
                <a:lnTo>
                  <a:pt x="1504" y="801"/>
                </a:lnTo>
                <a:lnTo>
                  <a:pt x="1504" y="801"/>
                </a:lnTo>
                <a:lnTo>
                  <a:pt x="1520" y="801"/>
                </a:lnTo>
                <a:lnTo>
                  <a:pt x="1520" y="801"/>
                </a:lnTo>
                <a:lnTo>
                  <a:pt x="1520" y="801"/>
                </a:lnTo>
                <a:lnTo>
                  <a:pt x="1525" y="801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2" name="Rectangle 547"/>
          <p:cNvSpPr>
            <a:spLocks noChangeArrowheads="1"/>
          </p:cNvSpPr>
          <p:nvPr/>
        </p:nvSpPr>
        <p:spPr bwMode="auto">
          <a:xfrm>
            <a:off x="4044645" y="2430875"/>
            <a:ext cx="43281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65.0543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23" name="Rectangle 547"/>
          <p:cNvSpPr>
            <a:spLocks noChangeArrowheads="1"/>
          </p:cNvSpPr>
          <p:nvPr/>
        </p:nvSpPr>
        <p:spPr bwMode="auto">
          <a:xfrm>
            <a:off x="4090404" y="2577344"/>
            <a:ext cx="47769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arent Ion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aphicFrame>
        <p:nvGraphicFramePr>
          <p:cNvPr id="627" name="Object 6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3285814"/>
              </p:ext>
            </p:extLst>
          </p:nvPr>
        </p:nvGraphicFramePr>
        <p:xfrm>
          <a:off x="5743375" y="3018225"/>
          <a:ext cx="1382018" cy="16809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7" name="CS ChemDraw Drawing" r:id="rId4" imgW="1599997" imgH="1945620" progId="ChemDraw.Document.6.0">
                  <p:embed/>
                </p:oleObj>
              </mc:Choice>
              <mc:Fallback>
                <p:oleObj name="CS ChemDraw Drawing" r:id="rId4" imgW="1599997" imgH="1945620" progId="ChemDraw.Document.6.0">
                  <p:embed/>
                  <p:pic>
                    <p:nvPicPr>
                      <p:cNvPr id="627" name="Object 626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743375" y="3018225"/>
                        <a:ext cx="1382018" cy="16809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1" name="TextBox 290">
            <a:extLst>
              <a:ext uri="{FF2B5EF4-FFF2-40B4-BE49-F238E27FC236}">
                <a16:creationId xmlns:a16="http://schemas.microsoft.com/office/drawing/2014/main" id="{70CC36DE-BE6F-4631-B511-E594A0575E40}"/>
              </a:ext>
            </a:extLst>
          </p:cNvPr>
          <p:cNvSpPr txBox="1"/>
          <p:nvPr/>
        </p:nvSpPr>
        <p:spPr>
          <a:xfrm>
            <a:off x="2620600" y="2074283"/>
            <a:ext cx="7025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284" name="Freeform 865">
            <a:extLst>
              <a:ext uri="{FF2B5EF4-FFF2-40B4-BE49-F238E27FC236}">
                <a16:creationId xmlns:a16="http://schemas.microsoft.com/office/drawing/2014/main" id="{D0FD3B3F-9580-4772-B3D7-106D355EC39F}"/>
              </a:ext>
            </a:extLst>
          </p:cNvPr>
          <p:cNvSpPr>
            <a:spLocks/>
          </p:cNvSpPr>
          <p:nvPr/>
        </p:nvSpPr>
        <p:spPr bwMode="auto">
          <a:xfrm>
            <a:off x="3325367" y="7174805"/>
            <a:ext cx="5872206" cy="3389469"/>
          </a:xfrm>
          <a:custGeom>
            <a:avLst/>
            <a:gdLst>
              <a:gd name="T0" fmla="*/ 14 w 4198"/>
              <a:gd name="T1" fmla="*/ 6117 h 6117"/>
              <a:gd name="T2" fmla="*/ 32 w 4198"/>
              <a:gd name="T3" fmla="*/ 6117 h 6117"/>
              <a:gd name="T4" fmla="*/ 53 w 4198"/>
              <a:gd name="T5" fmla="*/ 6117 h 6117"/>
              <a:gd name="T6" fmla="*/ 71 w 4198"/>
              <a:gd name="T7" fmla="*/ 6117 h 6117"/>
              <a:gd name="T8" fmla="*/ 92 w 4198"/>
              <a:gd name="T9" fmla="*/ 6116 h 6117"/>
              <a:gd name="T10" fmla="*/ 113 w 4198"/>
              <a:gd name="T11" fmla="*/ 6117 h 6117"/>
              <a:gd name="T12" fmla="*/ 132 w 4198"/>
              <a:gd name="T13" fmla="*/ 6117 h 6117"/>
              <a:gd name="T14" fmla="*/ 153 w 4198"/>
              <a:gd name="T15" fmla="*/ 6116 h 6117"/>
              <a:gd name="T16" fmla="*/ 172 w 4198"/>
              <a:gd name="T17" fmla="*/ 6116 h 6117"/>
              <a:gd name="T18" fmla="*/ 198 w 4198"/>
              <a:gd name="T19" fmla="*/ 6117 h 6117"/>
              <a:gd name="T20" fmla="*/ 220 w 4198"/>
              <a:gd name="T21" fmla="*/ 6116 h 6117"/>
              <a:gd name="T22" fmla="*/ 246 w 4198"/>
              <a:gd name="T23" fmla="*/ 6116 h 6117"/>
              <a:gd name="T24" fmla="*/ 279 w 4198"/>
              <a:gd name="T25" fmla="*/ 6116 h 6117"/>
              <a:gd name="T26" fmla="*/ 307 w 4198"/>
              <a:gd name="T27" fmla="*/ 6117 h 6117"/>
              <a:gd name="T28" fmla="*/ 329 w 4198"/>
              <a:gd name="T29" fmla="*/ 6117 h 6117"/>
              <a:gd name="T30" fmla="*/ 353 w 4198"/>
              <a:gd name="T31" fmla="*/ 6117 h 6117"/>
              <a:gd name="T32" fmla="*/ 388 w 4198"/>
              <a:gd name="T33" fmla="*/ 6117 h 6117"/>
              <a:gd name="T34" fmla="*/ 419 w 4198"/>
              <a:gd name="T35" fmla="*/ 6116 h 6117"/>
              <a:gd name="T36" fmla="*/ 446 w 4198"/>
              <a:gd name="T37" fmla="*/ 6117 h 6117"/>
              <a:gd name="T38" fmla="*/ 473 w 4198"/>
              <a:gd name="T39" fmla="*/ 6117 h 6117"/>
              <a:gd name="T40" fmla="*/ 499 w 4198"/>
              <a:gd name="T41" fmla="*/ 6115 h 6117"/>
              <a:gd name="T42" fmla="*/ 545 w 4198"/>
              <a:gd name="T43" fmla="*/ 6116 h 6117"/>
              <a:gd name="T44" fmla="*/ 575 w 4198"/>
              <a:gd name="T45" fmla="*/ 6116 h 6117"/>
              <a:gd name="T46" fmla="*/ 615 w 4198"/>
              <a:gd name="T47" fmla="*/ 6117 h 6117"/>
              <a:gd name="T48" fmla="*/ 649 w 4198"/>
              <a:gd name="T49" fmla="*/ 6117 h 6117"/>
              <a:gd name="T50" fmla="*/ 671 w 4198"/>
              <a:gd name="T51" fmla="*/ 6117 h 6117"/>
              <a:gd name="T52" fmla="*/ 716 w 4198"/>
              <a:gd name="T53" fmla="*/ 5757 h 6117"/>
              <a:gd name="T54" fmla="*/ 757 w 4198"/>
              <a:gd name="T55" fmla="*/ 6116 h 6117"/>
              <a:gd name="T56" fmla="*/ 786 w 4198"/>
              <a:gd name="T57" fmla="*/ 6117 h 6117"/>
              <a:gd name="T58" fmla="*/ 846 w 4198"/>
              <a:gd name="T59" fmla="*/ 6117 h 6117"/>
              <a:gd name="T60" fmla="*/ 893 w 4198"/>
              <a:gd name="T61" fmla="*/ 6117 h 6117"/>
              <a:gd name="T62" fmla="*/ 937 w 4198"/>
              <a:gd name="T63" fmla="*/ 6116 h 6117"/>
              <a:gd name="T64" fmla="*/ 980 w 4198"/>
              <a:gd name="T65" fmla="*/ 6116 h 6117"/>
              <a:gd name="T66" fmla="*/ 1015 w 4198"/>
              <a:gd name="T67" fmla="*/ 6116 h 6117"/>
              <a:gd name="T68" fmla="*/ 1050 w 4198"/>
              <a:gd name="T69" fmla="*/ 6117 h 6117"/>
              <a:gd name="T70" fmla="*/ 1098 w 4198"/>
              <a:gd name="T71" fmla="*/ 6117 h 6117"/>
              <a:gd name="T72" fmla="*/ 1137 w 4198"/>
              <a:gd name="T73" fmla="*/ 6117 h 6117"/>
              <a:gd name="T74" fmla="*/ 1204 w 4198"/>
              <a:gd name="T75" fmla="*/ 6117 h 6117"/>
              <a:gd name="T76" fmla="*/ 1240 w 4198"/>
              <a:gd name="T77" fmla="*/ 6116 h 6117"/>
              <a:gd name="T78" fmla="*/ 1336 w 4198"/>
              <a:gd name="T79" fmla="*/ 6117 h 6117"/>
              <a:gd name="T80" fmla="*/ 1486 w 4198"/>
              <a:gd name="T81" fmla="*/ 6117 h 6117"/>
              <a:gd name="T82" fmla="*/ 1595 w 4198"/>
              <a:gd name="T83" fmla="*/ 6117 h 6117"/>
              <a:gd name="T84" fmla="*/ 1666 w 4198"/>
              <a:gd name="T85" fmla="*/ 6117 h 6117"/>
              <a:gd name="T86" fmla="*/ 1751 w 4198"/>
              <a:gd name="T87" fmla="*/ 6116 h 6117"/>
              <a:gd name="T88" fmla="*/ 1873 w 4198"/>
              <a:gd name="T89" fmla="*/ 6117 h 6117"/>
              <a:gd name="T90" fmla="*/ 1995 w 4198"/>
              <a:gd name="T91" fmla="*/ 6117 h 6117"/>
              <a:gd name="T92" fmla="*/ 2012 w 4198"/>
              <a:gd name="T93" fmla="*/ 6117 h 6117"/>
              <a:gd name="T94" fmla="*/ 2091 w 4198"/>
              <a:gd name="T95" fmla="*/ 6117 h 6117"/>
              <a:gd name="T96" fmla="*/ 2172 w 4198"/>
              <a:gd name="T97" fmla="*/ 6117 h 6117"/>
              <a:gd name="T98" fmla="*/ 2298 w 4198"/>
              <a:gd name="T99" fmla="*/ 6116 h 6117"/>
              <a:gd name="T100" fmla="*/ 2373 w 4198"/>
              <a:gd name="T101" fmla="*/ 6116 h 6117"/>
              <a:gd name="T102" fmla="*/ 2484 w 4198"/>
              <a:gd name="T103" fmla="*/ 6117 h 6117"/>
              <a:gd name="T104" fmla="*/ 2564 w 4198"/>
              <a:gd name="T105" fmla="*/ 6116 h 6117"/>
              <a:gd name="T106" fmla="*/ 2719 w 4198"/>
              <a:gd name="T107" fmla="*/ 6116 h 6117"/>
              <a:gd name="T108" fmla="*/ 2920 w 4198"/>
              <a:gd name="T109" fmla="*/ 6116 h 6117"/>
              <a:gd name="T110" fmla="*/ 3068 w 4198"/>
              <a:gd name="T111" fmla="*/ 6117 h 6117"/>
              <a:gd name="T112" fmla="*/ 3217 w 4198"/>
              <a:gd name="T113" fmla="*/ 6117 h 6117"/>
              <a:gd name="T114" fmla="*/ 3449 w 4198"/>
              <a:gd name="T115" fmla="*/ 6117 h 6117"/>
              <a:gd name="T116" fmla="*/ 3636 w 4198"/>
              <a:gd name="T117" fmla="*/ 6116 h 6117"/>
              <a:gd name="T118" fmla="*/ 3986 w 4198"/>
              <a:gd name="T119" fmla="*/ 6117 h 6117"/>
              <a:gd name="T120" fmla="*/ 4129 w 4198"/>
              <a:gd name="T121" fmla="*/ 6117 h 61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4198" h="6117">
                <a:moveTo>
                  <a:pt x="0" y="6117"/>
                </a:moveTo>
                <a:lnTo>
                  <a:pt x="0" y="6117"/>
                </a:lnTo>
                <a:lnTo>
                  <a:pt x="2" y="6117"/>
                </a:lnTo>
                <a:lnTo>
                  <a:pt x="2" y="6116"/>
                </a:lnTo>
                <a:lnTo>
                  <a:pt x="2" y="6117"/>
                </a:lnTo>
                <a:lnTo>
                  <a:pt x="3" y="6116"/>
                </a:lnTo>
                <a:lnTo>
                  <a:pt x="3" y="6117"/>
                </a:lnTo>
                <a:lnTo>
                  <a:pt x="4" y="6116"/>
                </a:lnTo>
                <a:lnTo>
                  <a:pt x="4" y="6117"/>
                </a:lnTo>
                <a:lnTo>
                  <a:pt x="6" y="6117"/>
                </a:lnTo>
                <a:lnTo>
                  <a:pt x="6" y="6116"/>
                </a:lnTo>
                <a:lnTo>
                  <a:pt x="6" y="6117"/>
                </a:lnTo>
                <a:lnTo>
                  <a:pt x="7" y="6116"/>
                </a:lnTo>
                <a:lnTo>
                  <a:pt x="7" y="6117"/>
                </a:lnTo>
                <a:lnTo>
                  <a:pt x="8" y="6116"/>
                </a:lnTo>
                <a:lnTo>
                  <a:pt x="8" y="6117"/>
                </a:lnTo>
                <a:lnTo>
                  <a:pt x="10" y="6117"/>
                </a:lnTo>
                <a:lnTo>
                  <a:pt x="10" y="6116"/>
                </a:lnTo>
                <a:lnTo>
                  <a:pt x="10" y="6117"/>
                </a:lnTo>
                <a:lnTo>
                  <a:pt x="11" y="6116"/>
                </a:lnTo>
                <a:lnTo>
                  <a:pt x="11" y="6117"/>
                </a:lnTo>
                <a:lnTo>
                  <a:pt x="12" y="6116"/>
                </a:lnTo>
                <a:lnTo>
                  <a:pt x="12" y="6117"/>
                </a:lnTo>
                <a:lnTo>
                  <a:pt x="13" y="6116"/>
                </a:lnTo>
                <a:lnTo>
                  <a:pt x="13" y="6117"/>
                </a:lnTo>
                <a:lnTo>
                  <a:pt x="14" y="6116"/>
                </a:lnTo>
                <a:lnTo>
                  <a:pt x="14" y="6117"/>
                </a:lnTo>
                <a:lnTo>
                  <a:pt x="15" y="6116"/>
                </a:lnTo>
                <a:lnTo>
                  <a:pt x="15" y="6117"/>
                </a:lnTo>
                <a:lnTo>
                  <a:pt x="19" y="6117"/>
                </a:lnTo>
                <a:lnTo>
                  <a:pt x="19" y="6116"/>
                </a:lnTo>
                <a:lnTo>
                  <a:pt x="19" y="6117"/>
                </a:lnTo>
                <a:lnTo>
                  <a:pt x="20" y="6116"/>
                </a:lnTo>
                <a:lnTo>
                  <a:pt x="20" y="6117"/>
                </a:lnTo>
                <a:lnTo>
                  <a:pt x="22" y="6117"/>
                </a:lnTo>
                <a:lnTo>
                  <a:pt x="22" y="6116"/>
                </a:lnTo>
                <a:lnTo>
                  <a:pt x="22" y="6117"/>
                </a:lnTo>
                <a:lnTo>
                  <a:pt x="24" y="6117"/>
                </a:lnTo>
                <a:lnTo>
                  <a:pt x="24" y="6116"/>
                </a:lnTo>
                <a:lnTo>
                  <a:pt x="24" y="6117"/>
                </a:lnTo>
                <a:lnTo>
                  <a:pt x="25" y="6111"/>
                </a:lnTo>
                <a:lnTo>
                  <a:pt x="25" y="6117"/>
                </a:lnTo>
                <a:lnTo>
                  <a:pt x="26" y="6116"/>
                </a:lnTo>
                <a:lnTo>
                  <a:pt x="26" y="6117"/>
                </a:lnTo>
                <a:lnTo>
                  <a:pt x="27" y="6116"/>
                </a:lnTo>
                <a:lnTo>
                  <a:pt x="27" y="6117"/>
                </a:lnTo>
                <a:lnTo>
                  <a:pt x="29" y="6117"/>
                </a:lnTo>
                <a:lnTo>
                  <a:pt x="29" y="6116"/>
                </a:lnTo>
                <a:lnTo>
                  <a:pt x="29" y="6117"/>
                </a:lnTo>
                <a:lnTo>
                  <a:pt x="30" y="6116"/>
                </a:lnTo>
                <a:lnTo>
                  <a:pt x="30" y="6117"/>
                </a:lnTo>
                <a:lnTo>
                  <a:pt x="32" y="6117"/>
                </a:lnTo>
                <a:lnTo>
                  <a:pt x="32" y="6116"/>
                </a:lnTo>
                <a:lnTo>
                  <a:pt x="32" y="6117"/>
                </a:lnTo>
                <a:lnTo>
                  <a:pt x="34" y="6117"/>
                </a:lnTo>
                <a:lnTo>
                  <a:pt x="34" y="6116"/>
                </a:lnTo>
                <a:lnTo>
                  <a:pt x="34" y="6117"/>
                </a:lnTo>
                <a:lnTo>
                  <a:pt x="35" y="6116"/>
                </a:lnTo>
                <a:lnTo>
                  <a:pt x="35" y="6117"/>
                </a:lnTo>
                <a:lnTo>
                  <a:pt x="36" y="6117"/>
                </a:lnTo>
                <a:lnTo>
                  <a:pt x="36" y="6117"/>
                </a:lnTo>
                <a:lnTo>
                  <a:pt x="39" y="6117"/>
                </a:lnTo>
                <a:lnTo>
                  <a:pt x="39" y="5992"/>
                </a:lnTo>
                <a:lnTo>
                  <a:pt x="39" y="6117"/>
                </a:lnTo>
                <a:lnTo>
                  <a:pt x="41" y="6117"/>
                </a:lnTo>
                <a:lnTo>
                  <a:pt x="41" y="6116"/>
                </a:lnTo>
                <a:lnTo>
                  <a:pt x="41" y="6117"/>
                </a:lnTo>
                <a:lnTo>
                  <a:pt x="42" y="6116"/>
                </a:lnTo>
                <a:lnTo>
                  <a:pt x="42" y="6117"/>
                </a:lnTo>
                <a:lnTo>
                  <a:pt x="43" y="6116"/>
                </a:lnTo>
                <a:lnTo>
                  <a:pt x="43" y="6117"/>
                </a:lnTo>
                <a:lnTo>
                  <a:pt x="44" y="6116"/>
                </a:lnTo>
                <a:lnTo>
                  <a:pt x="44" y="6117"/>
                </a:lnTo>
                <a:lnTo>
                  <a:pt x="45" y="6116"/>
                </a:lnTo>
                <a:lnTo>
                  <a:pt x="45" y="6117"/>
                </a:lnTo>
                <a:lnTo>
                  <a:pt x="47" y="6117"/>
                </a:lnTo>
                <a:lnTo>
                  <a:pt x="47" y="6116"/>
                </a:lnTo>
                <a:lnTo>
                  <a:pt x="47" y="6117"/>
                </a:lnTo>
                <a:lnTo>
                  <a:pt x="48" y="6116"/>
                </a:lnTo>
                <a:lnTo>
                  <a:pt x="48" y="6117"/>
                </a:lnTo>
                <a:lnTo>
                  <a:pt x="53" y="6117"/>
                </a:lnTo>
                <a:lnTo>
                  <a:pt x="53" y="6116"/>
                </a:lnTo>
                <a:lnTo>
                  <a:pt x="53" y="6117"/>
                </a:lnTo>
                <a:lnTo>
                  <a:pt x="54" y="6116"/>
                </a:lnTo>
                <a:lnTo>
                  <a:pt x="54" y="6117"/>
                </a:lnTo>
                <a:lnTo>
                  <a:pt x="56" y="6117"/>
                </a:lnTo>
                <a:lnTo>
                  <a:pt x="56" y="6116"/>
                </a:lnTo>
                <a:lnTo>
                  <a:pt x="56" y="6117"/>
                </a:lnTo>
                <a:lnTo>
                  <a:pt x="57" y="6116"/>
                </a:lnTo>
                <a:lnTo>
                  <a:pt x="57" y="6117"/>
                </a:lnTo>
                <a:lnTo>
                  <a:pt x="58" y="6116"/>
                </a:lnTo>
                <a:lnTo>
                  <a:pt x="58" y="6117"/>
                </a:lnTo>
                <a:lnTo>
                  <a:pt x="59" y="6116"/>
                </a:lnTo>
                <a:lnTo>
                  <a:pt x="59" y="6117"/>
                </a:lnTo>
                <a:lnTo>
                  <a:pt x="61" y="6117"/>
                </a:lnTo>
                <a:lnTo>
                  <a:pt x="61" y="6116"/>
                </a:lnTo>
                <a:lnTo>
                  <a:pt x="61" y="6117"/>
                </a:lnTo>
                <a:lnTo>
                  <a:pt x="62" y="6116"/>
                </a:lnTo>
                <a:lnTo>
                  <a:pt x="62" y="6117"/>
                </a:lnTo>
                <a:lnTo>
                  <a:pt x="63" y="6116"/>
                </a:lnTo>
                <a:lnTo>
                  <a:pt x="63" y="6117"/>
                </a:lnTo>
                <a:lnTo>
                  <a:pt x="69" y="6117"/>
                </a:lnTo>
                <a:lnTo>
                  <a:pt x="69" y="6116"/>
                </a:lnTo>
                <a:lnTo>
                  <a:pt x="69" y="6117"/>
                </a:lnTo>
                <a:lnTo>
                  <a:pt x="70" y="6116"/>
                </a:lnTo>
                <a:lnTo>
                  <a:pt x="70" y="6117"/>
                </a:lnTo>
                <a:lnTo>
                  <a:pt x="71" y="6116"/>
                </a:lnTo>
                <a:lnTo>
                  <a:pt x="71" y="6117"/>
                </a:lnTo>
                <a:lnTo>
                  <a:pt x="72" y="6116"/>
                </a:lnTo>
                <a:lnTo>
                  <a:pt x="72" y="6117"/>
                </a:lnTo>
                <a:lnTo>
                  <a:pt x="74" y="6117"/>
                </a:lnTo>
                <a:lnTo>
                  <a:pt x="74" y="6116"/>
                </a:lnTo>
                <a:lnTo>
                  <a:pt x="74" y="6117"/>
                </a:lnTo>
                <a:lnTo>
                  <a:pt x="75" y="6116"/>
                </a:lnTo>
                <a:lnTo>
                  <a:pt x="75" y="6117"/>
                </a:lnTo>
                <a:lnTo>
                  <a:pt x="77" y="6117"/>
                </a:lnTo>
                <a:lnTo>
                  <a:pt x="77" y="6116"/>
                </a:lnTo>
                <a:lnTo>
                  <a:pt x="77" y="6117"/>
                </a:lnTo>
                <a:lnTo>
                  <a:pt x="80" y="6117"/>
                </a:lnTo>
                <a:lnTo>
                  <a:pt x="80" y="6116"/>
                </a:lnTo>
                <a:lnTo>
                  <a:pt x="80" y="6117"/>
                </a:lnTo>
                <a:lnTo>
                  <a:pt x="83" y="6117"/>
                </a:lnTo>
                <a:lnTo>
                  <a:pt x="83" y="6115"/>
                </a:lnTo>
                <a:lnTo>
                  <a:pt x="83" y="6117"/>
                </a:lnTo>
                <a:lnTo>
                  <a:pt x="84" y="6116"/>
                </a:lnTo>
                <a:lnTo>
                  <a:pt x="84" y="6117"/>
                </a:lnTo>
                <a:lnTo>
                  <a:pt x="85" y="6116"/>
                </a:lnTo>
                <a:lnTo>
                  <a:pt x="85" y="6117"/>
                </a:lnTo>
                <a:lnTo>
                  <a:pt x="86" y="6116"/>
                </a:lnTo>
                <a:lnTo>
                  <a:pt x="86" y="6117"/>
                </a:lnTo>
                <a:lnTo>
                  <a:pt x="90" y="6117"/>
                </a:lnTo>
                <a:lnTo>
                  <a:pt x="90" y="6116"/>
                </a:lnTo>
                <a:lnTo>
                  <a:pt x="90" y="6117"/>
                </a:lnTo>
                <a:lnTo>
                  <a:pt x="92" y="6117"/>
                </a:lnTo>
                <a:lnTo>
                  <a:pt x="92" y="6116"/>
                </a:lnTo>
                <a:lnTo>
                  <a:pt x="92" y="6117"/>
                </a:lnTo>
                <a:lnTo>
                  <a:pt x="93" y="6116"/>
                </a:lnTo>
                <a:lnTo>
                  <a:pt x="93" y="6117"/>
                </a:lnTo>
                <a:lnTo>
                  <a:pt x="95" y="6117"/>
                </a:lnTo>
                <a:lnTo>
                  <a:pt x="95" y="6116"/>
                </a:lnTo>
                <a:lnTo>
                  <a:pt x="95" y="6117"/>
                </a:lnTo>
                <a:lnTo>
                  <a:pt x="96" y="6116"/>
                </a:lnTo>
                <a:lnTo>
                  <a:pt x="96" y="6117"/>
                </a:lnTo>
                <a:lnTo>
                  <a:pt x="98" y="6117"/>
                </a:lnTo>
                <a:lnTo>
                  <a:pt x="98" y="6116"/>
                </a:lnTo>
                <a:lnTo>
                  <a:pt x="98" y="6117"/>
                </a:lnTo>
                <a:lnTo>
                  <a:pt x="99" y="6116"/>
                </a:lnTo>
                <a:lnTo>
                  <a:pt x="99" y="6117"/>
                </a:lnTo>
                <a:lnTo>
                  <a:pt x="101" y="6117"/>
                </a:lnTo>
                <a:lnTo>
                  <a:pt x="101" y="6116"/>
                </a:lnTo>
                <a:lnTo>
                  <a:pt x="101" y="6117"/>
                </a:lnTo>
                <a:lnTo>
                  <a:pt x="102" y="6116"/>
                </a:lnTo>
                <a:lnTo>
                  <a:pt x="102" y="6117"/>
                </a:lnTo>
                <a:lnTo>
                  <a:pt x="104" y="6117"/>
                </a:lnTo>
                <a:lnTo>
                  <a:pt x="104" y="6116"/>
                </a:lnTo>
                <a:lnTo>
                  <a:pt x="104" y="6117"/>
                </a:lnTo>
                <a:lnTo>
                  <a:pt x="108" y="6117"/>
                </a:lnTo>
                <a:lnTo>
                  <a:pt x="108" y="6116"/>
                </a:lnTo>
                <a:lnTo>
                  <a:pt x="108" y="6117"/>
                </a:lnTo>
                <a:lnTo>
                  <a:pt x="113" y="6117"/>
                </a:lnTo>
                <a:lnTo>
                  <a:pt x="113" y="6116"/>
                </a:lnTo>
                <a:lnTo>
                  <a:pt x="113" y="6117"/>
                </a:lnTo>
                <a:lnTo>
                  <a:pt x="114" y="6116"/>
                </a:lnTo>
                <a:lnTo>
                  <a:pt x="114" y="6117"/>
                </a:lnTo>
                <a:lnTo>
                  <a:pt x="118" y="6117"/>
                </a:lnTo>
                <a:lnTo>
                  <a:pt x="118" y="6116"/>
                </a:lnTo>
                <a:lnTo>
                  <a:pt x="118" y="6117"/>
                </a:lnTo>
                <a:lnTo>
                  <a:pt x="119" y="6116"/>
                </a:lnTo>
                <a:lnTo>
                  <a:pt x="119" y="6117"/>
                </a:lnTo>
                <a:lnTo>
                  <a:pt x="121" y="6117"/>
                </a:lnTo>
                <a:lnTo>
                  <a:pt x="121" y="6116"/>
                </a:lnTo>
                <a:lnTo>
                  <a:pt x="121" y="6117"/>
                </a:lnTo>
                <a:lnTo>
                  <a:pt x="123" y="6117"/>
                </a:lnTo>
                <a:lnTo>
                  <a:pt x="123" y="6116"/>
                </a:lnTo>
                <a:lnTo>
                  <a:pt x="123" y="6117"/>
                </a:lnTo>
                <a:lnTo>
                  <a:pt x="124" y="6116"/>
                </a:lnTo>
                <a:lnTo>
                  <a:pt x="124" y="6117"/>
                </a:lnTo>
                <a:lnTo>
                  <a:pt x="126" y="6117"/>
                </a:lnTo>
                <a:lnTo>
                  <a:pt x="126" y="6116"/>
                </a:lnTo>
                <a:lnTo>
                  <a:pt x="126" y="6117"/>
                </a:lnTo>
                <a:lnTo>
                  <a:pt x="127" y="6116"/>
                </a:lnTo>
                <a:lnTo>
                  <a:pt x="127" y="6117"/>
                </a:lnTo>
                <a:lnTo>
                  <a:pt x="128" y="6116"/>
                </a:lnTo>
                <a:lnTo>
                  <a:pt x="128" y="6117"/>
                </a:lnTo>
                <a:lnTo>
                  <a:pt x="131" y="6117"/>
                </a:lnTo>
                <a:lnTo>
                  <a:pt x="131" y="6116"/>
                </a:lnTo>
                <a:lnTo>
                  <a:pt x="131" y="6117"/>
                </a:lnTo>
                <a:lnTo>
                  <a:pt x="132" y="6116"/>
                </a:lnTo>
                <a:lnTo>
                  <a:pt x="132" y="6117"/>
                </a:lnTo>
                <a:lnTo>
                  <a:pt x="134" y="6117"/>
                </a:lnTo>
                <a:lnTo>
                  <a:pt x="134" y="6116"/>
                </a:lnTo>
                <a:lnTo>
                  <a:pt x="134" y="6117"/>
                </a:lnTo>
                <a:lnTo>
                  <a:pt x="135" y="6116"/>
                </a:lnTo>
                <a:lnTo>
                  <a:pt x="135" y="6117"/>
                </a:lnTo>
                <a:lnTo>
                  <a:pt x="139" y="6117"/>
                </a:lnTo>
                <a:lnTo>
                  <a:pt x="139" y="6116"/>
                </a:lnTo>
                <a:lnTo>
                  <a:pt x="139" y="6117"/>
                </a:lnTo>
                <a:lnTo>
                  <a:pt x="141" y="6117"/>
                </a:lnTo>
                <a:lnTo>
                  <a:pt x="141" y="6116"/>
                </a:lnTo>
                <a:lnTo>
                  <a:pt x="141" y="6117"/>
                </a:lnTo>
                <a:lnTo>
                  <a:pt x="142" y="6116"/>
                </a:lnTo>
                <a:lnTo>
                  <a:pt x="142" y="6117"/>
                </a:lnTo>
                <a:lnTo>
                  <a:pt x="143" y="6116"/>
                </a:lnTo>
                <a:lnTo>
                  <a:pt x="143" y="6117"/>
                </a:lnTo>
                <a:lnTo>
                  <a:pt x="144" y="6116"/>
                </a:lnTo>
                <a:lnTo>
                  <a:pt x="144" y="6117"/>
                </a:lnTo>
                <a:lnTo>
                  <a:pt x="149" y="6117"/>
                </a:lnTo>
                <a:lnTo>
                  <a:pt x="149" y="6116"/>
                </a:lnTo>
                <a:lnTo>
                  <a:pt x="149" y="6117"/>
                </a:lnTo>
                <a:lnTo>
                  <a:pt x="150" y="6116"/>
                </a:lnTo>
                <a:lnTo>
                  <a:pt x="150" y="6117"/>
                </a:lnTo>
                <a:lnTo>
                  <a:pt x="151" y="6116"/>
                </a:lnTo>
                <a:lnTo>
                  <a:pt x="151" y="6117"/>
                </a:lnTo>
                <a:lnTo>
                  <a:pt x="152" y="6116"/>
                </a:lnTo>
                <a:lnTo>
                  <a:pt x="152" y="6117"/>
                </a:lnTo>
                <a:lnTo>
                  <a:pt x="153" y="6116"/>
                </a:lnTo>
                <a:lnTo>
                  <a:pt x="153" y="6117"/>
                </a:lnTo>
                <a:lnTo>
                  <a:pt x="156" y="6117"/>
                </a:lnTo>
                <a:lnTo>
                  <a:pt x="156" y="6116"/>
                </a:lnTo>
                <a:lnTo>
                  <a:pt x="156" y="6117"/>
                </a:lnTo>
                <a:lnTo>
                  <a:pt x="157" y="6116"/>
                </a:lnTo>
                <a:lnTo>
                  <a:pt x="157" y="6117"/>
                </a:lnTo>
                <a:lnTo>
                  <a:pt x="159" y="6117"/>
                </a:lnTo>
                <a:lnTo>
                  <a:pt x="159" y="6116"/>
                </a:lnTo>
                <a:lnTo>
                  <a:pt x="159" y="6117"/>
                </a:lnTo>
                <a:lnTo>
                  <a:pt x="161" y="6117"/>
                </a:lnTo>
                <a:lnTo>
                  <a:pt x="161" y="6116"/>
                </a:lnTo>
                <a:lnTo>
                  <a:pt x="161" y="6117"/>
                </a:lnTo>
                <a:lnTo>
                  <a:pt x="162" y="6116"/>
                </a:lnTo>
                <a:lnTo>
                  <a:pt x="162" y="6117"/>
                </a:lnTo>
                <a:lnTo>
                  <a:pt x="163" y="6116"/>
                </a:lnTo>
                <a:lnTo>
                  <a:pt x="163" y="6117"/>
                </a:lnTo>
                <a:lnTo>
                  <a:pt x="164" y="6116"/>
                </a:lnTo>
                <a:lnTo>
                  <a:pt x="164" y="6117"/>
                </a:lnTo>
                <a:lnTo>
                  <a:pt x="165" y="6116"/>
                </a:lnTo>
                <a:lnTo>
                  <a:pt x="165" y="6117"/>
                </a:lnTo>
                <a:lnTo>
                  <a:pt x="166" y="6116"/>
                </a:lnTo>
                <a:lnTo>
                  <a:pt x="166" y="6117"/>
                </a:lnTo>
                <a:lnTo>
                  <a:pt x="168" y="6117"/>
                </a:lnTo>
                <a:lnTo>
                  <a:pt x="168" y="6116"/>
                </a:lnTo>
                <a:lnTo>
                  <a:pt x="168" y="6117"/>
                </a:lnTo>
                <a:lnTo>
                  <a:pt x="172" y="6117"/>
                </a:lnTo>
                <a:lnTo>
                  <a:pt x="172" y="6116"/>
                </a:lnTo>
                <a:lnTo>
                  <a:pt x="172" y="6117"/>
                </a:lnTo>
                <a:lnTo>
                  <a:pt x="174" y="6117"/>
                </a:lnTo>
                <a:lnTo>
                  <a:pt x="174" y="6116"/>
                </a:lnTo>
                <a:lnTo>
                  <a:pt x="174" y="6117"/>
                </a:lnTo>
                <a:lnTo>
                  <a:pt x="175" y="6116"/>
                </a:lnTo>
                <a:lnTo>
                  <a:pt x="175" y="6117"/>
                </a:lnTo>
                <a:lnTo>
                  <a:pt x="182" y="6117"/>
                </a:lnTo>
                <a:lnTo>
                  <a:pt x="182" y="6116"/>
                </a:lnTo>
                <a:lnTo>
                  <a:pt x="182" y="6117"/>
                </a:lnTo>
                <a:lnTo>
                  <a:pt x="183" y="6116"/>
                </a:lnTo>
                <a:lnTo>
                  <a:pt x="183" y="6117"/>
                </a:lnTo>
                <a:lnTo>
                  <a:pt x="184" y="6116"/>
                </a:lnTo>
                <a:lnTo>
                  <a:pt x="184" y="6117"/>
                </a:lnTo>
                <a:lnTo>
                  <a:pt x="185" y="6116"/>
                </a:lnTo>
                <a:lnTo>
                  <a:pt x="185" y="6117"/>
                </a:lnTo>
                <a:lnTo>
                  <a:pt x="187" y="6117"/>
                </a:lnTo>
                <a:lnTo>
                  <a:pt x="187" y="6116"/>
                </a:lnTo>
                <a:lnTo>
                  <a:pt x="187" y="6117"/>
                </a:lnTo>
                <a:lnTo>
                  <a:pt x="191" y="6117"/>
                </a:lnTo>
                <a:lnTo>
                  <a:pt x="191" y="6116"/>
                </a:lnTo>
                <a:lnTo>
                  <a:pt x="191" y="6117"/>
                </a:lnTo>
                <a:lnTo>
                  <a:pt x="192" y="6116"/>
                </a:lnTo>
                <a:lnTo>
                  <a:pt x="192" y="6117"/>
                </a:lnTo>
                <a:lnTo>
                  <a:pt x="194" y="6117"/>
                </a:lnTo>
                <a:lnTo>
                  <a:pt x="194" y="6116"/>
                </a:lnTo>
                <a:lnTo>
                  <a:pt x="194" y="6117"/>
                </a:lnTo>
                <a:lnTo>
                  <a:pt x="198" y="6117"/>
                </a:lnTo>
                <a:lnTo>
                  <a:pt x="198" y="6116"/>
                </a:lnTo>
                <a:lnTo>
                  <a:pt x="198" y="6117"/>
                </a:lnTo>
                <a:lnTo>
                  <a:pt x="201" y="6117"/>
                </a:lnTo>
                <a:lnTo>
                  <a:pt x="201" y="6116"/>
                </a:lnTo>
                <a:lnTo>
                  <a:pt x="201" y="6117"/>
                </a:lnTo>
                <a:lnTo>
                  <a:pt x="202" y="6116"/>
                </a:lnTo>
                <a:lnTo>
                  <a:pt x="202" y="6117"/>
                </a:lnTo>
                <a:lnTo>
                  <a:pt x="207" y="6117"/>
                </a:lnTo>
                <a:lnTo>
                  <a:pt x="207" y="6116"/>
                </a:lnTo>
                <a:lnTo>
                  <a:pt x="207" y="6117"/>
                </a:lnTo>
                <a:lnTo>
                  <a:pt x="209" y="6117"/>
                </a:lnTo>
                <a:lnTo>
                  <a:pt x="209" y="6116"/>
                </a:lnTo>
                <a:lnTo>
                  <a:pt x="209" y="6117"/>
                </a:lnTo>
                <a:lnTo>
                  <a:pt x="210" y="6116"/>
                </a:lnTo>
                <a:lnTo>
                  <a:pt x="210" y="6117"/>
                </a:lnTo>
                <a:lnTo>
                  <a:pt x="212" y="6117"/>
                </a:lnTo>
                <a:lnTo>
                  <a:pt x="212" y="6116"/>
                </a:lnTo>
                <a:lnTo>
                  <a:pt x="212" y="6117"/>
                </a:lnTo>
                <a:lnTo>
                  <a:pt x="216" y="6117"/>
                </a:lnTo>
                <a:lnTo>
                  <a:pt x="216" y="6116"/>
                </a:lnTo>
                <a:lnTo>
                  <a:pt x="216" y="6117"/>
                </a:lnTo>
                <a:lnTo>
                  <a:pt x="218" y="6117"/>
                </a:lnTo>
                <a:lnTo>
                  <a:pt x="218" y="6116"/>
                </a:lnTo>
                <a:lnTo>
                  <a:pt x="218" y="6117"/>
                </a:lnTo>
                <a:lnTo>
                  <a:pt x="219" y="6116"/>
                </a:lnTo>
                <a:lnTo>
                  <a:pt x="219" y="6117"/>
                </a:lnTo>
                <a:lnTo>
                  <a:pt x="220" y="6116"/>
                </a:lnTo>
                <a:lnTo>
                  <a:pt x="220" y="6117"/>
                </a:lnTo>
                <a:lnTo>
                  <a:pt x="227" y="6117"/>
                </a:lnTo>
                <a:lnTo>
                  <a:pt x="227" y="6116"/>
                </a:lnTo>
                <a:lnTo>
                  <a:pt x="227" y="6117"/>
                </a:lnTo>
                <a:lnTo>
                  <a:pt x="228" y="6116"/>
                </a:lnTo>
                <a:lnTo>
                  <a:pt x="228" y="6117"/>
                </a:lnTo>
                <a:lnTo>
                  <a:pt x="229" y="6116"/>
                </a:lnTo>
                <a:lnTo>
                  <a:pt x="229" y="6117"/>
                </a:lnTo>
                <a:lnTo>
                  <a:pt x="234" y="6117"/>
                </a:lnTo>
                <a:lnTo>
                  <a:pt x="234" y="6116"/>
                </a:lnTo>
                <a:lnTo>
                  <a:pt x="234" y="6117"/>
                </a:lnTo>
                <a:lnTo>
                  <a:pt x="237" y="6117"/>
                </a:lnTo>
                <a:lnTo>
                  <a:pt x="237" y="6116"/>
                </a:lnTo>
                <a:lnTo>
                  <a:pt x="237" y="6117"/>
                </a:lnTo>
                <a:lnTo>
                  <a:pt x="238" y="6116"/>
                </a:lnTo>
                <a:lnTo>
                  <a:pt x="238" y="6117"/>
                </a:lnTo>
                <a:lnTo>
                  <a:pt x="239" y="6116"/>
                </a:lnTo>
                <a:lnTo>
                  <a:pt x="239" y="6117"/>
                </a:lnTo>
                <a:lnTo>
                  <a:pt x="241" y="6117"/>
                </a:lnTo>
                <a:lnTo>
                  <a:pt x="241" y="6116"/>
                </a:lnTo>
                <a:lnTo>
                  <a:pt x="241" y="6117"/>
                </a:lnTo>
                <a:lnTo>
                  <a:pt x="242" y="6116"/>
                </a:lnTo>
                <a:lnTo>
                  <a:pt x="242" y="6117"/>
                </a:lnTo>
                <a:lnTo>
                  <a:pt x="243" y="6116"/>
                </a:lnTo>
                <a:lnTo>
                  <a:pt x="243" y="6117"/>
                </a:lnTo>
                <a:lnTo>
                  <a:pt x="246" y="6117"/>
                </a:lnTo>
                <a:lnTo>
                  <a:pt x="246" y="6116"/>
                </a:lnTo>
                <a:lnTo>
                  <a:pt x="246" y="6117"/>
                </a:lnTo>
                <a:lnTo>
                  <a:pt x="250" y="6117"/>
                </a:lnTo>
                <a:lnTo>
                  <a:pt x="250" y="6116"/>
                </a:lnTo>
                <a:lnTo>
                  <a:pt x="250" y="6117"/>
                </a:lnTo>
                <a:lnTo>
                  <a:pt x="253" y="6117"/>
                </a:lnTo>
                <a:lnTo>
                  <a:pt x="253" y="6116"/>
                </a:lnTo>
                <a:lnTo>
                  <a:pt x="253" y="6117"/>
                </a:lnTo>
                <a:lnTo>
                  <a:pt x="258" y="6117"/>
                </a:lnTo>
                <a:lnTo>
                  <a:pt x="258" y="6116"/>
                </a:lnTo>
                <a:lnTo>
                  <a:pt x="258" y="6117"/>
                </a:lnTo>
                <a:lnTo>
                  <a:pt x="260" y="6117"/>
                </a:lnTo>
                <a:lnTo>
                  <a:pt x="260" y="6116"/>
                </a:lnTo>
                <a:lnTo>
                  <a:pt x="260" y="6117"/>
                </a:lnTo>
                <a:lnTo>
                  <a:pt x="261" y="6116"/>
                </a:lnTo>
                <a:lnTo>
                  <a:pt x="261" y="6117"/>
                </a:lnTo>
                <a:lnTo>
                  <a:pt x="268" y="6117"/>
                </a:lnTo>
                <a:lnTo>
                  <a:pt x="268" y="6116"/>
                </a:lnTo>
                <a:lnTo>
                  <a:pt x="268" y="6117"/>
                </a:lnTo>
                <a:lnTo>
                  <a:pt x="270" y="6117"/>
                </a:lnTo>
                <a:lnTo>
                  <a:pt x="270" y="6116"/>
                </a:lnTo>
                <a:lnTo>
                  <a:pt x="270" y="6117"/>
                </a:lnTo>
                <a:lnTo>
                  <a:pt x="271" y="6116"/>
                </a:lnTo>
                <a:lnTo>
                  <a:pt x="271" y="6117"/>
                </a:lnTo>
                <a:lnTo>
                  <a:pt x="278" y="6117"/>
                </a:lnTo>
                <a:lnTo>
                  <a:pt x="278" y="6115"/>
                </a:lnTo>
                <a:lnTo>
                  <a:pt x="278" y="6117"/>
                </a:lnTo>
                <a:lnTo>
                  <a:pt x="279" y="6116"/>
                </a:lnTo>
                <a:lnTo>
                  <a:pt x="279" y="6117"/>
                </a:lnTo>
                <a:lnTo>
                  <a:pt x="280" y="6116"/>
                </a:lnTo>
                <a:lnTo>
                  <a:pt x="280" y="6117"/>
                </a:lnTo>
                <a:lnTo>
                  <a:pt x="281" y="6116"/>
                </a:lnTo>
                <a:lnTo>
                  <a:pt x="281" y="6117"/>
                </a:lnTo>
                <a:lnTo>
                  <a:pt x="285" y="6117"/>
                </a:lnTo>
                <a:lnTo>
                  <a:pt x="285" y="6116"/>
                </a:lnTo>
                <a:lnTo>
                  <a:pt x="285" y="6117"/>
                </a:lnTo>
                <a:lnTo>
                  <a:pt x="287" y="6117"/>
                </a:lnTo>
                <a:lnTo>
                  <a:pt x="287" y="6115"/>
                </a:lnTo>
                <a:lnTo>
                  <a:pt x="287" y="6117"/>
                </a:lnTo>
                <a:lnTo>
                  <a:pt x="290" y="6117"/>
                </a:lnTo>
                <a:lnTo>
                  <a:pt x="290" y="6116"/>
                </a:lnTo>
                <a:lnTo>
                  <a:pt x="290" y="6117"/>
                </a:lnTo>
                <a:lnTo>
                  <a:pt x="294" y="6117"/>
                </a:lnTo>
                <a:lnTo>
                  <a:pt x="294" y="6116"/>
                </a:lnTo>
                <a:lnTo>
                  <a:pt x="294" y="6117"/>
                </a:lnTo>
                <a:lnTo>
                  <a:pt x="300" y="6117"/>
                </a:lnTo>
                <a:lnTo>
                  <a:pt x="300" y="6116"/>
                </a:lnTo>
                <a:lnTo>
                  <a:pt x="300" y="6117"/>
                </a:lnTo>
                <a:lnTo>
                  <a:pt x="302" y="6117"/>
                </a:lnTo>
                <a:lnTo>
                  <a:pt x="302" y="6116"/>
                </a:lnTo>
                <a:lnTo>
                  <a:pt x="302" y="6117"/>
                </a:lnTo>
                <a:lnTo>
                  <a:pt x="305" y="6117"/>
                </a:lnTo>
                <a:lnTo>
                  <a:pt x="305" y="6053"/>
                </a:lnTo>
                <a:lnTo>
                  <a:pt x="305" y="6117"/>
                </a:lnTo>
                <a:lnTo>
                  <a:pt x="307" y="6117"/>
                </a:lnTo>
                <a:lnTo>
                  <a:pt x="307" y="6116"/>
                </a:lnTo>
                <a:lnTo>
                  <a:pt x="307" y="6117"/>
                </a:lnTo>
                <a:lnTo>
                  <a:pt x="309" y="6117"/>
                </a:lnTo>
                <a:lnTo>
                  <a:pt x="309" y="6115"/>
                </a:lnTo>
                <a:lnTo>
                  <a:pt x="309" y="6117"/>
                </a:lnTo>
                <a:lnTo>
                  <a:pt x="313" y="6117"/>
                </a:lnTo>
                <a:lnTo>
                  <a:pt x="313" y="6096"/>
                </a:lnTo>
                <a:lnTo>
                  <a:pt x="313" y="6117"/>
                </a:lnTo>
                <a:lnTo>
                  <a:pt x="317" y="6117"/>
                </a:lnTo>
                <a:lnTo>
                  <a:pt x="317" y="6116"/>
                </a:lnTo>
                <a:lnTo>
                  <a:pt x="317" y="6117"/>
                </a:lnTo>
                <a:lnTo>
                  <a:pt x="319" y="6117"/>
                </a:lnTo>
                <a:lnTo>
                  <a:pt x="319" y="6116"/>
                </a:lnTo>
                <a:lnTo>
                  <a:pt x="319" y="6117"/>
                </a:lnTo>
                <a:lnTo>
                  <a:pt x="321" y="6117"/>
                </a:lnTo>
                <a:lnTo>
                  <a:pt x="321" y="6116"/>
                </a:lnTo>
                <a:lnTo>
                  <a:pt x="321" y="6117"/>
                </a:lnTo>
                <a:lnTo>
                  <a:pt x="324" y="6117"/>
                </a:lnTo>
                <a:lnTo>
                  <a:pt x="324" y="6116"/>
                </a:lnTo>
                <a:lnTo>
                  <a:pt x="324" y="6117"/>
                </a:lnTo>
                <a:lnTo>
                  <a:pt x="325" y="6116"/>
                </a:lnTo>
                <a:lnTo>
                  <a:pt x="325" y="6117"/>
                </a:lnTo>
                <a:lnTo>
                  <a:pt x="326" y="6116"/>
                </a:lnTo>
                <a:lnTo>
                  <a:pt x="326" y="6117"/>
                </a:lnTo>
                <a:lnTo>
                  <a:pt x="329" y="6117"/>
                </a:lnTo>
                <a:lnTo>
                  <a:pt x="329" y="6116"/>
                </a:lnTo>
                <a:lnTo>
                  <a:pt x="329" y="6117"/>
                </a:lnTo>
                <a:lnTo>
                  <a:pt x="331" y="6117"/>
                </a:lnTo>
                <a:lnTo>
                  <a:pt x="331" y="6116"/>
                </a:lnTo>
                <a:lnTo>
                  <a:pt x="331" y="6117"/>
                </a:lnTo>
                <a:lnTo>
                  <a:pt x="332" y="6116"/>
                </a:lnTo>
                <a:lnTo>
                  <a:pt x="332" y="6117"/>
                </a:lnTo>
                <a:lnTo>
                  <a:pt x="333" y="6117"/>
                </a:lnTo>
                <a:lnTo>
                  <a:pt x="333" y="6109"/>
                </a:lnTo>
                <a:lnTo>
                  <a:pt x="334" y="6109"/>
                </a:lnTo>
                <a:lnTo>
                  <a:pt x="334" y="6117"/>
                </a:lnTo>
                <a:lnTo>
                  <a:pt x="335" y="6116"/>
                </a:lnTo>
                <a:lnTo>
                  <a:pt x="335" y="6117"/>
                </a:lnTo>
                <a:lnTo>
                  <a:pt x="336" y="6116"/>
                </a:lnTo>
                <a:lnTo>
                  <a:pt x="336" y="6117"/>
                </a:lnTo>
                <a:lnTo>
                  <a:pt x="340" y="6117"/>
                </a:lnTo>
                <a:lnTo>
                  <a:pt x="340" y="6098"/>
                </a:lnTo>
                <a:lnTo>
                  <a:pt x="340" y="6117"/>
                </a:lnTo>
                <a:lnTo>
                  <a:pt x="341" y="6116"/>
                </a:lnTo>
                <a:lnTo>
                  <a:pt x="341" y="6117"/>
                </a:lnTo>
                <a:lnTo>
                  <a:pt x="347" y="6117"/>
                </a:lnTo>
                <a:lnTo>
                  <a:pt x="347" y="6116"/>
                </a:lnTo>
                <a:lnTo>
                  <a:pt x="347" y="6117"/>
                </a:lnTo>
                <a:lnTo>
                  <a:pt x="349" y="6117"/>
                </a:lnTo>
                <a:lnTo>
                  <a:pt x="349" y="6116"/>
                </a:lnTo>
                <a:lnTo>
                  <a:pt x="349" y="6117"/>
                </a:lnTo>
                <a:lnTo>
                  <a:pt x="353" y="6117"/>
                </a:lnTo>
                <a:lnTo>
                  <a:pt x="353" y="6116"/>
                </a:lnTo>
                <a:lnTo>
                  <a:pt x="353" y="6117"/>
                </a:lnTo>
                <a:lnTo>
                  <a:pt x="357" y="6117"/>
                </a:lnTo>
                <a:lnTo>
                  <a:pt x="357" y="6116"/>
                </a:lnTo>
                <a:lnTo>
                  <a:pt x="357" y="6117"/>
                </a:lnTo>
                <a:lnTo>
                  <a:pt x="358" y="6115"/>
                </a:lnTo>
                <a:lnTo>
                  <a:pt x="358" y="6117"/>
                </a:lnTo>
                <a:lnTo>
                  <a:pt x="359" y="6116"/>
                </a:lnTo>
                <a:lnTo>
                  <a:pt x="359" y="6117"/>
                </a:lnTo>
                <a:lnTo>
                  <a:pt x="361" y="6117"/>
                </a:lnTo>
                <a:lnTo>
                  <a:pt x="361" y="6116"/>
                </a:lnTo>
                <a:lnTo>
                  <a:pt x="361" y="6117"/>
                </a:lnTo>
                <a:lnTo>
                  <a:pt x="367" y="6117"/>
                </a:lnTo>
                <a:lnTo>
                  <a:pt x="367" y="6116"/>
                </a:lnTo>
                <a:lnTo>
                  <a:pt x="367" y="6117"/>
                </a:lnTo>
                <a:lnTo>
                  <a:pt x="368" y="6116"/>
                </a:lnTo>
                <a:lnTo>
                  <a:pt x="368" y="6117"/>
                </a:lnTo>
                <a:lnTo>
                  <a:pt x="375" y="6117"/>
                </a:lnTo>
                <a:lnTo>
                  <a:pt x="375" y="6116"/>
                </a:lnTo>
                <a:lnTo>
                  <a:pt x="375" y="6117"/>
                </a:lnTo>
                <a:lnTo>
                  <a:pt x="377" y="6117"/>
                </a:lnTo>
                <a:lnTo>
                  <a:pt x="377" y="6116"/>
                </a:lnTo>
                <a:lnTo>
                  <a:pt x="377" y="6117"/>
                </a:lnTo>
                <a:lnTo>
                  <a:pt x="381" y="6117"/>
                </a:lnTo>
                <a:lnTo>
                  <a:pt x="381" y="6116"/>
                </a:lnTo>
                <a:lnTo>
                  <a:pt x="381" y="6117"/>
                </a:lnTo>
                <a:lnTo>
                  <a:pt x="388" y="6117"/>
                </a:lnTo>
                <a:lnTo>
                  <a:pt x="388" y="6116"/>
                </a:lnTo>
                <a:lnTo>
                  <a:pt x="388" y="6117"/>
                </a:lnTo>
                <a:lnTo>
                  <a:pt x="390" y="6117"/>
                </a:lnTo>
                <a:lnTo>
                  <a:pt x="390" y="6116"/>
                </a:lnTo>
                <a:lnTo>
                  <a:pt x="390" y="6117"/>
                </a:lnTo>
                <a:lnTo>
                  <a:pt x="391" y="6116"/>
                </a:lnTo>
                <a:lnTo>
                  <a:pt x="391" y="6117"/>
                </a:lnTo>
                <a:lnTo>
                  <a:pt x="396" y="6117"/>
                </a:lnTo>
                <a:lnTo>
                  <a:pt x="396" y="6116"/>
                </a:lnTo>
                <a:lnTo>
                  <a:pt x="396" y="6117"/>
                </a:lnTo>
                <a:lnTo>
                  <a:pt x="400" y="6117"/>
                </a:lnTo>
                <a:lnTo>
                  <a:pt x="400" y="6116"/>
                </a:lnTo>
                <a:lnTo>
                  <a:pt x="400" y="6117"/>
                </a:lnTo>
                <a:lnTo>
                  <a:pt x="401" y="6116"/>
                </a:lnTo>
                <a:lnTo>
                  <a:pt x="401" y="6117"/>
                </a:lnTo>
                <a:lnTo>
                  <a:pt x="402" y="5785"/>
                </a:lnTo>
                <a:lnTo>
                  <a:pt x="402" y="6117"/>
                </a:lnTo>
                <a:lnTo>
                  <a:pt x="403" y="6116"/>
                </a:lnTo>
                <a:lnTo>
                  <a:pt x="403" y="6117"/>
                </a:lnTo>
                <a:lnTo>
                  <a:pt x="406" y="6117"/>
                </a:lnTo>
                <a:lnTo>
                  <a:pt x="406" y="6109"/>
                </a:lnTo>
                <a:lnTo>
                  <a:pt x="406" y="6117"/>
                </a:lnTo>
                <a:lnTo>
                  <a:pt x="407" y="6116"/>
                </a:lnTo>
                <a:lnTo>
                  <a:pt x="407" y="6117"/>
                </a:lnTo>
                <a:lnTo>
                  <a:pt x="411" y="6117"/>
                </a:lnTo>
                <a:lnTo>
                  <a:pt x="411" y="6114"/>
                </a:lnTo>
                <a:lnTo>
                  <a:pt x="411" y="6117"/>
                </a:lnTo>
                <a:lnTo>
                  <a:pt x="419" y="6117"/>
                </a:lnTo>
                <a:lnTo>
                  <a:pt x="419" y="6116"/>
                </a:lnTo>
                <a:lnTo>
                  <a:pt x="419" y="6117"/>
                </a:lnTo>
                <a:lnTo>
                  <a:pt x="420" y="6116"/>
                </a:lnTo>
                <a:lnTo>
                  <a:pt x="420" y="6117"/>
                </a:lnTo>
                <a:lnTo>
                  <a:pt x="422" y="6117"/>
                </a:lnTo>
                <a:lnTo>
                  <a:pt x="422" y="6116"/>
                </a:lnTo>
                <a:lnTo>
                  <a:pt x="422" y="6117"/>
                </a:lnTo>
                <a:lnTo>
                  <a:pt x="425" y="6117"/>
                </a:lnTo>
                <a:lnTo>
                  <a:pt x="425" y="6116"/>
                </a:lnTo>
                <a:lnTo>
                  <a:pt x="425" y="6117"/>
                </a:lnTo>
                <a:lnTo>
                  <a:pt x="428" y="6117"/>
                </a:lnTo>
                <a:lnTo>
                  <a:pt x="428" y="6116"/>
                </a:lnTo>
                <a:lnTo>
                  <a:pt x="428" y="6117"/>
                </a:lnTo>
                <a:lnTo>
                  <a:pt x="429" y="6116"/>
                </a:lnTo>
                <a:lnTo>
                  <a:pt x="429" y="6117"/>
                </a:lnTo>
                <a:lnTo>
                  <a:pt x="439" y="6117"/>
                </a:lnTo>
                <a:lnTo>
                  <a:pt x="439" y="6116"/>
                </a:lnTo>
                <a:lnTo>
                  <a:pt x="439" y="6117"/>
                </a:lnTo>
                <a:lnTo>
                  <a:pt x="442" y="6117"/>
                </a:lnTo>
                <a:lnTo>
                  <a:pt x="442" y="6116"/>
                </a:lnTo>
                <a:lnTo>
                  <a:pt x="442" y="6117"/>
                </a:lnTo>
                <a:lnTo>
                  <a:pt x="444" y="6117"/>
                </a:lnTo>
                <a:lnTo>
                  <a:pt x="444" y="6116"/>
                </a:lnTo>
                <a:lnTo>
                  <a:pt x="444" y="6117"/>
                </a:lnTo>
                <a:lnTo>
                  <a:pt x="445" y="6116"/>
                </a:lnTo>
                <a:lnTo>
                  <a:pt x="445" y="6117"/>
                </a:lnTo>
                <a:lnTo>
                  <a:pt x="446" y="6116"/>
                </a:lnTo>
                <a:lnTo>
                  <a:pt x="446" y="6117"/>
                </a:lnTo>
                <a:lnTo>
                  <a:pt x="451" y="6117"/>
                </a:lnTo>
                <a:lnTo>
                  <a:pt x="451" y="6116"/>
                </a:lnTo>
                <a:lnTo>
                  <a:pt x="451" y="6117"/>
                </a:lnTo>
                <a:lnTo>
                  <a:pt x="454" y="6117"/>
                </a:lnTo>
                <a:lnTo>
                  <a:pt x="454" y="6116"/>
                </a:lnTo>
                <a:lnTo>
                  <a:pt x="454" y="6117"/>
                </a:lnTo>
                <a:lnTo>
                  <a:pt x="456" y="6117"/>
                </a:lnTo>
                <a:lnTo>
                  <a:pt x="456" y="6116"/>
                </a:lnTo>
                <a:lnTo>
                  <a:pt x="456" y="6117"/>
                </a:lnTo>
                <a:lnTo>
                  <a:pt x="458" y="6117"/>
                </a:lnTo>
                <a:lnTo>
                  <a:pt x="458" y="6116"/>
                </a:lnTo>
                <a:lnTo>
                  <a:pt x="458" y="6117"/>
                </a:lnTo>
                <a:lnTo>
                  <a:pt x="462" y="6117"/>
                </a:lnTo>
                <a:lnTo>
                  <a:pt x="462" y="6116"/>
                </a:lnTo>
                <a:lnTo>
                  <a:pt x="462" y="6117"/>
                </a:lnTo>
                <a:lnTo>
                  <a:pt x="463" y="6117"/>
                </a:lnTo>
                <a:lnTo>
                  <a:pt x="463" y="6117"/>
                </a:lnTo>
                <a:lnTo>
                  <a:pt x="464" y="6095"/>
                </a:lnTo>
                <a:lnTo>
                  <a:pt x="464" y="6117"/>
                </a:lnTo>
                <a:lnTo>
                  <a:pt x="468" y="6117"/>
                </a:lnTo>
                <a:lnTo>
                  <a:pt x="468" y="6057"/>
                </a:lnTo>
                <a:lnTo>
                  <a:pt x="468" y="6117"/>
                </a:lnTo>
                <a:lnTo>
                  <a:pt x="472" y="6117"/>
                </a:lnTo>
                <a:lnTo>
                  <a:pt x="472" y="6115"/>
                </a:lnTo>
                <a:lnTo>
                  <a:pt x="472" y="6117"/>
                </a:lnTo>
                <a:lnTo>
                  <a:pt x="473" y="6115"/>
                </a:lnTo>
                <a:lnTo>
                  <a:pt x="473" y="6117"/>
                </a:lnTo>
                <a:lnTo>
                  <a:pt x="475" y="6117"/>
                </a:lnTo>
                <a:lnTo>
                  <a:pt x="475" y="6116"/>
                </a:lnTo>
                <a:lnTo>
                  <a:pt x="475" y="6117"/>
                </a:lnTo>
                <a:lnTo>
                  <a:pt x="477" y="6117"/>
                </a:lnTo>
                <a:lnTo>
                  <a:pt x="477" y="6116"/>
                </a:lnTo>
                <a:lnTo>
                  <a:pt x="477" y="6117"/>
                </a:lnTo>
                <a:lnTo>
                  <a:pt x="479" y="6117"/>
                </a:lnTo>
                <a:lnTo>
                  <a:pt x="479" y="6116"/>
                </a:lnTo>
                <a:lnTo>
                  <a:pt x="479" y="6117"/>
                </a:lnTo>
                <a:lnTo>
                  <a:pt x="481" y="6117"/>
                </a:lnTo>
                <a:lnTo>
                  <a:pt x="481" y="6116"/>
                </a:lnTo>
                <a:lnTo>
                  <a:pt x="481" y="6117"/>
                </a:lnTo>
                <a:lnTo>
                  <a:pt x="484" y="6117"/>
                </a:lnTo>
                <a:lnTo>
                  <a:pt x="484" y="6116"/>
                </a:lnTo>
                <a:lnTo>
                  <a:pt x="484" y="6117"/>
                </a:lnTo>
                <a:lnTo>
                  <a:pt x="485" y="6116"/>
                </a:lnTo>
                <a:lnTo>
                  <a:pt x="485" y="6117"/>
                </a:lnTo>
                <a:lnTo>
                  <a:pt x="490" y="6117"/>
                </a:lnTo>
                <a:lnTo>
                  <a:pt x="490" y="6116"/>
                </a:lnTo>
                <a:lnTo>
                  <a:pt x="490" y="6117"/>
                </a:lnTo>
                <a:lnTo>
                  <a:pt x="491" y="6116"/>
                </a:lnTo>
                <a:lnTo>
                  <a:pt x="491" y="6117"/>
                </a:lnTo>
                <a:lnTo>
                  <a:pt x="497" y="6117"/>
                </a:lnTo>
                <a:lnTo>
                  <a:pt x="497" y="6116"/>
                </a:lnTo>
                <a:lnTo>
                  <a:pt x="497" y="6117"/>
                </a:lnTo>
                <a:lnTo>
                  <a:pt x="499" y="6117"/>
                </a:lnTo>
                <a:lnTo>
                  <a:pt x="499" y="6115"/>
                </a:lnTo>
                <a:lnTo>
                  <a:pt x="499" y="6117"/>
                </a:lnTo>
                <a:lnTo>
                  <a:pt x="501" y="6117"/>
                </a:lnTo>
                <a:lnTo>
                  <a:pt x="501" y="6116"/>
                </a:lnTo>
                <a:lnTo>
                  <a:pt x="501" y="6117"/>
                </a:lnTo>
                <a:lnTo>
                  <a:pt x="505" y="6117"/>
                </a:lnTo>
                <a:lnTo>
                  <a:pt x="505" y="6116"/>
                </a:lnTo>
                <a:lnTo>
                  <a:pt x="505" y="6117"/>
                </a:lnTo>
                <a:lnTo>
                  <a:pt x="510" y="6117"/>
                </a:lnTo>
                <a:lnTo>
                  <a:pt x="510" y="6116"/>
                </a:lnTo>
                <a:lnTo>
                  <a:pt x="510" y="6117"/>
                </a:lnTo>
                <a:lnTo>
                  <a:pt x="522" y="6117"/>
                </a:lnTo>
                <a:lnTo>
                  <a:pt x="522" y="6116"/>
                </a:lnTo>
                <a:lnTo>
                  <a:pt x="522" y="6117"/>
                </a:lnTo>
                <a:lnTo>
                  <a:pt x="532" y="6117"/>
                </a:lnTo>
                <a:lnTo>
                  <a:pt x="532" y="6116"/>
                </a:lnTo>
                <a:lnTo>
                  <a:pt x="532" y="6117"/>
                </a:lnTo>
                <a:lnTo>
                  <a:pt x="535" y="6117"/>
                </a:lnTo>
                <a:lnTo>
                  <a:pt x="535" y="6115"/>
                </a:lnTo>
                <a:lnTo>
                  <a:pt x="535" y="6117"/>
                </a:lnTo>
                <a:lnTo>
                  <a:pt x="536" y="6116"/>
                </a:lnTo>
                <a:lnTo>
                  <a:pt x="536" y="6117"/>
                </a:lnTo>
                <a:lnTo>
                  <a:pt x="543" y="6117"/>
                </a:lnTo>
                <a:lnTo>
                  <a:pt x="543" y="6117"/>
                </a:lnTo>
                <a:lnTo>
                  <a:pt x="543" y="6111"/>
                </a:lnTo>
                <a:lnTo>
                  <a:pt x="544" y="6115"/>
                </a:lnTo>
                <a:lnTo>
                  <a:pt x="544" y="6117"/>
                </a:lnTo>
                <a:lnTo>
                  <a:pt x="545" y="6116"/>
                </a:lnTo>
                <a:lnTo>
                  <a:pt x="545" y="6117"/>
                </a:lnTo>
                <a:lnTo>
                  <a:pt x="547" y="6117"/>
                </a:lnTo>
                <a:lnTo>
                  <a:pt x="547" y="6116"/>
                </a:lnTo>
                <a:lnTo>
                  <a:pt x="547" y="6117"/>
                </a:lnTo>
                <a:lnTo>
                  <a:pt x="549" y="6117"/>
                </a:lnTo>
                <a:lnTo>
                  <a:pt x="549" y="6116"/>
                </a:lnTo>
                <a:lnTo>
                  <a:pt x="549" y="6117"/>
                </a:lnTo>
                <a:lnTo>
                  <a:pt x="552" y="6117"/>
                </a:lnTo>
                <a:lnTo>
                  <a:pt x="552" y="6112"/>
                </a:lnTo>
                <a:lnTo>
                  <a:pt x="552" y="6117"/>
                </a:lnTo>
                <a:lnTo>
                  <a:pt x="561" y="6117"/>
                </a:lnTo>
                <a:lnTo>
                  <a:pt x="561" y="6116"/>
                </a:lnTo>
                <a:lnTo>
                  <a:pt x="561" y="6117"/>
                </a:lnTo>
                <a:lnTo>
                  <a:pt x="562" y="6116"/>
                </a:lnTo>
                <a:lnTo>
                  <a:pt x="562" y="6117"/>
                </a:lnTo>
                <a:lnTo>
                  <a:pt x="564" y="6117"/>
                </a:lnTo>
                <a:lnTo>
                  <a:pt x="564" y="6116"/>
                </a:lnTo>
                <a:lnTo>
                  <a:pt x="564" y="6117"/>
                </a:lnTo>
                <a:lnTo>
                  <a:pt x="565" y="6116"/>
                </a:lnTo>
                <a:lnTo>
                  <a:pt x="565" y="6117"/>
                </a:lnTo>
                <a:lnTo>
                  <a:pt x="567" y="6117"/>
                </a:lnTo>
                <a:lnTo>
                  <a:pt x="567" y="6116"/>
                </a:lnTo>
                <a:lnTo>
                  <a:pt x="567" y="6117"/>
                </a:lnTo>
                <a:lnTo>
                  <a:pt x="574" y="6117"/>
                </a:lnTo>
                <a:lnTo>
                  <a:pt x="574" y="6116"/>
                </a:lnTo>
                <a:lnTo>
                  <a:pt x="574" y="6117"/>
                </a:lnTo>
                <a:lnTo>
                  <a:pt x="575" y="6116"/>
                </a:lnTo>
                <a:lnTo>
                  <a:pt x="575" y="6117"/>
                </a:lnTo>
                <a:lnTo>
                  <a:pt x="578" y="6117"/>
                </a:lnTo>
                <a:lnTo>
                  <a:pt x="578" y="6114"/>
                </a:lnTo>
                <a:lnTo>
                  <a:pt x="578" y="6117"/>
                </a:lnTo>
                <a:lnTo>
                  <a:pt x="592" y="6117"/>
                </a:lnTo>
                <a:lnTo>
                  <a:pt x="592" y="6114"/>
                </a:lnTo>
                <a:lnTo>
                  <a:pt x="592" y="6117"/>
                </a:lnTo>
                <a:lnTo>
                  <a:pt x="594" y="6117"/>
                </a:lnTo>
                <a:lnTo>
                  <a:pt x="594" y="6116"/>
                </a:lnTo>
                <a:lnTo>
                  <a:pt x="594" y="6117"/>
                </a:lnTo>
                <a:lnTo>
                  <a:pt x="595" y="6116"/>
                </a:lnTo>
                <a:lnTo>
                  <a:pt x="595" y="6117"/>
                </a:lnTo>
                <a:lnTo>
                  <a:pt x="596" y="6116"/>
                </a:lnTo>
                <a:lnTo>
                  <a:pt x="596" y="6117"/>
                </a:lnTo>
                <a:lnTo>
                  <a:pt x="597" y="6115"/>
                </a:lnTo>
                <a:lnTo>
                  <a:pt x="597" y="6117"/>
                </a:lnTo>
                <a:lnTo>
                  <a:pt x="605" y="6117"/>
                </a:lnTo>
                <a:lnTo>
                  <a:pt x="605" y="6114"/>
                </a:lnTo>
                <a:lnTo>
                  <a:pt x="605" y="6117"/>
                </a:lnTo>
                <a:lnTo>
                  <a:pt x="606" y="6117"/>
                </a:lnTo>
                <a:lnTo>
                  <a:pt x="606" y="6117"/>
                </a:lnTo>
                <a:lnTo>
                  <a:pt x="611" y="6117"/>
                </a:lnTo>
                <a:lnTo>
                  <a:pt x="611" y="6116"/>
                </a:lnTo>
                <a:lnTo>
                  <a:pt x="611" y="6117"/>
                </a:lnTo>
                <a:lnTo>
                  <a:pt x="615" y="6117"/>
                </a:lnTo>
                <a:lnTo>
                  <a:pt x="615" y="6116"/>
                </a:lnTo>
                <a:lnTo>
                  <a:pt x="615" y="6117"/>
                </a:lnTo>
                <a:lnTo>
                  <a:pt x="623" y="6117"/>
                </a:lnTo>
                <a:lnTo>
                  <a:pt x="623" y="6116"/>
                </a:lnTo>
                <a:lnTo>
                  <a:pt x="623" y="6117"/>
                </a:lnTo>
                <a:lnTo>
                  <a:pt x="626" y="6117"/>
                </a:lnTo>
                <a:lnTo>
                  <a:pt x="626" y="6116"/>
                </a:lnTo>
                <a:lnTo>
                  <a:pt x="626" y="6117"/>
                </a:lnTo>
                <a:lnTo>
                  <a:pt x="627" y="6116"/>
                </a:lnTo>
                <a:lnTo>
                  <a:pt x="627" y="6117"/>
                </a:lnTo>
                <a:lnTo>
                  <a:pt x="629" y="6117"/>
                </a:lnTo>
                <a:lnTo>
                  <a:pt x="629" y="6116"/>
                </a:lnTo>
                <a:lnTo>
                  <a:pt x="629" y="6117"/>
                </a:lnTo>
                <a:lnTo>
                  <a:pt x="631" y="6117"/>
                </a:lnTo>
                <a:lnTo>
                  <a:pt x="631" y="6116"/>
                </a:lnTo>
                <a:lnTo>
                  <a:pt x="631" y="6117"/>
                </a:lnTo>
                <a:lnTo>
                  <a:pt x="636" y="6117"/>
                </a:lnTo>
                <a:lnTo>
                  <a:pt x="636" y="6116"/>
                </a:lnTo>
                <a:lnTo>
                  <a:pt x="636" y="6117"/>
                </a:lnTo>
                <a:lnTo>
                  <a:pt x="637" y="6116"/>
                </a:lnTo>
                <a:lnTo>
                  <a:pt x="637" y="6117"/>
                </a:lnTo>
                <a:lnTo>
                  <a:pt x="638" y="6116"/>
                </a:lnTo>
                <a:lnTo>
                  <a:pt x="638" y="6117"/>
                </a:lnTo>
                <a:lnTo>
                  <a:pt x="640" y="6117"/>
                </a:lnTo>
                <a:lnTo>
                  <a:pt x="640" y="6116"/>
                </a:lnTo>
                <a:lnTo>
                  <a:pt x="640" y="6117"/>
                </a:lnTo>
                <a:lnTo>
                  <a:pt x="649" y="6117"/>
                </a:lnTo>
                <a:lnTo>
                  <a:pt x="649" y="6116"/>
                </a:lnTo>
                <a:lnTo>
                  <a:pt x="649" y="6117"/>
                </a:lnTo>
                <a:lnTo>
                  <a:pt x="652" y="6117"/>
                </a:lnTo>
                <a:lnTo>
                  <a:pt x="652" y="6116"/>
                </a:lnTo>
                <a:lnTo>
                  <a:pt x="652" y="6117"/>
                </a:lnTo>
                <a:lnTo>
                  <a:pt x="653" y="6116"/>
                </a:lnTo>
                <a:lnTo>
                  <a:pt x="653" y="6117"/>
                </a:lnTo>
                <a:lnTo>
                  <a:pt x="656" y="6117"/>
                </a:lnTo>
                <a:lnTo>
                  <a:pt x="656" y="6113"/>
                </a:lnTo>
                <a:lnTo>
                  <a:pt x="656" y="6117"/>
                </a:lnTo>
                <a:lnTo>
                  <a:pt x="657" y="6116"/>
                </a:lnTo>
                <a:lnTo>
                  <a:pt x="657" y="6117"/>
                </a:lnTo>
                <a:lnTo>
                  <a:pt x="659" y="6117"/>
                </a:lnTo>
                <a:lnTo>
                  <a:pt x="659" y="6115"/>
                </a:lnTo>
                <a:lnTo>
                  <a:pt x="659" y="6117"/>
                </a:lnTo>
                <a:lnTo>
                  <a:pt x="661" y="6117"/>
                </a:lnTo>
                <a:lnTo>
                  <a:pt x="661" y="6116"/>
                </a:lnTo>
                <a:lnTo>
                  <a:pt x="661" y="6117"/>
                </a:lnTo>
                <a:lnTo>
                  <a:pt x="662" y="6116"/>
                </a:lnTo>
                <a:lnTo>
                  <a:pt x="662" y="6117"/>
                </a:lnTo>
                <a:lnTo>
                  <a:pt x="665" y="6117"/>
                </a:lnTo>
                <a:lnTo>
                  <a:pt x="665" y="6116"/>
                </a:lnTo>
                <a:lnTo>
                  <a:pt x="665" y="6117"/>
                </a:lnTo>
                <a:lnTo>
                  <a:pt x="667" y="6117"/>
                </a:lnTo>
                <a:lnTo>
                  <a:pt x="667" y="6086"/>
                </a:lnTo>
                <a:lnTo>
                  <a:pt x="667" y="6117"/>
                </a:lnTo>
                <a:lnTo>
                  <a:pt x="671" y="6117"/>
                </a:lnTo>
                <a:lnTo>
                  <a:pt x="671" y="6115"/>
                </a:lnTo>
                <a:lnTo>
                  <a:pt x="671" y="6117"/>
                </a:lnTo>
                <a:lnTo>
                  <a:pt x="675" y="6117"/>
                </a:lnTo>
                <a:lnTo>
                  <a:pt x="675" y="6116"/>
                </a:lnTo>
                <a:lnTo>
                  <a:pt x="675" y="6117"/>
                </a:lnTo>
                <a:lnTo>
                  <a:pt x="676" y="6104"/>
                </a:lnTo>
                <a:lnTo>
                  <a:pt x="676" y="6117"/>
                </a:lnTo>
                <a:lnTo>
                  <a:pt x="679" y="6117"/>
                </a:lnTo>
                <a:lnTo>
                  <a:pt x="679" y="6116"/>
                </a:lnTo>
                <a:lnTo>
                  <a:pt x="679" y="6117"/>
                </a:lnTo>
                <a:lnTo>
                  <a:pt x="685" y="6117"/>
                </a:lnTo>
                <a:lnTo>
                  <a:pt x="685" y="6114"/>
                </a:lnTo>
                <a:lnTo>
                  <a:pt x="685" y="6117"/>
                </a:lnTo>
                <a:lnTo>
                  <a:pt x="690" y="6117"/>
                </a:lnTo>
                <a:lnTo>
                  <a:pt x="690" y="6116"/>
                </a:lnTo>
                <a:lnTo>
                  <a:pt x="690" y="6117"/>
                </a:lnTo>
                <a:lnTo>
                  <a:pt x="692" y="6117"/>
                </a:lnTo>
                <a:lnTo>
                  <a:pt x="692" y="6116"/>
                </a:lnTo>
                <a:lnTo>
                  <a:pt x="692" y="6117"/>
                </a:lnTo>
                <a:lnTo>
                  <a:pt x="702" y="6117"/>
                </a:lnTo>
                <a:lnTo>
                  <a:pt x="702" y="6114"/>
                </a:lnTo>
                <a:lnTo>
                  <a:pt x="702" y="6117"/>
                </a:lnTo>
                <a:lnTo>
                  <a:pt x="708" y="6117"/>
                </a:lnTo>
                <a:lnTo>
                  <a:pt x="708" y="6116"/>
                </a:lnTo>
                <a:lnTo>
                  <a:pt x="708" y="6117"/>
                </a:lnTo>
                <a:lnTo>
                  <a:pt x="709" y="6116"/>
                </a:lnTo>
                <a:lnTo>
                  <a:pt x="709" y="6117"/>
                </a:lnTo>
                <a:lnTo>
                  <a:pt x="716" y="6117"/>
                </a:lnTo>
                <a:lnTo>
                  <a:pt x="716" y="5757"/>
                </a:lnTo>
                <a:lnTo>
                  <a:pt x="716" y="6117"/>
                </a:lnTo>
                <a:lnTo>
                  <a:pt x="720" y="6117"/>
                </a:lnTo>
                <a:lnTo>
                  <a:pt x="720" y="6098"/>
                </a:lnTo>
                <a:lnTo>
                  <a:pt x="720" y="6117"/>
                </a:lnTo>
                <a:lnTo>
                  <a:pt x="722" y="6117"/>
                </a:lnTo>
                <a:lnTo>
                  <a:pt x="722" y="6116"/>
                </a:lnTo>
                <a:lnTo>
                  <a:pt x="722" y="6117"/>
                </a:lnTo>
                <a:lnTo>
                  <a:pt x="723" y="6116"/>
                </a:lnTo>
                <a:lnTo>
                  <a:pt x="723" y="6117"/>
                </a:lnTo>
                <a:lnTo>
                  <a:pt x="724" y="6116"/>
                </a:lnTo>
                <a:lnTo>
                  <a:pt x="724" y="6117"/>
                </a:lnTo>
                <a:lnTo>
                  <a:pt x="725" y="6115"/>
                </a:lnTo>
                <a:lnTo>
                  <a:pt x="725" y="6117"/>
                </a:lnTo>
                <a:lnTo>
                  <a:pt x="730" y="6117"/>
                </a:lnTo>
                <a:lnTo>
                  <a:pt x="730" y="6116"/>
                </a:lnTo>
                <a:lnTo>
                  <a:pt x="730" y="6117"/>
                </a:lnTo>
                <a:lnTo>
                  <a:pt x="737" y="6117"/>
                </a:lnTo>
                <a:lnTo>
                  <a:pt x="737" y="5901"/>
                </a:lnTo>
                <a:lnTo>
                  <a:pt x="737" y="6117"/>
                </a:lnTo>
                <a:lnTo>
                  <a:pt x="738" y="6117"/>
                </a:lnTo>
                <a:lnTo>
                  <a:pt x="741" y="6117"/>
                </a:lnTo>
                <a:lnTo>
                  <a:pt x="741" y="6116"/>
                </a:lnTo>
                <a:lnTo>
                  <a:pt x="741" y="6117"/>
                </a:lnTo>
                <a:lnTo>
                  <a:pt x="742" y="6111"/>
                </a:lnTo>
                <a:lnTo>
                  <a:pt x="742" y="6117"/>
                </a:lnTo>
                <a:lnTo>
                  <a:pt x="757" y="6117"/>
                </a:lnTo>
                <a:lnTo>
                  <a:pt x="757" y="6116"/>
                </a:lnTo>
                <a:lnTo>
                  <a:pt x="757" y="6117"/>
                </a:lnTo>
                <a:lnTo>
                  <a:pt x="762" y="6117"/>
                </a:lnTo>
                <a:lnTo>
                  <a:pt x="762" y="6116"/>
                </a:lnTo>
                <a:lnTo>
                  <a:pt x="762" y="6117"/>
                </a:lnTo>
                <a:lnTo>
                  <a:pt x="763" y="6116"/>
                </a:lnTo>
                <a:lnTo>
                  <a:pt x="763" y="6117"/>
                </a:lnTo>
                <a:lnTo>
                  <a:pt x="764" y="6088"/>
                </a:lnTo>
                <a:lnTo>
                  <a:pt x="764" y="6117"/>
                </a:lnTo>
                <a:lnTo>
                  <a:pt x="768" y="6117"/>
                </a:lnTo>
                <a:lnTo>
                  <a:pt x="768" y="6116"/>
                </a:lnTo>
                <a:lnTo>
                  <a:pt x="768" y="6117"/>
                </a:lnTo>
                <a:lnTo>
                  <a:pt x="769" y="6116"/>
                </a:lnTo>
                <a:lnTo>
                  <a:pt x="769" y="6117"/>
                </a:lnTo>
                <a:lnTo>
                  <a:pt x="773" y="6117"/>
                </a:lnTo>
                <a:lnTo>
                  <a:pt x="773" y="6116"/>
                </a:lnTo>
                <a:lnTo>
                  <a:pt x="773" y="6117"/>
                </a:lnTo>
                <a:lnTo>
                  <a:pt x="774" y="6116"/>
                </a:lnTo>
                <a:lnTo>
                  <a:pt x="774" y="6117"/>
                </a:lnTo>
                <a:lnTo>
                  <a:pt x="777" y="6117"/>
                </a:lnTo>
                <a:lnTo>
                  <a:pt x="777" y="6099"/>
                </a:lnTo>
                <a:lnTo>
                  <a:pt x="777" y="6117"/>
                </a:lnTo>
                <a:lnTo>
                  <a:pt x="784" y="6117"/>
                </a:lnTo>
                <a:lnTo>
                  <a:pt x="784" y="6116"/>
                </a:lnTo>
                <a:lnTo>
                  <a:pt x="784" y="6117"/>
                </a:lnTo>
                <a:lnTo>
                  <a:pt x="786" y="6117"/>
                </a:lnTo>
                <a:lnTo>
                  <a:pt x="786" y="6116"/>
                </a:lnTo>
                <a:lnTo>
                  <a:pt x="786" y="6117"/>
                </a:lnTo>
                <a:lnTo>
                  <a:pt x="809" y="6117"/>
                </a:lnTo>
                <a:lnTo>
                  <a:pt x="809" y="6116"/>
                </a:lnTo>
                <a:lnTo>
                  <a:pt x="809" y="6117"/>
                </a:lnTo>
                <a:lnTo>
                  <a:pt x="813" y="6117"/>
                </a:lnTo>
                <a:lnTo>
                  <a:pt x="813" y="6116"/>
                </a:lnTo>
                <a:lnTo>
                  <a:pt x="813" y="6117"/>
                </a:lnTo>
                <a:lnTo>
                  <a:pt x="819" y="6117"/>
                </a:lnTo>
                <a:lnTo>
                  <a:pt x="819" y="6116"/>
                </a:lnTo>
                <a:lnTo>
                  <a:pt x="819" y="6117"/>
                </a:lnTo>
                <a:lnTo>
                  <a:pt x="824" y="6117"/>
                </a:lnTo>
                <a:lnTo>
                  <a:pt x="824" y="6116"/>
                </a:lnTo>
                <a:lnTo>
                  <a:pt x="824" y="6117"/>
                </a:lnTo>
                <a:lnTo>
                  <a:pt x="826" y="6117"/>
                </a:lnTo>
                <a:lnTo>
                  <a:pt x="826" y="6116"/>
                </a:lnTo>
                <a:lnTo>
                  <a:pt x="826" y="6117"/>
                </a:lnTo>
                <a:lnTo>
                  <a:pt x="835" y="6117"/>
                </a:lnTo>
                <a:lnTo>
                  <a:pt x="835" y="6116"/>
                </a:lnTo>
                <a:lnTo>
                  <a:pt x="835" y="6117"/>
                </a:lnTo>
                <a:lnTo>
                  <a:pt x="839" y="6117"/>
                </a:lnTo>
                <a:lnTo>
                  <a:pt x="839" y="6116"/>
                </a:lnTo>
                <a:lnTo>
                  <a:pt x="839" y="6117"/>
                </a:lnTo>
                <a:lnTo>
                  <a:pt x="840" y="6116"/>
                </a:lnTo>
                <a:lnTo>
                  <a:pt x="840" y="6117"/>
                </a:lnTo>
                <a:lnTo>
                  <a:pt x="842" y="6117"/>
                </a:lnTo>
                <a:lnTo>
                  <a:pt x="842" y="6116"/>
                </a:lnTo>
                <a:lnTo>
                  <a:pt x="842" y="6117"/>
                </a:lnTo>
                <a:lnTo>
                  <a:pt x="846" y="6117"/>
                </a:lnTo>
                <a:lnTo>
                  <a:pt x="846" y="6116"/>
                </a:lnTo>
                <a:lnTo>
                  <a:pt x="846" y="6117"/>
                </a:lnTo>
                <a:lnTo>
                  <a:pt x="853" y="6117"/>
                </a:lnTo>
                <a:lnTo>
                  <a:pt x="853" y="6112"/>
                </a:lnTo>
                <a:lnTo>
                  <a:pt x="853" y="6117"/>
                </a:lnTo>
                <a:lnTo>
                  <a:pt x="856" y="6117"/>
                </a:lnTo>
                <a:lnTo>
                  <a:pt x="856" y="6116"/>
                </a:lnTo>
                <a:lnTo>
                  <a:pt x="856" y="6117"/>
                </a:lnTo>
                <a:lnTo>
                  <a:pt x="859" y="6117"/>
                </a:lnTo>
                <a:lnTo>
                  <a:pt x="859" y="6116"/>
                </a:lnTo>
                <a:lnTo>
                  <a:pt x="859" y="6117"/>
                </a:lnTo>
                <a:lnTo>
                  <a:pt x="871" y="6117"/>
                </a:lnTo>
                <a:lnTo>
                  <a:pt x="871" y="6117"/>
                </a:lnTo>
                <a:lnTo>
                  <a:pt x="871" y="6117"/>
                </a:lnTo>
                <a:lnTo>
                  <a:pt x="872" y="6116"/>
                </a:lnTo>
                <a:lnTo>
                  <a:pt x="872" y="6117"/>
                </a:lnTo>
                <a:lnTo>
                  <a:pt x="883" y="6117"/>
                </a:lnTo>
                <a:lnTo>
                  <a:pt x="883" y="6116"/>
                </a:lnTo>
                <a:lnTo>
                  <a:pt x="883" y="6117"/>
                </a:lnTo>
                <a:lnTo>
                  <a:pt x="884" y="6115"/>
                </a:lnTo>
                <a:lnTo>
                  <a:pt x="884" y="6117"/>
                </a:lnTo>
                <a:lnTo>
                  <a:pt x="887" y="6117"/>
                </a:lnTo>
                <a:lnTo>
                  <a:pt x="887" y="6116"/>
                </a:lnTo>
                <a:lnTo>
                  <a:pt x="887" y="6117"/>
                </a:lnTo>
                <a:lnTo>
                  <a:pt x="893" y="6117"/>
                </a:lnTo>
                <a:lnTo>
                  <a:pt x="893" y="6116"/>
                </a:lnTo>
                <a:lnTo>
                  <a:pt x="893" y="6117"/>
                </a:lnTo>
                <a:lnTo>
                  <a:pt x="901" y="6117"/>
                </a:lnTo>
                <a:lnTo>
                  <a:pt x="901" y="6116"/>
                </a:lnTo>
                <a:lnTo>
                  <a:pt x="901" y="6117"/>
                </a:lnTo>
                <a:lnTo>
                  <a:pt x="906" y="6117"/>
                </a:lnTo>
                <a:lnTo>
                  <a:pt x="906" y="6115"/>
                </a:lnTo>
                <a:lnTo>
                  <a:pt x="906" y="6117"/>
                </a:lnTo>
                <a:lnTo>
                  <a:pt x="908" y="6117"/>
                </a:lnTo>
                <a:lnTo>
                  <a:pt x="908" y="6116"/>
                </a:lnTo>
                <a:lnTo>
                  <a:pt x="908" y="6117"/>
                </a:lnTo>
                <a:lnTo>
                  <a:pt x="910" y="6117"/>
                </a:lnTo>
                <a:lnTo>
                  <a:pt x="910" y="6112"/>
                </a:lnTo>
                <a:lnTo>
                  <a:pt x="910" y="6117"/>
                </a:lnTo>
                <a:lnTo>
                  <a:pt x="912" y="6117"/>
                </a:lnTo>
                <a:lnTo>
                  <a:pt x="912" y="6116"/>
                </a:lnTo>
                <a:lnTo>
                  <a:pt x="912" y="6117"/>
                </a:lnTo>
                <a:lnTo>
                  <a:pt x="914" y="6117"/>
                </a:lnTo>
                <a:lnTo>
                  <a:pt x="914" y="6115"/>
                </a:lnTo>
                <a:lnTo>
                  <a:pt x="914" y="6117"/>
                </a:lnTo>
                <a:lnTo>
                  <a:pt x="915" y="6116"/>
                </a:lnTo>
                <a:lnTo>
                  <a:pt x="915" y="6117"/>
                </a:lnTo>
                <a:lnTo>
                  <a:pt x="924" y="6117"/>
                </a:lnTo>
                <a:lnTo>
                  <a:pt x="924" y="6116"/>
                </a:lnTo>
                <a:lnTo>
                  <a:pt x="924" y="6117"/>
                </a:lnTo>
                <a:lnTo>
                  <a:pt x="925" y="6116"/>
                </a:lnTo>
                <a:lnTo>
                  <a:pt x="925" y="6117"/>
                </a:lnTo>
                <a:lnTo>
                  <a:pt x="937" y="6117"/>
                </a:lnTo>
                <a:lnTo>
                  <a:pt x="937" y="6116"/>
                </a:lnTo>
                <a:lnTo>
                  <a:pt x="937" y="6117"/>
                </a:lnTo>
                <a:lnTo>
                  <a:pt x="941" y="6117"/>
                </a:lnTo>
                <a:lnTo>
                  <a:pt x="941" y="6116"/>
                </a:lnTo>
                <a:lnTo>
                  <a:pt x="941" y="6117"/>
                </a:lnTo>
                <a:lnTo>
                  <a:pt x="945" y="6117"/>
                </a:lnTo>
                <a:lnTo>
                  <a:pt x="945" y="6116"/>
                </a:lnTo>
                <a:lnTo>
                  <a:pt x="945" y="6117"/>
                </a:lnTo>
                <a:lnTo>
                  <a:pt x="954" y="6117"/>
                </a:lnTo>
                <a:lnTo>
                  <a:pt x="954" y="6116"/>
                </a:lnTo>
                <a:lnTo>
                  <a:pt x="954" y="6117"/>
                </a:lnTo>
                <a:lnTo>
                  <a:pt x="956" y="6117"/>
                </a:lnTo>
                <a:lnTo>
                  <a:pt x="956" y="6116"/>
                </a:lnTo>
                <a:lnTo>
                  <a:pt x="956" y="6117"/>
                </a:lnTo>
                <a:lnTo>
                  <a:pt x="963" y="6117"/>
                </a:lnTo>
                <a:lnTo>
                  <a:pt x="963" y="6115"/>
                </a:lnTo>
                <a:lnTo>
                  <a:pt x="963" y="6117"/>
                </a:lnTo>
                <a:lnTo>
                  <a:pt x="965" y="6117"/>
                </a:lnTo>
                <a:lnTo>
                  <a:pt x="965" y="6116"/>
                </a:lnTo>
                <a:lnTo>
                  <a:pt x="965" y="6117"/>
                </a:lnTo>
                <a:lnTo>
                  <a:pt x="968" y="6117"/>
                </a:lnTo>
                <a:lnTo>
                  <a:pt x="968" y="6116"/>
                </a:lnTo>
                <a:lnTo>
                  <a:pt x="968" y="6117"/>
                </a:lnTo>
                <a:lnTo>
                  <a:pt x="976" y="6117"/>
                </a:lnTo>
                <a:lnTo>
                  <a:pt x="976" y="6098"/>
                </a:lnTo>
                <a:lnTo>
                  <a:pt x="976" y="6117"/>
                </a:lnTo>
                <a:lnTo>
                  <a:pt x="980" y="6117"/>
                </a:lnTo>
                <a:lnTo>
                  <a:pt x="980" y="6116"/>
                </a:lnTo>
                <a:lnTo>
                  <a:pt x="980" y="6117"/>
                </a:lnTo>
                <a:lnTo>
                  <a:pt x="981" y="6116"/>
                </a:lnTo>
                <a:lnTo>
                  <a:pt x="981" y="6117"/>
                </a:lnTo>
                <a:lnTo>
                  <a:pt x="983" y="6117"/>
                </a:lnTo>
                <a:lnTo>
                  <a:pt x="983" y="6116"/>
                </a:lnTo>
                <a:lnTo>
                  <a:pt x="983" y="6117"/>
                </a:lnTo>
                <a:lnTo>
                  <a:pt x="984" y="6116"/>
                </a:lnTo>
                <a:lnTo>
                  <a:pt x="984" y="6117"/>
                </a:lnTo>
                <a:lnTo>
                  <a:pt x="989" y="6117"/>
                </a:lnTo>
                <a:lnTo>
                  <a:pt x="989" y="6116"/>
                </a:lnTo>
                <a:lnTo>
                  <a:pt x="989" y="6117"/>
                </a:lnTo>
                <a:lnTo>
                  <a:pt x="990" y="6116"/>
                </a:lnTo>
                <a:lnTo>
                  <a:pt x="990" y="6117"/>
                </a:lnTo>
                <a:lnTo>
                  <a:pt x="993" y="6117"/>
                </a:lnTo>
                <a:lnTo>
                  <a:pt x="993" y="6116"/>
                </a:lnTo>
                <a:lnTo>
                  <a:pt x="993" y="6117"/>
                </a:lnTo>
                <a:lnTo>
                  <a:pt x="1003" y="6117"/>
                </a:lnTo>
                <a:lnTo>
                  <a:pt x="1003" y="6116"/>
                </a:lnTo>
                <a:lnTo>
                  <a:pt x="1003" y="6117"/>
                </a:lnTo>
                <a:lnTo>
                  <a:pt x="1007" y="6117"/>
                </a:lnTo>
                <a:lnTo>
                  <a:pt x="1007" y="6116"/>
                </a:lnTo>
                <a:lnTo>
                  <a:pt x="1007" y="6117"/>
                </a:lnTo>
                <a:lnTo>
                  <a:pt x="1010" y="6117"/>
                </a:lnTo>
                <a:lnTo>
                  <a:pt x="1010" y="6116"/>
                </a:lnTo>
                <a:lnTo>
                  <a:pt x="1010" y="6117"/>
                </a:lnTo>
                <a:lnTo>
                  <a:pt x="1015" y="6117"/>
                </a:lnTo>
                <a:lnTo>
                  <a:pt x="1015" y="6116"/>
                </a:lnTo>
                <a:lnTo>
                  <a:pt x="1015" y="6117"/>
                </a:lnTo>
                <a:lnTo>
                  <a:pt x="1017" y="6117"/>
                </a:lnTo>
                <a:lnTo>
                  <a:pt x="1017" y="6116"/>
                </a:lnTo>
                <a:lnTo>
                  <a:pt x="1017" y="6117"/>
                </a:lnTo>
                <a:lnTo>
                  <a:pt x="1021" y="6117"/>
                </a:lnTo>
                <a:lnTo>
                  <a:pt x="1021" y="6116"/>
                </a:lnTo>
                <a:lnTo>
                  <a:pt x="1021" y="6117"/>
                </a:lnTo>
                <a:lnTo>
                  <a:pt x="1025" y="6117"/>
                </a:lnTo>
                <a:lnTo>
                  <a:pt x="1025" y="6116"/>
                </a:lnTo>
                <a:lnTo>
                  <a:pt x="1025" y="6117"/>
                </a:lnTo>
                <a:lnTo>
                  <a:pt x="1033" y="6117"/>
                </a:lnTo>
                <a:lnTo>
                  <a:pt x="1033" y="6116"/>
                </a:lnTo>
                <a:lnTo>
                  <a:pt x="1033" y="6117"/>
                </a:lnTo>
                <a:lnTo>
                  <a:pt x="1034" y="6116"/>
                </a:lnTo>
                <a:lnTo>
                  <a:pt x="1034" y="6117"/>
                </a:lnTo>
                <a:lnTo>
                  <a:pt x="1038" y="6117"/>
                </a:lnTo>
                <a:lnTo>
                  <a:pt x="1038" y="6114"/>
                </a:lnTo>
                <a:lnTo>
                  <a:pt x="1038" y="6117"/>
                </a:lnTo>
                <a:lnTo>
                  <a:pt x="1039" y="6116"/>
                </a:lnTo>
                <a:lnTo>
                  <a:pt x="1039" y="6117"/>
                </a:lnTo>
                <a:lnTo>
                  <a:pt x="1043" y="6117"/>
                </a:lnTo>
                <a:lnTo>
                  <a:pt x="1043" y="6114"/>
                </a:lnTo>
                <a:lnTo>
                  <a:pt x="1043" y="6117"/>
                </a:lnTo>
                <a:lnTo>
                  <a:pt x="1048" y="6117"/>
                </a:lnTo>
                <a:lnTo>
                  <a:pt x="1048" y="6116"/>
                </a:lnTo>
                <a:lnTo>
                  <a:pt x="1048" y="6117"/>
                </a:lnTo>
                <a:lnTo>
                  <a:pt x="1050" y="6117"/>
                </a:lnTo>
                <a:lnTo>
                  <a:pt x="1050" y="6116"/>
                </a:lnTo>
                <a:lnTo>
                  <a:pt x="1050" y="6117"/>
                </a:lnTo>
                <a:lnTo>
                  <a:pt x="1056" y="6117"/>
                </a:lnTo>
                <a:lnTo>
                  <a:pt x="1056" y="6116"/>
                </a:lnTo>
                <a:lnTo>
                  <a:pt x="1056" y="6117"/>
                </a:lnTo>
                <a:lnTo>
                  <a:pt x="1065" y="6117"/>
                </a:lnTo>
                <a:lnTo>
                  <a:pt x="1065" y="6116"/>
                </a:lnTo>
                <a:lnTo>
                  <a:pt x="1065" y="6117"/>
                </a:lnTo>
                <a:lnTo>
                  <a:pt x="1070" y="6117"/>
                </a:lnTo>
                <a:lnTo>
                  <a:pt x="1070" y="6116"/>
                </a:lnTo>
                <a:lnTo>
                  <a:pt x="1070" y="6117"/>
                </a:lnTo>
                <a:lnTo>
                  <a:pt x="1082" y="6117"/>
                </a:lnTo>
                <a:lnTo>
                  <a:pt x="1082" y="6116"/>
                </a:lnTo>
                <a:lnTo>
                  <a:pt x="1082" y="6117"/>
                </a:lnTo>
                <a:lnTo>
                  <a:pt x="1087" y="6117"/>
                </a:lnTo>
                <a:lnTo>
                  <a:pt x="1087" y="6114"/>
                </a:lnTo>
                <a:lnTo>
                  <a:pt x="1087" y="6117"/>
                </a:lnTo>
                <a:lnTo>
                  <a:pt x="1091" y="6117"/>
                </a:lnTo>
                <a:lnTo>
                  <a:pt x="1091" y="6098"/>
                </a:lnTo>
                <a:lnTo>
                  <a:pt x="1091" y="6117"/>
                </a:lnTo>
                <a:lnTo>
                  <a:pt x="1094" y="6117"/>
                </a:lnTo>
                <a:lnTo>
                  <a:pt x="1094" y="6116"/>
                </a:lnTo>
                <a:lnTo>
                  <a:pt x="1094" y="6117"/>
                </a:lnTo>
                <a:lnTo>
                  <a:pt x="1096" y="6117"/>
                </a:lnTo>
                <a:lnTo>
                  <a:pt x="1096" y="6114"/>
                </a:lnTo>
                <a:lnTo>
                  <a:pt x="1096" y="6117"/>
                </a:lnTo>
                <a:lnTo>
                  <a:pt x="1098" y="6117"/>
                </a:lnTo>
                <a:lnTo>
                  <a:pt x="1098" y="6116"/>
                </a:lnTo>
                <a:lnTo>
                  <a:pt x="1098" y="6117"/>
                </a:lnTo>
                <a:lnTo>
                  <a:pt x="1100" y="6117"/>
                </a:lnTo>
                <a:lnTo>
                  <a:pt x="1100" y="6094"/>
                </a:lnTo>
                <a:lnTo>
                  <a:pt x="1100" y="6117"/>
                </a:lnTo>
                <a:lnTo>
                  <a:pt x="1104" y="6117"/>
                </a:lnTo>
                <a:lnTo>
                  <a:pt x="1104" y="6117"/>
                </a:lnTo>
                <a:lnTo>
                  <a:pt x="1104" y="6117"/>
                </a:lnTo>
                <a:lnTo>
                  <a:pt x="1105" y="6114"/>
                </a:lnTo>
                <a:lnTo>
                  <a:pt x="1105" y="6117"/>
                </a:lnTo>
                <a:lnTo>
                  <a:pt x="1106" y="6116"/>
                </a:lnTo>
                <a:lnTo>
                  <a:pt x="1106" y="6117"/>
                </a:lnTo>
                <a:lnTo>
                  <a:pt x="1126" y="6117"/>
                </a:lnTo>
                <a:lnTo>
                  <a:pt x="1126" y="6116"/>
                </a:lnTo>
                <a:lnTo>
                  <a:pt x="1126" y="6117"/>
                </a:lnTo>
                <a:lnTo>
                  <a:pt x="1130" y="6117"/>
                </a:lnTo>
                <a:lnTo>
                  <a:pt x="1130" y="6116"/>
                </a:lnTo>
                <a:lnTo>
                  <a:pt x="1130" y="6117"/>
                </a:lnTo>
                <a:lnTo>
                  <a:pt x="1134" y="6117"/>
                </a:lnTo>
                <a:lnTo>
                  <a:pt x="1134" y="6116"/>
                </a:lnTo>
                <a:lnTo>
                  <a:pt x="1134" y="6117"/>
                </a:lnTo>
                <a:lnTo>
                  <a:pt x="1135" y="6116"/>
                </a:lnTo>
                <a:lnTo>
                  <a:pt x="1135" y="6117"/>
                </a:lnTo>
                <a:lnTo>
                  <a:pt x="1136" y="6116"/>
                </a:lnTo>
                <a:lnTo>
                  <a:pt x="1136" y="6117"/>
                </a:lnTo>
                <a:lnTo>
                  <a:pt x="1137" y="6116"/>
                </a:lnTo>
                <a:lnTo>
                  <a:pt x="1137" y="6117"/>
                </a:lnTo>
                <a:lnTo>
                  <a:pt x="1143" y="6117"/>
                </a:lnTo>
                <a:lnTo>
                  <a:pt x="1143" y="6116"/>
                </a:lnTo>
                <a:lnTo>
                  <a:pt x="1143" y="6117"/>
                </a:lnTo>
                <a:lnTo>
                  <a:pt x="1153" y="6117"/>
                </a:lnTo>
                <a:lnTo>
                  <a:pt x="1153" y="6112"/>
                </a:lnTo>
                <a:lnTo>
                  <a:pt x="1153" y="6117"/>
                </a:lnTo>
                <a:lnTo>
                  <a:pt x="1158" y="6117"/>
                </a:lnTo>
                <a:lnTo>
                  <a:pt x="1158" y="6116"/>
                </a:lnTo>
                <a:lnTo>
                  <a:pt x="1158" y="6117"/>
                </a:lnTo>
                <a:lnTo>
                  <a:pt x="1162" y="6117"/>
                </a:lnTo>
                <a:lnTo>
                  <a:pt x="1162" y="6077"/>
                </a:lnTo>
                <a:lnTo>
                  <a:pt x="1162" y="6117"/>
                </a:lnTo>
                <a:lnTo>
                  <a:pt x="1165" y="6117"/>
                </a:lnTo>
                <a:lnTo>
                  <a:pt x="1165" y="6116"/>
                </a:lnTo>
                <a:lnTo>
                  <a:pt x="1165" y="6117"/>
                </a:lnTo>
                <a:lnTo>
                  <a:pt x="1166" y="5435"/>
                </a:lnTo>
                <a:lnTo>
                  <a:pt x="1166" y="6117"/>
                </a:lnTo>
                <a:lnTo>
                  <a:pt x="1171" y="6117"/>
                </a:lnTo>
                <a:lnTo>
                  <a:pt x="1171" y="6064"/>
                </a:lnTo>
                <a:lnTo>
                  <a:pt x="1171" y="6117"/>
                </a:lnTo>
                <a:lnTo>
                  <a:pt x="1175" y="6117"/>
                </a:lnTo>
                <a:lnTo>
                  <a:pt x="1175" y="6113"/>
                </a:lnTo>
                <a:lnTo>
                  <a:pt x="1175" y="6117"/>
                </a:lnTo>
                <a:lnTo>
                  <a:pt x="1186" y="6117"/>
                </a:lnTo>
                <a:lnTo>
                  <a:pt x="1186" y="6116"/>
                </a:lnTo>
                <a:lnTo>
                  <a:pt x="1186" y="6117"/>
                </a:lnTo>
                <a:lnTo>
                  <a:pt x="1204" y="6117"/>
                </a:lnTo>
                <a:lnTo>
                  <a:pt x="1204" y="6116"/>
                </a:lnTo>
                <a:lnTo>
                  <a:pt x="1204" y="6117"/>
                </a:lnTo>
                <a:lnTo>
                  <a:pt x="1206" y="6117"/>
                </a:lnTo>
                <a:lnTo>
                  <a:pt x="1206" y="6116"/>
                </a:lnTo>
                <a:lnTo>
                  <a:pt x="1206" y="6117"/>
                </a:lnTo>
                <a:lnTo>
                  <a:pt x="1225" y="6117"/>
                </a:lnTo>
                <a:lnTo>
                  <a:pt x="1225" y="6116"/>
                </a:lnTo>
                <a:lnTo>
                  <a:pt x="1225" y="6117"/>
                </a:lnTo>
                <a:lnTo>
                  <a:pt x="1228" y="6117"/>
                </a:lnTo>
                <a:lnTo>
                  <a:pt x="1228" y="6116"/>
                </a:lnTo>
                <a:lnTo>
                  <a:pt x="1228" y="6117"/>
                </a:lnTo>
                <a:lnTo>
                  <a:pt x="1230" y="6117"/>
                </a:lnTo>
                <a:lnTo>
                  <a:pt x="1230" y="6116"/>
                </a:lnTo>
                <a:lnTo>
                  <a:pt x="1230" y="6117"/>
                </a:lnTo>
                <a:lnTo>
                  <a:pt x="1231" y="6116"/>
                </a:lnTo>
                <a:lnTo>
                  <a:pt x="1231" y="6117"/>
                </a:lnTo>
                <a:lnTo>
                  <a:pt x="1232" y="6117"/>
                </a:lnTo>
                <a:lnTo>
                  <a:pt x="1232" y="6108"/>
                </a:lnTo>
                <a:lnTo>
                  <a:pt x="1233" y="0"/>
                </a:lnTo>
                <a:lnTo>
                  <a:pt x="1233" y="6117"/>
                </a:lnTo>
                <a:lnTo>
                  <a:pt x="1234" y="6116"/>
                </a:lnTo>
                <a:lnTo>
                  <a:pt x="1234" y="6117"/>
                </a:lnTo>
                <a:lnTo>
                  <a:pt x="1237" y="6117"/>
                </a:lnTo>
                <a:lnTo>
                  <a:pt x="1237" y="4975"/>
                </a:lnTo>
                <a:lnTo>
                  <a:pt x="1237" y="6117"/>
                </a:lnTo>
                <a:lnTo>
                  <a:pt x="1240" y="6117"/>
                </a:lnTo>
                <a:lnTo>
                  <a:pt x="1240" y="6116"/>
                </a:lnTo>
                <a:lnTo>
                  <a:pt x="1240" y="6117"/>
                </a:lnTo>
                <a:lnTo>
                  <a:pt x="1241" y="6116"/>
                </a:lnTo>
                <a:lnTo>
                  <a:pt x="1241" y="6117"/>
                </a:lnTo>
                <a:lnTo>
                  <a:pt x="1242" y="6072"/>
                </a:lnTo>
                <a:lnTo>
                  <a:pt x="1242" y="6117"/>
                </a:lnTo>
                <a:lnTo>
                  <a:pt x="1246" y="6117"/>
                </a:lnTo>
                <a:lnTo>
                  <a:pt x="1246" y="6114"/>
                </a:lnTo>
                <a:lnTo>
                  <a:pt x="1246" y="6117"/>
                </a:lnTo>
                <a:lnTo>
                  <a:pt x="1252" y="6117"/>
                </a:lnTo>
                <a:lnTo>
                  <a:pt x="1252" y="6116"/>
                </a:lnTo>
                <a:lnTo>
                  <a:pt x="1252" y="6117"/>
                </a:lnTo>
                <a:lnTo>
                  <a:pt x="1287" y="6117"/>
                </a:lnTo>
                <a:lnTo>
                  <a:pt x="1287" y="6116"/>
                </a:lnTo>
                <a:lnTo>
                  <a:pt x="1287" y="6117"/>
                </a:lnTo>
                <a:lnTo>
                  <a:pt x="1295" y="6117"/>
                </a:lnTo>
                <a:lnTo>
                  <a:pt x="1295" y="6116"/>
                </a:lnTo>
                <a:lnTo>
                  <a:pt x="1295" y="6117"/>
                </a:lnTo>
                <a:lnTo>
                  <a:pt x="1317" y="6117"/>
                </a:lnTo>
                <a:lnTo>
                  <a:pt x="1317" y="6116"/>
                </a:lnTo>
                <a:lnTo>
                  <a:pt x="1317" y="6117"/>
                </a:lnTo>
                <a:lnTo>
                  <a:pt x="1319" y="6117"/>
                </a:lnTo>
                <a:lnTo>
                  <a:pt x="1319" y="6116"/>
                </a:lnTo>
                <a:lnTo>
                  <a:pt x="1319" y="6117"/>
                </a:lnTo>
                <a:lnTo>
                  <a:pt x="1329" y="6117"/>
                </a:lnTo>
                <a:lnTo>
                  <a:pt x="1329" y="6116"/>
                </a:lnTo>
                <a:lnTo>
                  <a:pt x="1329" y="6117"/>
                </a:lnTo>
                <a:lnTo>
                  <a:pt x="1336" y="6117"/>
                </a:lnTo>
                <a:lnTo>
                  <a:pt x="1336" y="6116"/>
                </a:lnTo>
                <a:lnTo>
                  <a:pt x="1336" y="6117"/>
                </a:lnTo>
                <a:lnTo>
                  <a:pt x="1339" y="6117"/>
                </a:lnTo>
                <a:lnTo>
                  <a:pt x="1339" y="6116"/>
                </a:lnTo>
                <a:lnTo>
                  <a:pt x="1339" y="6117"/>
                </a:lnTo>
                <a:lnTo>
                  <a:pt x="1346" y="6117"/>
                </a:lnTo>
                <a:lnTo>
                  <a:pt x="1346" y="6116"/>
                </a:lnTo>
                <a:lnTo>
                  <a:pt x="1346" y="6117"/>
                </a:lnTo>
                <a:lnTo>
                  <a:pt x="1362" y="6117"/>
                </a:lnTo>
                <a:lnTo>
                  <a:pt x="1362" y="6116"/>
                </a:lnTo>
                <a:lnTo>
                  <a:pt x="1362" y="6117"/>
                </a:lnTo>
                <a:lnTo>
                  <a:pt x="1367" y="6117"/>
                </a:lnTo>
                <a:lnTo>
                  <a:pt x="1367" y="6116"/>
                </a:lnTo>
                <a:lnTo>
                  <a:pt x="1367" y="6117"/>
                </a:lnTo>
                <a:lnTo>
                  <a:pt x="1394" y="6117"/>
                </a:lnTo>
                <a:lnTo>
                  <a:pt x="1394" y="6116"/>
                </a:lnTo>
                <a:lnTo>
                  <a:pt x="1394" y="6117"/>
                </a:lnTo>
                <a:lnTo>
                  <a:pt x="1446" y="6117"/>
                </a:lnTo>
                <a:lnTo>
                  <a:pt x="1446" y="6116"/>
                </a:lnTo>
                <a:lnTo>
                  <a:pt x="1446" y="6117"/>
                </a:lnTo>
                <a:lnTo>
                  <a:pt x="1453" y="6117"/>
                </a:lnTo>
                <a:lnTo>
                  <a:pt x="1453" y="6116"/>
                </a:lnTo>
                <a:lnTo>
                  <a:pt x="1453" y="6117"/>
                </a:lnTo>
                <a:lnTo>
                  <a:pt x="1464" y="6117"/>
                </a:lnTo>
                <a:lnTo>
                  <a:pt x="1464" y="6116"/>
                </a:lnTo>
                <a:lnTo>
                  <a:pt x="1464" y="6117"/>
                </a:lnTo>
                <a:lnTo>
                  <a:pt x="1486" y="6117"/>
                </a:lnTo>
                <a:lnTo>
                  <a:pt x="1486" y="6116"/>
                </a:lnTo>
                <a:lnTo>
                  <a:pt x="1486" y="6117"/>
                </a:lnTo>
                <a:lnTo>
                  <a:pt x="1494" y="6117"/>
                </a:lnTo>
                <a:lnTo>
                  <a:pt x="1494" y="6117"/>
                </a:lnTo>
                <a:lnTo>
                  <a:pt x="1494" y="6117"/>
                </a:lnTo>
                <a:lnTo>
                  <a:pt x="1495" y="6116"/>
                </a:lnTo>
                <a:lnTo>
                  <a:pt x="1495" y="6117"/>
                </a:lnTo>
                <a:lnTo>
                  <a:pt x="1517" y="6117"/>
                </a:lnTo>
                <a:lnTo>
                  <a:pt x="1517" y="6116"/>
                </a:lnTo>
                <a:lnTo>
                  <a:pt x="1517" y="6117"/>
                </a:lnTo>
                <a:lnTo>
                  <a:pt x="1533" y="6117"/>
                </a:lnTo>
                <a:lnTo>
                  <a:pt x="1533" y="6115"/>
                </a:lnTo>
                <a:lnTo>
                  <a:pt x="1533" y="6117"/>
                </a:lnTo>
                <a:lnTo>
                  <a:pt x="1547" y="6117"/>
                </a:lnTo>
                <a:lnTo>
                  <a:pt x="1547" y="6116"/>
                </a:lnTo>
                <a:lnTo>
                  <a:pt x="1547" y="6117"/>
                </a:lnTo>
                <a:lnTo>
                  <a:pt x="1580" y="6117"/>
                </a:lnTo>
                <a:lnTo>
                  <a:pt x="1580" y="6116"/>
                </a:lnTo>
                <a:lnTo>
                  <a:pt x="1580" y="6117"/>
                </a:lnTo>
                <a:lnTo>
                  <a:pt x="1591" y="6117"/>
                </a:lnTo>
                <a:lnTo>
                  <a:pt x="1591" y="6116"/>
                </a:lnTo>
                <a:lnTo>
                  <a:pt x="1591" y="6117"/>
                </a:lnTo>
                <a:lnTo>
                  <a:pt x="1594" y="6117"/>
                </a:lnTo>
                <a:lnTo>
                  <a:pt x="1594" y="6116"/>
                </a:lnTo>
                <a:lnTo>
                  <a:pt x="1594" y="6117"/>
                </a:lnTo>
                <a:lnTo>
                  <a:pt x="1595" y="6087"/>
                </a:lnTo>
                <a:lnTo>
                  <a:pt x="1595" y="6117"/>
                </a:lnTo>
                <a:lnTo>
                  <a:pt x="1600" y="6117"/>
                </a:lnTo>
                <a:lnTo>
                  <a:pt x="1600" y="6116"/>
                </a:lnTo>
                <a:lnTo>
                  <a:pt x="1600" y="6117"/>
                </a:lnTo>
                <a:lnTo>
                  <a:pt x="1603" y="6117"/>
                </a:lnTo>
                <a:lnTo>
                  <a:pt x="1603" y="6116"/>
                </a:lnTo>
                <a:lnTo>
                  <a:pt x="1603" y="6117"/>
                </a:lnTo>
                <a:lnTo>
                  <a:pt x="1604" y="6116"/>
                </a:lnTo>
                <a:lnTo>
                  <a:pt x="1604" y="6117"/>
                </a:lnTo>
                <a:lnTo>
                  <a:pt x="1605" y="6116"/>
                </a:lnTo>
                <a:lnTo>
                  <a:pt x="1605" y="6117"/>
                </a:lnTo>
                <a:lnTo>
                  <a:pt x="1639" y="6117"/>
                </a:lnTo>
                <a:lnTo>
                  <a:pt x="1639" y="6116"/>
                </a:lnTo>
                <a:lnTo>
                  <a:pt x="1639" y="6117"/>
                </a:lnTo>
                <a:lnTo>
                  <a:pt x="1641" y="6117"/>
                </a:lnTo>
                <a:lnTo>
                  <a:pt x="1641" y="6116"/>
                </a:lnTo>
                <a:lnTo>
                  <a:pt x="1641" y="6117"/>
                </a:lnTo>
                <a:lnTo>
                  <a:pt x="1646" y="6117"/>
                </a:lnTo>
                <a:lnTo>
                  <a:pt x="1646" y="6116"/>
                </a:lnTo>
                <a:lnTo>
                  <a:pt x="1646" y="6117"/>
                </a:lnTo>
                <a:lnTo>
                  <a:pt x="1647" y="6116"/>
                </a:lnTo>
                <a:lnTo>
                  <a:pt x="1647" y="6117"/>
                </a:lnTo>
                <a:lnTo>
                  <a:pt x="1658" y="6117"/>
                </a:lnTo>
                <a:lnTo>
                  <a:pt x="1658" y="6116"/>
                </a:lnTo>
                <a:lnTo>
                  <a:pt x="1658" y="6117"/>
                </a:lnTo>
                <a:lnTo>
                  <a:pt x="1666" y="6117"/>
                </a:lnTo>
                <a:lnTo>
                  <a:pt x="1666" y="6116"/>
                </a:lnTo>
                <a:lnTo>
                  <a:pt x="1666" y="6117"/>
                </a:lnTo>
                <a:lnTo>
                  <a:pt x="1671" y="6117"/>
                </a:lnTo>
                <a:lnTo>
                  <a:pt x="1671" y="6116"/>
                </a:lnTo>
                <a:lnTo>
                  <a:pt x="1671" y="6117"/>
                </a:lnTo>
                <a:lnTo>
                  <a:pt x="1681" y="6117"/>
                </a:lnTo>
                <a:lnTo>
                  <a:pt x="1681" y="6116"/>
                </a:lnTo>
                <a:lnTo>
                  <a:pt x="1681" y="6117"/>
                </a:lnTo>
                <a:lnTo>
                  <a:pt x="1692" y="6117"/>
                </a:lnTo>
                <a:lnTo>
                  <a:pt x="1692" y="6116"/>
                </a:lnTo>
                <a:lnTo>
                  <a:pt x="1692" y="6117"/>
                </a:lnTo>
                <a:lnTo>
                  <a:pt x="1697" y="6117"/>
                </a:lnTo>
                <a:lnTo>
                  <a:pt x="1697" y="6116"/>
                </a:lnTo>
                <a:lnTo>
                  <a:pt x="1697" y="6117"/>
                </a:lnTo>
                <a:lnTo>
                  <a:pt x="1698" y="6117"/>
                </a:lnTo>
                <a:lnTo>
                  <a:pt x="1714" y="6117"/>
                </a:lnTo>
                <a:lnTo>
                  <a:pt x="1714" y="6116"/>
                </a:lnTo>
                <a:lnTo>
                  <a:pt x="1714" y="6117"/>
                </a:lnTo>
                <a:lnTo>
                  <a:pt x="1725" y="6117"/>
                </a:lnTo>
                <a:lnTo>
                  <a:pt x="1725" y="6116"/>
                </a:lnTo>
                <a:lnTo>
                  <a:pt x="1725" y="6117"/>
                </a:lnTo>
                <a:lnTo>
                  <a:pt x="1727" y="6117"/>
                </a:lnTo>
                <a:lnTo>
                  <a:pt x="1727" y="6116"/>
                </a:lnTo>
                <a:lnTo>
                  <a:pt x="1727" y="6117"/>
                </a:lnTo>
                <a:lnTo>
                  <a:pt x="1743" y="6117"/>
                </a:lnTo>
                <a:lnTo>
                  <a:pt x="1743" y="6116"/>
                </a:lnTo>
                <a:lnTo>
                  <a:pt x="1743" y="6117"/>
                </a:lnTo>
                <a:lnTo>
                  <a:pt x="1751" y="6117"/>
                </a:lnTo>
                <a:lnTo>
                  <a:pt x="1751" y="6116"/>
                </a:lnTo>
                <a:lnTo>
                  <a:pt x="1751" y="6117"/>
                </a:lnTo>
                <a:lnTo>
                  <a:pt x="1795" y="6117"/>
                </a:lnTo>
                <a:lnTo>
                  <a:pt x="1795" y="6116"/>
                </a:lnTo>
                <a:lnTo>
                  <a:pt x="1795" y="6117"/>
                </a:lnTo>
                <a:lnTo>
                  <a:pt x="1799" y="6117"/>
                </a:lnTo>
                <a:lnTo>
                  <a:pt x="1799" y="6116"/>
                </a:lnTo>
                <a:lnTo>
                  <a:pt x="1799" y="6117"/>
                </a:lnTo>
                <a:lnTo>
                  <a:pt x="1812" y="6117"/>
                </a:lnTo>
                <a:lnTo>
                  <a:pt x="1812" y="6116"/>
                </a:lnTo>
                <a:lnTo>
                  <a:pt x="1812" y="6117"/>
                </a:lnTo>
                <a:lnTo>
                  <a:pt x="1834" y="6117"/>
                </a:lnTo>
                <a:lnTo>
                  <a:pt x="1834" y="6116"/>
                </a:lnTo>
                <a:lnTo>
                  <a:pt x="1834" y="6117"/>
                </a:lnTo>
                <a:lnTo>
                  <a:pt x="1840" y="6117"/>
                </a:lnTo>
                <a:lnTo>
                  <a:pt x="1840" y="6117"/>
                </a:lnTo>
                <a:lnTo>
                  <a:pt x="1840" y="6117"/>
                </a:lnTo>
                <a:lnTo>
                  <a:pt x="1841" y="6116"/>
                </a:lnTo>
                <a:lnTo>
                  <a:pt x="1841" y="6117"/>
                </a:lnTo>
                <a:lnTo>
                  <a:pt x="1844" y="6117"/>
                </a:lnTo>
                <a:lnTo>
                  <a:pt x="1844" y="6116"/>
                </a:lnTo>
                <a:lnTo>
                  <a:pt x="1844" y="6117"/>
                </a:lnTo>
                <a:lnTo>
                  <a:pt x="1852" y="6117"/>
                </a:lnTo>
                <a:lnTo>
                  <a:pt x="1852" y="6116"/>
                </a:lnTo>
                <a:lnTo>
                  <a:pt x="1852" y="6117"/>
                </a:lnTo>
                <a:lnTo>
                  <a:pt x="1873" y="6117"/>
                </a:lnTo>
                <a:lnTo>
                  <a:pt x="1873" y="6116"/>
                </a:lnTo>
                <a:lnTo>
                  <a:pt x="1873" y="6117"/>
                </a:lnTo>
                <a:lnTo>
                  <a:pt x="1904" y="6117"/>
                </a:lnTo>
                <a:lnTo>
                  <a:pt x="1904" y="6116"/>
                </a:lnTo>
                <a:lnTo>
                  <a:pt x="1904" y="6117"/>
                </a:lnTo>
                <a:lnTo>
                  <a:pt x="1934" y="6117"/>
                </a:lnTo>
                <a:lnTo>
                  <a:pt x="1934" y="6116"/>
                </a:lnTo>
                <a:lnTo>
                  <a:pt x="1934" y="6117"/>
                </a:lnTo>
                <a:lnTo>
                  <a:pt x="1949" y="6117"/>
                </a:lnTo>
                <a:lnTo>
                  <a:pt x="1949" y="6116"/>
                </a:lnTo>
                <a:lnTo>
                  <a:pt x="1949" y="6117"/>
                </a:lnTo>
                <a:lnTo>
                  <a:pt x="1952" y="6117"/>
                </a:lnTo>
                <a:lnTo>
                  <a:pt x="1952" y="6116"/>
                </a:lnTo>
                <a:lnTo>
                  <a:pt x="1952" y="6117"/>
                </a:lnTo>
                <a:lnTo>
                  <a:pt x="1955" y="6117"/>
                </a:lnTo>
                <a:lnTo>
                  <a:pt x="1955" y="6116"/>
                </a:lnTo>
                <a:lnTo>
                  <a:pt x="1955" y="6117"/>
                </a:lnTo>
                <a:lnTo>
                  <a:pt x="1968" y="6117"/>
                </a:lnTo>
                <a:lnTo>
                  <a:pt x="1968" y="6116"/>
                </a:lnTo>
                <a:lnTo>
                  <a:pt x="1968" y="6117"/>
                </a:lnTo>
                <a:lnTo>
                  <a:pt x="1992" y="6117"/>
                </a:lnTo>
                <a:lnTo>
                  <a:pt x="1992" y="6116"/>
                </a:lnTo>
                <a:lnTo>
                  <a:pt x="1992" y="6117"/>
                </a:lnTo>
                <a:lnTo>
                  <a:pt x="1993" y="6116"/>
                </a:lnTo>
                <a:lnTo>
                  <a:pt x="1993" y="6117"/>
                </a:lnTo>
                <a:lnTo>
                  <a:pt x="1994" y="6116"/>
                </a:lnTo>
                <a:lnTo>
                  <a:pt x="1994" y="6117"/>
                </a:lnTo>
                <a:lnTo>
                  <a:pt x="1995" y="6115"/>
                </a:lnTo>
                <a:lnTo>
                  <a:pt x="1995" y="6117"/>
                </a:lnTo>
                <a:lnTo>
                  <a:pt x="1996" y="6117"/>
                </a:lnTo>
                <a:lnTo>
                  <a:pt x="1996" y="6116"/>
                </a:lnTo>
                <a:lnTo>
                  <a:pt x="1997" y="6117"/>
                </a:lnTo>
                <a:lnTo>
                  <a:pt x="1997" y="6112"/>
                </a:lnTo>
                <a:lnTo>
                  <a:pt x="1998" y="6095"/>
                </a:lnTo>
                <a:lnTo>
                  <a:pt x="1998" y="6117"/>
                </a:lnTo>
                <a:lnTo>
                  <a:pt x="1999" y="6107"/>
                </a:lnTo>
                <a:lnTo>
                  <a:pt x="1999" y="6117"/>
                </a:lnTo>
                <a:lnTo>
                  <a:pt x="2000" y="6114"/>
                </a:lnTo>
                <a:lnTo>
                  <a:pt x="2000" y="6117"/>
                </a:lnTo>
                <a:lnTo>
                  <a:pt x="2001" y="6116"/>
                </a:lnTo>
                <a:lnTo>
                  <a:pt x="2001" y="6117"/>
                </a:lnTo>
                <a:lnTo>
                  <a:pt x="2002" y="6116"/>
                </a:lnTo>
                <a:lnTo>
                  <a:pt x="2002" y="6117"/>
                </a:lnTo>
                <a:lnTo>
                  <a:pt x="2003" y="6116"/>
                </a:lnTo>
                <a:lnTo>
                  <a:pt x="2003" y="6117"/>
                </a:lnTo>
                <a:lnTo>
                  <a:pt x="2004" y="6116"/>
                </a:lnTo>
                <a:lnTo>
                  <a:pt x="2004" y="6117"/>
                </a:lnTo>
                <a:lnTo>
                  <a:pt x="2006" y="6117"/>
                </a:lnTo>
                <a:lnTo>
                  <a:pt x="2006" y="6116"/>
                </a:lnTo>
                <a:lnTo>
                  <a:pt x="2006" y="6117"/>
                </a:lnTo>
                <a:lnTo>
                  <a:pt x="2009" y="6117"/>
                </a:lnTo>
                <a:lnTo>
                  <a:pt x="2009" y="6116"/>
                </a:lnTo>
                <a:lnTo>
                  <a:pt x="2009" y="6117"/>
                </a:lnTo>
                <a:lnTo>
                  <a:pt x="2012" y="6117"/>
                </a:lnTo>
                <a:lnTo>
                  <a:pt x="2012" y="6116"/>
                </a:lnTo>
                <a:lnTo>
                  <a:pt x="2012" y="6117"/>
                </a:lnTo>
                <a:lnTo>
                  <a:pt x="2013" y="6116"/>
                </a:lnTo>
                <a:lnTo>
                  <a:pt x="2013" y="6117"/>
                </a:lnTo>
                <a:lnTo>
                  <a:pt x="2025" y="6117"/>
                </a:lnTo>
                <a:lnTo>
                  <a:pt x="2025" y="6116"/>
                </a:lnTo>
                <a:lnTo>
                  <a:pt x="2025" y="6117"/>
                </a:lnTo>
                <a:lnTo>
                  <a:pt x="2027" y="6117"/>
                </a:lnTo>
                <a:lnTo>
                  <a:pt x="2027" y="6116"/>
                </a:lnTo>
                <a:lnTo>
                  <a:pt x="2027" y="6117"/>
                </a:lnTo>
                <a:lnTo>
                  <a:pt x="2028" y="6116"/>
                </a:lnTo>
                <a:lnTo>
                  <a:pt x="2028" y="6117"/>
                </a:lnTo>
                <a:lnTo>
                  <a:pt x="2031" y="6117"/>
                </a:lnTo>
                <a:lnTo>
                  <a:pt x="2031" y="6116"/>
                </a:lnTo>
                <a:lnTo>
                  <a:pt x="2031" y="6117"/>
                </a:lnTo>
                <a:lnTo>
                  <a:pt x="2034" y="6117"/>
                </a:lnTo>
                <a:lnTo>
                  <a:pt x="2034" y="6116"/>
                </a:lnTo>
                <a:lnTo>
                  <a:pt x="2034" y="6117"/>
                </a:lnTo>
                <a:lnTo>
                  <a:pt x="2046" y="6117"/>
                </a:lnTo>
                <a:lnTo>
                  <a:pt x="2046" y="6116"/>
                </a:lnTo>
                <a:lnTo>
                  <a:pt x="2046" y="6117"/>
                </a:lnTo>
                <a:lnTo>
                  <a:pt x="2047" y="6116"/>
                </a:lnTo>
                <a:lnTo>
                  <a:pt x="2047" y="6117"/>
                </a:lnTo>
                <a:lnTo>
                  <a:pt x="2048" y="6116"/>
                </a:lnTo>
                <a:lnTo>
                  <a:pt x="2048" y="6117"/>
                </a:lnTo>
                <a:lnTo>
                  <a:pt x="2059" y="6117"/>
                </a:lnTo>
                <a:lnTo>
                  <a:pt x="2059" y="6116"/>
                </a:lnTo>
                <a:lnTo>
                  <a:pt x="2059" y="6117"/>
                </a:lnTo>
                <a:lnTo>
                  <a:pt x="2091" y="6117"/>
                </a:lnTo>
                <a:lnTo>
                  <a:pt x="2091" y="6116"/>
                </a:lnTo>
                <a:lnTo>
                  <a:pt x="2091" y="6117"/>
                </a:lnTo>
                <a:lnTo>
                  <a:pt x="2096" y="6117"/>
                </a:lnTo>
                <a:lnTo>
                  <a:pt x="2096" y="6116"/>
                </a:lnTo>
                <a:lnTo>
                  <a:pt x="2096" y="6117"/>
                </a:lnTo>
                <a:lnTo>
                  <a:pt x="2109" y="6117"/>
                </a:lnTo>
                <a:lnTo>
                  <a:pt x="2109" y="6116"/>
                </a:lnTo>
                <a:lnTo>
                  <a:pt x="2109" y="6117"/>
                </a:lnTo>
                <a:lnTo>
                  <a:pt x="2110" y="6116"/>
                </a:lnTo>
                <a:lnTo>
                  <a:pt x="2110" y="6117"/>
                </a:lnTo>
                <a:lnTo>
                  <a:pt x="2119" y="6117"/>
                </a:lnTo>
                <a:lnTo>
                  <a:pt x="2119" y="6116"/>
                </a:lnTo>
                <a:lnTo>
                  <a:pt x="2119" y="6117"/>
                </a:lnTo>
                <a:lnTo>
                  <a:pt x="2120" y="6116"/>
                </a:lnTo>
                <a:lnTo>
                  <a:pt x="2120" y="6117"/>
                </a:lnTo>
                <a:lnTo>
                  <a:pt x="2144" y="6117"/>
                </a:lnTo>
                <a:lnTo>
                  <a:pt x="2144" y="6116"/>
                </a:lnTo>
                <a:lnTo>
                  <a:pt x="2144" y="6117"/>
                </a:lnTo>
                <a:lnTo>
                  <a:pt x="2155" y="6117"/>
                </a:lnTo>
                <a:lnTo>
                  <a:pt x="2155" y="6116"/>
                </a:lnTo>
                <a:lnTo>
                  <a:pt x="2155" y="6117"/>
                </a:lnTo>
                <a:lnTo>
                  <a:pt x="2157" y="6117"/>
                </a:lnTo>
                <a:lnTo>
                  <a:pt x="2157" y="6116"/>
                </a:lnTo>
                <a:lnTo>
                  <a:pt x="2157" y="6117"/>
                </a:lnTo>
                <a:lnTo>
                  <a:pt x="2172" y="6117"/>
                </a:lnTo>
                <a:lnTo>
                  <a:pt x="2172" y="6116"/>
                </a:lnTo>
                <a:lnTo>
                  <a:pt x="2172" y="6117"/>
                </a:lnTo>
                <a:lnTo>
                  <a:pt x="2190" y="6117"/>
                </a:lnTo>
                <a:lnTo>
                  <a:pt x="2190" y="6116"/>
                </a:lnTo>
                <a:lnTo>
                  <a:pt x="2190" y="6117"/>
                </a:lnTo>
                <a:lnTo>
                  <a:pt x="2200" y="6117"/>
                </a:lnTo>
                <a:lnTo>
                  <a:pt x="2200" y="6116"/>
                </a:lnTo>
                <a:lnTo>
                  <a:pt x="2200" y="6117"/>
                </a:lnTo>
                <a:lnTo>
                  <a:pt x="2222" y="6117"/>
                </a:lnTo>
                <a:lnTo>
                  <a:pt x="2222" y="6116"/>
                </a:lnTo>
                <a:lnTo>
                  <a:pt x="2222" y="6117"/>
                </a:lnTo>
                <a:lnTo>
                  <a:pt x="2231" y="6117"/>
                </a:lnTo>
                <a:lnTo>
                  <a:pt x="2231" y="6116"/>
                </a:lnTo>
                <a:lnTo>
                  <a:pt x="2231" y="6117"/>
                </a:lnTo>
                <a:lnTo>
                  <a:pt x="2233" y="6117"/>
                </a:lnTo>
                <a:lnTo>
                  <a:pt x="2233" y="6116"/>
                </a:lnTo>
                <a:lnTo>
                  <a:pt x="2233" y="6117"/>
                </a:lnTo>
                <a:lnTo>
                  <a:pt x="2261" y="6117"/>
                </a:lnTo>
                <a:lnTo>
                  <a:pt x="2261" y="6116"/>
                </a:lnTo>
                <a:lnTo>
                  <a:pt x="2261" y="6117"/>
                </a:lnTo>
                <a:lnTo>
                  <a:pt x="2292" y="6117"/>
                </a:lnTo>
                <a:lnTo>
                  <a:pt x="2292" y="6116"/>
                </a:lnTo>
                <a:lnTo>
                  <a:pt x="2292" y="6117"/>
                </a:lnTo>
                <a:lnTo>
                  <a:pt x="2295" y="6117"/>
                </a:lnTo>
                <a:lnTo>
                  <a:pt x="2296" y="6116"/>
                </a:lnTo>
                <a:lnTo>
                  <a:pt x="2296" y="6117"/>
                </a:lnTo>
                <a:lnTo>
                  <a:pt x="2297" y="6116"/>
                </a:lnTo>
                <a:lnTo>
                  <a:pt x="2297" y="6117"/>
                </a:lnTo>
                <a:lnTo>
                  <a:pt x="2298" y="6116"/>
                </a:lnTo>
                <a:lnTo>
                  <a:pt x="2298" y="6117"/>
                </a:lnTo>
                <a:lnTo>
                  <a:pt x="2301" y="6117"/>
                </a:lnTo>
                <a:lnTo>
                  <a:pt x="2301" y="6116"/>
                </a:lnTo>
                <a:lnTo>
                  <a:pt x="2301" y="6117"/>
                </a:lnTo>
                <a:lnTo>
                  <a:pt x="2303" y="6117"/>
                </a:lnTo>
                <a:lnTo>
                  <a:pt x="2303" y="6116"/>
                </a:lnTo>
                <a:lnTo>
                  <a:pt x="2303" y="6117"/>
                </a:lnTo>
                <a:lnTo>
                  <a:pt x="2310" y="6117"/>
                </a:lnTo>
                <a:lnTo>
                  <a:pt x="2310" y="6116"/>
                </a:lnTo>
                <a:lnTo>
                  <a:pt x="2310" y="6117"/>
                </a:lnTo>
                <a:lnTo>
                  <a:pt x="2331" y="6117"/>
                </a:lnTo>
                <a:lnTo>
                  <a:pt x="2331" y="6116"/>
                </a:lnTo>
                <a:lnTo>
                  <a:pt x="2331" y="6117"/>
                </a:lnTo>
                <a:lnTo>
                  <a:pt x="2336" y="6117"/>
                </a:lnTo>
                <a:lnTo>
                  <a:pt x="2336" y="6116"/>
                </a:lnTo>
                <a:lnTo>
                  <a:pt x="2336" y="6117"/>
                </a:lnTo>
                <a:lnTo>
                  <a:pt x="2356" y="6117"/>
                </a:lnTo>
                <a:lnTo>
                  <a:pt x="2356" y="6116"/>
                </a:lnTo>
                <a:lnTo>
                  <a:pt x="2356" y="6117"/>
                </a:lnTo>
                <a:lnTo>
                  <a:pt x="2362" y="6117"/>
                </a:lnTo>
                <a:lnTo>
                  <a:pt x="2362" y="6116"/>
                </a:lnTo>
                <a:lnTo>
                  <a:pt x="2362" y="6117"/>
                </a:lnTo>
                <a:lnTo>
                  <a:pt x="2367" y="6117"/>
                </a:lnTo>
                <a:lnTo>
                  <a:pt x="2367" y="6116"/>
                </a:lnTo>
                <a:lnTo>
                  <a:pt x="2367" y="6117"/>
                </a:lnTo>
                <a:lnTo>
                  <a:pt x="2373" y="6117"/>
                </a:lnTo>
                <a:lnTo>
                  <a:pt x="2373" y="6116"/>
                </a:lnTo>
                <a:lnTo>
                  <a:pt x="2373" y="6117"/>
                </a:lnTo>
                <a:lnTo>
                  <a:pt x="2406" y="6117"/>
                </a:lnTo>
                <a:lnTo>
                  <a:pt x="2406" y="6116"/>
                </a:lnTo>
                <a:lnTo>
                  <a:pt x="2406" y="6117"/>
                </a:lnTo>
                <a:lnTo>
                  <a:pt x="2424" y="6117"/>
                </a:lnTo>
                <a:lnTo>
                  <a:pt x="2424" y="6116"/>
                </a:lnTo>
                <a:lnTo>
                  <a:pt x="2424" y="6117"/>
                </a:lnTo>
                <a:lnTo>
                  <a:pt x="2442" y="6117"/>
                </a:lnTo>
                <a:lnTo>
                  <a:pt x="2442" y="6117"/>
                </a:lnTo>
                <a:lnTo>
                  <a:pt x="2442" y="6116"/>
                </a:lnTo>
                <a:lnTo>
                  <a:pt x="2443" y="6116"/>
                </a:lnTo>
                <a:lnTo>
                  <a:pt x="2443" y="6117"/>
                </a:lnTo>
                <a:lnTo>
                  <a:pt x="2449" y="6117"/>
                </a:lnTo>
                <a:lnTo>
                  <a:pt x="2449" y="6116"/>
                </a:lnTo>
                <a:lnTo>
                  <a:pt x="2449" y="6117"/>
                </a:lnTo>
                <a:lnTo>
                  <a:pt x="2455" y="6117"/>
                </a:lnTo>
                <a:lnTo>
                  <a:pt x="2455" y="6116"/>
                </a:lnTo>
                <a:lnTo>
                  <a:pt x="2455" y="6117"/>
                </a:lnTo>
                <a:lnTo>
                  <a:pt x="2462" y="6117"/>
                </a:lnTo>
                <a:lnTo>
                  <a:pt x="2462" y="6116"/>
                </a:lnTo>
                <a:lnTo>
                  <a:pt x="2462" y="6117"/>
                </a:lnTo>
                <a:lnTo>
                  <a:pt x="2482" y="6117"/>
                </a:lnTo>
                <a:lnTo>
                  <a:pt x="2482" y="6116"/>
                </a:lnTo>
                <a:lnTo>
                  <a:pt x="2482" y="6117"/>
                </a:lnTo>
                <a:lnTo>
                  <a:pt x="2484" y="6117"/>
                </a:lnTo>
                <a:lnTo>
                  <a:pt x="2484" y="6116"/>
                </a:lnTo>
                <a:lnTo>
                  <a:pt x="2484" y="6117"/>
                </a:lnTo>
                <a:lnTo>
                  <a:pt x="2517" y="6117"/>
                </a:lnTo>
                <a:lnTo>
                  <a:pt x="2517" y="6116"/>
                </a:lnTo>
                <a:lnTo>
                  <a:pt x="2517" y="6117"/>
                </a:lnTo>
                <a:lnTo>
                  <a:pt x="2523" y="6117"/>
                </a:lnTo>
                <a:lnTo>
                  <a:pt x="2523" y="6116"/>
                </a:lnTo>
                <a:lnTo>
                  <a:pt x="2523" y="6117"/>
                </a:lnTo>
                <a:lnTo>
                  <a:pt x="2530" y="6117"/>
                </a:lnTo>
                <a:lnTo>
                  <a:pt x="2530" y="6116"/>
                </a:lnTo>
                <a:lnTo>
                  <a:pt x="2530" y="6117"/>
                </a:lnTo>
                <a:lnTo>
                  <a:pt x="2534" y="6117"/>
                </a:lnTo>
                <a:lnTo>
                  <a:pt x="2534" y="6116"/>
                </a:lnTo>
                <a:lnTo>
                  <a:pt x="2534" y="6117"/>
                </a:lnTo>
                <a:lnTo>
                  <a:pt x="2542" y="6117"/>
                </a:lnTo>
                <a:lnTo>
                  <a:pt x="2542" y="6117"/>
                </a:lnTo>
                <a:lnTo>
                  <a:pt x="2542" y="6115"/>
                </a:lnTo>
                <a:lnTo>
                  <a:pt x="2543" y="6116"/>
                </a:lnTo>
                <a:lnTo>
                  <a:pt x="2543" y="6117"/>
                </a:lnTo>
                <a:lnTo>
                  <a:pt x="2545" y="6117"/>
                </a:lnTo>
                <a:lnTo>
                  <a:pt x="2545" y="6116"/>
                </a:lnTo>
                <a:lnTo>
                  <a:pt x="2545" y="6117"/>
                </a:lnTo>
                <a:lnTo>
                  <a:pt x="2551" y="6117"/>
                </a:lnTo>
                <a:lnTo>
                  <a:pt x="2551" y="6116"/>
                </a:lnTo>
                <a:lnTo>
                  <a:pt x="2551" y="6117"/>
                </a:lnTo>
                <a:lnTo>
                  <a:pt x="2552" y="6116"/>
                </a:lnTo>
                <a:lnTo>
                  <a:pt x="2552" y="6117"/>
                </a:lnTo>
                <a:lnTo>
                  <a:pt x="2564" y="6117"/>
                </a:lnTo>
                <a:lnTo>
                  <a:pt x="2564" y="6116"/>
                </a:lnTo>
                <a:lnTo>
                  <a:pt x="2564" y="6117"/>
                </a:lnTo>
                <a:lnTo>
                  <a:pt x="2591" y="6117"/>
                </a:lnTo>
                <a:lnTo>
                  <a:pt x="2591" y="6116"/>
                </a:lnTo>
                <a:lnTo>
                  <a:pt x="2591" y="6117"/>
                </a:lnTo>
                <a:lnTo>
                  <a:pt x="2637" y="6117"/>
                </a:lnTo>
                <a:lnTo>
                  <a:pt x="2637" y="6116"/>
                </a:lnTo>
                <a:lnTo>
                  <a:pt x="2637" y="6117"/>
                </a:lnTo>
                <a:lnTo>
                  <a:pt x="2644" y="6117"/>
                </a:lnTo>
                <a:lnTo>
                  <a:pt x="2644" y="6116"/>
                </a:lnTo>
                <a:lnTo>
                  <a:pt x="2644" y="6117"/>
                </a:lnTo>
                <a:lnTo>
                  <a:pt x="2647" y="6117"/>
                </a:lnTo>
                <a:lnTo>
                  <a:pt x="2647" y="6116"/>
                </a:lnTo>
                <a:lnTo>
                  <a:pt x="2647" y="6117"/>
                </a:lnTo>
                <a:lnTo>
                  <a:pt x="2669" y="6117"/>
                </a:lnTo>
                <a:lnTo>
                  <a:pt x="2669" y="6116"/>
                </a:lnTo>
                <a:lnTo>
                  <a:pt x="2669" y="6117"/>
                </a:lnTo>
                <a:lnTo>
                  <a:pt x="2673" y="6117"/>
                </a:lnTo>
                <a:lnTo>
                  <a:pt x="2673" y="6116"/>
                </a:lnTo>
                <a:lnTo>
                  <a:pt x="2673" y="6117"/>
                </a:lnTo>
                <a:lnTo>
                  <a:pt x="2683" y="6117"/>
                </a:lnTo>
                <a:lnTo>
                  <a:pt x="2683" y="6116"/>
                </a:lnTo>
                <a:lnTo>
                  <a:pt x="2683" y="6117"/>
                </a:lnTo>
                <a:lnTo>
                  <a:pt x="2700" y="6117"/>
                </a:lnTo>
                <a:lnTo>
                  <a:pt x="2700" y="6116"/>
                </a:lnTo>
                <a:lnTo>
                  <a:pt x="2700" y="6117"/>
                </a:lnTo>
                <a:lnTo>
                  <a:pt x="2719" y="6117"/>
                </a:lnTo>
                <a:lnTo>
                  <a:pt x="2719" y="6116"/>
                </a:lnTo>
                <a:lnTo>
                  <a:pt x="2719" y="6117"/>
                </a:lnTo>
                <a:lnTo>
                  <a:pt x="2780" y="6117"/>
                </a:lnTo>
                <a:lnTo>
                  <a:pt x="2780" y="6116"/>
                </a:lnTo>
                <a:lnTo>
                  <a:pt x="2780" y="6117"/>
                </a:lnTo>
                <a:lnTo>
                  <a:pt x="2793" y="6117"/>
                </a:lnTo>
                <a:lnTo>
                  <a:pt x="2793" y="6116"/>
                </a:lnTo>
                <a:lnTo>
                  <a:pt x="2793" y="6117"/>
                </a:lnTo>
                <a:lnTo>
                  <a:pt x="2797" y="6117"/>
                </a:lnTo>
                <a:lnTo>
                  <a:pt x="2797" y="6116"/>
                </a:lnTo>
                <a:lnTo>
                  <a:pt x="2797" y="6117"/>
                </a:lnTo>
                <a:lnTo>
                  <a:pt x="2808" y="6117"/>
                </a:lnTo>
                <a:lnTo>
                  <a:pt x="2808" y="6116"/>
                </a:lnTo>
                <a:lnTo>
                  <a:pt x="2808" y="6117"/>
                </a:lnTo>
                <a:lnTo>
                  <a:pt x="2832" y="6117"/>
                </a:lnTo>
                <a:lnTo>
                  <a:pt x="2832" y="6116"/>
                </a:lnTo>
                <a:lnTo>
                  <a:pt x="2832" y="6117"/>
                </a:lnTo>
                <a:lnTo>
                  <a:pt x="2835" y="6117"/>
                </a:lnTo>
                <a:lnTo>
                  <a:pt x="2835" y="6116"/>
                </a:lnTo>
                <a:lnTo>
                  <a:pt x="2835" y="6117"/>
                </a:lnTo>
                <a:lnTo>
                  <a:pt x="2870" y="6117"/>
                </a:lnTo>
                <a:lnTo>
                  <a:pt x="2870" y="6116"/>
                </a:lnTo>
                <a:lnTo>
                  <a:pt x="2870" y="6117"/>
                </a:lnTo>
                <a:lnTo>
                  <a:pt x="2893" y="6117"/>
                </a:lnTo>
                <a:lnTo>
                  <a:pt x="2893" y="6116"/>
                </a:lnTo>
                <a:lnTo>
                  <a:pt x="2893" y="6117"/>
                </a:lnTo>
                <a:lnTo>
                  <a:pt x="2920" y="6117"/>
                </a:lnTo>
                <a:lnTo>
                  <a:pt x="2920" y="6116"/>
                </a:lnTo>
                <a:lnTo>
                  <a:pt x="2920" y="6117"/>
                </a:lnTo>
                <a:lnTo>
                  <a:pt x="2925" y="6117"/>
                </a:lnTo>
                <a:lnTo>
                  <a:pt x="2925" y="6116"/>
                </a:lnTo>
                <a:lnTo>
                  <a:pt x="2925" y="6117"/>
                </a:lnTo>
                <a:lnTo>
                  <a:pt x="2953" y="6117"/>
                </a:lnTo>
                <a:lnTo>
                  <a:pt x="2953" y="6116"/>
                </a:lnTo>
                <a:lnTo>
                  <a:pt x="2953" y="6117"/>
                </a:lnTo>
                <a:lnTo>
                  <a:pt x="2954" y="6117"/>
                </a:lnTo>
                <a:lnTo>
                  <a:pt x="2970" y="6117"/>
                </a:lnTo>
                <a:lnTo>
                  <a:pt x="2970" y="6116"/>
                </a:lnTo>
                <a:lnTo>
                  <a:pt x="2970" y="6117"/>
                </a:lnTo>
                <a:lnTo>
                  <a:pt x="2973" y="6117"/>
                </a:lnTo>
                <a:lnTo>
                  <a:pt x="2973" y="6116"/>
                </a:lnTo>
                <a:lnTo>
                  <a:pt x="2973" y="6117"/>
                </a:lnTo>
                <a:lnTo>
                  <a:pt x="3007" y="6117"/>
                </a:lnTo>
                <a:lnTo>
                  <a:pt x="3007" y="6116"/>
                </a:lnTo>
                <a:lnTo>
                  <a:pt x="3007" y="6117"/>
                </a:lnTo>
                <a:lnTo>
                  <a:pt x="3009" y="6117"/>
                </a:lnTo>
                <a:lnTo>
                  <a:pt x="3009" y="6116"/>
                </a:lnTo>
                <a:lnTo>
                  <a:pt x="3009" y="6117"/>
                </a:lnTo>
                <a:lnTo>
                  <a:pt x="3013" y="6117"/>
                </a:lnTo>
                <a:lnTo>
                  <a:pt x="3013" y="6116"/>
                </a:lnTo>
                <a:lnTo>
                  <a:pt x="3013" y="6117"/>
                </a:lnTo>
                <a:lnTo>
                  <a:pt x="3019" y="6117"/>
                </a:lnTo>
                <a:lnTo>
                  <a:pt x="3019" y="6116"/>
                </a:lnTo>
                <a:lnTo>
                  <a:pt x="3019" y="6117"/>
                </a:lnTo>
                <a:lnTo>
                  <a:pt x="3068" y="6117"/>
                </a:lnTo>
                <a:lnTo>
                  <a:pt x="3068" y="6116"/>
                </a:lnTo>
                <a:lnTo>
                  <a:pt x="3068" y="6117"/>
                </a:lnTo>
                <a:lnTo>
                  <a:pt x="3085" y="6117"/>
                </a:lnTo>
                <a:lnTo>
                  <a:pt x="3085" y="6116"/>
                </a:lnTo>
                <a:lnTo>
                  <a:pt x="3085" y="6117"/>
                </a:lnTo>
                <a:lnTo>
                  <a:pt x="3111" y="6117"/>
                </a:lnTo>
                <a:lnTo>
                  <a:pt x="3111" y="6117"/>
                </a:lnTo>
                <a:lnTo>
                  <a:pt x="3111" y="6117"/>
                </a:lnTo>
                <a:lnTo>
                  <a:pt x="3112" y="6116"/>
                </a:lnTo>
                <a:lnTo>
                  <a:pt x="3112" y="6117"/>
                </a:lnTo>
                <a:lnTo>
                  <a:pt x="3141" y="6117"/>
                </a:lnTo>
                <a:lnTo>
                  <a:pt x="3141" y="6116"/>
                </a:lnTo>
                <a:lnTo>
                  <a:pt x="3141" y="6117"/>
                </a:lnTo>
                <a:lnTo>
                  <a:pt x="3144" y="6117"/>
                </a:lnTo>
                <a:lnTo>
                  <a:pt x="3144" y="6116"/>
                </a:lnTo>
                <a:lnTo>
                  <a:pt x="3144" y="6117"/>
                </a:lnTo>
                <a:lnTo>
                  <a:pt x="3146" y="6117"/>
                </a:lnTo>
                <a:lnTo>
                  <a:pt x="3146" y="6116"/>
                </a:lnTo>
                <a:lnTo>
                  <a:pt x="3146" y="6117"/>
                </a:lnTo>
                <a:lnTo>
                  <a:pt x="3210" y="6117"/>
                </a:lnTo>
                <a:lnTo>
                  <a:pt x="3210" y="6116"/>
                </a:lnTo>
                <a:lnTo>
                  <a:pt x="3210" y="6117"/>
                </a:lnTo>
                <a:lnTo>
                  <a:pt x="3213" y="6117"/>
                </a:lnTo>
                <a:lnTo>
                  <a:pt x="3213" y="6116"/>
                </a:lnTo>
                <a:lnTo>
                  <a:pt x="3213" y="6117"/>
                </a:lnTo>
                <a:lnTo>
                  <a:pt x="3214" y="6117"/>
                </a:lnTo>
                <a:lnTo>
                  <a:pt x="3217" y="6117"/>
                </a:lnTo>
                <a:lnTo>
                  <a:pt x="3217" y="6116"/>
                </a:lnTo>
                <a:lnTo>
                  <a:pt x="3217" y="6117"/>
                </a:lnTo>
                <a:lnTo>
                  <a:pt x="3223" y="6117"/>
                </a:lnTo>
                <a:lnTo>
                  <a:pt x="3223" y="6116"/>
                </a:lnTo>
                <a:lnTo>
                  <a:pt x="3223" y="6117"/>
                </a:lnTo>
                <a:lnTo>
                  <a:pt x="3256" y="6117"/>
                </a:lnTo>
                <a:lnTo>
                  <a:pt x="3256" y="6116"/>
                </a:lnTo>
                <a:lnTo>
                  <a:pt x="3256" y="6117"/>
                </a:lnTo>
                <a:lnTo>
                  <a:pt x="3262" y="6117"/>
                </a:lnTo>
                <a:lnTo>
                  <a:pt x="3262" y="6116"/>
                </a:lnTo>
                <a:lnTo>
                  <a:pt x="3262" y="6117"/>
                </a:lnTo>
                <a:lnTo>
                  <a:pt x="3351" y="6117"/>
                </a:lnTo>
                <a:lnTo>
                  <a:pt x="3351" y="6116"/>
                </a:lnTo>
                <a:lnTo>
                  <a:pt x="3351" y="6117"/>
                </a:lnTo>
                <a:lnTo>
                  <a:pt x="3352" y="6116"/>
                </a:lnTo>
                <a:lnTo>
                  <a:pt x="3352" y="6117"/>
                </a:lnTo>
                <a:lnTo>
                  <a:pt x="3413" y="6117"/>
                </a:lnTo>
                <a:lnTo>
                  <a:pt x="3413" y="6116"/>
                </a:lnTo>
                <a:lnTo>
                  <a:pt x="3413" y="6117"/>
                </a:lnTo>
                <a:lnTo>
                  <a:pt x="3444" y="6117"/>
                </a:lnTo>
                <a:lnTo>
                  <a:pt x="3444" y="6117"/>
                </a:lnTo>
                <a:lnTo>
                  <a:pt x="3444" y="6116"/>
                </a:lnTo>
                <a:lnTo>
                  <a:pt x="3445" y="6117"/>
                </a:lnTo>
                <a:lnTo>
                  <a:pt x="3445" y="6117"/>
                </a:lnTo>
                <a:lnTo>
                  <a:pt x="3446" y="6116"/>
                </a:lnTo>
                <a:lnTo>
                  <a:pt x="3446" y="6117"/>
                </a:lnTo>
                <a:lnTo>
                  <a:pt x="3449" y="6117"/>
                </a:lnTo>
                <a:lnTo>
                  <a:pt x="3449" y="6117"/>
                </a:lnTo>
                <a:lnTo>
                  <a:pt x="3449" y="6117"/>
                </a:lnTo>
                <a:lnTo>
                  <a:pt x="3450" y="6116"/>
                </a:lnTo>
                <a:lnTo>
                  <a:pt x="3450" y="6117"/>
                </a:lnTo>
                <a:lnTo>
                  <a:pt x="3469" y="6117"/>
                </a:lnTo>
                <a:lnTo>
                  <a:pt x="3469" y="6116"/>
                </a:lnTo>
                <a:lnTo>
                  <a:pt x="3469" y="6117"/>
                </a:lnTo>
                <a:lnTo>
                  <a:pt x="3496" y="6117"/>
                </a:lnTo>
                <a:lnTo>
                  <a:pt x="3496" y="6116"/>
                </a:lnTo>
                <a:lnTo>
                  <a:pt x="3496" y="6117"/>
                </a:lnTo>
                <a:lnTo>
                  <a:pt x="3510" y="6117"/>
                </a:lnTo>
                <a:lnTo>
                  <a:pt x="3510" y="6116"/>
                </a:lnTo>
                <a:lnTo>
                  <a:pt x="3510" y="6117"/>
                </a:lnTo>
                <a:lnTo>
                  <a:pt x="3512" y="6117"/>
                </a:lnTo>
                <a:lnTo>
                  <a:pt x="3513" y="6116"/>
                </a:lnTo>
                <a:lnTo>
                  <a:pt x="3513" y="6117"/>
                </a:lnTo>
                <a:lnTo>
                  <a:pt x="3538" y="6117"/>
                </a:lnTo>
                <a:lnTo>
                  <a:pt x="3538" y="6116"/>
                </a:lnTo>
                <a:lnTo>
                  <a:pt x="3538" y="6117"/>
                </a:lnTo>
                <a:lnTo>
                  <a:pt x="3583" y="6117"/>
                </a:lnTo>
                <a:lnTo>
                  <a:pt x="3583" y="6116"/>
                </a:lnTo>
                <a:lnTo>
                  <a:pt x="3583" y="6117"/>
                </a:lnTo>
                <a:lnTo>
                  <a:pt x="3608" y="6117"/>
                </a:lnTo>
                <a:lnTo>
                  <a:pt x="3608" y="6116"/>
                </a:lnTo>
                <a:lnTo>
                  <a:pt x="3608" y="6117"/>
                </a:lnTo>
                <a:lnTo>
                  <a:pt x="3636" y="6117"/>
                </a:lnTo>
                <a:lnTo>
                  <a:pt x="3636" y="6116"/>
                </a:lnTo>
                <a:lnTo>
                  <a:pt x="3636" y="6117"/>
                </a:lnTo>
                <a:lnTo>
                  <a:pt x="3692" y="6117"/>
                </a:lnTo>
                <a:lnTo>
                  <a:pt x="3692" y="6116"/>
                </a:lnTo>
                <a:lnTo>
                  <a:pt x="3692" y="6117"/>
                </a:lnTo>
                <a:lnTo>
                  <a:pt x="3766" y="6117"/>
                </a:lnTo>
                <a:lnTo>
                  <a:pt x="3766" y="6116"/>
                </a:lnTo>
                <a:lnTo>
                  <a:pt x="3766" y="6117"/>
                </a:lnTo>
                <a:lnTo>
                  <a:pt x="3780" y="6117"/>
                </a:lnTo>
                <a:lnTo>
                  <a:pt x="3780" y="6116"/>
                </a:lnTo>
                <a:lnTo>
                  <a:pt x="3780" y="6117"/>
                </a:lnTo>
                <a:lnTo>
                  <a:pt x="3879" y="6117"/>
                </a:lnTo>
                <a:lnTo>
                  <a:pt x="3879" y="6116"/>
                </a:lnTo>
                <a:lnTo>
                  <a:pt x="3879" y="6117"/>
                </a:lnTo>
                <a:lnTo>
                  <a:pt x="3896" y="6117"/>
                </a:lnTo>
                <a:lnTo>
                  <a:pt x="3896" y="6116"/>
                </a:lnTo>
                <a:lnTo>
                  <a:pt x="3896" y="6117"/>
                </a:lnTo>
                <a:lnTo>
                  <a:pt x="3921" y="6117"/>
                </a:lnTo>
                <a:lnTo>
                  <a:pt x="3921" y="6116"/>
                </a:lnTo>
                <a:lnTo>
                  <a:pt x="3921" y="6117"/>
                </a:lnTo>
                <a:lnTo>
                  <a:pt x="3964" y="6117"/>
                </a:lnTo>
                <a:lnTo>
                  <a:pt x="3964" y="6117"/>
                </a:lnTo>
                <a:lnTo>
                  <a:pt x="3964" y="6117"/>
                </a:lnTo>
                <a:lnTo>
                  <a:pt x="3965" y="6116"/>
                </a:lnTo>
                <a:lnTo>
                  <a:pt x="3965" y="6117"/>
                </a:lnTo>
                <a:lnTo>
                  <a:pt x="3986" y="6117"/>
                </a:lnTo>
                <a:lnTo>
                  <a:pt x="3986" y="6116"/>
                </a:lnTo>
                <a:lnTo>
                  <a:pt x="3986" y="6117"/>
                </a:lnTo>
                <a:lnTo>
                  <a:pt x="3989" y="6117"/>
                </a:lnTo>
                <a:lnTo>
                  <a:pt x="3989" y="6116"/>
                </a:lnTo>
                <a:lnTo>
                  <a:pt x="3989" y="6117"/>
                </a:lnTo>
                <a:lnTo>
                  <a:pt x="4022" y="6117"/>
                </a:lnTo>
                <a:lnTo>
                  <a:pt x="4022" y="6116"/>
                </a:lnTo>
                <a:lnTo>
                  <a:pt x="4022" y="6117"/>
                </a:lnTo>
                <a:lnTo>
                  <a:pt x="4079" y="6117"/>
                </a:lnTo>
                <a:lnTo>
                  <a:pt x="4079" y="6116"/>
                </a:lnTo>
                <a:lnTo>
                  <a:pt x="4079" y="6117"/>
                </a:lnTo>
                <a:lnTo>
                  <a:pt x="4086" y="6117"/>
                </a:lnTo>
                <a:lnTo>
                  <a:pt x="4086" y="6116"/>
                </a:lnTo>
                <a:lnTo>
                  <a:pt x="4086" y="6117"/>
                </a:lnTo>
                <a:lnTo>
                  <a:pt x="4099" y="6117"/>
                </a:lnTo>
                <a:lnTo>
                  <a:pt x="4099" y="6117"/>
                </a:lnTo>
                <a:lnTo>
                  <a:pt x="4099" y="6116"/>
                </a:lnTo>
                <a:lnTo>
                  <a:pt x="4100" y="6116"/>
                </a:lnTo>
                <a:lnTo>
                  <a:pt x="4100" y="6117"/>
                </a:lnTo>
                <a:lnTo>
                  <a:pt x="4102" y="6117"/>
                </a:lnTo>
                <a:lnTo>
                  <a:pt x="4102" y="6116"/>
                </a:lnTo>
                <a:lnTo>
                  <a:pt x="4102" y="6117"/>
                </a:lnTo>
                <a:lnTo>
                  <a:pt x="4106" y="6117"/>
                </a:lnTo>
                <a:lnTo>
                  <a:pt x="4107" y="6116"/>
                </a:lnTo>
                <a:lnTo>
                  <a:pt x="4107" y="6117"/>
                </a:lnTo>
                <a:lnTo>
                  <a:pt x="4128" y="6117"/>
                </a:lnTo>
                <a:lnTo>
                  <a:pt x="4128" y="6117"/>
                </a:lnTo>
                <a:lnTo>
                  <a:pt x="4128" y="6116"/>
                </a:lnTo>
                <a:lnTo>
                  <a:pt x="4129" y="6117"/>
                </a:lnTo>
                <a:lnTo>
                  <a:pt x="4129" y="6117"/>
                </a:lnTo>
                <a:lnTo>
                  <a:pt x="4140" y="6117"/>
                </a:lnTo>
                <a:lnTo>
                  <a:pt x="4140" y="6116"/>
                </a:lnTo>
                <a:lnTo>
                  <a:pt x="4140" y="6117"/>
                </a:lnTo>
                <a:lnTo>
                  <a:pt x="4146" y="6117"/>
                </a:lnTo>
                <a:lnTo>
                  <a:pt x="4146" y="6116"/>
                </a:lnTo>
                <a:lnTo>
                  <a:pt x="4146" y="6117"/>
                </a:lnTo>
                <a:lnTo>
                  <a:pt x="4152" y="6117"/>
                </a:lnTo>
                <a:lnTo>
                  <a:pt x="4152" y="6116"/>
                </a:lnTo>
                <a:lnTo>
                  <a:pt x="4152" y="6117"/>
                </a:lnTo>
                <a:lnTo>
                  <a:pt x="4168" y="6117"/>
                </a:lnTo>
                <a:lnTo>
                  <a:pt x="4168" y="6116"/>
                </a:lnTo>
                <a:lnTo>
                  <a:pt x="4168" y="6117"/>
                </a:lnTo>
                <a:lnTo>
                  <a:pt x="4183" y="6117"/>
                </a:lnTo>
                <a:lnTo>
                  <a:pt x="4183" y="6116"/>
                </a:lnTo>
                <a:lnTo>
                  <a:pt x="4183" y="6117"/>
                </a:lnTo>
                <a:lnTo>
                  <a:pt x="4184" y="6116"/>
                </a:lnTo>
                <a:lnTo>
                  <a:pt x="4184" y="6117"/>
                </a:lnTo>
                <a:lnTo>
                  <a:pt x="4198" y="6117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b="1"/>
          </a:p>
        </p:txBody>
      </p:sp>
      <p:sp>
        <p:nvSpPr>
          <p:cNvPr id="415" name="Rectangle 292">
            <a:extLst>
              <a:ext uri="{FF2B5EF4-FFF2-40B4-BE49-F238E27FC236}">
                <a16:creationId xmlns:a16="http://schemas.microsoft.com/office/drawing/2014/main" id="{19D7A91E-689E-4643-972D-DCDE4CDE0B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1749" y="6893163"/>
            <a:ext cx="29029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36" name="Rectangle 301">
            <a:extLst>
              <a:ext uri="{FF2B5EF4-FFF2-40B4-BE49-F238E27FC236}">
                <a16:creationId xmlns:a16="http://schemas.microsoft.com/office/drawing/2014/main" id="{8AF798AB-87B1-4AF4-BBDA-E9BA289196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5161" y="6928193"/>
            <a:ext cx="95921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F: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40" name="Rectangle 302">
            <a:extLst>
              <a:ext uri="{FF2B5EF4-FFF2-40B4-BE49-F238E27FC236}">
                <a16:creationId xmlns:a16="http://schemas.microsoft.com/office/drawing/2014/main" id="{8A3C1E7A-B7A2-45CC-92E0-4A6E077513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56227" y="6921187"/>
            <a:ext cx="1782110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C80000"/>
                </a:solidFill>
                <a:effectLst/>
                <a:cs typeface="Arial" panose="020B0604020202020204" pitchFamily="34" charset="0"/>
              </a:rPr>
              <a:t>FTMS - p ESI Full </a:t>
            </a:r>
            <a:r>
              <a:rPr kumimoji="0" lang="en-US" altLang="en-US" sz="800" b="1" i="0" u="none" strike="noStrike" cap="none" normalizeH="0" baseline="0" dirty="0" err="1">
                <a:ln>
                  <a:noFill/>
                </a:ln>
                <a:solidFill>
                  <a:srgbClr val="C80000"/>
                </a:solidFill>
                <a:effectLst/>
                <a:cs typeface="Arial" panose="020B0604020202020204" pitchFamily="34" charset="0"/>
              </a:rPr>
              <a:t>ms</a:t>
            </a: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C80000"/>
                </a:solidFill>
                <a:effectLst/>
                <a:cs typeface="Arial" panose="020B0604020202020204" pitchFamily="34" charset="0"/>
              </a:rPr>
              <a:t> [50.00-1000.00]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44" name="Line 303">
            <a:extLst>
              <a:ext uri="{FF2B5EF4-FFF2-40B4-BE49-F238E27FC236}">
                <a16:creationId xmlns:a16="http://schemas.microsoft.com/office/drawing/2014/main" id="{6A6B1C49-FAB7-431E-BAEE-827BD9834928}"/>
              </a:ext>
            </a:extLst>
          </p:cNvPr>
          <p:cNvSpPr>
            <a:spLocks noChangeShapeType="1"/>
          </p:cNvSpPr>
          <p:nvPr/>
        </p:nvSpPr>
        <p:spPr bwMode="auto">
          <a:xfrm>
            <a:off x="3312053" y="10564362"/>
            <a:ext cx="587894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8" name="Line 304">
            <a:extLst>
              <a:ext uri="{FF2B5EF4-FFF2-40B4-BE49-F238E27FC236}">
                <a16:creationId xmlns:a16="http://schemas.microsoft.com/office/drawing/2014/main" id="{13B15AB6-3493-4CD7-B4DB-EB6D27A1C369}"/>
              </a:ext>
            </a:extLst>
          </p:cNvPr>
          <p:cNvSpPr>
            <a:spLocks noChangeShapeType="1"/>
          </p:cNvSpPr>
          <p:nvPr/>
        </p:nvSpPr>
        <p:spPr bwMode="auto">
          <a:xfrm>
            <a:off x="3373897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9" name="Line 305">
            <a:extLst>
              <a:ext uri="{FF2B5EF4-FFF2-40B4-BE49-F238E27FC236}">
                <a16:creationId xmlns:a16="http://schemas.microsoft.com/office/drawing/2014/main" id="{468C6817-9DE0-4E22-BCE1-883250B40485}"/>
              </a:ext>
            </a:extLst>
          </p:cNvPr>
          <p:cNvSpPr>
            <a:spLocks noChangeShapeType="1"/>
          </p:cNvSpPr>
          <p:nvPr/>
        </p:nvSpPr>
        <p:spPr bwMode="auto">
          <a:xfrm>
            <a:off x="3435741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1" name="Line 306">
            <a:extLst>
              <a:ext uri="{FF2B5EF4-FFF2-40B4-BE49-F238E27FC236}">
                <a16:creationId xmlns:a16="http://schemas.microsoft.com/office/drawing/2014/main" id="{50E0236E-0D4A-47D1-990B-996E59F4A952}"/>
              </a:ext>
            </a:extLst>
          </p:cNvPr>
          <p:cNvSpPr>
            <a:spLocks noChangeShapeType="1"/>
          </p:cNvSpPr>
          <p:nvPr/>
        </p:nvSpPr>
        <p:spPr bwMode="auto">
          <a:xfrm>
            <a:off x="3497584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2" name="Line 307">
            <a:extLst>
              <a:ext uri="{FF2B5EF4-FFF2-40B4-BE49-F238E27FC236}">
                <a16:creationId xmlns:a16="http://schemas.microsoft.com/office/drawing/2014/main" id="{FB4E2332-932F-4C38-8092-529B0C829C47}"/>
              </a:ext>
            </a:extLst>
          </p:cNvPr>
          <p:cNvSpPr>
            <a:spLocks noChangeShapeType="1"/>
          </p:cNvSpPr>
          <p:nvPr/>
        </p:nvSpPr>
        <p:spPr bwMode="auto">
          <a:xfrm>
            <a:off x="3559428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4" name="Line 308">
            <a:extLst>
              <a:ext uri="{FF2B5EF4-FFF2-40B4-BE49-F238E27FC236}">
                <a16:creationId xmlns:a16="http://schemas.microsoft.com/office/drawing/2014/main" id="{6C35A57C-AA2B-4DAA-A3BD-225B2E219A5D}"/>
              </a:ext>
            </a:extLst>
          </p:cNvPr>
          <p:cNvSpPr>
            <a:spLocks noChangeShapeType="1"/>
          </p:cNvSpPr>
          <p:nvPr/>
        </p:nvSpPr>
        <p:spPr bwMode="auto">
          <a:xfrm>
            <a:off x="3683116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5" name="Line 309">
            <a:extLst>
              <a:ext uri="{FF2B5EF4-FFF2-40B4-BE49-F238E27FC236}">
                <a16:creationId xmlns:a16="http://schemas.microsoft.com/office/drawing/2014/main" id="{46FE72A3-AA4D-4F2B-98F3-C891B9C01F75}"/>
              </a:ext>
            </a:extLst>
          </p:cNvPr>
          <p:cNvSpPr>
            <a:spLocks noChangeShapeType="1"/>
          </p:cNvSpPr>
          <p:nvPr/>
        </p:nvSpPr>
        <p:spPr bwMode="auto">
          <a:xfrm>
            <a:off x="3743697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6" name="Line 310">
            <a:extLst>
              <a:ext uri="{FF2B5EF4-FFF2-40B4-BE49-F238E27FC236}">
                <a16:creationId xmlns:a16="http://schemas.microsoft.com/office/drawing/2014/main" id="{911C746A-CA81-49C0-8B47-FF7E38D39E01}"/>
              </a:ext>
            </a:extLst>
          </p:cNvPr>
          <p:cNvSpPr>
            <a:spLocks noChangeShapeType="1"/>
          </p:cNvSpPr>
          <p:nvPr/>
        </p:nvSpPr>
        <p:spPr bwMode="auto">
          <a:xfrm>
            <a:off x="3805541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8" name="Line 311">
            <a:extLst>
              <a:ext uri="{FF2B5EF4-FFF2-40B4-BE49-F238E27FC236}">
                <a16:creationId xmlns:a16="http://schemas.microsoft.com/office/drawing/2014/main" id="{A301B4D4-D091-40B9-9519-5E07CC9A5D99}"/>
              </a:ext>
            </a:extLst>
          </p:cNvPr>
          <p:cNvSpPr>
            <a:spLocks noChangeShapeType="1"/>
          </p:cNvSpPr>
          <p:nvPr/>
        </p:nvSpPr>
        <p:spPr bwMode="auto">
          <a:xfrm>
            <a:off x="3867385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" name="Line 312">
            <a:extLst>
              <a:ext uri="{FF2B5EF4-FFF2-40B4-BE49-F238E27FC236}">
                <a16:creationId xmlns:a16="http://schemas.microsoft.com/office/drawing/2014/main" id="{BDEDEEA1-FD06-4B68-BC87-9F0A0217B0B6}"/>
              </a:ext>
            </a:extLst>
          </p:cNvPr>
          <p:cNvSpPr>
            <a:spLocks noChangeShapeType="1"/>
          </p:cNvSpPr>
          <p:nvPr/>
        </p:nvSpPr>
        <p:spPr bwMode="auto">
          <a:xfrm>
            <a:off x="3991073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" name="Line 313">
            <a:extLst>
              <a:ext uri="{FF2B5EF4-FFF2-40B4-BE49-F238E27FC236}">
                <a16:creationId xmlns:a16="http://schemas.microsoft.com/office/drawing/2014/main" id="{DA4FC8CC-2CB4-45CF-A307-5087CDEC7F72}"/>
              </a:ext>
            </a:extLst>
          </p:cNvPr>
          <p:cNvSpPr>
            <a:spLocks noChangeShapeType="1"/>
          </p:cNvSpPr>
          <p:nvPr/>
        </p:nvSpPr>
        <p:spPr bwMode="auto">
          <a:xfrm>
            <a:off x="4052916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1" name="Line 314">
            <a:extLst>
              <a:ext uri="{FF2B5EF4-FFF2-40B4-BE49-F238E27FC236}">
                <a16:creationId xmlns:a16="http://schemas.microsoft.com/office/drawing/2014/main" id="{79BAB77D-E211-4909-AC5B-38F57FC861A7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4760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2" name="Line 315">
            <a:extLst>
              <a:ext uri="{FF2B5EF4-FFF2-40B4-BE49-F238E27FC236}">
                <a16:creationId xmlns:a16="http://schemas.microsoft.com/office/drawing/2014/main" id="{6A4258CF-F382-47A8-BDC6-93F478F52EB9}"/>
              </a:ext>
            </a:extLst>
          </p:cNvPr>
          <p:cNvSpPr>
            <a:spLocks noChangeShapeType="1"/>
          </p:cNvSpPr>
          <p:nvPr/>
        </p:nvSpPr>
        <p:spPr bwMode="auto">
          <a:xfrm>
            <a:off x="4175342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3" name="Line 316">
            <a:extLst>
              <a:ext uri="{FF2B5EF4-FFF2-40B4-BE49-F238E27FC236}">
                <a16:creationId xmlns:a16="http://schemas.microsoft.com/office/drawing/2014/main" id="{D5E1B6A3-69B1-46A3-B468-B20672A06B2D}"/>
              </a:ext>
            </a:extLst>
          </p:cNvPr>
          <p:cNvSpPr>
            <a:spLocks noChangeShapeType="1"/>
          </p:cNvSpPr>
          <p:nvPr/>
        </p:nvSpPr>
        <p:spPr bwMode="auto">
          <a:xfrm>
            <a:off x="4299029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4" name="Line 317">
            <a:extLst>
              <a:ext uri="{FF2B5EF4-FFF2-40B4-BE49-F238E27FC236}">
                <a16:creationId xmlns:a16="http://schemas.microsoft.com/office/drawing/2014/main" id="{BF28DE08-4EBF-4C40-9D4B-FF52BB811C68}"/>
              </a:ext>
            </a:extLst>
          </p:cNvPr>
          <p:cNvSpPr>
            <a:spLocks noChangeShapeType="1"/>
          </p:cNvSpPr>
          <p:nvPr/>
        </p:nvSpPr>
        <p:spPr bwMode="auto">
          <a:xfrm>
            <a:off x="4360873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5" name="Line 318">
            <a:extLst>
              <a:ext uri="{FF2B5EF4-FFF2-40B4-BE49-F238E27FC236}">
                <a16:creationId xmlns:a16="http://schemas.microsoft.com/office/drawing/2014/main" id="{C409AC3C-F5E6-4F35-B457-30579D3487E2}"/>
              </a:ext>
            </a:extLst>
          </p:cNvPr>
          <p:cNvSpPr>
            <a:spLocks noChangeShapeType="1"/>
          </p:cNvSpPr>
          <p:nvPr/>
        </p:nvSpPr>
        <p:spPr bwMode="auto">
          <a:xfrm>
            <a:off x="4422717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6" name="Line 319">
            <a:extLst>
              <a:ext uri="{FF2B5EF4-FFF2-40B4-BE49-F238E27FC236}">
                <a16:creationId xmlns:a16="http://schemas.microsoft.com/office/drawing/2014/main" id="{6EC7C167-A4E5-4EAC-8BB5-930BA4FC9E13}"/>
              </a:ext>
            </a:extLst>
          </p:cNvPr>
          <p:cNvSpPr>
            <a:spLocks noChangeShapeType="1"/>
          </p:cNvSpPr>
          <p:nvPr/>
        </p:nvSpPr>
        <p:spPr bwMode="auto">
          <a:xfrm>
            <a:off x="4488347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7" name="Line 320">
            <a:extLst>
              <a:ext uri="{FF2B5EF4-FFF2-40B4-BE49-F238E27FC236}">
                <a16:creationId xmlns:a16="http://schemas.microsoft.com/office/drawing/2014/main" id="{21512776-262E-47D9-B05F-D8EBC5191125}"/>
              </a:ext>
            </a:extLst>
          </p:cNvPr>
          <p:cNvSpPr>
            <a:spLocks noChangeShapeType="1"/>
          </p:cNvSpPr>
          <p:nvPr/>
        </p:nvSpPr>
        <p:spPr bwMode="auto">
          <a:xfrm>
            <a:off x="4612035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8" name="Line 321">
            <a:extLst>
              <a:ext uri="{FF2B5EF4-FFF2-40B4-BE49-F238E27FC236}">
                <a16:creationId xmlns:a16="http://schemas.microsoft.com/office/drawing/2014/main" id="{CD790F42-DE40-4E59-A8CF-ECC76B270BBA}"/>
              </a:ext>
            </a:extLst>
          </p:cNvPr>
          <p:cNvSpPr>
            <a:spLocks noChangeShapeType="1"/>
          </p:cNvSpPr>
          <p:nvPr/>
        </p:nvSpPr>
        <p:spPr bwMode="auto">
          <a:xfrm>
            <a:off x="4672616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9" name="Line 322">
            <a:extLst>
              <a:ext uri="{FF2B5EF4-FFF2-40B4-BE49-F238E27FC236}">
                <a16:creationId xmlns:a16="http://schemas.microsoft.com/office/drawing/2014/main" id="{4DE04878-818D-4876-B971-6E2FFBBD17ED}"/>
              </a:ext>
            </a:extLst>
          </p:cNvPr>
          <p:cNvSpPr>
            <a:spLocks noChangeShapeType="1"/>
          </p:cNvSpPr>
          <p:nvPr/>
        </p:nvSpPr>
        <p:spPr bwMode="auto">
          <a:xfrm>
            <a:off x="4734460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" name="Line 323">
            <a:extLst>
              <a:ext uri="{FF2B5EF4-FFF2-40B4-BE49-F238E27FC236}">
                <a16:creationId xmlns:a16="http://schemas.microsoft.com/office/drawing/2014/main" id="{948C535F-E014-4B32-A951-9E6DC7E4FFA8}"/>
              </a:ext>
            </a:extLst>
          </p:cNvPr>
          <p:cNvSpPr>
            <a:spLocks noChangeShapeType="1"/>
          </p:cNvSpPr>
          <p:nvPr/>
        </p:nvSpPr>
        <p:spPr bwMode="auto">
          <a:xfrm>
            <a:off x="4796304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" name="Line 324">
            <a:extLst>
              <a:ext uri="{FF2B5EF4-FFF2-40B4-BE49-F238E27FC236}">
                <a16:creationId xmlns:a16="http://schemas.microsoft.com/office/drawing/2014/main" id="{44E46E0B-C3FF-4457-B268-E5397C465700}"/>
              </a:ext>
            </a:extLst>
          </p:cNvPr>
          <p:cNvSpPr>
            <a:spLocks noChangeShapeType="1"/>
          </p:cNvSpPr>
          <p:nvPr/>
        </p:nvSpPr>
        <p:spPr bwMode="auto">
          <a:xfrm>
            <a:off x="4919991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2" name="Line 325">
            <a:extLst>
              <a:ext uri="{FF2B5EF4-FFF2-40B4-BE49-F238E27FC236}">
                <a16:creationId xmlns:a16="http://schemas.microsoft.com/office/drawing/2014/main" id="{4B7F3E13-46FD-41AA-9D58-FB8996CFBB96}"/>
              </a:ext>
            </a:extLst>
          </p:cNvPr>
          <p:cNvSpPr>
            <a:spLocks noChangeShapeType="1"/>
          </p:cNvSpPr>
          <p:nvPr/>
        </p:nvSpPr>
        <p:spPr bwMode="auto">
          <a:xfrm>
            <a:off x="4981835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3" name="Line 326">
            <a:extLst>
              <a:ext uri="{FF2B5EF4-FFF2-40B4-BE49-F238E27FC236}">
                <a16:creationId xmlns:a16="http://schemas.microsoft.com/office/drawing/2014/main" id="{F8686102-F235-41A4-B0E5-16ACA1AB3AA6}"/>
              </a:ext>
            </a:extLst>
          </p:cNvPr>
          <p:cNvSpPr>
            <a:spLocks noChangeShapeType="1"/>
          </p:cNvSpPr>
          <p:nvPr/>
        </p:nvSpPr>
        <p:spPr bwMode="auto">
          <a:xfrm>
            <a:off x="5043679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4" name="Line 327">
            <a:extLst>
              <a:ext uri="{FF2B5EF4-FFF2-40B4-BE49-F238E27FC236}">
                <a16:creationId xmlns:a16="http://schemas.microsoft.com/office/drawing/2014/main" id="{61B046EB-C689-45F1-9957-F6A2B3C84486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4260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5" name="Line 328">
            <a:extLst>
              <a:ext uri="{FF2B5EF4-FFF2-40B4-BE49-F238E27FC236}">
                <a16:creationId xmlns:a16="http://schemas.microsoft.com/office/drawing/2014/main" id="{3FDA0F79-7E77-45EA-A886-179723810F65}"/>
              </a:ext>
            </a:extLst>
          </p:cNvPr>
          <p:cNvSpPr>
            <a:spLocks noChangeShapeType="1"/>
          </p:cNvSpPr>
          <p:nvPr/>
        </p:nvSpPr>
        <p:spPr bwMode="auto">
          <a:xfrm>
            <a:off x="5227948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6" name="Line 329">
            <a:extLst>
              <a:ext uri="{FF2B5EF4-FFF2-40B4-BE49-F238E27FC236}">
                <a16:creationId xmlns:a16="http://schemas.microsoft.com/office/drawing/2014/main" id="{5981B15D-9069-4EB7-8CD2-E748F7A2A71A}"/>
              </a:ext>
            </a:extLst>
          </p:cNvPr>
          <p:cNvSpPr>
            <a:spLocks noChangeShapeType="1"/>
          </p:cNvSpPr>
          <p:nvPr/>
        </p:nvSpPr>
        <p:spPr bwMode="auto">
          <a:xfrm>
            <a:off x="5289792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7" name="Line 330">
            <a:extLst>
              <a:ext uri="{FF2B5EF4-FFF2-40B4-BE49-F238E27FC236}">
                <a16:creationId xmlns:a16="http://schemas.microsoft.com/office/drawing/2014/main" id="{F5F4F1BE-B586-40CD-8F3D-CDA86B3E8C2E}"/>
              </a:ext>
            </a:extLst>
          </p:cNvPr>
          <p:cNvSpPr>
            <a:spLocks noChangeShapeType="1"/>
          </p:cNvSpPr>
          <p:nvPr/>
        </p:nvSpPr>
        <p:spPr bwMode="auto">
          <a:xfrm>
            <a:off x="5351636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8" name="Line 331">
            <a:extLst>
              <a:ext uri="{FF2B5EF4-FFF2-40B4-BE49-F238E27FC236}">
                <a16:creationId xmlns:a16="http://schemas.microsoft.com/office/drawing/2014/main" id="{206C6071-2EC8-4822-BC37-25FB130E9319}"/>
              </a:ext>
            </a:extLst>
          </p:cNvPr>
          <p:cNvSpPr>
            <a:spLocks noChangeShapeType="1"/>
          </p:cNvSpPr>
          <p:nvPr/>
        </p:nvSpPr>
        <p:spPr bwMode="auto">
          <a:xfrm>
            <a:off x="5413479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9" name="Line 332">
            <a:extLst>
              <a:ext uri="{FF2B5EF4-FFF2-40B4-BE49-F238E27FC236}">
                <a16:creationId xmlns:a16="http://schemas.microsoft.com/office/drawing/2014/main" id="{F7D403AD-D676-435C-A84C-E9F36D014608}"/>
              </a:ext>
            </a:extLst>
          </p:cNvPr>
          <p:cNvSpPr>
            <a:spLocks noChangeShapeType="1"/>
          </p:cNvSpPr>
          <p:nvPr/>
        </p:nvSpPr>
        <p:spPr bwMode="auto">
          <a:xfrm>
            <a:off x="5537167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0" name="Line 333">
            <a:extLst>
              <a:ext uri="{FF2B5EF4-FFF2-40B4-BE49-F238E27FC236}">
                <a16:creationId xmlns:a16="http://schemas.microsoft.com/office/drawing/2014/main" id="{CD762E9E-98E2-41B6-B906-BD4CF3E2D8E0}"/>
              </a:ext>
            </a:extLst>
          </p:cNvPr>
          <p:cNvSpPr>
            <a:spLocks noChangeShapeType="1"/>
          </p:cNvSpPr>
          <p:nvPr/>
        </p:nvSpPr>
        <p:spPr bwMode="auto">
          <a:xfrm>
            <a:off x="5597749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1" name="Line 334">
            <a:extLst>
              <a:ext uri="{FF2B5EF4-FFF2-40B4-BE49-F238E27FC236}">
                <a16:creationId xmlns:a16="http://schemas.microsoft.com/office/drawing/2014/main" id="{6850AF7E-2AFF-406B-905C-8CFA27DB749F}"/>
              </a:ext>
            </a:extLst>
          </p:cNvPr>
          <p:cNvSpPr>
            <a:spLocks noChangeShapeType="1"/>
          </p:cNvSpPr>
          <p:nvPr/>
        </p:nvSpPr>
        <p:spPr bwMode="auto">
          <a:xfrm>
            <a:off x="5663379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2" name="Line 335">
            <a:extLst>
              <a:ext uri="{FF2B5EF4-FFF2-40B4-BE49-F238E27FC236}">
                <a16:creationId xmlns:a16="http://schemas.microsoft.com/office/drawing/2014/main" id="{28D72EA8-668C-439D-8719-26B6DF915C21}"/>
              </a:ext>
            </a:extLst>
          </p:cNvPr>
          <p:cNvSpPr>
            <a:spLocks noChangeShapeType="1"/>
          </p:cNvSpPr>
          <p:nvPr/>
        </p:nvSpPr>
        <p:spPr bwMode="auto">
          <a:xfrm>
            <a:off x="5725223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3" name="Line 336">
            <a:extLst>
              <a:ext uri="{FF2B5EF4-FFF2-40B4-BE49-F238E27FC236}">
                <a16:creationId xmlns:a16="http://schemas.microsoft.com/office/drawing/2014/main" id="{1216757E-7E5A-44DD-B48C-B392A7F0108B}"/>
              </a:ext>
            </a:extLst>
          </p:cNvPr>
          <p:cNvSpPr>
            <a:spLocks noChangeShapeType="1"/>
          </p:cNvSpPr>
          <p:nvPr/>
        </p:nvSpPr>
        <p:spPr bwMode="auto">
          <a:xfrm>
            <a:off x="5848910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4" name="Line 337">
            <a:extLst>
              <a:ext uri="{FF2B5EF4-FFF2-40B4-BE49-F238E27FC236}">
                <a16:creationId xmlns:a16="http://schemas.microsoft.com/office/drawing/2014/main" id="{165267AE-3943-495A-B0EC-167755D87A4A}"/>
              </a:ext>
            </a:extLst>
          </p:cNvPr>
          <p:cNvSpPr>
            <a:spLocks noChangeShapeType="1"/>
          </p:cNvSpPr>
          <p:nvPr/>
        </p:nvSpPr>
        <p:spPr bwMode="auto">
          <a:xfrm>
            <a:off x="5910754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5" name="Line 338">
            <a:extLst>
              <a:ext uri="{FF2B5EF4-FFF2-40B4-BE49-F238E27FC236}">
                <a16:creationId xmlns:a16="http://schemas.microsoft.com/office/drawing/2014/main" id="{BD637E60-7578-44BC-B406-A341AE34FB32}"/>
              </a:ext>
            </a:extLst>
          </p:cNvPr>
          <p:cNvSpPr>
            <a:spLocks noChangeShapeType="1"/>
          </p:cNvSpPr>
          <p:nvPr/>
        </p:nvSpPr>
        <p:spPr bwMode="auto">
          <a:xfrm>
            <a:off x="5972598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6" name="Line 339">
            <a:extLst>
              <a:ext uri="{FF2B5EF4-FFF2-40B4-BE49-F238E27FC236}">
                <a16:creationId xmlns:a16="http://schemas.microsoft.com/office/drawing/2014/main" id="{6C595F07-29A7-48DA-8CEE-FC9DD47984A4}"/>
              </a:ext>
            </a:extLst>
          </p:cNvPr>
          <p:cNvSpPr>
            <a:spLocks noChangeShapeType="1"/>
          </p:cNvSpPr>
          <p:nvPr/>
        </p:nvSpPr>
        <p:spPr bwMode="auto">
          <a:xfrm>
            <a:off x="6033179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7" name="Line 340">
            <a:extLst>
              <a:ext uri="{FF2B5EF4-FFF2-40B4-BE49-F238E27FC236}">
                <a16:creationId xmlns:a16="http://schemas.microsoft.com/office/drawing/2014/main" id="{29F184C7-1CA4-4CBB-AB84-AE4CEA35D0A4}"/>
              </a:ext>
            </a:extLst>
          </p:cNvPr>
          <p:cNvSpPr>
            <a:spLocks noChangeShapeType="1"/>
          </p:cNvSpPr>
          <p:nvPr/>
        </p:nvSpPr>
        <p:spPr bwMode="auto">
          <a:xfrm>
            <a:off x="6156867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8" name="Line 341">
            <a:extLst>
              <a:ext uri="{FF2B5EF4-FFF2-40B4-BE49-F238E27FC236}">
                <a16:creationId xmlns:a16="http://schemas.microsoft.com/office/drawing/2014/main" id="{5C6FB894-2FF4-4D27-AF4E-44923D1BD1B7}"/>
              </a:ext>
            </a:extLst>
          </p:cNvPr>
          <p:cNvSpPr>
            <a:spLocks noChangeShapeType="1"/>
          </p:cNvSpPr>
          <p:nvPr/>
        </p:nvSpPr>
        <p:spPr bwMode="auto">
          <a:xfrm>
            <a:off x="6218711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9" name="Line 342">
            <a:extLst>
              <a:ext uri="{FF2B5EF4-FFF2-40B4-BE49-F238E27FC236}">
                <a16:creationId xmlns:a16="http://schemas.microsoft.com/office/drawing/2014/main" id="{972A104D-5A6A-4EA5-A6E5-099D6D3C40A6}"/>
              </a:ext>
            </a:extLst>
          </p:cNvPr>
          <p:cNvSpPr>
            <a:spLocks noChangeShapeType="1"/>
          </p:cNvSpPr>
          <p:nvPr/>
        </p:nvSpPr>
        <p:spPr bwMode="auto">
          <a:xfrm>
            <a:off x="6280554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0" name="Line 343">
            <a:extLst>
              <a:ext uri="{FF2B5EF4-FFF2-40B4-BE49-F238E27FC236}">
                <a16:creationId xmlns:a16="http://schemas.microsoft.com/office/drawing/2014/main" id="{F62DDA07-354B-4E36-B36B-E7F77DA0F31E}"/>
              </a:ext>
            </a:extLst>
          </p:cNvPr>
          <p:cNvSpPr>
            <a:spLocks noChangeShapeType="1"/>
          </p:cNvSpPr>
          <p:nvPr/>
        </p:nvSpPr>
        <p:spPr bwMode="auto">
          <a:xfrm>
            <a:off x="6342398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1" name="Line 344">
            <a:extLst>
              <a:ext uri="{FF2B5EF4-FFF2-40B4-BE49-F238E27FC236}">
                <a16:creationId xmlns:a16="http://schemas.microsoft.com/office/drawing/2014/main" id="{08DC8BF7-00B4-4E1C-BD07-9A8C62F3525D}"/>
              </a:ext>
            </a:extLst>
          </p:cNvPr>
          <p:cNvSpPr>
            <a:spLocks noChangeShapeType="1"/>
          </p:cNvSpPr>
          <p:nvPr/>
        </p:nvSpPr>
        <p:spPr bwMode="auto">
          <a:xfrm>
            <a:off x="6466086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2" name="Line 345">
            <a:extLst>
              <a:ext uri="{FF2B5EF4-FFF2-40B4-BE49-F238E27FC236}">
                <a16:creationId xmlns:a16="http://schemas.microsoft.com/office/drawing/2014/main" id="{77F7413B-F820-4361-AA89-86C68B58F0BF}"/>
              </a:ext>
            </a:extLst>
          </p:cNvPr>
          <p:cNvSpPr>
            <a:spLocks noChangeShapeType="1"/>
          </p:cNvSpPr>
          <p:nvPr/>
        </p:nvSpPr>
        <p:spPr bwMode="auto">
          <a:xfrm>
            <a:off x="6526667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3" name="Line 346">
            <a:extLst>
              <a:ext uri="{FF2B5EF4-FFF2-40B4-BE49-F238E27FC236}">
                <a16:creationId xmlns:a16="http://schemas.microsoft.com/office/drawing/2014/main" id="{CEFEE832-F264-43F4-BDD5-0CF6A92773C5}"/>
              </a:ext>
            </a:extLst>
          </p:cNvPr>
          <p:cNvSpPr>
            <a:spLocks noChangeShapeType="1"/>
          </p:cNvSpPr>
          <p:nvPr/>
        </p:nvSpPr>
        <p:spPr bwMode="auto">
          <a:xfrm>
            <a:off x="6588511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4" name="Line 347">
            <a:extLst>
              <a:ext uri="{FF2B5EF4-FFF2-40B4-BE49-F238E27FC236}">
                <a16:creationId xmlns:a16="http://schemas.microsoft.com/office/drawing/2014/main" id="{689C6641-1F84-4E56-8EB6-334F85D20026}"/>
              </a:ext>
            </a:extLst>
          </p:cNvPr>
          <p:cNvSpPr>
            <a:spLocks noChangeShapeType="1"/>
          </p:cNvSpPr>
          <p:nvPr/>
        </p:nvSpPr>
        <p:spPr bwMode="auto">
          <a:xfrm>
            <a:off x="6650355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5" name="Line 348">
            <a:extLst>
              <a:ext uri="{FF2B5EF4-FFF2-40B4-BE49-F238E27FC236}">
                <a16:creationId xmlns:a16="http://schemas.microsoft.com/office/drawing/2014/main" id="{CEF26721-B914-4429-B6B2-3EA2486C3723}"/>
              </a:ext>
            </a:extLst>
          </p:cNvPr>
          <p:cNvSpPr>
            <a:spLocks noChangeShapeType="1"/>
          </p:cNvSpPr>
          <p:nvPr/>
        </p:nvSpPr>
        <p:spPr bwMode="auto">
          <a:xfrm>
            <a:off x="6774042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6" name="Line 349">
            <a:extLst>
              <a:ext uri="{FF2B5EF4-FFF2-40B4-BE49-F238E27FC236}">
                <a16:creationId xmlns:a16="http://schemas.microsoft.com/office/drawing/2014/main" id="{17AC4D88-5DDE-4791-8F4F-7E18E2097908}"/>
              </a:ext>
            </a:extLst>
          </p:cNvPr>
          <p:cNvSpPr>
            <a:spLocks noChangeShapeType="1"/>
          </p:cNvSpPr>
          <p:nvPr/>
        </p:nvSpPr>
        <p:spPr bwMode="auto">
          <a:xfrm>
            <a:off x="6839673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7" name="Line 350">
            <a:extLst>
              <a:ext uri="{FF2B5EF4-FFF2-40B4-BE49-F238E27FC236}">
                <a16:creationId xmlns:a16="http://schemas.microsoft.com/office/drawing/2014/main" id="{1A4ECB8A-6BC7-478B-ACC0-87369F585ACA}"/>
              </a:ext>
            </a:extLst>
          </p:cNvPr>
          <p:cNvSpPr>
            <a:spLocks noChangeShapeType="1"/>
          </p:cNvSpPr>
          <p:nvPr/>
        </p:nvSpPr>
        <p:spPr bwMode="auto">
          <a:xfrm>
            <a:off x="6901516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8" name="Line 351">
            <a:extLst>
              <a:ext uri="{FF2B5EF4-FFF2-40B4-BE49-F238E27FC236}">
                <a16:creationId xmlns:a16="http://schemas.microsoft.com/office/drawing/2014/main" id="{9CF4C403-5390-477D-BD23-07306D49E7CB}"/>
              </a:ext>
            </a:extLst>
          </p:cNvPr>
          <p:cNvSpPr>
            <a:spLocks noChangeShapeType="1"/>
          </p:cNvSpPr>
          <p:nvPr/>
        </p:nvSpPr>
        <p:spPr bwMode="auto">
          <a:xfrm>
            <a:off x="6962098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9" name="Line 352">
            <a:extLst>
              <a:ext uri="{FF2B5EF4-FFF2-40B4-BE49-F238E27FC236}">
                <a16:creationId xmlns:a16="http://schemas.microsoft.com/office/drawing/2014/main" id="{12CE5B97-2AB8-4112-B63D-BCD3355685F8}"/>
              </a:ext>
            </a:extLst>
          </p:cNvPr>
          <p:cNvSpPr>
            <a:spLocks noChangeShapeType="1"/>
          </p:cNvSpPr>
          <p:nvPr/>
        </p:nvSpPr>
        <p:spPr bwMode="auto">
          <a:xfrm>
            <a:off x="7085786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0" name="Line 353">
            <a:extLst>
              <a:ext uri="{FF2B5EF4-FFF2-40B4-BE49-F238E27FC236}">
                <a16:creationId xmlns:a16="http://schemas.microsoft.com/office/drawing/2014/main" id="{FC52E803-B2B4-4F24-82D7-8C6C8F633AD9}"/>
              </a:ext>
            </a:extLst>
          </p:cNvPr>
          <p:cNvSpPr>
            <a:spLocks noChangeShapeType="1"/>
          </p:cNvSpPr>
          <p:nvPr/>
        </p:nvSpPr>
        <p:spPr bwMode="auto">
          <a:xfrm>
            <a:off x="7147629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1" name="Line 354">
            <a:extLst>
              <a:ext uri="{FF2B5EF4-FFF2-40B4-BE49-F238E27FC236}">
                <a16:creationId xmlns:a16="http://schemas.microsoft.com/office/drawing/2014/main" id="{D32697A4-2830-467E-8116-6F42D6F8B859}"/>
              </a:ext>
            </a:extLst>
          </p:cNvPr>
          <p:cNvSpPr>
            <a:spLocks noChangeShapeType="1"/>
          </p:cNvSpPr>
          <p:nvPr/>
        </p:nvSpPr>
        <p:spPr bwMode="auto">
          <a:xfrm>
            <a:off x="7209473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2" name="Line 355">
            <a:extLst>
              <a:ext uri="{FF2B5EF4-FFF2-40B4-BE49-F238E27FC236}">
                <a16:creationId xmlns:a16="http://schemas.microsoft.com/office/drawing/2014/main" id="{B08C6BE8-1E5B-4F39-93A0-42FF04C42D66}"/>
              </a:ext>
            </a:extLst>
          </p:cNvPr>
          <p:cNvSpPr>
            <a:spLocks noChangeShapeType="1"/>
          </p:cNvSpPr>
          <p:nvPr/>
        </p:nvSpPr>
        <p:spPr bwMode="auto">
          <a:xfrm>
            <a:off x="7271317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3" name="Line 356">
            <a:extLst>
              <a:ext uri="{FF2B5EF4-FFF2-40B4-BE49-F238E27FC236}">
                <a16:creationId xmlns:a16="http://schemas.microsoft.com/office/drawing/2014/main" id="{E37808E3-EA54-47BA-A994-EA47422448CF}"/>
              </a:ext>
            </a:extLst>
          </p:cNvPr>
          <p:cNvSpPr>
            <a:spLocks noChangeShapeType="1"/>
          </p:cNvSpPr>
          <p:nvPr/>
        </p:nvSpPr>
        <p:spPr bwMode="auto">
          <a:xfrm>
            <a:off x="7393742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4" name="Line 357">
            <a:extLst>
              <a:ext uri="{FF2B5EF4-FFF2-40B4-BE49-F238E27FC236}">
                <a16:creationId xmlns:a16="http://schemas.microsoft.com/office/drawing/2014/main" id="{05A5DFCB-F834-4907-8C4D-BD1F971D7C18}"/>
              </a:ext>
            </a:extLst>
          </p:cNvPr>
          <p:cNvSpPr>
            <a:spLocks noChangeShapeType="1"/>
          </p:cNvSpPr>
          <p:nvPr/>
        </p:nvSpPr>
        <p:spPr bwMode="auto">
          <a:xfrm>
            <a:off x="7455586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5" name="Line 358">
            <a:extLst>
              <a:ext uri="{FF2B5EF4-FFF2-40B4-BE49-F238E27FC236}">
                <a16:creationId xmlns:a16="http://schemas.microsoft.com/office/drawing/2014/main" id="{C0EC2047-48F7-46EA-9ED9-7C08814F5863}"/>
              </a:ext>
            </a:extLst>
          </p:cNvPr>
          <p:cNvSpPr>
            <a:spLocks noChangeShapeType="1"/>
          </p:cNvSpPr>
          <p:nvPr/>
        </p:nvSpPr>
        <p:spPr bwMode="auto">
          <a:xfrm>
            <a:off x="7517430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6" name="Line 359">
            <a:extLst>
              <a:ext uri="{FF2B5EF4-FFF2-40B4-BE49-F238E27FC236}">
                <a16:creationId xmlns:a16="http://schemas.microsoft.com/office/drawing/2014/main" id="{37975CE9-46A8-4415-902E-2154C59EBB30}"/>
              </a:ext>
            </a:extLst>
          </p:cNvPr>
          <p:cNvSpPr>
            <a:spLocks noChangeShapeType="1"/>
          </p:cNvSpPr>
          <p:nvPr/>
        </p:nvSpPr>
        <p:spPr bwMode="auto">
          <a:xfrm>
            <a:off x="7579274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7" name="Line 360">
            <a:extLst>
              <a:ext uri="{FF2B5EF4-FFF2-40B4-BE49-F238E27FC236}">
                <a16:creationId xmlns:a16="http://schemas.microsoft.com/office/drawing/2014/main" id="{CD30AA37-0BBF-47C7-B94C-96BF8B197602}"/>
              </a:ext>
            </a:extLst>
          </p:cNvPr>
          <p:cNvSpPr>
            <a:spLocks noChangeShapeType="1"/>
          </p:cNvSpPr>
          <p:nvPr/>
        </p:nvSpPr>
        <p:spPr bwMode="auto">
          <a:xfrm>
            <a:off x="7702961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8" name="Line 361">
            <a:extLst>
              <a:ext uri="{FF2B5EF4-FFF2-40B4-BE49-F238E27FC236}">
                <a16:creationId xmlns:a16="http://schemas.microsoft.com/office/drawing/2014/main" id="{CD1FFADD-0F20-4D32-B09E-70EB87653097}"/>
              </a:ext>
            </a:extLst>
          </p:cNvPr>
          <p:cNvSpPr>
            <a:spLocks noChangeShapeType="1"/>
          </p:cNvSpPr>
          <p:nvPr/>
        </p:nvSpPr>
        <p:spPr bwMode="auto">
          <a:xfrm>
            <a:off x="7764805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9" name="Line 362">
            <a:extLst>
              <a:ext uri="{FF2B5EF4-FFF2-40B4-BE49-F238E27FC236}">
                <a16:creationId xmlns:a16="http://schemas.microsoft.com/office/drawing/2014/main" id="{6A6FEFA5-6FEF-4085-B4E8-80F778AB662D}"/>
              </a:ext>
            </a:extLst>
          </p:cNvPr>
          <p:cNvSpPr>
            <a:spLocks noChangeShapeType="1"/>
          </p:cNvSpPr>
          <p:nvPr/>
        </p:nvSpPr>
        <p:spPr bwMode="auto">
          <a:xfrm>
            <a:off x="7826649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0" name="Line 363">
            <a:extLst>
              <a:ext uri="{FF2B5EF4-FFF2-40B4-BE49-F238E27FC236}">
                <a16:creationId xmlns:a16="http://schemas.microsoft.com/office/drawing/2014/main" id="{88B4449A-85CF-443C-9F35-66A8EA1A8125}"/>
              </a:ext>
            </a:extLst>
          </p:cNvPr>
          <p:cNvSpPr>
            <a:spLocks noChangeShapeType="1"/>
          </p:cNvSpPr>
          <p:nvPr/>
        </p:nvSpPr>
        <p:spPr bwMode="auto">
          <a:xfrm>
            <a:off x="7887230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1" name="Line 364">
            <a:extLst>
              <a:ext uri="{FF2B5EF4-FFF2-40B4-BE49-F238E27FC236}">
                <a16:creationId xmlns:a16="http://schemas.microsoft.com/office/drawing/2014/main" id="{0EBCE6D9-4F79-4D24-93A9-216A32314275}"/>
              </a:ext>
            </a:extLst>
          </p:cNvPr>
          <p:cNvSpPr>
            <a:spLocks noChangeShapeType="1"/>
          </p:cNvSpPr>
          <p:nvPr/>
        </p:nvSpPr>
        <p:spPr bwMode="auto">
          <a:xfrm>
            <a:off x="8014704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2" name="Line 365">
            <a:extLst>
              <a:ext uri="{FF2B5EF4-FFF2-40B4-BE49-F238E27FC236}">
                <a16:creationId xmlns:a16="http://schemas.microsoft.com/office/drawing/2014/main" id="{AA093097-AE44-4ABD-968F-7DAABEF782D7}"/>
              </a:ext>
            </a:extLst>
          </p:cNvPr>
          <p:cNvSpPr>
            <a:spLocks noChangeShapeType="1"/>
          </p:cNvSpPr>
          <p:nvPr/>
        </p:nvSpPr>
        <p:spPr bwMode="auto">
          <a:xfrm>
            <a:off x="8076548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3" name="Line 366">
            <a:extLst>
              <a:ext uri="{FF2B5EF4-FFF2-40B4-BE49-F238E27FC236}">
                <a16:creationId xmlns:a16="http://schemas.microsoft.com/office/drawing/2014/main" id="{356B2417-C34E-4BEC-9469-423F76DA74C5}"/>
              </a:ext>
            </a:extLst>
          </p:cNvPr>
          <p:cNvSpPr>
            <a:spLocks noChangeShapeType="1"/>
          </p:cNvSpPr>
          <p:nvPr/>
        </p:nvSpPr>
        <p:spPr bwMode="auto">
          <a:xfrm>
            <a:off x="8138392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4" name="Line 367">
            <a:extLst>
              <a:ext uri="{FF2B5EF4-FFF2-40B4-BE49-F238E27FC236}">
                <a16:creationId xmlns:a16="http://schemas.microsoft.com/office/drawing/2014/main" id="{A284834C-BF7B-4F4F-8BE9-6EE080C812EB}"/>
              </a:ext>
            </a:extLst>
          </p:cNvPr>
          <p:cNvSpPr>
            <a:spLocks noChangeShapeType="1"/>
          </p:cNvSpPr>
          <p:nvPr/>
        </p:nvSpPr>
        <p:spPr bwMode="auto">
          <a:xfrm>
            <a:off x="8200236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5" name="Line 368">
            <a:extLst>
              <a:ext uri="{FF2B5EF4-FFF2-40B4-BE49-F238E27FC236}">
                <a16:creationId xmlns:a16="http://schemas.microsoft.com/office/drawing/2014/main" id="{AB600E6E-BEF8-4980-9E38-EB8489E28EAE}"/>
              </a:ext>
            </a:extLst>
          </p:cNvPr>
          <p:cNvSpPr>
            <a:spLocks noChangeShapeType="1"/>
          </p:cNvSpPr>
          <p:nvPr/>
        </p:nvSpPr>
        <p:spPr bwMode="auto">
          <a:xfrm>
            <a:off x="8322661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6" name="Line 369">
            <a:extLst>
              <a:ext uri="{FF2B5EF4-FFF2-40B4-BE49-F238E27FC236}">
                <a16:creationId xmlns:a16="http://schemas.microsoft.com/office/drawing/2014/main" id="{1A7C229F-4399-4D09-AB73-1DE80E605666}"/>
              </a:ext>
            </a:extLst>
          </p:cNvPr>
          <p:cNvSpPr>
            <a:spLocks noChangeShapeType="1"/>
          </p:cNvSpPr>
          <p:nvPr/>
        </p:nvSpPr>
        <p:spPr bwMode="auto">
          <a:xfrm>
            <a:off x="8384505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7" name="Line 370">
            <a:extLst>
              <a:ext uri="{FF2B5EF4-FFF2-40B4-BE49-F238E27FC236}">
                <a16:creationId xmlns:a16="http://schemas.microsoft.com/office/drawing/2014/main" id="{9EADABDE-6296-49A4-AA45-CB2B9667B9E6}"/>
              </a:ext>
            </a:extLst>
          </p:cNvPr>
          <p:cNvSpPr>
            <a:spLocks noChangeShapeType="1"/>
          </p:cNvSpPr>
          <p:nvPr/>
        </p:nvSpPr>
        <p:spPr bwMode="auto">
          <a:xfrm>
            <a:off x="8446349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8" name="Line 371">
            <a:extLst>
              <a:ext uri="{FF2B5EF4-FFF2-40B4-BE49-F238E27FC236}">
                <a16:creationId xmlns:a16="http://schemas.microsoft.com/office/drawing/2014/main" id="{74057860-E840-4793-835F-EC1261071C83}"/>
              </a:ext>
            </a:extLst>
          </p:cNvPr>
          <p:cNvSpPr>
            <a:spLocks noChangeShapeType="1"/>
          </p:cNvSpPr>
          <p:nvPr/>
        </p:nvSpPr>
        <p:spPr bwMode="auto">
          <a:xfrm>
            <a:off x="8508192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9" name="Line 372">
            <a:extLst>
              <a:ext uri="{FF2B5EF4-FFF2-40B4-BE49-F238E27FC236}">
                <a16:creationId xmlns:a16="http://schemas.microsoft.com/office/drawing/2014/main" id="{AC8633E9-3034-43EF-97C5-ECA7772E793C}"/>
              </a:ext>
            </a:extLst>
          </p:cNvPr>
          <p:cNvSpPr>
            <a:spLocks noChangeShapeType="1"/>
          </p:cNvSpPr>
          <p:nvPr/>
        </p:nvSpPr>
        <p:spPr bwMode="auto">
          <a:xfrm>
            <a:off x="8631880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0" name="Line 373">
            <a:extLst>
              <a:ext uri="{FF2B5EF4-FFF2-40B4-BE49-F238E27FC236}">
                <a16:creationId xmlns:a16="http://schemas.microsoft.com/office/drawing/2014/main" id="{45E8C8BC-4710-4B45-841D-FF3664E7108F}"/>
              </a:ext>
            </a:extLst>
          </p:cNvPr>
          <p:cNvSpPr>
            <a:spLocks noChangeShapeType="1"/>
          </p:cNvSpPr>
          <p:nvPr/>
        </p:nvSpPr>
        <p:spPr bwMode="auto">
          <a:xfrm>
            <a:off x="8693724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1" name="Line 374">
            <a:extLst>
              <a:ext uri="{FF2B5EF4-FFF2-40B4-BE49-F238E27FC236}">
                <a16:creationId xmlns:a16="http://schemas.microsoft.com/office/drawing/2014/main" id="{12A490F5-A6C3-4335-B6DC-7ED5C538A854}"/>
              </a:ext>
            </a:extLst>
          </p:cNvPr>
          <p:cNvSpPr>
            <a:spLocks noChangeShapeType="1"/>
          </p:cNvSpPr>
          <p:nvPr/>
        </p:nvSpPr>
        <p:spPr bwMode="auto">
          <a:xfrm>
            <a:off x="8755568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2" name="Line 375">
            <a:extLst>
              <a:ext uri="{FF2B5EF4-FFF2-40B4-BE49-F238E27FC236}">
                <a16:creationId xmlns:a16="http://schemas.microsoft.com/office/drawing/2014/main" id="{67B3D55D-B35E-489A-88E3-75F56F71A162}"/>
              </a:ext>
            </a:extLst>
          </p:cNvPr>
          <p:cNvSpPr>
            <a:spLocks noChangeShapeType="1"/>
          </p:cNvSpPr>
          <p:nvPr/>
        </p:nvSpPr>
        <p:spPr bwMode="auto">
          <a:xfrm>
            <a:off x="8816149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3" name="Line 376">
            <a:extLst>
              <a:ext uri="{FF2B5EF4-FFF2-40B4-BE49-F238E27FC236}">
                <a16:creationId xmlns:a16="http://schemas.microsoft.com/office/drawing/2014/main" id="{E2C9E64D-CD3F-49F5-BEA2-6B867B3655DA}"/>
              </a:ext>
            </a:extLst>
          </p:cNvPr>
          <p:cNvSpPr>
            <a:spLocks noChangeShapeType="1"/>
          </p:cNvSpPr>
          <p:nvPr/>
        </p:nvSpPr>
        <p:spPr bwMode="auto">
          <a:xfrm>
            <a:off x="8939837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4" name="Line 377">
            <a:extLst>
              <a:ext uri="{FF2B5EF4-FFF2-40B4-BE49-F238E27FC236}">
                <a16:creationId xmlns:a16="http://schemas.microsoft.com/office/drawing/2014/main" id="{8688F585-E984-4773-BBA2-C9B4EE2D1E5F}"/>
              </a:ext>
            </a:extLst>
          </p:cNvPr>
          <p:cNvSpPr>
            <a:spLocks noChangeShapeType="1"/>
          </p:cNvSpPr>
          <p:nvPr/>
        </p:nvSpPr>
        <p:spPr bwMode="auto">
          <a:xfrm>
            <a:off x="9001681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5" name="Line 378">
            <a:extLst>
              <a:ext uri="{FF2B5EF4-FFF2-40B4-BE49-F238E27FC236}">
                <a16:creationId xmlns:a16="http://schemas.microsoft.com/office/drawing/2014/main" id="{40C8C648-94E0-4A4B-9395-97E0EC24598D}"/>
              </a:ext>
            </a:extLst>
          </p:cNvPr>
          <p:cNvSpPr>
            <a:spLocks noChangeShapeType="1"/>
          </p:cNvSpPr>
          <p:nvPr/>
        </p:nvSpPr>
        <p:spPr bwMode="auto">
          <a:xfrm>
            <a:off x="9063524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6" name="Line 379">
            <a:extLst>
              <a:ext uri="{FF2B5EF4-FFF2-40B4-BE49-F238E27FC236}">
                <a16:creationId xmlns:a16="http://schemas.microsoft.com/office/drawing/2014/main" id="{63633970-5A57-42FD-892B-D888E440BCAA}"/>
              </a:ext>
            </a:extLst>
          </p:cNvPr>
          <p:cNvSpPr>
            <a:spLocks noChangeShapeType="1"/>
          </p:cNvSpPr>
          <p:nvPr/>
        </p:nvSpPr>
        <p:spPr bwMode="auto">
          <a:xfrm>
            <a:off x="9125368" y="10564362"/>
            <a:ext cx="0" cy="29426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7" name="Line 380">
            <a:extLst>
              <a:ext uri="{FF2B5EF4-FFF2-40B4-BE49-F238E27FC236}">
                <a16:creationId xmlns:a16="http://schemas.microsoft.com/office/drawing/2014/main" id="{0E72B4BB-FF10-4A60-855A-1160D8EA1B53}"/>
              </a:ext>
            </a:extLst>
          </p:cNvPr>
          <p:cNvSpPr>
            <a:spLocks noChangeShapeType="1"/>
          </p:cNvSpPr>
          <p:nvPr/>
        </p:nvSpPr>
        <p:spPr bwMode="auto">
          <a:xfrm>
            <a:off x="3312053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8" name="Rectangle 381">
            <a:extLst>
              <a:ext uri="{FF2B5EF4-FFF2-40B4-BE49-F238E27FC236}">
                <a16:creationId xmlns:a16="http://schemas.microsoft.com/office/drawing/2014/main" id="{5D597830-8880-4921-B642-6A5792930B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7782" y="10606398"/>
            <a:ext cx="0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99" name="Line 382">
            <a:extLst>
              <a:ext uri="{FF2B5EF4-FFF2-40B4-BE49-F238E27FC236}">
                <a16:creationId xmlns:a16="http://schemas.microsoft.com/office/drawing/2014/main" id="{5935207F-6CEA-4874-8B2F-ADD2E83AE147}"/>
              </a:ext>
            </a:extLst>
          </p:cNvPr>
          <p:cNvSpPr>
            <a:spLocks noChangeShapeType="1"/>
          </p:cNvSpPr>
          <p:nvPr/>
        </p:nvSpPr>
        <p:spPr bwMode="auto">
          <a:xfrm>
            <a:off x="3621272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0" name="Rectangle 383">
            <a:extLst>
              <a:ext uri="{FF2B5EF4-FFF2-40B4-BE49-F238E27FC236}">
                <a16:creationId xmlns:a16="http://schemas.microsoft.com/office/drawing/2014/main" id="{DD19BD69-68BF-4120-81DE-956256F54B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48069" y="10606398"/>
            <a:ext cx="172910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01" name="Line 384">
            <a:extLst>
              <a:ext uri="{FF2B5EF4-FFF2-40B4-BE49-F238E27FC236}">
                <a16:creationId xmlns:a16="http://schemas.microsoft.com/office/drawing/2014/main" id="{6F76DB19-94C2-41CD-AC5F-C87A97A7F74A}"/>
              </a:ext>
            </a:extLst>
          </p:cNvPr>
          <p:cNvSpPr>
            <a:spLocks noChangeShapeType="1"/>
          </p:cNvSpPr>
          <p:nvPr/>
        </p:nvSpPr>
        <p:spPr bwMode="auto">
          <a:xfrm>
            <a:off x="3929229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2" name="Line 386">
            <a:extLst>
              <a:ext uri="{FF2B5EF4-FFF2-40B4-BE49-F238E27FC236}">
                <a16:creationId xmlns:a16="http://schemas.microsoft.com/office/drawing/2014/main" id="{816A7AF7-0162-4A39-B6CE-BD766499F99D}"/>
              </a:ext>
            </a:extLst>
          </p:cNvPr>
          <p:cNvSpPr>
            <a:spLocks noChangeShapeType="1"/>
          </p:cNvSpPr>
          <p:nvPr/>
        </p:nvSpPr>
        <p:spPr bwMode="auto">
          <a:xfrm>
            <a:off x="4237186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3" name="Rectangle 387">
            <a:extLst>
              <a:ext uri="{FF2B5EF4-FFF2-40B4-BE49-F238E27FC236}">
                <a16:creationId xmlns:a16="http://schemas.microsoft.com/office/drawing/2014/main" id="{E05BBAB8-F632-4694-89EB-30582228AF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3983" y="10606398"/>
            <a:ext cx="172910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04" name="Line 388">
            <a:extLst>
              <a:ext uri="{FF2B5EF4-FFF2-40B4-BE49-F238E27FC236}">
                <a16:creationId xmlns:a16="http://schemas.microsoft.com/office/drawing/2014/main" id="{50DDB31E-DB53-4444-924C-5777E437A401}"/>
              </a:ext>
            </a:extLst>
          </p:cNvPr>
          <p:cNvSpPr>
            <a:spLocks noChangeShapeType="1"/>
          </p:cNvSpPr>
          <p:nvPr/>
        </p:nvSpPr>
        <p:spPr bwMode="auto">
          <a:xfrm>
            <a:off x="4550191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5" name="Line 390">
            <a:extLst>
              <a:ext uri="{FF2B5EF4-FFF2-40B4-BE49-F238E27FC236}">
                <a16:creationId xmlns:a16="http://schemas.microsoft.com/office/drawing/2014/main" id="{DABF979B-4ED6-48BF-97D4-C77123F716AC}"/>
              </a:ext>
            </a:extLst>
          </p:cNvPr>
          <p:cNvSpPr>
            <a:spLocks noChangeShapeType="1"/>
          </p:cNvSpPr>
          <p:nvPr/>
        </p:nvSpPr>
        <p:spPr bwMode="auto">
          <a:xfrm>
            <a:off x="4858148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6" name="Rectangle 391">
            <a:extLst>
              <a:ext uri="{FF2B5EF4-FFF2-40B4-BE49-F238E27FC236}">
                <a16:creationId xmlns:a16="http://schemas.microsoft.com/office/drawing/2014/main" id="{F988794E-1B82-4846-B462-210A12D9F8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84945" y="10606398"/>
            <a:ext cx="172910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0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07" name="Line 392">
            <a:extLst>
              <a:ext uri="{FF2B5EF4-FFF2-40B4-BE49-F238E27FC236}">
                <a16:creationId xmlns:a16="http://schemas.microsoft.com/office/drawing/2014/main" id="{FF198DDB-6BA8-4415-9905-D2B5FC3C3C3D}"/>
              </a:ext>
            </a:extLst>
          </p:cNvPr>
          <p:cNvSpPr>
            <a:spLocks noChangeShapeType="1"/>
          </p:cNvSpPr>
          <p:nvPr/>
        </p:nvSpPr>
        <p:spPr bwMode="auto">
          <a:xfrm>
            <a:off x="5166104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8" name="Line 394">
            <a:extLst>
              <a:ext uri="{FF2B5EF4-FFF2-40B4-BE49-F238E27FC236}">
                <a16:creationId xmlns:a16="http://schemas.microsoft.com/office/drawing/2014/main" id="{49E0A4E7-B5EA-41EA-8A22-2DE74F15C586}"/>
              </a:ext>
            </a:extLst>
          </p:cNvPr>
          <p:cNvSpPr>
            <a:spLocks noChangeShapeType="1"/>
          </p:cNvSpPr>
          <p:nvPr/>
        </p:nvSpPr>
        <p:spPr bwMode="auto">
          <a:xfrm>
            <a:off x="5475323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9" name="Rectangle 395">
            <a:extLst>
              <a:ext uri="{FF2B5EF4-FFF2-40B4-BE49-F238E27FC236}">
                <a16:creationId xmlns:a16="http://schemas.microsoft.com/office/drawing/2014/main" id="{0F3DB7B8-8CEC-4504-912D-688227CD2F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2120" y="10606398"/>
            <a:ext cx="172910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0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10" name="Line 396">
            <a:extLst>
              <a:ext uri="{FF2B5EF4-FFF2-40B4-BE49-F238E27FC236}">
                <a16:creationId xmlns:a16="http://schemas.microsoft.com/office/drawing/2014/main" id="{AE6EC713-F2CF-4238-B22B-6C7E7435ED9D}"/>
              </a:ext>
            </a:extLst>
          </p:cNvPr>
          <p:cNvSpPr>
            <a:spLocks noChangeShapeType="1"/>
          </p:cNvSpPr>
          <p:nvPr/>
        </p:nvSpPr>
        <p:spPr bwMode="auto">
          <a:xfrm>
            <a:off x="5787066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1" name="Line 398">
            <a:extLst>
              <a:ext uri="{FF2B5EF4-FFF2-40B4-BE49-F238E27FC236}">
                <a16:creationId xmlns:a16="http://schemas.microsoft.com/office/drawing/2014/main" id="{B7836141-67D1-4861-8EA0-CB55C14380E7}"/>
              </a:ext>
            </a:extLst>
          </p:cNvPr>
          <p:cNvSpPr>
            <a:spLocks noChangeShapeType="1"/>
          </p:cNvSpPr>
          <p:nvPr/>
        </p:nvSpPr>
        <p:spPr bwMode="auto">
          <a:xfrm>
            <a:off x="6095023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2" name="Rectangle 399">
            <a:extLst>
              <a:ext uri="{FF2B5EF4-FFF2-40B4-BE49-F238E27FC236}">
                <a16:creationId xmlns:a16="http://schemas.microsoft.com/office/drawing/2014/main" id="{F1DAC781-3C06-421C-9E24-2A4C68254C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21820" y="10606398"/>
            <a:ext cx="172910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0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13" name="Line 400">
            <a:extLst>
              <a:ext uri="{FF2B5EF4-FFF2-40B4-BE49-F238E27FC236}">
                <a16:creationId xmlns:a16="http://schemas.microsoft.com/office/drawing/2014/main" id="{91D47BD8-6980-4378-944A-A15EE68419C0}"/>
              </a:ext>
            </a:extLst>
          </p:cNvPr>
          <p:cNvSpPr>
            <a:spLocks noChangeShapeType="1"/>
          </p:cNvSpPr>
          <p:nvPr/>
        </p:nvSpPr>
        <p:spPr bwMode="auto">
          <a:xfrm>
            <a:off x="6404242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4" name="Line 402">
            <a:extLst>
              <a:ext uri="{FF2B5EF4-FFF2-40B4-BE49-F238E27FC236}">
                <a16:creationId xmlns:a16="http://schemas.microsoft.com/office/drawing/2014/main" id="{7AF1B777-0BE2-4D80-A517-7E4289BF593F}"/>
              </a:ext>
            </a:extLst>
          </p:cNvPr>
          <p:cNvSpPr>
            <a:spLocks noChangeShapeType="1"/>
          </p:cNvSpPr>
          <p:nvPr/>
        </p:nvSpPr>
        <p:spPr bwMode="auto">
          <a:xfrm>
            <a:off x="6712199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5" name="Rectangle 403">
            <a:extLst>
              <a:ext uri="{FF2B5EF4-FFF2-40B4-BE49-F238E27FC236}">
                <a16:creationId xmlns:a16="http://schemas.microsoft.com/office/drawing/2014/main" id="{9BCB1531-4F1F-4870-BC1E-217B32D6A2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38996" y="10606398"/>
            <a:ext cx="172910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00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16" name="Line 404">
            <a:extLst>
              <a:ext uri="{FF2B5EF4-FFF2-40B4-BE49-F238E27FC236}">
                <a16:creationId xmlns:a16="http://schemas.microsoft.com/office/drawing/2014/main" id="{FB937C01-CB0D-4ECE-861E-10168D7DD570}"/>
              </a:ext>
            </a:extLst>
          </p:cNvPr>
          <p:cNvSpPr>
            <a:spLocks noChangeShapeType="1"/>
          </p:cNvSpPr>
          <p:nvPr/>
        </p:nvSpPr>
        <p:spPr bwMode="auto">
          <a:xfrm>
            <a:off x="7023942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7" name="Line 406">
            <a:extLst>
              <a:ext uri="{FF2B5EF4-FFF2-40B4-BE49-F238E27FC236}">
                <a16:creationId xmlns:a16="http://schemas.microsoft.com/office/drawing/2014/main" id="{E3D9A302-4B9F-4329-B93F-00B81C65D614}"/>
              </a:ext>
            </a:extLst>
          </p:cNvPr>
          <p:cNvSpPr>
            <a:spLocks noChangeShapeType="1"/>
          </p:cNvSpPr>
          <p:nvPr/>
        </p:nvSpPr>
        <p:spPr bwMode="auto">
          <a:xfrm>
            <a:off x="7333161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8" name="Rectangle 407">
            <a:extLst>
              <a:ext uri="{FF2B5EF4-FFF2-40B4-BE49-F238E27FC236}">
                <a16:creationId xmlns:a16="http://schemas.microsoft.com/office/drawing/2014/main" id="{1FE67315-7EC3-4BBE-BABD-5C36219B76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9958" y="10606398"/>
            <a:ext cx="172910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0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19" name="Line 408">
            <a:extLst>
              <a:ext uri="{FF2B5EF4-FFF2-40B4-BE49-F238E27FC236}">
                <a16:creationId xmlns:a16="http://schemas.microsoft.com/office/drawing/2014/main" id="{85042E3B-8422-42D4-9C52-6FF4CDABD39C}"/>
              </a:ext>
            </a:extLst>
          </p:cNvPr>
          <p:cNvSpPr>
            <a:spLocks noChangeShapeType="1"/>
          </p:cNvSpPr>
          <p:nvPr/>
        </p:nvSpPr>
        <p:spPr bwMode="auto">
          <a:xfrm>
            <a:off x="7641117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0" name="Line 410">
            <a:extLst>
              <a:ext uri="{FF2B5EF4-FFF2-40B4-BE49-F238E27FC236}">
                <a16:creationId xmlns:a16="http://schemas.microsoft.com/office/drawing/2014/main" id="{8C7DBFEC-A621-4287-BED2-2006E5FBC8BB}"/>
              </a:ext>
            </a:extLst>
          </p:cNvPr>
          <p:cNvSpPr>
            <a:spLocks noChangeShapeType="1"/>
          </p:cNvSpPr>
          <p:nvPr/>
        </p:nvSpPr>
        <p:spPr bwMode="auto">
          <a:xfrm>
            <a:off x="7949074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1" name="Rectangle 411">
            <a:extLst>
              <a:ext uri="{FF2B5EF4-FFF2-40B4-BE49-F238E27FC236}">
                <a16:creationId xmlns:a16="http://schemas.microsoft.com/office/drawing/2014/main" id="{00148DBF-47F3-4281-98B0-BDC88A86F6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75871" y="10606398"/>
            <a:ext cx="172910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0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22" name="Line 412">
            <a:extLst>
              <a:ext uri="{FF2B5EF4-FFF2-40B4-BE49-F238E27FC236}">
                <a16:creationId xmlns:a16="http://schemas.microsoft.com/office/drawing/2014/main" id="{3040606C-2160-4DE1-9942-1476FCFF4900}"/>
              </a:ext>
            </a:extLst>
          </p:cNvPr>
          <p:cNvSpPr>
            <a:spLocks noChangeShapeType="1"/>
          </p:cNvSpPr>
          <p:nvPr/>
        </p:nvSpPr>
        <p:spPr bwMode="auto">
          <a:xfrm>
            <a:off x="8262079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3" name="Line 414">
            <a:extLst>
              <a:ext uri="{FF2B5EF4-FFF2-40B4-BE49-F238E27FC236}">
                <a16:creationId xmlns:a16="http://schemas.microsoft.com/office/drawing/2014/main" id="{29FFAA84-7936-4C49-AE9C-6E16E45EE571}"/>
              </a:ext>
            </a:extLst>
          </p:cNvPr>
          <p:cNvSpPr>
            <a:spLocks noChangeShapeType="1"/>
          </p:cNvSpPr>
          <p:nvPr/>
        </p:nvSpPr>
        <p:spPr bwMode="auto">
          <a:xfrm>
            <a:off x="8570036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4" name="Rectangle 415">
            <a:extLst>
              <a:ext uri="{FF2B5EF4-FFF2-40B4-BE49-F238E27FC236}">
                <a16:creationId xmlns:a16="http://schemas.microsoft.com/office/drawing/2014/main" id="{E886D63A-339C-4822-8105-0E9271B763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96833" y="10606398"/>
            <a:ext cx="172910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0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25" name="Line 416">
            <a:extLst>
              <a:ext uri="{FF2B5EF4-FFF2-40B4-BE49-F238E27FC236}">
                <a16:creationId xmlns:a16="http://schemas.microsoft.com/office/drawing/2014/main" id="{5C293E9A-B0CD-4AA1-B1C0-3106F3CA8224}"/>
              </a:ext>
            </a:extLst>
          </p:cNvPr>
          <p:cNvSpPr>
            <a:spLocks noChangeShapeType="1"/>
          </p:cNvSpPr>
          <p:nvPr/>
        </p:nvSpPr>
        <p:spPr bwMode="auto">
          <a:xfrm>
            <a:off x="8877993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6" name="Line 418">
            <a:extLst>
              <a:ext uri="{FF2B5EF4-FFF2-40B4-BE49-F238E27FC236}">
                <a16:creationId xmlns:a16="http://schemas.microsoft.com/office/drawing/2014/main" id="{C7A274B2-C1AD-473F-AF46-97025DA2E08E}"/>
              </a:ext>
            </a:extLst>
          </p:cNvPr>
          <p:cNvSpPr>
            <a:spLocks noChangeShapeType="1"/>
          </p:cNvSpPr>
          <p:nvPr/>
        </p:nvSpPr>
        <p:spPr bwMode="auto">
          <a:xfrm>
            <a:off x="9190998" y="10564362"/>
            <a:ext cx="0" cy="42037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7" name="Rectangle 419">
            <a:extLst>
              <a:ext uri="{FF2B5EF4-FFF2-40B4-BE49-F238E27FC236}">
                <a16:creationId xmlns:a16="http://schemas.microsoft.com/office/drawing/2014/main" id="{CC7D464E-BDBC-4395-BB03-F37A590970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96339" y="10606398"/>
            <a:ext cx="230968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28" name="Rectangle 420">
            <a:extLst>
              <a:ext uri="{FF2B5EF4-FFF2-40B4-BE49-F238E27FC236}">
                <a16:creationId xmlns:a16="http://schemas.microsoft.com/office/drawing/2014/main" id="{9799AB08-E78A-4D1A-9BDF-AAF988588B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78323" y="10697478"/>
            <a:ext cx="171648" cy="123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/z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29" name="Line 421">
            <a:extLst>
              <a:ext uri="{FF2B5EF4-FFF2-40B4-BE49-F238E27FC236}">
                <a16:creationId xmlns:a16="http://schemas.microsoft.com/office/drawing/2014/main" id="{922FD55E-FA1E-467B-B84C-CEE88C4A79D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312053" y="7128568"/>
            <a:ext cx="0" cy="343159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0" name="Line 422">
            <a:extLst>
              <a:ext uri="{FF2B5EF4-FFF2-40B4-BE49-F238E27FC236}">
                <a16:creationId xmlns:a16="http://schemas.microsoft.com/office/drawing/2014/main" id="{5AA6224C-E085-4517-82C8-ECEC65EB54B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52512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1" name="Line 423">
            <a:extLst>
              <a:ext uri="{FF2B5EF4-FFF2-40B4-BE49-F238E27FC236}">
                <a16:creationId xmlns:a16="http://schemas.microsoft.com/office/drawing/2014/main" id="{6444AF85-563A-4C73-AE26-DAAA0968561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49149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2" name="Line 424">
            <a:extLst>
              <a:ext uri="{FF2B5EF4-FFF2-40B4-BE49-F238E27FC236}">
                <a16:creationId xmlns:a16="http://schemas.microsoft.com/office/drawing/2014/main" id="{29C30615-7DFE-4ADB-96B0-585E1CBA02C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45646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3" name="Line 425">
            <a:extLst>
              <a:ext uri="{FF2B5EF4-FFF2-40B4-BE49-F238E27FC236}">
                <a16:creationId xmlns:a16="http://schemas.microsoft.com/office/drawing/2014/main" id="{465FF365-C715-4B55-BAED-816126426BE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42283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4" name="Line 426">
            <a:extLst>
              <a:ext uri="{FF2B5EF4-FFF2-40B4-BE49-F238E27FC236}">
                <a16:creationId xmlns:a16="http://schemas.microsoft.com/office/drawing/2014/main" id="{D48537CF-1E49-4EB6-BE52-842AC580A46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35417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5" name="Line 427">
            <a:extLst>
              <a:ext uri="{FF2B5EF4-FFF2-40B4-BE49-F238E27FC236}">
                <a16:creationId xmlns:a16="http://schemas.microsoft.com/office/drawing/2014/main" id="{FC71EDFE-382F-499D-9406-9398C0BAD37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32054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6" name="Line 428">
            <a:extLst>
              <a:ext uri="{FF2B5EF4-FFF2-40B4-BE49-F238E27FC236}">
                <a16:creationId xmlns:a16="http://schemas.microsoft.com/office/drawing/2014/main" id="{45051308-E47D-4F3A-BB5F-61115C2D1DC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28551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7" name="Line 429">
            <a:extLst>
              <a:ext uri="{FF2B5EF4-FFF2-40B4-BE49-F238E27FC236}">
                <a16:creationId xmlns:a16="http://schemas.microsoft.com/office/drawing/2014/main" id="{B70B0CAA-AC95-4101-B05B-D91B248BDE6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25188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8" name="Line 430">
            <a:extLst>
              <a:ext uri="{FF2B5EF4-FFF2-40B4-BE49-F238E27FC236}">
                <a16:creationId xmlns:a16="http://schemas.microsoft.com/office/drawing/2014/main" id="{12D0BCA4-961B-48F7-9A41-4EFCA61BF45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18322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9" name="Line 431">
            <a:extLst>
              <a:ext uri="{FF2B5EF4-FFF2-40B4-BE49-F238E27FC236}">
                <a16:creationId xmlns:a16="http://schemas.microsoft.com/office/drawing/2014/main" id="{2F2811CF-B80E-4035-86C7-ECA3A6710DD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14819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0" name="Line 432">
            <a:extLst>
              <a:ext uri="{FF2B5EF4-FFF2-40B4-BE49-F238E27FC236}">
                <a16:creationId xmlns:a16="http://schemas.microsoft.com/office/drawing/2014/main" id="{7BF8F193-B31D-4801-B50B-B20C6085A8D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11457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1" name="Line 433">
            <a:extLst>
              <a:ext uri="{FF2B5EF4-FFF2-40B4-BE49-F238E27FC236}">
                <a16:creationId xmlns:a16="http://schemas.microsoft.com/office/drawing/2014/main" id="{F38552AE-6ADF-4D96-80BB-85212B7D4E3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07953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2" name="Line 434">
            <a:extLst>
              <a:ext uri="{FF2B5EF4-FFF2-40B4-BE49-F238E27FC236}">
                <a16:creationId xmlns:a16="http://schemas.microsoft.com/office/drawing/2014/main" id="{AA007990-965F-4795-B32D-603FCD9F1C3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1001087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3" name="Line 435">
            <a:extLst>
              <a:ext uri="{FF2B5EF4-FFF2-40B4-BE49-F238E27FC236}">
                <a16:creationId xmlns:a16="http://schemas.microsoft.com/office/drawing/2014/main" id="{E2A40079-274D-448E-AD52-6A01183D882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97725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4" name="Line 436">
            <a:extLst>
              <a:ext uri="{FF2B5EF4-FFF2-40B4-BE49-F238E27FC236}">
                <a16:creationId xmlns:a16="http://schemas.microsoft.com/office/drawing/2014/main" id="{3A7D1E1F-DED3-4D44-B85D-31DBFCEDA6C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94362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5" name="Line 437">
            <a:extLst>
              <a:ext uri="{FF2B5EF4-FFF2-40B4-BE49-F238E27FC236}">
                <a16:creationId xmlns:a16="http://schemas.microsoft.com/office/drawing/2014/main" id="{06035489-5AE7-4F79-BE49-3F04E645BE1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90859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6" name="Line 438">
            <a:extLst>
              <a:ext uri="{FF2B5EF4-FFF2-40B4-BE49-F238E27FC236}">
                <a16:creationId xmlns:a16="http://schemas.microsoft.com/office/drawing/2014/main" id="{8A3C3F36-688D-4822-983B-58B7B80926D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83993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7" name="Line 439">
            <a:extLst>
              <a:ext uri="{FF2B5EF4-FFF2-40B4-BE49-F238E27FC236}">
                <a16:creationId xmlns:a16="http://schemas.microsoft.com/office/drawing/2014/main" id="{46FA2094-AB08-443D-8E75-7646D998604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80630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8" name="Line 440">
            <a:extLst>
              <a:ext uri="{FF2B5EF4-FFF2-40B4-BE49-F238E27FC236}">
                <a16:creationId xmlns:a16="http://schemas.microsoft.com/office/drawing/2014/main" id="{DD4E15C3-315F-47A5-8D68-6CAB659F460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77127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9" name="Line 441">
            <a:extLst>
              <a:ext uri="{FF2B5EF4-FFF2-40B4-BE49-F238E27FC236}">
                <a16:creationId xmlns:a16="http://schemas.microsoft.com/office/drawing/2014/main" id="{B44CB453-E318-4ADC-91DB-90ABA9D0387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73764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0" name="Line 442">
            <a:extLst>
              <a:ext uri="{FF2B5EF4-FFF2-40B4-BE49-F238E27FC236}">
                <a16:creationId xmlns:a16="http://schemas.microsoft.com/office/drawing/2014/main" id="{197EB7DE-03CA-4FFE-A869-65D33C1E130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66898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1" name="Line 443">
            <a:extLst>
              <a:ext uri="{FF2B5EF4-FFF2-40B4-BE49-F238E27FC236}">
                <a16:creationId xmlns:a16="http://schemas.microsoft.com/office/drawing/2014/main" id="{2911A17F-92ED-491A-8FEF-B9F71D9112E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633951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2" name="Line 444">
            <a:extLst>
              <a:ext uri="{FF2B5EF4-FFF2-40B4-BE49-F238E27FC236}">
                <a16:creationId xmlns:a16="http://schemas.microsoft.com/office/drawing/2014/main" id="{731DF82B-FE2B-4B5B-84A7-4A1B4BC7889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60032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3" name="Line 445">
            <a:extLst>
              <a:ext uri="{FF2B5EF4-FFF2-40B4-BE49-F238E27FC236}">
                <a16:creationId xmlns:a16="http://schemas.microsoft.com/office/drawing/2014/main" id="{4F5D359C-44E4-4EB6-8922-7F4F52B6FA3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56669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4" name="Line 446">
            <a:extLst>
              <a:ext uri="{FF2B5EF4-FFF2-40B4-BE49-F238E27FC236}">
                <a16:creationId xmlns:a16="http://schemas.microsoft.com/office/drawing/2014/main" id="{4A0A7F68-D619-44EA-8E87-BBCF444EAC4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49803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5" name="Line 447">
            <a:extLst>
              <a:ext uri="{FF2B5EF4-FFF2-40B4-BE49-F238E27FC236}">
                <a16:creationId xmlns:a16="http://schemas.microsoft.com/office/drawing/2014/main" id="{16F28E47-2E70-4701-AB5E-AF5F1615E89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46300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6" name="Line 448">
            <a:extLst>
              <a:ext uri="{FF2B5EF4-FFF2-40B4-BE49-F238E27FC236}">
                <a16:creationId xmlns:a16="http://schemas.microsoft.com/office/drawing/2014/main" id="{847298D7-75C2-43C9-A825-739830B396A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429373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7" name="Line 449">
            <a:extLst>
              <a:ext uri="{FF2B5EF4-FFF2-40B4-BE49-F238E27FC236}">
                <a16:creationId xmlns:a16="http://schemas.microsoft.com/office/drawing/2014/main" id="{49640609-DA6F-4DDD-93CD-CE4E8FFF854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39434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8" name="Line 450">
            <a:extLst>
              <a:ext uri="{FF2B5EF4-FFF2-40B4-BE49-F238E27FC236}">
                <a16:creationId xmlns:a16="http://schemas.microsoft.com/office/drawing/2014/main" id="{1678602F-0D00-43A9-8857-84609E80232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32568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9" name="Line 451">
            <a:extLst>
              <a:ext uri="{FF2B5EF4-FFF2-40B4-BE49-F238E27FC236}">
                <a16:creationId xmlns:a16="http://schemas.microsoft.com/office/drawing/2014/main" id="{578A2206-582F-4734-A4B7-4E64D546507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292053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0" name="Line 452">
            <a:extLst>
              <a:ext uri="{FF2B5EF4-FFF2-40B4-BE49-F238E27FC236}">
                <a16:creationId xmlns:a16="http://schemas.microsoft.com/office/drawing/2014/main" id="{A5B8598A-87DC-439B-9793-1854E0B41C3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257022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1" name="Line 453">
            <a:extLst>
              <a:ext uri="{FF2B5EF4-FFF2-40B4-BE49-F238E27FC236}">
                <a16:creationId xmlns:a16="http://schemas.microsoft.com/office/drawing/2014/main" id="{72E01991-364D-45EF-B29F-3A4A430595E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223393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2" name="Line 454">
            <a:extLst>
              <a:ext uri="{FF2B5EF4-FFF2-40B4-BE49-F238E27FC236}">
                <a16:creationId xmlns:a16="http://schemas.microsoft.com/office/drawing/2014/main" id="{9F8F0A8F-2E22-4C1A-80A5-31E96E27D9E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154733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3" name="Line 455">
            <a:extLst>
              <a:ext uri="{FF2B5EF4-FFF2-40B4-BE49-F238E27FC236}">
                <a16:creationId xmlns:a16="http://schemas.microsoft.com/office/drawing/2014/main" id="{5D5F3D83-036C-4F02-81FE-07C4C7AA70F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12110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4" name="Line 456">
            <a:extLst>
              <a:ext uri="{FF2B5EF4-FFF2-40B4-BE49-F238E27FC236}">
                <a16:creationId xmlns:a16="http://schemas.microsoft.com/office/drawing/2014/main" id="{66B32547-EF9F-4574-8E0E-1DBF9DBF7C0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086073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5" name="Line 457">
            <a:extLst>
              <a:ext uri="{FF2B5EF4-FFF2-40B4-BE49-F238E27FC236}">
                <a16:creationId xmlns:a16="http://schemas.microsoft.com/office/drawing/2014/main" id="{52A7113E-B794-47F4-8EBE-EBDA6EB5464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905244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6" name="Line 458">
            <a:extLst>
              <a:ext uri="{FF2B5EF4-FFF2-40B4-BE49-F238E27FC236}">
                <a16:creationId xmlns:a16="http://schemas.microsoft.com/office/drawing/2014/main" id="{7D2FEED0-EBB6-43F8-8EAB-D356AD56905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98378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7" name="Line 459">
            <a:extLst>
              <a:ext uri="{FF2B5EF4-FFF2-40B4-BE49-F238E27FC236}">
                <a16:creationId xmlns:a16="http://schemas.microsoft.com/office/drawing/2014/main" id="{8A1F7851-4F7F-4645-83A0-B6DDE28247F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94875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8" name="Line 460">
            <a:extLst>
              <a:ext uri="{FF2B5EF4-FFF2-40B4-BE49-F238E27FC236}">
                <a16:creationId xmlns:a16="http://schemas.microsoft.com/office/drawing/2014/main" id="{4BC3E47A-BDD9-475D-B4E7-A112860604D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91512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9" name="Line 461">
            <a:extLst>
              <a:ext uri="{FF2B5EF4-FFF2-40B4-BE49-F238E27FC236}">
                <a16:creationId xmlns:a16="http://schemas.microsoft.com/office/drawing/2014/main" id="{AE6C4589-931A-4596-AB77-434C7CDD6D1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880094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0" name="Line 462">
            <a:extLst>
              <a:ext uri="{FF2B5EF4-FFF2-40B4-BE49-F238E27FC236}">
                <a16:creationId xmlns:a16="http://schemas.microsoft.com/office/drawing/2014/main" id="{22B52FD6-F3E9-4FDB-A928-DF0EFC28E4E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81283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1" name="Line 463">
            <a:extLst>
              <a:ext uri="{FF2B5EF4-FFF2-40B4-BE49-F238E27FC236}">
                <a16:creationId xmlns:a16="http://schemas.microsoft.com/office/drawing/2014/main" id="{732D6BEB-95AD-4F5B-AEE1-B7800442E3A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77780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2" name="Line 464">
            <a:extLst>
              <a:ext uri="{FF2B5EF4-FFF2-40B4-BE49-F238E27FC236}">
                <a16:creationId xmlns:a16="http://schemas.microsoft.com/office/drawing/2014/main" id="{89A460F4-5200-4A07-9B16-E23E1757014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74417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3" name="Line 465">
            <a:extLst>
              <a:ext uri="{FF2B5EF4-FFF2-40B4-BE49-F238E27FC236}">
                <a16:creationId xmlns:a16="http://schemas.microsoft.com/office/drawing/2014/main" id="{96A8D984-A243-4EC5-BD08-1658AAEE033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70914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4" name="Line 466">
            <a:extLst>
              <a:ext uri="{FF2B5EF4-FFF2-40B4-BE49-F238E27FC236}">
                <a16:creationId xmlns:a16="http://schemas.microsoft.com/office/drawing/2014/main" id="{DABBE1DE-4AB3-40A2-8627-FEC8196EAFC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64048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5" name="Line 467">
            <a:extLst>
              <a:ext uri="{FF2B5EF4-FFF2-40B4-BE49-F238E27FC236}">
                <a16:creationId xmlns:a16="http://schemas.microsoft.com/office/drawing/2014/main" id="{DFD3FB56-180F-4FFB-BB8A-A9B329B49E9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60685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6" name="Line 468">
            <a:extLst>
              <a:ext uri="{FF2B5EF4-FFF2-40B4-BE49-F238E27FC236}">
                <a16:creationId xmlns:a16="http://schemas.microsoft.com/office/drawing/2014/main" id="{B5580FA8-C953-4EFB-BC27-6879335826B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57182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7" name="Line 469">
            <a:extLst>
              <a:ext uri="{FF2B5EF4-FFF2-40B4-BE49-F238E27FC236}">
                <a16:creationId xmlns:a16="http://schemas.microsoft.com/office/drawing/2014/main" id="{435D63B2-1A63-4C2F-8D6E-8486B61380A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53819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8" name="Line 470">
            <a:extLst>
              <a:ext uri="{FF2B5EF4-FFF2-40B4-BE49-F238E27FC236}">
                <a16:creationId xmlns:a16="http://schemas.microsoft.com/office/drawing/2014/main" id="{E4BDAC0C-F0F3-4605-B02C-EA1844E6F4C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46953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9" name="Line 471">
            <a:extLst>
              <a:ext uri="{FF2B5EF4-FFF2-40B4-BE49-F238E27FC236}">
                <a16:creationId xmlns:a16="http://schemas.microsoft.com/office/drawing/2014/main" id="{98914CAB-F165-4E5C-8F0C-5AEAA3A4FCC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43590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0" name="Line 472">
            <a:extLst>
              <a:ext uri="{FF2B5EF4-FFF2-40B4-BE49-F238E27FC236}">
                <a16:creationId xmlns:a16="http://schemas.microsoft.com/office/drawing/2014/main" id="{3A718028-33CF-4C65-861A-9260E63B419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40087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1" name="Line 473">
            <a:extLst>
              <a:ext uri="{FF2B5EF4-FFF2-40B4-BE49-F238E27FC236}">
                <a16:creationId xmlns:a16="http://schemas.microsoft.com/office/drawing/2014/main" id="{EF26F70E-54BC-4517-ABCA-FEDB7874977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36724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2" name="Line 474">
            <a:extLst>
              <a:ext uri="{FF2B5EF4-FFF2-40B4-BE49-F238E27FC236}">
                <a16:creationId xmlns:a16="http://schemas.microsoft.com/office/drawing/2014/main" id="{BBB22709-8EDA-4135-B2A5-92C0A5CEF5B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29858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3" name="Line 475">
            <a:extLst>
              <a:ext uri="{FF2B5EF4-FFF2-40B4-BE49-F238E27FC236}">
                <a16:creationId xmlns:a16="http://schemas.microsoft.com/office/drawing/2014/main" id="{B16B68A3-8885-4ABD-AA60-67C77912887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26355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4" name="Line 476">
            <a:extLst>
              <a:ext uri="{FF2B5EF4-FFF2-40B4-BE49-F238E27FC236}">
                <a16:creationId xmlns:a16="http://schemas.microsoft.com/office/drawing/2014/main" id="{A7C14AAF-3D05-4642-85C5-96D947DE951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22992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5" name="Line 477">
            <a:extLst>
              <a:ext uri="{FF2B5EF4-FFF2-40B4-BE49-F238E27FC236}">
                <a16:creationId xmlns:a16="http://schemas.microsoft.com/office/drawing/2014/main" id="{60C0E9B6-6C50-4D7A-B65F-50AA663A102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19489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6" name="Line 478">
            <a:extLst>
              <a:ext uri="{FF2B5EF4-FFF2-40B4-BE49-F238E27FC236}">
                <a16:creationId xmlns:a16="http://schemas.microsoft.com/office/drawing/2014/main" id="{A6BD5709-D5C5-4453-9E19-1986E6D748C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12623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7" name="Line 479">
            <a:extLst>
              <a:ext uri="{FF2B5EF4-FFF2-40B4-BE49-F238E27FC236}">
                <a16:creationId xmlns:a16="http://schemas.microsoft.com/office/drawing/2014/main" id="{C556AA01-6669-4E02-86F3-7AA64D6C8E6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09260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8" name="Line 480">
            <a:extLst>
              <a:ext uri="{FF2B5EF4-FFF2-40B4-BE49-F238E27FC236}">
                <a16:creationId xmlns:a16="http://schemas.microsoft.com/office/drawing/2014/main" id="{0B300A24-37E3-444B-A3DF-0B9EEBAA172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05897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9" name="Line 481">
            <a:extLst>
              <a:ext uri="{FF2B5EF4-FFF2-40B4-BE49-F238E27FC236}">
                <a16:creationId xmlns:a16="http://schemas.microsoft.com/office/drawing/2014/main" id="{6E16C4DF-78C6-4A05-8E8F-A2F40C0CD3A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802394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0" name="Line 482">
            <a:extLst>
              <a:ext uri="{FF2B5EF4-FFF2-40B4-BE49-F238E27FC236}">
                <a16:creationId xmlns:a16="http://schemas.microsoft.com/office/drawing/2014/main" id="{AD47686F-838C-46DC-B527-A4AF13B8430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95528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1" name="Line 483">
            <a:extLst>
              <a:ext uri="{FF2B5EF4-FFF2-40B4-BE49-F238E27FC236}">
                <a16:creationId xmlns:a16="http://schemas.microsoft.com/office/drawing/2014/main" id="{3996EE67-34B4-49EE-AF8F-DE43F3BF125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92165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2" name="Line 484">
            <a:extLst>
              <a:ext uri="{FF2B5EF4-FFF2-40B4-BE49-F238E27FC236}">
                <a16:creationId xmlns:a16="http://schemas.microsoft.com/office/drawing/2014/main" id="{1C30726E-4A49-40CE-B948-D8088625382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886628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3" name="Line 485">
            <a:extLst>
              <a:ext uri="{FF2B5EF4-FFF2-40B4-BE49-F238E27FC236}">
                <a16:creationId xmlns:a16="http://schemas.microsoft.com/office/drawing/2014/main" id="{BB23524F-0A15-4E18-B01F-BCE67659CE6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85299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4" name="Line 486">
            <a:extLst>
              <a:ext uri="{FF2B5EF4-FFF2-40B4-BE49-F238E27FC236}">
                <a16:creationId xmlns:a16="http://schemas.microsoft.com/office/drawing/2014/main" id="{F51FA790-F1BB-41B8-82EB-56FB53A4065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78433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5" name="Line 487">
            <a:extLst>
              <a:ext uri="{FF2B5EF4-FFF2-40B4-BE49-F238E27FC236}">
                <a16:creationId xmlns:a16="http://schemas.microsoft.com/office/drawing/2014/main" id="{6C5A20AF-16AC-490C-AF8A-19F70702149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74930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6" name="Line 488">
            <a:extLst>
              <a:ext uri="{FF2B5EF4-FFF2-40B4-BE49-F238E27FC236}">
                <a16:creationId xmlns:a16="http://schemas.microsoft.com/office/drawing/2014/main" id="{8B43527F-2748-46BC-BA22-72503F34DB6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715679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7" name="Line 489">
            <a:extLst>
              <a:ext uri="{FF2B5EF4-FFF2-40B4-BE49-F238E27FC236}">
                <a16:creationId xmlns:a16="http://schemas.microsoft.com/office/drawing/2014/main" id="{240F0E49-709F-4A6B-99E4-90CC36FB201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68205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8" name="Line 490">
            <a:extLst>
              <a:ext uri="{FF2B5EF4-FFF2-40B4-BE49-F238E27FC236}">
                <a16:creationId xmlns:a16="http://schemas.microsoft.com/office/drawing/2014/main" id="{C52BA517-2D96-4F3E-BBDF-2A22FDD9841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613390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Line 492">
            <a:extLst>
              <a:ext uri="{FF2B5EF4-FFF2-40B4-BE49-F238E27FC236}">
                <a16:creationId xmlns:a16="http://schemas.microsoft.com/office/drawing/2014/main" id="{18DB44AC-FB09-4D8F-A2F9-4A4B6614C9B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57836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Line 493">
            <a:extLst>
              <a:ext uri="{FF2B5EF4-FFF2-40B4-BE49-F238E27FC236}">
                <a16:creationId xmlns:a16="http://schemas.microsoft.com/office/drawing/2014/main" id="{F12D7660-D5FF-4465-A435-652F532A07D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54473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Line 494">
            <a:extLst>
              <a:ext uri="{FF2B5EF4-FFF2-40B4-BE49-F238E27FC236}">
                <a16:creationId xmlns:a16="http://schemas.microsoft.com/office/drawing/2014/main" id="{07473BF0-9DDD-4CA0-BA20-EEBA1768DD1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50970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Line 495">
            <a:extLst>
              <a:ext uri="{FF2B5EF4-FFF2-40B4-BE49-F238E27FC236}">
                <a16:creationId xmlns:a16="http://schemas.microsoft.com/office/drawing/2014/main" id="{73F5E1AB-E761-4A64-BFD6-26657F879A0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44104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Line 496">
            <a:extLst>
              <a:ext uri="{FF2B5EF4-FFF2-40B4-BE49-F238E27FC236}">
                <a16:creationId xmlns:a16="http://schemas.microsoft.com/office/drawing/2014/main" id="{6F3B2D13-DA32-4D89-8A7B-684A3374D68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40741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Line 497">
            <a:extLst>
              <a:ext uri="{FF2B5EF4-FFF2-40B4-BE49-F238E27FC236}">
                <a16:creationId xmlns:a16="http://schemas.microsoft.com/office/drawing/2014/main" id="{9ED7F951-1BAC-4177-99F3-078DF987D12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372385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Line 498">
            <a:extLst>
              <a:ext uri="{FF2B5EF4-FFF2-40B4-BE49-F238E27FC236}">
                <a16:creationId xmlns:a16="http://schemas.microsoft.com/office/drawing/2014/main" id="{FFF1698D-9CF0-4770-8786-BC1D981674B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33875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Line 499">
            <a:extLst>
              <a:ext uri="{FF2B5EF4-FFF2-40B4-BE49-F238E27FC236}">
                <a16:creationId xmlns:a16="http://schemas.microsoft.com/office/drawing/2014/main" id="{62BF5FFA-B2CB-40CF-BE58-9D9DA93895E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27009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Line 500">
            <a:extLst>
              <a:ext uri="{FF2B5EF4-FFF2-40B4-BE49-F238E27FC236}">
                <a16:creationId xmlns:a16="http://schemas.microsoft.com/office/drawing/2014/main" id="{46855666-9643-43E2-97CE-50018ED2D6A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23646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Line 501">
            <a:extLst>
              <a:ext uri="{FF2B5EF4-FFF2-40B4-BE49-F238E27FC236}">
                <a16:creationId xmlns:a16="http://schemas.microsoft.com/office/drawing/2014/main" id="{DDA837F2-DB87-4077-8BB7-D55EEC20461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201436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Line 502">
            <a:extLst>
              <a:ext uri="{FF2B5EF4-FFF2-40B4-BE49-F238E27FC236}">
                <a16:creationId xmlns:a16="http://schemas.microsoft.com/office/drawing/2014/main" id="{A6B494D6-3A03-41ED-888D-4D2A96C3290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85549" y="7167807"/>
            <a:ext cx="2650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Line 503">
            <a:extLst>
              <a:ext uri="{FF2B5EF4-FFF2-40B4-BE49-F238E27FC236}">
                <a16:creationId xmlns:a16="http://schemas.microsoft.com/office/drawing/2014/main" id="{D37C6CA2-CA02-4A25-8238-8F4C0A043EC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10560167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Rectangle 504">
            <a:extLst>
              <a:ext uri="{FF2B5EF4-FFF2-40B4-BE49-F238E27FC236}">
                <a16:creationId xmlns:a16="http://schemas.microsoft.com/office/drawing/2014/main" id="{0305639B-FFAA-42DE-BFFB-D634C5C8DC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04774" y="1052093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34" name="Line 505">
            <a:extLst>
              <a:ext uri="{FF2B5EF4-FFF2-40B4-BE49-F238E27FC236}">
                <a16:creationId xmlns:a16="http://schemas.microsoft.com/office/drawing/2014/main" id="{BC6CAED3-C29F-4E5F-8B4B-1D9D13828F5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10389217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Line 507">
            <a:extLst>
              <a:ext uri="{FF2B5EF4-FFF2-40B4-BE49-F238E27FC236}">
                <a16:creationId xmlns:a16="http://schemas.microsoft.com/office/drawing/2014/main" id="{F593308D-DB1A-4A75-814D-50577481C65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10216867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Rectangle 508">
            <a:extLst>
              <a:ext uri="{FF2B5EF4-FFF2-40B4-BE49-F238E27FC236}">
                <a16:creationId xmlns:a16="http://schemas.microsoft.com/office/drawing/2014/main" id="{49DCB9A4-01B0-41C6-B99B-1D8CA3D053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5648" y="10179034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37" name="Line 509">
            <a:extLst>
              <a:ext uri="{FF2B5EF4-FFF2-40B4-BE49-F238E27FC236}">
                <a16:creationId xmlns:a16="http://schemas.microsoft.com/office/drawing/2014/main" id="{45E10822-A549-4D81-8CF0-B0F9BC33767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10045918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Line 511">
            <a:extLst>
              <a:ext uri="{FF2B5EF4-FFF2-40B4-BE49-F238E27FC236}">
                <a16:creationId xmlns:a16="http://schemas.microsoft.com/office/drawing/2014/main" id="{045EB4AC-8660-427D-BD34-A96F229E045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9874969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Rectangle 512">
            <a:extLst>
              <a:ext uri="{FF2B5EF4-FFF2-40B4-BE49-F238E27FC236}">
                <a16:creationId xmlns:a16="http://schemas.microsoft.com/office/drawing/2014/main" id="{76C02D55-3FC6-4FB4-935F-3CC596495C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5648" y="9835735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40" name="Line 513">
            <a:extLst>
              <a:ext uri="{FF2B5EF4-FFF2-40B4-BE49-F238E27FC236}">
                <a16:creationId xmlns:a16="http://schemas.microsoft.com/office/drawing/2014/main" id="{5B2C4CE7-FCCC-42F6-8D02-98DB1D837A1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9702618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Line 515">
            <a:extLst>
              <a:ext uri="{FF2B5EF4-FFF2-40B4-BE49-F238E27FC236}">
                <a16:creationId xmlns:a16="http://schemas.microsoft.com/office/drawing/2014/main" id="{E797352A-9395-484B-B890-B999C6A66EB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9531669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Rectangle 516">
            <a:extLst>
              <a:ext uri="{FF2B5EF4-FFF2-40B4-BE49-F238E27FC236}">
                <a16:creationId xmlns:a16="http://schemas.microsoft.com/office/drawing/2014/main" id="{5A8F6394-6C35-42EF-B3F2-EC1B5AF3AA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5648" y="9492435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43" name="Line 517">
            <a:extLst>
              <a:ext uri="{FF2B5EF4-FFF2-40B4-BE49-F238E27FC236}">
                <a16:creationId xmlns:a16="http://schemas.microsoft.com/office/drawing/2014/main" id="{EECED53C-3AE1-44ED-A8B0-B4531579FF4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9360720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Line 519">
            <a:extLst>
              <a:ext uri="{FF2B5EF4-FFF2-40B4-BE49-F238E27FC236}">
                <a16:creationId xmlns:a16="http://schemas.microsoft.com/office/drawing/2014/main" id="{E7EBCBD4-13E9-464A-BDE9-BA4F057AD92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9189771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5" name="Rectangle 520">
            <a:extLst>
              <a:ext uri="{FF2B5EF4-FFF2-40B4-BE49-F238E27FC236}">
                <a16:creationId xmlns:a16="http://schemas.microsoft.com/office/drawing/2014/main" id="{F4A5708B-09FC-4FFB-8DAF-E953CADAAC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5648" y="915053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46" name="Line 521">
            <a:extLst>
              <a:ext uri="{FF2B5EF4-FFF2-40B4-BE49-F238E27FC236}">
                <a16:creationId xmlns:a16="http://schemas.microsoft.com/office/drawing/2014/main" id="{EFA754A2-7793-429A-B9CC-0C6BF7EC2B7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9017421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7" name="Line 523">
            <a:extLst>
              <a:ext uri="{FF2B5EF4-FFF2-40B4-BE49-F238E27FC236}">
                <a16:creationId xmlns:a16="http://schemas.microsoft.com/office/drawing/2014/main" id="{31057FB7-C656-4014-9B1B-93EE6437741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8846472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Rectangle 524">
            <a:extLst>
              <a:ext uri="{FF2B5EF4-FFF2-40B4-BE49-F238E27FC236}">
                <a16:creationId xmlns:a16="http://schemas.microsoft.com/office/drawing/2014/main" id="{3A80A198-86E7-40FF-9EFA-8860D98F9D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5648" y="880723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49" name="Line 525">
            <a:extLst>
              <a:ext uri="{FF2B5EF4-FFF2-40B4-BE49-F238E27FC236}">
                <a16:creationId xmlns:a16="http://schemas.microsoft.com/office/drawing/2014/main" id="{FD7882BC-93AC-4797-B642-7B7F3CD84AA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8675522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Line 527">
            <a:extLst>
              <a:ext uri="{FF2B5EF4-FFF2-40B4-BE49-F238E27FC236}">
                <a16:creationId xmlns:a16="http://schemas.microsoft.com/office/drawing/2014/main" id="{15CAD41F-2BF7-458E-8A59-815F04BC73C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8503172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1" name="Rectangle 528">
            <a:extLst>
              <a:ext uri="{FF2B5EF4-FFF2-40B4-BE49-F238E27FC236}">
                <a16:creationId xmlns:a16="http://schemas.microsoft.com/office/drawing/2014/main" id="{C8B41DC2-87F9-47A8-BB80-91EBDE1546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5648" y="8465339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52" name="Line 529">
            <a:extLst>
              <a:ext uri="{FF2B5EF4-FFF2-40B4-BE49-F238E27FC236}">
                <a16:creationId xmlns:a16="http://schemas.microsoft.com/office/drawing/2014/main" id="{0350BBF9-B26E-4218-8889-CFDCC4BE2C5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8332222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Line 531">
            <a:extLst>
              <a:ext uri="{FF2B5EF4-FFF2-40B4-BE49-F238E27FC236}">
                <a16:creationId xmlns:a16="http://schemas.microsoft.com/office/drawing/2014/main" id="{5AA99173-0BF7-4EF8-A86E-38846518BFF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8161273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4" name="Rectangle 532">
            <a:extLst>
              <a:ext uri="{FF2B5EF4-FFF2-40B4-BE49-F238E27FC236}">
                <a16:creationId xmlns:a16="http://schemas.microsoft.com/office/drawing/2014/main" id="{32827AAB-A732-4459-8CEF-9AF657C400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5648" y="8122039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0</a:t>
            </a:r>
            <a:endParaRPr kumimoji="0" lang="en-US" altLang="en-US" sz="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55" name="Line 533">
            <a:extLst>
              <a:ext uri="{FF2B5EF4-FFF2-40B4-BE49-F238E27FC236}">
                <a16:creationId xmlns:a16="http://schemas.microsoft.com/office/drawing/2014/main" id="{A7F405EC-B996-4368-B475-B958A0C2F65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7990324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1" name="Line 535">
            <a:extLst>
              <a:ext uri="{FF2B5EF4-FFF2-40B4-BE49-F238E27FC236}">
                <a16:creationId xmlns:a16="http://schemas.microsoft.com/office/drawing/2014/main" id="{55C988AF-F992-4E1F-89C7-546735CEDA1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7817974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Rectangle 536">
            <a:extLst>
              <a:ext uri="{FF2B5EF4-FFF2-40B4-BE49-F238E27FC236}">
                <a16:creationId xmlns:a16="http://schemas.microsoft.com/office/drawing/2014/main" id="{17914762-4C0C-49D8-8741-EBF3C9B63E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5648" y="7780141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0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79" name="Line 537">
            <a:extLst>
              <a:ext uri="{FF2B5EF4-FFF2-40B4-BE49-F238E27FC236}">
                <a16:creationId xmlns:a16="http://schemas.microsoft.com/office/drawing/2014/main" id="{C80B7EB6-22E1-4701-B361-A4341879462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7647025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3" name="Line 539">
            <a:extLst>
              <a:ext uri="{FF2B5EF4-FFF2-40B4-BE49-F238E27FC236}">
                <a16:creationId xmlns:a16="http://schemas.microsoft.com/office/drawing/2014/main" id="{B3D37B8C-7358-4609-8515-3B7530321D9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7476076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7" name="Rectangle 540">
            <a:extLst>
              <a:ext uri="{FF2B5EF4-FFF2-40B4-BE49-F238E27FC236}">
                <a16:creationId xmlns:a16="http://schemas.microsoft.com/office/drawing/2014/main" id="{191ECDB2-8C9E-4EBD-BC70-A25E1E9280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5648" y="7436842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0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91" name="Line 541">
            <a:extLst>
              <a:ext uri="{FF2B5EF4-FFF2-40B4-BE49-F238E27FC236}">
                <a16:creationId xmlns:a16="http://schemas.microsoft.com/office/drawing/2014/main" id="{4175DE61-F0BF-414F-8A55-5E35FAFE4B9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7305127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5" name="Line 543">
            <a:extLst>
              <a:ext uri="{FF2B5EF4-FFF2-40B4-BE49-F238E27FC236}">
                <a16:creationId xmlns:a16="http://schemas.microsoft.com/office/drawing/2014/main" id="{0EC5CCD1-46F8-417A-AAC3-0E8163D939C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4190" y="7128573"/>
            <a:ext cx="37864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9" name="Rectangle 544">
            <a:extLst>
              <a:ext uri="{FF2B5EF4-FFF2-40B4-BE49-F238E27FC236}">
                <a16:creationId xmlns:a16="http://schemas.microsoft.com/office/drawing/2014/main" id="{EADACF63-F393-4A96-BBAC-EA565E0B33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05737" y="7077464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03" name="Rectangle 545">
            <a:extLst>
              <a:ext uri="{FF2B5EF4-FFF2-40B4-BE49-F238E27FC236}">
                <a16:creationId xmlns:a16="http://schemas.microsoft.com/office/drawing/2014/main" id="{D789340D-6C23-4690-B8B5-49634F13DA0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519919" y="8800014"/>
            <a:ext cx="98424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elative Abundance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07" name="Rectangle 547">
            <a:extLst>
              <a:ext uri="{FF2B5EF4-FFF2-40B4-BE49-F238E27FC236}">
                <a16:creationId xmlns:a16="http://schemas.microsoft.com/office/drawing/2014/main" id="{3A4D51BA-0EC8-47D6-BFE5-6B37D2B3DB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12293" y="7109025"/>
            <a:ext cx="50334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arent Ion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13" name="Rectangle 547">
            <a:extLst>
              <a:ext uri="{FF2B5EF4-FFF2-40B4-BE49-F238E27FC236}">
                <a16:creationId xmlns:a16="http://schemas.microsoft.com/office/drawing/2014/main" id="{195B6B71-0450-4A1A-ABAF-71471FEB67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9896" y="7251752"/>
            <a:ext cx="43281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29.1058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aphicFrame>
        <p:nvGraphicFramePr>
          <p:cNvPr id="283" name="Object 282">
            <a:extLst>
              <a:ext uri="{FF2B5EF4-FFF2-40B4-BE49-F238E27FC236}">
                <a16:creationId xmlns:a16="http://schemas.microsoft.com/office/drawing/2014/main" id="{BF37B6CA-22A7-44D9-979A-B2C895CB18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9526409"/>
              </p:ext>
            </p:extLst>
          </p:nvPr>
        </p:nvGraphicFramePr>
        <p:xfrm>
          <a:off x="5492652" y="7463058"/>
          <a:ext cx="2302366" cy="1855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8" r:id="rId6" imgW="3393440" imgH="2735172" progId="">
                  <p:embed/>
                </p:oleObj>
              </mc:Choice>
              <mc:Fallback>
                <p:oleObj r:id="rId6" imgW="3393440" imgH="2735172" progId="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BEAE10D-506F-4523-819C-AE51F5239BB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492652" y="7463058"/>
                        <a:ext cx="2302366" cy="1855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99" name="TextBox 798">
            <a:extLst>
              <a:ext uri="{FF2B5EF4-FFF2-40B4-BE49-F238E27FC236}">
                <a16:creationId xmlns:a16="http://schemas.microsoft.com/office/drawing/2014/main" id="{33172A58-B9A2-4A89-A0DF-E23895943C99}"/>
              </a:ext>
            </a:extLst>
          </p:cNvPr>
          <p:cNvSpPr txBox="1"/>
          <p:nvPr/>
        </p:nvSpPr>
        <p:spPr>
          <a:xfrm>
            <a:off x="2569072" y="6615408"/>
            <a:ext cx="7025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734BB33-F334-49CF-9AD8-7D98EC2C60A3}"/>
              </a:ext>
            </a:extLst>
          </p:cNvPr>
          <p:cNvSpPr/>
          <p:nvPr/>
        </p:nvSpPr>
        <p:spPr>
          <a:xfrm>
            <a:off x="2777382" y="11379709"/>
            <a:ext cx="707146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mass spectra of apocynin and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diapocyn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alytes (1000 ng/mL) were dissolved in methanol/water (1:1 v/v) and the full-scan spectra were obtained in negative heated electrospray ionization mode of Orbitrap. (a) Apocynin spectra showed a prominent parent peak at m/z 165.0543. (b)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Diapocyn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spectra showed a prominent parent peak at m/z 329.1058. </a:t>
            </a:r>
          </a:p>
        </p:txBody>
      </p:sp>
    </p:spTree>
    <p:extLst>
      <p:ext uri="{BB962C8B-B14F-4D97-AF65-F5344CB8AC3E}">
        <p14:creationId xmlns:p14="http://schemas.microsoft.com/office/powerpoint/2010/main" val="34872323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05CDFD84-0C14-4A4C-A7A8-948DB42450B3}"/>
              </a:ext>
            </a:extLst>
          </p:cNvPr>
          <p:cNvGrpSpPr/>
          <p:nvPr/>
        </p:nvGrpSpPr>
        <p:grpSpPr>
          <a:xfrm>
            <a:off x="2735163" y="2540964"/>
            <a:ext cx="7118549" cy="12021607"/>
            <a:chOff x="2735163" y="2540964"/>
            <a:chExt cx="7118549" cy="12021607"/>
          </a:xfrm>
        </p:grpSpPr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9CE2656C-97FC-45AD-B50A-742DD0590F53}"/>
                </a:ext>
              </a:extLst>
            </p:cNvPr>
            <p:cNvSpPr txBox="1"/>
            <p:nvPr/>
          </p:nvSpPr>
          <p:spPr>
            <a:xfrm>
              <a:off x="2735163" y="13546908"/>
              <a:ext cx="7118549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l Figure 2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. Levels of ROS production detected in organs of vehicle injected mice.</a:t>
              </a:r>
            </a:p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 mice (n=3) were injected (iv) with vehicle  (v/v. ethanol/saline = 1/99) and organs were harvested at the times as described for the apocynin group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.-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production in tissue homogenates was measured by lucigenin-chemiluminescence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. Data were expressed as % of the levels of ROS production by samples harvested at time 0 point (100%). </a:t>
              </a:r>
            </a:p>
          </p:txBody>
        </p:sp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A1E2E64B-2B7F-4F52-BCDE-C95A76E91AE0}"/>
                </a:ext>
              </a:extLst>
            </p:cNvPr>
            <p:cNvGrpSpPr/>
            <p:nvPr/>
          </p:nvGrpSpPr>
          <p:grpSpPr>
            <a:xfrm>
              <a:off x="3789363" y="3095933"/>
              <a:ext cx="4754563" cy="2601913"/>
              <a:chOff x="3819525" y="3309938"/>
              <a:chExt cx="4754563" cy="2601913"/>
            </a:xfrm>
          </p:grpSpPr>
          <p:sp>
            <p:nvSpPr>
              <p:cNvPr id="1123" name="Freeform 6">
                <a:extLst>
                  <a:ext uri="{FF2B5EF4-FFF2-40B4-BE49-F238E27FC236}">
                    <a16:creationId xmlns:a16="http://schemas.microsoft.com/office/drawing/2014/main" id="{A944E31E-86A9-4FCB-89D6-9453E091F27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038600" y="3894138"/>
                <a:ext cx="4356100" cy="1981200"/>
              </a:xfrm>
              <a:custGeom>
                <a:avLst/>
                <a:gdLst>
                  <a:gd name="T0" fmla="*/ 0 w 2744"/>
                  <a:gd name="T1" fmla="*/ 125 h 1248"/>
                  <a:gd name="T2" fmla="*/ 103 w 2744"/>
                  <a:gd name="T3" fmla="*/ 125 h 1248"/>
                  <a:gd name="T4" fmla="*/ 103 w 2744"/>
                  <a:gd name="T5" fmla="*/ 1248 h 1248"/>
                  <a:gd name="T6" fmla="*/ 0 w 2744"/>
                  <a:gd name="T7" fmla="*/ 1248 h 1248"/>
                  <a:gd name="T8" fmla="*/ 0 w 2744"/>
                  <a:gd name="T9" fmla="*/ 125 h 1248"/>
                  <a:gd name="T10" fmla="*/ 330 w 2744"/>
                  <a:gd name="T11" fmla="*/ 81 h 1248"/>
                  <a:gd name="T12" fmla="*/ 434 w 2744"/>
                  <a:gd name="T13" fmla="*/ 81 h 1248"/>
                  <a:gd name="T14" fmla="*/ 434 w 2744"/>
                  <a:gd name="T15" fmla="*/ 1248 h 1248"/>
                  <a:gd name="T16" fmla="*/ 330 w 2744"/>
                  <a:gd name="T17" fmla="*/ 1248 h 1248"/>
                  <a:gd name="T18" fmla="*/ 330 w 2744"/>
                  <a:gd name="T19" fmla="*/ 81 h 1248"/>
                  <a:gd name="T20" fmla="*/ 660 w 2744"/>
                  <a:gd name="T21" fmla="*/ 10 h 1248"/>
                  <a:gd name="T22" fmla="*/ 763 w 2744"/>
                  <a:gd name="T23" fmla="*/ 10 h 1248"/>
                  <a:gd name="T24" fmla="*/ 763 w 2744"/>
                  <a:gd name="T25" fmla="*/ 1248 h 1248"/>
                  <a:gd name="T26" fmla="*/ 660 w 2744"/>
                  <a:gd name="T27" fmla="*/ 1248 h 1248"/>
                  <a:gd name="T28" fmla="*/ 660 w 2744"/>
                  <a:gd name="T29" fmla="*/ 10 h 1248"/>
                  <a:gd name="T30" fmla="*/ 990 w 2744"/>
                  <a:gd name="T31" fmla="*/ 9 h 1248"/>
                  <a:gd name="T32" fmla="*/ 1094 w 2744"/>
                  <a:gd name="T33" fmla="*/ 9 h 1248"/>
                  <a:gd name="T34" fmla="*/ 1094 w 2744"/>
                  <a:gd name="T35" fmla="*/ 1248 h 1248"/>
                  <a:gd name="T36" fmla="*/ 990 w 2744"/>
                  <a:gd name="T37" fmla="*/ 1248 h 1248"/>
                  <a:gd name="T38" fmla="*/ 990 w 2744"/>
                  <a:gd name="T39" fmla="*/ 9 h 1248"/>
                  <a:gd name="T40" fmla="*/ 1320 w 2744"/>
                  <a:gd name="T41" fmla="*/ 63 h 1248"/>
                  <a:gd name="T42" fmla="*/ 1424 w 2744"/>
                  <a:gd name="T43" fmla="*/ 63 h 1248"/>
                  <a:gd name="T44" fmla="*/ 1424 w 2744"/>
                  <a:gd name="T45" fmla="*/ 1248 h 1248"/>
                  <a:gd name="T46" fmla="*/ 1320 w 2744"/>
                  <a:gd name="T47" fmla="*/ 1248 h 1248"/>
                  <a:gd name="T48" fmla="*/ 1320 w 2744"/>
                  <a:gd name="T49" fmla="*/ 63 h 1248"/>
                  <a:gd name="T50" fmla="*/ 1650 w 2744"/>
                  <a:gd name="T51" fmla="*/ 0 h 1248"/>
                  <a:gd name="T52" fmla="*/ 1753 w 2744"/>
                  <a:gd name="T53" fmla="*/ 0 h 1248"/>
                  <a:gd name="T54" fmla="*/ 1753 w 2744"/>
                  <a:gd name="T55" fmla="*/ 1248 h 1248"/>
                  <a:gd name="T56" fmla="*/ 1650 w 2744"/>
                  <a:gd name="T57" fmla="*/ 1248 h 1248"/>
                  <a:gd name="T58" fmla="*/ 1650 w 2744"/>
                  <a:gd name="T59" fmla="*/ 0 h 1248"/>
                  <a:gd name="T60" fmla="*/ 1980 w 2744"/>
                  <a:gd name="T61" fmla="*/ 43 h 1248"/>
                  <a:gd name="T62" fmla="*/ 2084 w 2744"/>
                  <a:gd name="T63" fmla="*/ 43 h 1248"/>
                  <a:gd name="T64" fmla="*/ 2084 w 2744"/>
                  <a:gd name="T65" fmla="*/ 1248 h 1248"/>
                  <a:gd name="T66" fmla="*/ 1980 w 2744"/>
                  <a:gd name="T67" fmla="*/ 1248 h 1248"/>
                  <a:gd name="T68" fmla="*/ 1980 w 2744"/>
                  <a:gd name="T69" fmla="*/ 43 h 1248"/>
                  <a:gd name="T70" fmla="*/ 2310 w 2744"/>
                  <a:gd name="T71" fmla="*/ 138 h 1248"/>
                  <a:gd name="T72" fmla="*/ 2413 w 2744"/>
                  <a:gd name="T73" fmla="*/ 138 h 1248"/>
                  <a:gd name="T74" fmla="*/ 2413 w 2744"/>
                  <a:gd name="T75" fmla="*/ 1248 h 1248"/>
                  <a:gd name="T76" fmla="*/ 2310 w 2744"/>
                  <a:gd name="T77" fmla="*/ 1248 h 1248"/>
                  <a:gd name="T78" fmla="*/ 2310 w 2744"/>
                  <a:gd name="T79" fmla="*/ 138 h 1248"/>
                  <a:gd name="T80" fmla="*/ 2640 w 2744"/>
                  <a:gd name="T81" fmla="*/ 135 h 1248"/>
                  <a:gd name="T82" fmla="*/ 2744 w 2744"/>
                  <a:gd name="T83" fmla="*/ 135 h 1248"/>
                  <a:gd name="T84" fmla="*/ 2744 w 2744"/>
                  <a:gd name="T85" fmla="*/ 1248 h 1248"/>
                  <a:gd name="T86" fmla="*/ 2640 w 2744"/>
                  <a:gd name="T87" fmla="*/ 1248 h 1248"/>
                  <a:gd name="T88" fmla="*/ 2640 w 2744"/>
                  <a:gd name="T89" fmla="*/ 135 h 12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2744" h="1248">
                    <a:moveTo>
                      <a:pt x="0" y="125"/>
                    </a:moveTo>
                    <a:lnTo>
                      <a:pt x="103" y="125"/>
                    </a:lnTo>
                    <a:lnTo>
                      <a:pt x="103" y="1248"/>
                    </a:lnTo>
                    <a:lnTo>
                      <a:pt x="0" y="1248"/>
                    </a:lnTo>
                    <a:lnTo>
                      <a:pt x="0" y="125"/>
                    </a:lnTo>
                    <a:close/>
                    <a:moveTo>
                      <a:pt x="330" y="81"/>
                    </a:moveTo>
                    <a:lnTo>
                      <a:pt x="434" y="81"/>
                    </a:lnTo>
                    <a:lnTo>
                      <a:pt x="434" y="1248"/>
                    </a:lnTo>
                    <a:lnTo>
                      <a:pt x="330" y="1248"/>
                    </a:lnTo>
                    <a:lnTo>
                      <a:pt x="330" y="81"/>
                    </a:lnTo>
                    <a:close/>
                    <a:moveTo>
                      <a:pt x="660" y="10"/>
                    </a:moveTo>
                    <a:lnTo>
                      <a:pt x="763" y="10"/>
                    </a:lnTo>
                    <a:lnTo>
                      <a:pt x="763" y="1248"/>
                    </a:lnTo>
                    <a:lnTo>
                      <a:pt x="660" y="1248"/>
                    </a:lnTo>
                    <a:lnTo>
                      <a:pt x="660" y="10"/>
                    </a:lnTo>
                    <a:close/>
                    <a:moveTo>
                      <a:pt x="990" y="9"/>
                    </a:moveTo>
                    <a:lnTo>
                      <a:pt x="1094" y="9"/>
                    </a:lnTo>
                    <a:lnTo>
                      <a:pt x="1094" y="1248"/>
                    </a:lnTo>
                    <a:lnTo>
                      <a:pt x="990" y="1248"/>
                    </a:lnTo>
                    <a:lnTo>
                      <a:pt x="990" y="9"/>
                    </a:lnTo>
                    <a:close/>
                    <a:moveTo>
                      <a:pt x="1320" y="63"/>
                    </a:moveTo>
                    <a:lnTo>
                      <a:pt x="1424" y="63"/>
                    </a:lnTo>
                    <a:lnTo>
                      <a:pt x="1424" y="1248"/>
                    </a:lnTo>
                    <a:lnTo>
                      <a:pt x="1320" y="1248"/>
                    </a:lnTo>
                    <a:lnTo>
                      <a:pt x="1320" y="63"/>
                    </a:lnTo>
                    <a:close/>
                    <a:moveTo>
                      <a:pt x="1650" y="0"/>
                    </a:moveTo>
                    <a:lnTo>
                      <a:pt x="1753" y="0"/>
                    </a:lnTo>
                    <a:lnTo>
                      <a:pt x="1753" y="1248"/>
                    </a:lnTo>
                    <a:lnTo>
                      <a:pt x="1650" y="1248"/>
                    </a:lnTo>
                    <a:lnTo>
                      <a:pt x="1650" y="0"/>
                    </a:lnTo>
                    <a:close/>
                    <a:moveTo>
                      <a:pt x="1980" y="43"/>
                    </a:moveTo>
                    <a:lnTo>
                      <a:pt x="2084" y="43"/>
                    </a:lnTo>
                    <a:lnTo>
                      <a:pt x="2084" y="1248"/>
                    </a:lnTo>
                    <a:lnTo>
                      <a:pt x="1980" y="1248"/>
                    </a:lnTo>
                    <a:lnTo>
                      <a:pt x="1980" y="43"/>
                    </a:lnTo>
                    <a:close/>
                    <a:moveTo>
                      <a:pt x="2310" y="138"/>
                    </a:moveTo>
                    <a:lnTo>
                      <a:pt x="2413" y="138"/>
                    </a:lnTo>
                    <a:lnTo>
                      <a:pt x="2413" y="1248"/>
                    </a:lnTo>
                    <a:lnTo>
                      <a:pt x="2310" y="1248"/>
                    </a:lnTo>
                    <a:lnTo>
                      <a:pt x="2310" y="138"/>
                    </a:lnTo>
                    <a:close/>
                    <a:moveTo>
                      <a:pt x="2640" y="135"/>
                    </a:moveTo>
                    <a:lnTo>
                      <a:pt x="2744" y="135"/>
                    </a:lnTo>
                    <a:lnTo>
                      <a:pt x="2744" y="1248"/>
                    </a:lnTo>
                    <a:lnTo>
                      <a:pt x="2640" y="1248"/>
                    </a:lnTo>
                    <a:lnTo>
                      <a:pt x="2640" y="135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4" name="Freeform 7">
                <a:extLst>
                  <a:ext uri="{FF2B5EF4-FFF2-40B4-BE49-F238E27FC236}">
                    <a16:creationId xmlns:a16="http://schemas.microsoft.com/office/drawing/2014/main" id="{2FAC63AC-900E-42EE-A862-9FC198D3F97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038600" y="3894138"/>
                <a:ext cx="4356100" cy="1981200"/>
              </a:xfrm>
              <a:custGeom>
                <a:avLst/>
                <a:gdLst>
                  <a:gd name="T0" fmla="*/ 0 w 2744"/>
                  <a:gd name="T1" fmla="*/ 125 h 1248"/>
                  <a:gd name="T2" fmla="*/ 103 w 2744"/>
                  <a:gd name="T3" fmla="*/ 125 h 1248"/>
                  <a:gd name="T4" fmla="*/ 103 w 2744"/>
                  <a:gd name="T5" fmla="*/ 1248 h 1248"/>
                  <a:gd name="T6" fmla="*/ 0 w 2744"/>
                  <a:gd name="T7" fmla="*/ 1248 h 1248"/>
                  <a:gd name="T8" fmla="*/ 0 w 2744"/>
                  <a:gd name="T9" fmla="*/ 125 h 1248"/>
                  <a:gd name="T10" fmla="*/ 330 w 2744"/>
                  <a:gd name="T11" fmla="*/ 81 h 1248"/>
                  <a:gd name="T12" fmla="*/ 434 w 2744"/>
                  <a:gd name="T13" fmla="*/ 81 h 1248"/>
                  <a:gd name="T14" fmla="*/ 434 w 2744"/>
                  <a:gd name="T15" fmla="*/ 1248 h 1248"/>
                  <a:gd name="T16" fmla="*/ 330 w 2744"/>
                  <a:gd name="T17" fmla="*/ 1248 h 1248"/>
                  <a:gd name="T18" fmla="*/ 330 w 2744"/>
                  <a:gd name="T19" fmla="*/ 81 h 1248"/>
                  <a:gd name="T20" fmla="*/ 660 w 2744"/>
                  <a:gd name="T21" fmla="*/ 10 h 1248"/>
                  <a:gd name="T22" fmla="*/ 763 w 2744"/>
                  <a:gd name="T23" fmla="*/ 10 h 1248"/>
                  <a:gd name="T24" fmla="*/ 763 w 2744"/>
                  <a:gd name="T25" fmla="*/ 1248 h 1248"/>
                  <a:gd name="T26" fmla="*/ 660 w 2744"/>
                  <a:gd name="T27" fmla="*/ 1248 h 1248"/>
                  <a:gd name="T28" fmla="*/ 660 w 2744"/>
                  <a:gd name="T29" fmla="*/ 10 h 1248"/>
                  <a:gd name="T30" fmla="*/ 990 w 2744"/>
                  <a:gd name="T31" fmla="*/ 9 h 1248"/>
                  <a:gd name="T32" fmla="*/ 1094 w 2744"/>
                  <a:gd name="T33" fmla="*/ 9 h 1248"/>
                  <a:gd name="T34" fmla="*/ 1094 w 2744"/>
                  <a:gd name="T35" fmla="*/ 1248 h 1248"/>
                  <a:gd name="T36" fmla="*/ 990 w 2744"/>
                  <a:gd name="T37" fmla="*/ 1248 h 1248"/>
                  <a:gd name="T38" fmla="*/ 990 w 2744"/>
                  <a:gd name="T39" fmla="*/ 9 h 1248"/>
                  <a:gd name="T40" fmla="*/ 1320 w 2744"/>
                  <a:gd name="T41" fmla="*/ 63 h 1248"/>
                  <a:gd name="T42" fmla="*/ 1424 w 2744"/>
                  <a:gd name="T43" fmla="*/ 63 h 1248"/>
                  <a:gd name="T44" fmla="*/ 1424 w 2744"/>
                  <a:gd name="T45" fmla="*/ 1248 h 1248"/>
                  <a:gd name="T46" fmla="*/ 1320 w 2744"/>
                  <a:gd name="T47" fmla="*/ 1248 h 1248"/>
                  <a:gd name="T48" fmla="*/ 1320 w 2744"/>
                  <a:gd name="T49" fmla="*/ 63 h 1248"/>
                  <a:gd name="T50" fmla="*/ 1650 w 2744"/>
                  <a:gd name="T51" fmla="*/ 0 h 1248"/>
                  <a:gd name="T52" fmla="*/ 1753 w 2744"/>
                  <a:gd name="T53" fmla="*/ 0 h 1248"/>
                  <a:gd name="T54" fmla="*/ 1753 w 2744"/>
                  <a:gd name="T55" fmla="*/ 1248 h 1248"/>
                  <a:gd name="T56" fmla="*/ 1650 w 2744"/>
                  <a:gd name="T57" fmla="*/ 1248 h 1248"/>
                  <a:gd name="T58" fmla="*/ 1650 w 2744"/>
                  <a:gd name="T59" fmla="*/ 0 h 1248"/>
                  <a:gd name="T60" fmla="*/ 1980 w 2744"/>
                  <a:gd name="T61" fmla="*/ 43 h 1248"/>
                  <a:gd name="T62" fmla="*/ 2084 w 2744"/>
                  <a:gd name="T63" fmla="*/ 43 h 1248"/>
                  <a:gd name="T64" fmla="*/ 2084 w 2744"/>
                  <a:gd name="T65" fmla="*/ 1248 h 1248"/>
                  <a:gd name="T66" fmla="*/ 1980 w 2744"/>
                  <a:gd name="T67" fmla="*/ 1248 h 1248"/>
                  <a:gd name="T68" fmla="*/ 1980 w 2744"/>
                  <a:gd name="T69" fmla="*/ 43 h 1248"/>
                  <a:gd name="T70" fmla="*/ 2310 w 2744"/>
                  <a:gd name="T71" fmla="*/ 138 h 1248"/>
                  <a:gd name="T72" fmla="*/ 2413 w 2744"/>
                  <a:gd name="T73" fmla="*/ 138 h 1248"/>
                  <a:gd name="T74" fmla="*/ 2413 w 2744"/>
                  <a:gd name="T75" fmla="*/ 1248 h 1248"/>
                  <a:gd name="T76" fmla="*/ 2310 w 2744"/>
                  <a:gd name="T77" fmla="*/ 1248 h 1248"/>
                  <a:gd name="T78" fmla="*/ 2310 w 2744"/>
                  <a:gd name="T79" fmla="*/ 138 h 1248"/>
                  <a:gd name="T80" fmla="*/ 2640 w 2744"/>
                  <a:gd name="T81" fmla="*/ 135 h 1248"/>
                  <a:gd name="T82" fmla="*/ 2744 w 2744"/>
                  <a:gd name="T83" fmla="*/ 135 h 1248"/>
                  <a:gd name="T84" fmla="*/ 2744 w 2744"/>
                  <a:gd name="T85" fmla="*/ 1248 h 1248"/>
                  <a:gd name="T86" fmla="*/ 2640 w 2744"/>
                  <a:gd name="T87" fmla="*/ 1248 h 1248"/>
                  <a:gd name="T88" fmla="*/ 2640 w 2744"/>
                  <a:gd name="T89" fmla="*/ 135 h 12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2744" h="1248">
                    <a:moveTo>
                      <a:pt x="0" y="125"/>
                    </a:moveTo>
                    <a:lnTo>
                      <a:pt x="103" y="125"/>
                    </a:lnTo>
                    <a:lnTo>
                      <a:pt x="103" y="1248"/>
                    </a:lnTo>
                    <a:lnTo>
                      <a:pt x="0" y="1248"/>
                    </a:lnTo>
                    <a:lnTo>
                      <a:pt x="0" y="125"/>
                    </a:lnTo>
                    <a:close/>
                    <a:moveTo>
                      <a:pt x="330" y="81"/>
                    </a:moveTo>
                    <a:lnTo>
                      <a:pt x="434" y="81"/>
                    </a:lnTo>
                    <a:lnTo>
                      <a:pt x="434" y="1248"/>
                    </a:lnTo>
                    <a:lnTo>
                      <a:pt x="330" y="1248"/>
                    </a:lnTo>
                    <a:lnTo>
                      <a:pt x="330" y="81"/>
                    </a:lnTo>
                    <a:close/>
                    <a:moveTo>
                      <a:pt x="660" y="10"/>
                    </a:moveTo>
                    <a:lnTo>
                      <a:pt x="763" y="10"/>
                    </a:lnTo>
                    <a:lnTo>
                      <a:pt x="763" y="1248"/>
                    </a:lnTo>
                    <a:lnTo>
                      <a:pt x="660" y="1248"/>
                    </a:lnTo>
                    <a:lnTo>
                      <a:pt x="660" y="10"/>
                    </a:lnTo>
                    <a:close/>
                    <a:moveTo>
                      <a:pt x="990" y="9"/>
                    </a:moveTo>
                    <a:lnTo>
                      <a:pt x="1094" y="9"/>
                    </a:lnTo>
                    <a:lnTo>
                      <a:pt x="1094" y="1248"/>
                    </a:lnTo>
                    <a:lnTo>
                      <a:pt x="990" y="1248"/>
                    </a:lnTo>
                    <a:lnTo>
                      <a:pt x="990" y="9"/>
                    </a:lnTo>
                    <a:close/>
                    <a:moveTo>
                      <a:pt x="1320" y="63"/>
                    </a:moveTo>
                    <a:lnTo>
                      <a:pt x="1424" y="63"/>
                    </a:lnTo>
                    <a:lnTo>
                      <a:pt x="1424" y="1248"/>
                    </a:lnTo>
                    <a:lnTo>
                      <a:pt x="1320" y="1248"/>
                    </a:lnTo>
                    <a:lnTo>
                      <a:pt x="1320" y="63"/>
                    </a:lnTo>
                    <a:close/>
                    <a:moveTo>
                      <a:pt x="1650" y="0"/>
                    </a:moveTo>
                    <a:lnTo>
                      <a:pt x="1753" y="0"/>
                    </a:lnTo>
                    <a:lnTo>
                      <a:pt x="1753" y="1248"/>
                    </a:lnTo>
                    <a:lnTo>
                      <a:pt x="1650" y="1248"/>
                    </a:lnTo>
                    <a:lnTo>
                      <a:pt x="1650" y="0"/>
                    </a:lnTo>
                    <a:close/>
                    <a:moveTo>
                      <a:pt x="1980" y="43"/>
                    </a:moveTo>
                    <a:lnTo>
                      <a:pt x="2084" y="43"/>
                    </a:lnTo>
                    <a:lnTo>
                      <a:pt x="2084" y="1248"/>
                    </a:lnTo>
                    <a:lnTo>
                      <a:pt x="1980" y="1248"/>
                    </a:lnTo>
                    <a:lnTo>
                      <a:pt x="1980" y="43"/>
                    </a:lnTo>
                    <a:close/>
                    <a:moveTo>
                      <a:pt x="2310" y="138"/>
                    </a:moveTo>
                    <a:lnTo>
                      <a:pt x="2413" y="138"/>
                    </a:lnTo>
                    <a:lnTo>
                      <a:pt x="2413" y="1248"/>
                    </a:lnTo>
                    <a:lnTo>
                      <a:pt x="2310" y="1248"/>
                    </a:lnTo>
                    <a:lnTo>
                      <a:pt x="2310" y="138"/>
                    </a:lnTo>
                    <a:close/>
                    <a:moveTo>
                      <a:pt x="2640" y="135"/>
                    </a:moveTo>
                    <a:lnTo>
                      <a:pt x="2744" y="135"/>
                    </a:lnTo>
                    <a:lnTo>
                      <a:pt x="2744" y="1248"/>
                    </a:lnTo>
                    <a:lnTo>
                      <a:pt x="2640" y="1248"/>
                    </a:lnTo>
                    <a:lnTo>
                      <a:pt x="2640" y="135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5" name="Freeform 8">
                <a:extLst>
                  <a:ext uri="{FF2B5EF4-FFF2-40B4-BE49-F238E27FC236}">
                    <a16:creationId xmlns:a16="http://schemas.microsoft.com/office/drawing/2014/main" id="{C6D2677A-1A55-44EF-BD12-22F4DDC95A6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087813" y="3692525"/>
                <a:ext cx="65087" cy="400050"/>
              </a:xfrm>
              <a:custGeom>
                <a:avLst/>
                <a:gdLst>
                  <a:gd name="T0" fmla="*/ 20 w 41"/>
                  <a:gd name="T1" fmla="*/ 252 h 252"/>
                  <a:gd name="T2" fmla="*/ 20 w 41"/>
                  <a:gd name="T3" fmla="*/ 0 h 252"/>
                  <a:gd name="T4" fmla="*/ 0 w 41"/>
                  <a:gd name="T5" fmla="*/ 0 h 252"/>
                  <a:gd name="T6" fmla="*/ 41 w 41"/>
                  <a:gd name="T7" fmla="*/ 0 h 2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1" h="252">
                    <a:moveTo>
                      <a:pt x="20" y="252"/>
                    </a:moveTo>
                    <a:lnTo>
                      <a:pt x="20" y="0"/>
                    </a:lnTo>
                    <a:moveTo>
                      <a:pt x="0" y="0"/>
                    </a:moveTo>
                    <a:lnTo>
                      <a:pt x="41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6" name="Freeform 9">
                <a:extLst>
                  <a:ext uri="{FF2B5EF4-FFF2-40B4-BE49-F238E27FC236}">
                    <a16:creationId xmlns:a16="http://schemas.microsoft.com/office/drawing/2014/main" id="{FC9E2938-B491-45F7-93E1-81DB893ABFD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613275" y="3521075"/>
                <a:ext cx="61912" cy="501650"/>
              </a:xfrm>
              <a:custGeom>
                <a:avLst/>
                <a:gdLst>
                  <a:gd name="T0" fmla="*/ 20 w 39"/>
                  <a:gd name="T1" fmla="*/ 316 h 316"/>
                  <a:gd name="T2" fmla="*/ 20 w 39"/>
                  <a:gd name="T3" fmla="*/ 0 h 316"/>
                  <a:gd name="T4" fmla="*/ 0 w 39"/>
                  <a:gd name="T5" fmla="*/ 0 h 316"/>
                  <a:gd name="T6" fmla="*/ 39 w 39"/>
                  <a:gd name="T7" fmla="*/ 0 h 3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9" h="316">
                    <a:moveTo>
                      <a:pt x="20" y="316"/>
                    </a:moveTo>
                    <a:lnTo>
                      <a:pt x="20" y="0"/>
                    </a:lnTo>
                    <a:moveTo>
                      <a:pt x="0" y="0"/>
                    </a:moveTo>
                    <a:lnTo>
                      <a:pt x="39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7" name="Freeform 10">
                <a:extLst>
                  <a:ext uri="{FF2B5EF4-FFF2-40B4-BE49-F238E27FC236}">
                    <a16:creationId xmlns:a16="http://schemas.microsoft.com/office/drawing/2014/main" id="{EA01DC38-E0FC-4E0A-92CA-1976B2F4126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137150" y="3576638"/>
                <a:ext cx="63500" cy="333375"/>
              </a:xfrm>
              <a:custGeom>
                <a:avLst/>
                <a:gdLst>
                  <a:gd name="T0" fmla="*/ 20 w 40"/>
                  <a:gd name="T1" fmla="*/ 210 h 210"/>
                  <a:gd name="T2" fmla="*/ 20 w 40"/>
                  <a:gd name="T3" fmla="*/ 0 h 210"/>
                  <a:gd name="T4" fmla="*/ 0 w 40"/>
                  <a:gd name="T5" fmla="*/ 0 h 210"/>
                  <a:gd name="T6" fmla="*/ 40 w 40"/>
                  <a:gd name="T7" fmla="*/ 0 h 2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0" h="210">
                    <a:moveTo>
                      <a:pt x="20" y="210"/>
                    </a:moveTo>
                    <a:lnTo>
                      <a:pt x="20" y="0"/>
                    </a:lnTo>
                    <a:moveTo>
                      <a:pt x="0" y="0"/>
                    </a:moveTo>
                    <a:lnTo>
                      <a:pt x="40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8" name="Freeform 11">
                <a:extLst>
                  <a:ext uri="{FF2B5EF4-FFF2-40B4-BE49-F238E27FC236}">
                    <a16:creationId xmlns:a16="http://schemas.microsoft.com/office/drawing/2014/main" id="{21E05D38-8A23-4207-8613-ACEA38EDEEB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661025" y="3584575"/>
                <a:ext cx="61912" cy="323850"/>
              </a:xfrm>
              <a:custGeom>
                <a:avLst/>
                <a:gdLst>
                  <a:gd name="T0" fmla="*/ 20 w 39"/>
                  <a:gd name="T1" fmla="*/ 204 h 204"/>
                  <a:gd name="T2" fmla="*/ 20 w 39"/>
                  <a:gd name="T3" fmla="*/ 0 h 204"/>
                  <a:gd name="T4" fmla="*/ 0 w 39"/>
                  <a:gd name="T5" fmla="*/ 0 h 204"/>
                  <a:gd name="T6" fmla="*/ 39 w 39"/>
                  <a:gd name="T7" fmla="*/ 0 h 2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9" h="204">
                    <a:moveTo>
                      <a:pt x="20" y="204"/>
                    </a:moveTo>
                    <a:lnTo>
                      <a:pt x="20" y="0"/>
                    </a:lnTo>
                    <a:moveTo>
                      <a:pt x="0" y="0"/>
                    </a:moveTo>
                    <a:lnTo>
                      <a:pt x="39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9" name="Freeform 12">
                <a:extLst>
                  <a:ext uri="{FF2B5EF4-FFF2-40B4-BE49-F238E27FC236}">
                    <a16:creationId xmlns:a16="http://schemas.microsoft.com/office/drawing/2014/main" id="{8CB996A6-3BBC-4E4B-A67B-8880AEFC12B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184900" y="3895725"/>
                <a:ext cx="63500" cy="98425"/>
              </a:xfrm>
              <a:custGeom>
                <a:avLst/>
                <a:gdLst>
                  <a:gd name="T0" fmla="*/ 20 w 40"/>
                  <a:gd name="T1" fmla="*/ 62 h 62"/>
                  <a:gd name="T2" fmla="*/ 20 w 40"/>
                  <a:gd name="T3" fmla="*/ 0 h 62"/>
                  <a:gd name="T4" fmla="*/ 0 w 40"/>
                  <a:gd name="T5" fmla="*/ 0 h 62"/>
                  <a:gd name="T6" fmla="*/ 40 w 40"/>
                  <a:gd name="T7" fmla="*/ 0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0" h="62">
                    <a:moveTo>
                      <a:pt x="20" y="62"/>
                    </a:moveTo>
                    <a:lnTo>
                      <a:pt x="20" y="0"/>
                    </a:lnTo>
                    <a:moveTo>
                      <a:pt x="0" y="0"/>
                    </a:moveTo>
                    <a:lnTo>
                      <a:pt x="40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0" name="Freeform 13">
                <a:extLst>
                  <a:ext uri="{FF2B5EF4-FFF2-40B4-BE49-F238E27FC236}">
                    <a16:creationId xmlns:a16="http://schemas.microsoft.com/office/drawing/2014/main" id="{D9FC4887-625D-4DBC-BB87-1B703DA9706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708775" y="3587750"/>
                <a:ext cx="61912" cy="306388"/>
              </a:xfrm>
              <a:custGeom>
                <a:avLst/>
                <a:gdLst>
                  <a:gd name="T0" fmla="*/ 19 w 39"/>
                  <a:gd name="T1" fmla="*/ 193 h 193"/>
                  <a:gd name="T2" fmla="*/ 19 w 39"/>
                  <a:gd name="T3" fmla="*/ 0 h 193"/>
                  <a:gd name="T4" fmla="*/ 0 w 39"/>
                  <a:gd name="T5" fmla="*/ 0 h 193"/>
                  <a:gd name="T6" fmla="*/ 39 w 39"/>
                  <a:gd name="T7" fmla="*/ 0 h 1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9" h="193">
                    <a:moveTo>
                      <a:pt x="19" y="193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9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1" name="Freeform 14">
                <a:extLst>
                  <a:ext uri="{FF2B5EF4-FFF2-40B4-BE49-F238E27FC236}">
                    <a16:creationId xmlns:a16="http://schemas.microsoft.com/office/drawing/2014/main" id="{7CA587AE-1DEC-4743-B3E2-02A90F10586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232650" y="3675063"/>
                <a:ext cx="63500" cy="287338"/>
              </a:xfrm>
              <a:custGeom>
                <a:avLst/>
                <a:gdLst>
                  <a:gd name="T0" fmla="*/ 20 w 40"/>
                  <a:gd name="T1" fmla="*/ 181 h 181"/>
                  <a:gd name="T2" fmla="*/ 20 w 40"/>
                  <a:gd name="T3" fmla="*/ 0 h 181"/>
                  <a:gd name="T4" fmla="*/ 0 w 40"/>
                  <a:gd name="T5" fmla="*/ 0 h 181"/>
                  <a:gd name="T6" fmla="*/ 40 w 40"/>
                  <a:gd name="T7" fmla="*/ 0 h 1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0" h="181">
                    <a:moveTo>
                      <a:pt x="20" y="181"/>
                    </a:moveTo>
                    <a:lnTo>
                      <a:pt x="20" y="0"/>
                    </a:lnTo>
                    <a:moveTo>
                      <a:pt x="0" y="0"/>
                    </a:moveTo>
                    <a:lnTo>
                      <a:pt x="40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2" name="Freeform 15">
                <a:extLst>
                  <a:ext uri="{FF2B5EF4-FFF2-40B4-BE49-F238E27FC236}">
                    <a16:creationId xmlns:a16="http://schemas.microsoft.com/office/drawing/2014/main" id="{C9212A95-A151-449B-B6F4-98E978790F4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758113" y="3759200"/>
                <a:ext cx="61912" cy="354013"/>
              </a:xfrm>
              <a:custGeom>
                <a:avLst/>
                <a:gdLst>
                  <a:gd name="T0" fmla="*/ 19 w 39"/>
                  <a:gd name="T1" fmla="*/ 223 h 223"/>
                  <a:gd name="T2" fmla="*/ 19 w 39"/>
                  <a:gd name="T3" fmla="*/ 0 h 223"/>
                  <a:gd name="T4" fmla="*/ 0 w 39"/>
                  <a:gd name="T5" fmla="*/ 0 h 223"/>
                  <a:gd name="T6" fmla="*/ 39 w 39"/>
                  <a:gd name="T7" fmla="*/ 0 h 2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9" h="223">
                    <a:moveTo>
                      <a:pt x="19" y="223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9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3" name="Freeform 16">
                <a:extLst>
                  <a:ext uri="{FF2B5EF4-FFF2-40B4-BE49-F238E27FC236}">
                    <a16:creationId xmlns:a16="http://schemas.microsoft.com/office/drawing/2014/main" id="{5FE9A339-23A4-43D2-A98A-881C1518944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280400" y="3748088"/>
                <a:ext cx="63500" cy="360363"/>
              </a:xfrm>
              <a:custGeom>
                <a:avLst/>
                <a:gdLst>
                  <a:gd name="T0" fmla="*/ 20 w 40"/>
                  <a:gd name="T1" fmla="*/ 227 h 227"/>
                  <a:gd name="T2" fmla="*/ 20 w 40"/>
                  <a:gd name="T3" fmla="*/ 0 h 227"/>
                  <a:gd name="T4" fmla="*/ 0 w 40"/>
                  <a:gd name="T5" fmla="*/ 0 h 227"/>
                  <a:gd name="T6" fmla="*/ 40 w 40"/>
                  <a:gd name="T7" fmla="*/ 0 h 2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0" h="227">
                    <a:moveTo>
                      <a:pt x="20" y="227"/>
                    </a:moveTo>
                    <a:lnTo>
                      <a:pt x="20" y="0"/>
                    </a:lnTo>
                    <a:moveTo>
                      <a:pt x="0" y="0"/>
                    </a:moveTo>
                    <a:lnTo>
                      <a:pt x="40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4" name="Line 17">
                <a:extLst>
                  <a:ext uri="{FF2B5EF4-FFF2-40B4-BE49-F238E27FC236}">
                    <a16:creationId xmlns:a16="http://schemas.microsoft.com/office/drawing/2014/main" id="{6967E69F-73A7-4E40-9E32-9A4754683B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59213" y="3309938"/>
                <a:ext cx="0" cy="256540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5" name="Freeform 18">
                <a:extLst>
                  <a:ext uri="{FF2B5EF4-FFF2-40B4-BE49-F238E27FC236}">
                    <a16:creationId xmlns:a16="http://schemas.microsoft.com/office/drawing/2014/main" id="{A14345DE-9204-4E4A-8612-DFD3F40D0F9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819525" y="3309938"/>
                <a:ext cx="39687" cy="2565400"/>
              </a:xfrm>
              <a:custGeom>
                <a:avLst/>
                <a:gdLst>
                  <a:gd name="T0" fmla="*/ 0 w 25"/>
                  <a:gd name="T1" fmla="*/ 1616 h 1616"/>
                  <a:gd name="T2" fmla="*/ 25 w 25"/>
                  <a:gd name="T3" fmla="*/ 1616 h 1616"/>
                  <a:gd name="T4" fmla="*/ 0 w 25"/>
                  <a:gd name="T5" fmla="*/ 1385 h 1616"/>
                  <a:gd name="T6" fmla="*/ 25 w 25"/>
                  <a:gd name="T7" fmla="*/ 1385 h 1616"/>
                  <a:gd name="T8" fmla="*/ 0 w 25"/>
                  <a:gd name="T9" fmla="*/ 1154 h 1616"/>
                  <a:gd name="T10" fmla="*/ 25 w 25"/>
                  <a:gd name="T11" fmla="*/ 1154 h 1616"/>
                  <a:gd name="T12" fmla="*/ 0 w 25"/>
                  <a:gd name="T13" fmla="*/ 923 h 1616"/>
                  <a:gd name="T14" fmla="*/ 25 w 25"/>
                  <a:gd name="T15" fmla="*/ 923 h 1616"/>
                  <a:gd name="T16" fmla="*/ 0 w 25"/>
                  <a:gd name="T17" fmla="*/ 692 h 1616"/>
                  <a:gd name="T18" fmla="*/ 25 w 25"/>
                  <a:gd name="T19" fmla="*/ 692 h 1616"/>
                  <a:gd name="T20" fmla="*/ 0 w 25"/>
                  <a:gd name="T21" fmla="*/ 462 h 1616"/>
                  <a:gd name="T22" fmla="*/ 25 w 25"/>
                  <a:gd name="T23" fmla="*/ 462 h 1616"/>
                  <a:gd name="T24" fmla="*/ 0 w 25"/>
                  <a:gd name="T25" fmla="*/ 231 h 1616"/>
                  <a:gd name="T26" fmla="*/ 25 w 25"/>
                  <a:gd name="T27" fmla="*/ 231 h 1616"/>
                  <a:gd name="T28" fmla="*/ 0 w 25"/>
                  <a:gd name="T29" fmla="*/ 0 h 1616"/>
                  <a:gd name="T30" fmla="*/ 25 w 25"/>
                  <a:gd name="T31" fmla="*/ 0 h 16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25" h="1616">
                    <a:moveTo>
                      <a:pt x="0" y="1616"/>
                    </a:moveTo>
                    <a:lnTo>
                      <a:pt x="25" y="1616"/>
                    </a:lnTo>
                    <a:moveTo>
                      <a:pt x="0" y="1385"/>
                    </a:moveTo>
                    <a:lnTo>
                      <a:pt x="25" y="1385"/>
                    </a:lnTo>
                    <a:moveTo>
                      <a:pt x="0" y="1154"/>
                    </a:moveTo>
                    <a:lnTo>
                      <a:pt x="25" y="1154"/>
                    </a:lnTo>
                    <a:moveTo>
                      <a:pt x="0" y="923"/>
                    </a:moveTo>
                    <a:lnTo>
                      <a:pt x="25" y="923"/>
                    </a:lnTo>
                    <a:moveTo>
                      <a:pt x="0" y="692"/>
                    </a:moveTo>
                    <a:lnTo>
                      <a:pt x="25" y="692"/>
                    </a:lnTo>
                    <a:moveTo>
                      <a:pt x="0" y="462"/>
                    </a:moveTo>
                    <a:lnTo>
                      <a:pt x="25" y="462"/>
                    </a:lnTo>
                    <a:moveTo>
                      <a:pt x="0" y="231"/>
                    </a:moveTo>
                    <a:lnTo>
                      <a:pt x="25" y="231"/>
                    </a:lnTo>
                    <a:moveTo>
                      <a:pt x="0" y="0"/>
                    </a:moveTo>
                    <a:lnTo>
                      <a:pt x="25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6" name="Line 19">
                <a:extLst>
                  <a:ext uri="{FF2B5EF4-FFF2-40B4-BE49-F238E27FC236}">
                    <a16:creationId xmlns:a16="http://schemas.microsoft.com/office/drawing/2014/main" id="{5A901A8D-60CE-43B5-B6B4-413E08FBE9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59213" y="5875338"/>
                <a:ext cx="471487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7" name="Freeform 20">
                <a:extLst>
                  <a:ext uri="{FF2B5EF4-FFF2-40B4-BE49-F238E27FC236}">
                    <a16:creationId xmlns:a16="http://schemas.microsoft.com/office/drawing/2014/main" id="{8583F4E8-C4E1-4843-8CA8-965087BD353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859213" y="5875338"/>
                <a:ext cx="4714875" cy="36513"/>
              </a:xfrm>
              <a:custGeom>
                <a:avLst/>
                <a:gdLst>
                  <a:gd name="T0" fmla="*/ 0 w 2970"/>
                  <a:gd name="T1" fmla="*/ 0 h 23"/>
                  <a:gd name="T2" fmla="*/ 0 w 2970"/>
                  <a:gd name="T3" fmla="*/ 23 h 23"/>
                  <a:gd name="T4" fmla="*/ 329 w 2970"/>
                  <a:gd name="T5" fmla="*/ 0 h 23"/>
                  <a:gd name="T6" fmla="*/ 329 w 2970"/>
                  <a:gd name="T7" fmla="*/ 23 h 23"/>
                  <a:gd name="T8" fmla="*/ 660 w 2970"/>
                  <a:gd name="T9" fmla="*/ 0 h 23"/>
                  <a:gd name="T10" fmla="*/ 660 w 2970"/>
                  <a:gd name="T11" fmla="*/ 23 h 23"/>
                  <a:gd name="T12" fmla="*/ 989 w 2970"/>
                  <a:gd name="T13" fmla="*/ 0 h 23"/>
                  <a:gd name="T14" fmla="*/ 989 w 2970"/>
                  <a:gd name="T15" fmla="*/ 23 h 23"/>
                  <a:gd name="T16" fmla="*/ 1320 w 2970"/>
                  <a:gd name="T17" fmla="*/ 0 h 23"/>
                  <a:gd name="T18" fmla="*/ 1320 w 2970"/>
                  <a:gd name="T19" fmla="*/ 23 h 23"/>
                  <a:gd name="T20" fmla="*/ 1650 w 2970"/>
                  <a:gd name="T21" fmla="*/ 0 h 23"/>
                  <a:gd name="T22" fmla="*/ 1650 w 2970"/>
                  <a:gd name="T23" fmla="*/ 23 h 23"/>
                  <a:gd name="T24" fmla="*/ 1980 w 2970"/>
                  <a:gd name="T25" fmla="*/ 0 h 23"/>
                  <a:gd name="T26" fmla="*/ 1980 w 2970"/>
                  <a:gd name="T27" fmla="*/ 23 h 23"/>
                  <a:gd name="T28" fmla="*/ 2310 w 2970"/>
                  <a:gd name="T29" fmla="*/ 0 h 23"/>
                  <a:gd name="T30" fmla="*/ 2310 w 2970"/>
                  <a:gd name="T31" fmla="*/ 23 h 23"/>
                  <a:gd name="T32" fmla="*/ 2640 w 2970"/>
                  <a:gd name="T33" fmla="*/ 0 h 23"/>
                  <a:gd name="T34" fmla="*/ 2640 w 2970"/>
                  <a:gd name="T35" fmla="*/ 23 h 23"/>
                  <a:gd name="T36" fmla="*/ 2970 w 2970"/>
                  <a:gd name="T37" fmla="*/ 0 h 23"/>
                  <a:gd name="T38" fmla="*/ 2970 w 2970"/>
                  <a:gd name="T39" fmla="*/ 23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2970" h="23">
                    <a:moveTo>
                      <a:pt x="0" y="0"/>
                    </a:moveTo>
                    <a:lnTo>
                      <a:pt x="0" y="23"/>
                    </a:lnTo>
                    <a:moveTo>
                      <a:pt x="329" y="0"/>
                    </a:moveTo>
                    <a:lnTo>
                      <a:pt x="329" y="23"/>
                    </a:lnTo>
                    <a:moveTo>
                      <a:pt x="660" y="0"/>
                    </a:moveTo>
                    <a:lnTo>
                      <a:pt x="660" y="23"/>
                    </a:lnTo>
                    <a:moveTo>
                      <a:pt x="989" y="0"/>
                    </a:moveTo>
                    <a:lnTo>
                      <a:pt x="989" y="23"/>
                    </a:lnTo>
                    <a:moveTo>
                      <a:pt x="1320" y="0"/>
                    </a:moveTo>
                    <a:lnTo>
                      <a:pt x="1320" y="23"/>
                    </a:lnTo>
                    <a:moveTo>
                      <a:pt x="1650" y="0"/>
                    </a:moveTo>
                    <a:lnTo>
                      <a:pt x="1650" y="23"/>
                    </a:lnTo>
                    <a:moveTo>
                      <a:pt x="1980" y="0"/>
                    </a:moveTo>
                    <a:lnTo>
                      <a:pt x="1980" y="23"/>
                    </a:lnTo>
                    <a:moveTo>
                      <a:pt x="2310" y="0"/>
                    </a:moveTo>
                    <a:lnTo>
                      <a:pt x="2310" y="23"/>
                    </a:lnTo>
                    <a:moveTo>
                      <a:pt x="2640" y="0"/>
                    </a:moveTo>
                    <a:lnTo>
                      <a:pt x="2640" y="23"/>
                    </a:lnTo>
                    <a:moveTo>
                      <a:pt x="2970" y="0"/>
                    </a:moveTo>
                    <a:lnTo>
                      <a:pt x="2970" y="23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6" name="Group 215">
              <a:extLst>
                <a:ext uri="{FF2B5EF4-FFF2-40B4-BE49-F238E27FC236}">
                  <a16:creationId xmlns:a16="http://schemas.microsoft.com/office/drawing/2014/main" id="{1B284B02-9CFC-469F-A97D-D250419B4036}"/>
                </a:ext>
              </a:extLst>
            </p:cNvPr>
            <p:cNvGrpSpPr/>
            <p:nvPr/>
          </p:nvGrpSpPr>
          <p:grpSpPr>
            <a:xfrm>
              <a:off x="3494723" y="3024495"/>
              <a:ext cx="211596" cy="2719288"/>
              <a:chOff x="3541713" y="3238500"/>
              <a:chExt cx="211596" cy="2719288"/>
            </a:xfrm>
          </p:grpSpPr>
          <p:sp>
            <p:nvSpPr>
              <p:cNvPr id="1138" name="Rectangle 21">
                <a:extLst>
                  <a:ext uri="{FF2B5EF4-FFF2-40B4-BE49-F238E27FC236}">
                    <a16:creationId xmlns:a16="http://schemas.microsoft.com/office/drawing/2014/main" id="{8D03D23F-2BE3-4F20-A2EB-FCEBA1DCEE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82777" y="5803900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39" name="Rectangle 22">
                <a:extLst>
                  <a:ext uri="{FF2B5EF4-FFF2-40B4-BE49-F238E27FC236}">
                    <a16:creationId xmlns:a16="http://schemas.microsoft.com/office/drawing/2014/main" id="{BF4F677F-9C11-4609-B943-400C46F6C4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12245" y="5437188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40" name="Rectangle 23">
                <a:extLst>
                  <a:ext uri="{FF2B5EF4-FFF2-40B4-BE49-F238E27FC236}">
                    <a16:creationId xmlns:a16="http://schemas.microsoft.com/office/drawing/2014/main" id="{405B7CFC-2740-44BD-8E76-FF71062A55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12245" y="5070475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41" name="Rectangle 24">
                <a:extLst>
                  <a:ext uri="{FF2B5EF4-FFF2-40B4-BE49-F238E27FC236}">
                    <a16:creationId xmlns:a16="http://schemas.microsoft.com/office/drawing/2014/main" id="{C44EA81D-5A38-40B8-9436-B2D8E22DAD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12245" y="4702175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43" name="Rectangle 25">
                <a:extLst>
                  <a:ext uri="{FF2B5EF4-FFF2-40B4-BE49-F238E27FC236}">
                    <a16:creationId xmlns:a16="http://schemas.microsoft.com/office/drawing/2014/main" id="{A58F713E-2A24-44EC-B621-9A3EA143DA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12245" y="4335463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4" name="Rectangle 26">
                <a:extLst>
                  <a:ext uri="{FF2B5EF4-FFF2-40B4-BE49-F238E27FC236}">
                    <a16:creationId xmlns:a16="http://schemas.microsoft.com/office/drawing/2014/main" id="{6B29A489-D911-4D21-8029-EB50E978A3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1713" y="3968750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6" name="Rectangle 27">
                <a:extLst>
                  <a:ext uri="{FF2B5EF4-FFF2-40B4-BE49-F238E27FC236}">
                    <a16:creationId xmlns:a16="http://schemas.microsoft.com/office/drawing/2014/main" id="{8044B570-7D4B-49F3-8271-6CB4CB08D3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1713" y="3605213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2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7" name="Rectangle 28">
                <a:extLst>
                  <a:ext uri="{FF2B5EF4-FFF2-40B4-BE49-F238E27FC236}">
                    <a16:creationId xmlns:a16="http://schemas.microsoft.com/office/drawing/2014/main" id="{CCEBA203-9CF6-429C-B71D-5785072578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1713" y="3238500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4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2" name="Group 161">
              <a:extLst>
                <a:ext uri="{FF2B5EF4-FFF2-40B4-BE49-F238E27FC236}">
                  <a16:creationId xmlns:a16="http://schemas.microsoft.com/office/drawing/2014/main" id="{09872B99-BA8A-4073-85D7-8C3626F43C8F}"/>
                </a:ext>
              </a:extLst>
            </p:cNvPr>
            <p:cNvGrpSpPr/>
            <p:nvPr/>
          </p:nvGrpSpPr>
          <p:grpSpPr>
            <a:xfrm>
              <a:off x="4086225" y="5739120"/>
              <a:ext cx="4332746" cy="153888"/>
              <a:chOff x="4086225" y="5953125"/>
              <a:chExt cx="4332746" cy="153888"/>
            </a:xfrm>
          </p:grpSpPr>
          <p:sp>
            <p:nvSpPr>
              <p:cNvPr id="68" name="Rectangle 29">
                <a:extLst>
                  <a:ext uri="{FF2B5EF4-FFF2-40B4-BE49-F238E27FC236}">
                    <a16:creationId xmlns:a16="http://schemas.microsoft.com/office/drawing/2014/main" id="{0424F2B8-A90F-42BA-AFC6-842F35DFE6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86225" y="595312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9" name="Rectangle 30">
                <a:extLst>
                  <a:ext uri="{FF2B5EF4-FFF2-40B4-BE49-F238E27FC236}">
                    <a16:creationId xmlns:a16="http://schemas.microsoft.com/office/drawing/2014/main" id="{283D07AB-8D3D-4CBF-9E4D-A28AD814D0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10100" y="595312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8" name="Rectangle 31">
                <a:extLst>
                  <a:ext uri="{FF2B5EF4-FFF2-40B4-BE49-F238E27FC236}">
                    <a16:creationId xmlns:a16="http://schemas.microsoft.com/office/drawing/2014/main" id="{CF01ADC9-FF08-4BD0-BB78-12D2A95109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81588" y="5953125"/>
                <a:ext cx="176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.5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5" name="Rectangle 32">
                <a:extLst>
                  <a:ext uri="{FF2B5EF4-FFF2-40B4-BE49-F238E27FC236}">
                    <a16:creationId xmlns:a16="http://schemas.microsoft.com/office/drawing/2014/main" id="{37FA438B-88A2-4357-8AB1-0EB2035A06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57850" y="595312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6" name="Rectangle 33">
                <a:extLst>
                  <a:ext uri="{FF2B5EF4-FFF2-40B4-BE49-F238E27FC236}">
                    <a16:creationId xmlns:a16="http://schemas.microsoft.com/office/drawing/2014/main" id="{9ED90D08-A682-4B3A-8432-BD3D13C2D5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46800" y="5953125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5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8" name="Rectangle 34">
                <a:extLst>
                  <a:ext uri="{FF2B5EF4-FFF2-40B4-BE49-F238E27FC236}">
                    <a16:creationId xmlns:a16="http://schemas.microsoft.com/office/drawing/2014/main" id="{2C55825E-FCCB-449F-9CE6-D13ADF2548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70675" y="5953125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9" name="Rectangle 35">
                <a:extLst>
                  <a:ext uri="{FF2B5EF4-FFF2-40B4-BE49-F238E27FC236}">
                    <a16:creationId xmlns:a16="http://schemas.microsoft.com/office/drawing/2014/main" id="{B2CFBE65-7B28-4660-82EC-EFFCD80863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94550" y="5953125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0" name="Rectangle 36">
                <a:extLst>
                  <a:ext uri="{FF2B5EF4-FFF2-40B4-BE49-F238E27FC236}">
                    <a16:creationId xmlns:a16="http://schemas.microsoft.com/office/drawing/2014/main" id="{C02892DD-8603-44F1-950C-3114D3A130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83500" y="5953125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8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2" name="Rectangle 37">
                <a:extLst>
                  <a:ext uri="{FF2B5EF4-FFF2-40B4-BE49-F238E27FC236}">
                    <a16:creationId xmlns:a16="http://schemas.microsoft.com/office/drawing/2014/main" id="{A1657456-740A-460D-B524-72A599C29D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07375" y="5953125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6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3" name="Rectangle 38">
              <a:extLst>
                <a:ext uri="{FF2B5EF4-FFF2-40B4-BE49-F238E27FC236}">
                  <a16:creationId xmlns:a16="http://schemas.microsoft.com/office/drawing/2014/main" id="{DC7C898F-4B39-4C91-8B1C-5BF34C62AEB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02411" y="4337771"/>
              <a:ext cx="63799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% of </a:t>
              </a:r>
              <a:r>
                <a:rPr lang="en-US" altLang="en-US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time 0</a:t>
              </a:r>
              <a:endPara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4" name="Rectangle 39">
              <a:extLst>
                <a:ext uri="{FF2B5EF4-FFF2-40B4-BE49-F238E27FC236}">
                  <a16:creationId xmlns:a16="http://schemas.microsoft.com/office/drawing/2014/main" id="{D45D352D-708B-44F7-874C-E124F96945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3031" y="5971689"/>
              <a:ext cx="4472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Minutes</a:t>
              </a:r>
              <a:endPara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5" name="Rectangle 40">
              <a:extLst>
                <a:ext uri="{FF2B5EF4-FFF2-40B4-BE49-F238E27FC236}">
                  <a16:creationId xmlns:a16="http://schemas.microsoft.com/office/drawing/2014/main" id="{34B25A4F-EF5C-4BA8-BABF-0A5D3DDFAC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7998" y="2540964"/>
              <a:ext cx="170719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) Liver ROS production 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grpSp>
          <p:nvGrpSpPr>
            <p:cNvPr id="161" name="Group 160">
              <a:extLst>
                <a:ext uri="{FF2B5EF4-FFF2-40B4-BE49-F238E27FC236}">
                  <a16:creationId xmlns:a16="http://schemas.microsoft.com/office/drawing/2014/main" id="{8BAFC255-4339-47AD-A6FD-AC63FFCFF42E}"/>
                </a:ext>
              </a:extLst>
            </p:cNvPr>
            <p:cNvGrpSpPr/>
            <p:nvPr/>
          </p:nvGrpSpPr>
          <p:grpSpPr>
            <a:xfrm>
              <a:off x="3789363" y="6517857"/>
              <a:ext cx="4749800" cy="2601912"/>
              <a:chOff x="3824288" y="7723188"/>
              <a:chExt cx="4749800" cy="2601912"/>
            </a:xfrm>
          </p:grpSpPr>
          <p:sp>
            <p:nvSpPr>
              <p:cNvPr id="143" name="Freeform 47">
                <a:extLst>
                  <a:ext uri="{FF2B5EF4-FFF2-40B4-BE49-F238E27FC236}">
                    <a16:creationId xmlns:a16="http://schemas.microsoft.com/office/drawing/2014/main" id="{B7667ADE-06A2-4E62-8F9B-7E6AC83F60C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038600" y="8532813"/>
                <a:ext cx="4356100" cy="1757363"/>
              </a:xfrm>
              <a:custGeom>
                <a:avLst/>
                <a:gdLst>
                  <a:gd name="T0" fmla="*/ 0 w 2744"/>
                  <a:gd name="T1" fmla="*/ 2 h 1107"/>
                  <a:gd name="T2" fmla="*/ 104 w 2744"/>
                  <a:gd name="T3" fmla="*/ 2 h 1107"/>
                  <a:gd name="T4" fmla="*/ 104 w 2744"/>
                  <a:gd name="T5" fmla="*/ 1107 h 1107"/>
                  <a:gd name="T6" fmla="*/ 0 w 2744"/>
                  <a:gd name="T7" fmla="*/ 1107 h 1107"/>
                  <a:gd name="T8" fmla="*/ 0 w 2744"/>
                  <a:gd name="T9" fmla="*/ 2 h 1107"/>
                  <a:gd name="T10" fmla="*/ 331 w 2744"/>
                  <a:gd name="T11" fmla="*/ 88 h 1107"/>
                  <a:gd name="T12" fmla="*/ 433 w 2744"/>
                  <a:gd name="T13" fmla="*/ 88 h 1107"/>
                  <a:gd name="T14" fmla="*/ 433 w 2744"/>
                  <a:gd name="T15" fmla="*/ 1107 h 1107"/>
                  <a:gd name="T16" fmla="*/ 331 w 2744"/>
                  <a:gd name="T17" fmla="*/ 1107 h 1107"/>
                  <a:gd name="T18" fmla="*/ 331 w 2744"/>
                  <a:gd name="T19" fmla="*/ 88 h 1107"/>
                  <a:gd name="T20" fmla="*/ 660 w 2744"/>
                  <a:gd name="T21" fmla="*/ 78 h 1107"/>
                  <a:gd name="T22" fmla="*/ 764 w 2744"/>
                  <a:gd name="T23" fmla="*/ 78 h 1107"/>
                  <a:gd name="T24" fmla="*/ 764 w 2744"/>
                  <a:gd name="T25" fmla="*/ 1107 h 1107"/>
                  <a:gd name="T26" fmla="*/ 660 w 2744"/>
                  <a:gd name="T27" fmla="*/ 1107 h 1107"/>
                  <a:gd name="T28" fmla="*/ 660 w 2744"/>
                  <a:gd name="T29" fmla="*/ 78 h 1107"/>
                  <a:gd name="T30" fmla="*/ 990 w 2744"/>
                  <a:gd name="T31" fmla="*/ 0 h 1107"/>
                  <a:gd name="T32" fmla="*/ 1094 w 2744"/>
                  <a:gd name="T33" fmla="*/ 0 h 1107"/>
                  <a:gd name="T34" fmla="*/ 1094 w 2744"/>
                  <a:gd name="T35" fmla="*/ 1107 h 1107"/>
                  <a:gd name="T36" fmla="*/ 990 w 2744"/>
                  <a:gd name="T37" fmla="*/ 1107 h 1107"/>
                  <a:gd name="T38" fmla="*/ 990 w 2744"/>
                  <a:gd name="T39" fmla="*/ 0 h 1107"/>
                  <a:gd name="T40" fmla="*/ 1321 w 2744"/>
                  <a:gd name="T41" fmla="*/ 123 h 1107"/>
                  <a:gd name="T42" fmla="*/ 1424 w 2744"/>
                  <a:gd name="T43" fmla="*/ 123 h 1107"/>
                  <a:gd name="T44" fmla="*/ 1424 w 2744"/>
                  <a:gd name="T45" fmla="*/ 1107 h 1107"/>
                  <a:gd name="T46" fmla="*/ 1321 w 2744"/>
                  <a:gd name="T47" fmla="*/ 1107 h 1107"/>
                  <a:gd name="T48" fmla="*/ 1321 w 2744"/>
                  <a:gd name="T49" fmla="*/ 123 h 1107"/>
                  <a:gd name="T50" fmla="*/ 1650 w 2744"/>
                  <a:gd name="T51" fmla="*/ 55 h 1107"/>
                  <a:gd name="T52" fmla="*/ 1754 w 2744"/>
                  <a:gd name="T53" fmla="*/ 55 h 1107"/>
                  <a:gd name="T54" fmla="*/ 1754 w 2744"/>
                  <a:gd name="T55" fmla="*/ 1107 h 1107"/>
                  <a:gd name="T56" fmla="*/ 1650 w 2744"/>
                  <a:gd name="T57" fmla="*/ 1107 h 1107"/>
                  <a:gd name="T58" fmla="*/ 1650 w 2744"/>
                  <a:gd name="T59" fmla="*/ 55 h 1107"/>
                  <a:gd name="T60" fmla="*/ 1981 w 2744"/>
                  <a:gd name="T61" fmla="*/ 20 h 1107"/>
                  <a:gd name="T62" fmla="*/ 2084 w 2744"/>
                  <a:gd name="T63" fmla="*/ 20 h 1107"/>
                  <a:gd name="T64" fmla="*/ 2084 w 2744"/>
                  <a:gd name="T65" fmla="*/ 1107 h 1107"/>
                  <a:gd name="T66" fmla="*/ 1981 w 2744"/>
                  <a:gd name="T67" fmla="*/ 1107 h 1107"/>
                  <a:gd name="T68" fmla="*/ 1981 w 2744"/>
                  <a:gd name="T69" fmla="*/ 20 h 1107"/>
                  <a:gd name="T70" fmla="*/ 2310 w 2744"/>
                  <a:gd name="T71" fmla="*/ 18 h 1107"/>
                  <a:gd name="T72" fmla="*/ 2414 w 2744"/>
                  <a:gd name="T73" fmla="*/ 18 h 1107"/>
                  <a:gd name="T74" fmla="*/ 2414 w 2744"/>
                  <a:gd name="T75" fmla="*/ 1107 h 1107"/>
                  <a:gd name="T76" fmla="*/ 2310 w 2744"/>
                  <a:gd name="T77" fmla="*/ 1107 h 1107"/>
                  <a:gd name="T78" fmla="*/ 2310 w 2744"/>
                  <a:gd name="T79" fmla="*/ 18 h 1107"/>
                  <a:gd name="T80" fmla="*/ 2640 w 2744"/>
                  <a:gd name="T81" fmla="*/ 108 h 1107"/>
                  <a:gd name="T82" fmla="*/ 2744 w 2744"/>
                  <a:gd name="T83" fmla="*/ 108 h 1107"/>
                  <a:gd name="T84" fmla="*/ 2744 w 2744"/>
                  <a:gd name="T85" fmla="*/ 1107 h 1107"/>
                  <a:gd name="T86" fmla="*/ 2640 w 2744"/>
                  <a:gd name="T87" fmla="*/ 1107 h 1107"/>
                  <a:gd name="T88" fmla="*/ 2640 w 2744"/>
                  <a:gd name="T89" fmla="*/ 108 h 11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2744" h="1107">
                    <a:moveTo>
                      <a:pt x="0" y="2"/>
                    </a:moveTo>
                    <a:lnTo>
                      <a:pt x="104" y="2"/>
                    </a:lnTo>
                    <a:lnTo>
                      <a:pt x="104" y="1107"/>
                    </a:lnTo>
                    <a:lnTo>
                      <a:pt x="0" y="1107"/>
                    </a:lnTo>
                    <a:lnTo>
                      <a:pt x="0" y="2"/>
                    </a:lnTo>
                    <a:close/>
                    <a:moveTo>
                      <a:pt x="331" y="88"/>
                    </a:moveTo>
                    <a:lnTo>
                      <a:pt x="433" y="88"/>
                    </a:lnTo>
                    <a:lnTo>
                      <a:pt x="433" y="1107"/>
                    </a:lnTo>
                    <a:lnTo>
                      <a:pt x="331" y="1107"/>
                    </a:lnTo>
                    <a:lnTo>
                      <a:pt x="331" y="88"/>
                    </a:lnTo>
                    <a:close/>
                    <a:moveTo>
                      <a:pt x="660" y="78"/>
                    </a:moveTo>
                    <a:lnTo>
                      <a:pt x="764" y="78"/>
                    </a:lnTo>
                    <a:lnTo>
                      <a:pt x="764" y="1107"/>
                    </a:lnTo>
                    <a:lnTo>
                      <a:pt x="660" y="1107"/>
                    </a:lnTo>
                    <a:lnTo>
                      <a:pt x="660" y="78"/>
                    </a:lnTo>
                    <a:close/>
                    <a:moveTo>
                      <a:pt x="990" y="0"/>
                    </a:moveTo>
                    <a:lnTo>
                      <a:pt x="1094" y="0"/>
                    </a:lnTo>
                    <a:lnTo>
                      <a:pt x="1094" y="1107"/>
                    </a:lnTo>
                    <a:lnTo>
                      <a:pt x="990" y="1107"/>
                    </a:lnTo>
                    <a:lnTo>
                      <a:pt x="990" y="0"/>
                    </a:lnTo>
                    <a:close/>
                    <a:moveTo>
                      <a:pt x="1321" y="123"/>
                    </a:moveTo>
                    <a:lnTo>
                      <a:pt x="1424" y="123"/>
                    </a:lnTo>
                    <a:lnTo>
                      <a:pt x="1424" y="1107"/>
                    </a:lnTo>
                    <a:lnTo>
                      <a:pt x="1321" y="1107"/>
                    </a:lnTo>
                    <a:lnTo>
                      <a:pt x="1321" y="123"/>
                    </a:lnTo>
                    <a:close/>
                    <a:moveTo>
                      <a:pt x="1650" y="55"/>
                    </a:moveTo>
                    <a:lnTo>
                      <a:pt x="1754" y="55"/>
                    </a:lnTo>
                    <a:lnTo>
                      <a:pt x="1754" y="1107"/>
                    </a:lnTo>
                    <a:lnTo>
                      <a:pt x="1650" y="1107"/>
                    </a:lnTo>
                    <a:lnTo>
                      <a:pt x="1650" y="55"/>
                    </a:lnTo>
                    <a:close/>
                    <a:moveTo>
                      <a:pt x="1981" y="20"/>
                    </a:moveTo>
                    <a:lnTo>
                      <a:pt x="2084" y="20"/>
                    </a:lnTo>
                    <a:lnTo>
                      <a:pt x="2084" y="1107"/>
                    </a:lnTo>
                    <a:lnTo>
                      <a:pt x="1981" y="1107"/>
                    </a:lnTo>
                    <a:lnTo>
                      <a:pt x="1981" y="20"/>
                    </a:lnTo>
                    <a:close/>
                    <a:moveTo>
                      <a:pt x="2310" y="18"/>
                    </a:moveTo>
                    <a:lnTo>
                      <a:pt x="2414" y="18"/>
                    </a:lnTo>
                    <a:lnTo>
                      <a:pt x="2414" y="1107"/>
                    </a:lnTo>
                    <a:lnTo>
                      <a:pt x="2310" y="1107"/>
                    </a:lnTo>
                    <a:lnTo>
                      <a:pt x="2310" y="18"/>
                    </a:lnTo>
                    <a:close/>
                    <a:moveTo>
                      <a:pt x="2640" y="108"/>
                    </a:moveTo>
                    <a:lnTo>
                      <a:pt x="2744" y="108"/>
                    </a:lnTo>
                    <a:lnTo>
                      <a:pt x="2744" y="1107"/>
                    </a:lnTo>
                    <a:lnTo>
                      <a:pt x="2640" y="1107"/>
                    </a:lnTo>
                    <a:lnTo>
                      <a:pt x="2640" y="108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" name="Freeform 48">
                <a:extLst>
                  <a:ext uri="{FF2B5EF4-FFF2-40B4-BE49-F238E27FC236}">
                    <a16:creationId xmlns:a16="http://schemas.microsoft.com/office/drawing/2014/main" id="{655CD83F-0F11-43A6-B811-746753BEABD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038600" y="8532813"/>
                <a:ext cx="4356100" cy="1757363"/>
              </a:xfrm>
              <a:custGeom>
                <a:avLst/>
                <a:gdLst>
                  <a:gd name="T0" fmla="*/ 0 w 2744"/>
                  <a:gd name="T1" fmla="*/ 2 h 1107"/>
                  <a:gd name="T2" fmla="*/ 104 w 2744"/>
                  <a:gd name="T3" fmla="*/ 2 h 1107"/>
                  <a:gd name="T4" fmla="*/ 104 w 2744"/>
                  <a:gd name="T5" fmla="*/ 1107 h 1107"/>
                  <a:gd name="T6" fmla="*/ 0 w 2744"/>
                  <a:gd name="T7" fmla="*/ 1107 h 1107"/>
                  <a:gd name="T8" fmla="*/ 0 w 2744"/>
                  <a:gd name="T9" fmla="*/ 2 h 1107"/>
                  <a:gd name="T10" fmla="*/ 331 w 2744"/>
                  <a:gd name="T11" fmla="*/ 88 h 1107"/>
                  <a:gd name="T12" fmla="*/ 433 w 2744"/>
                  <a:gd name="T13" fmla="*/ 88 h 1107"/>
                  <a:gd name="T14" fmla="*/ 433 w 2744"/>
                  <a:gd name="T15" fmla="*/ 1107 h 1107"/>
                  <a:gd name="T16" fmla="*/ 331 w 2744"/>
                  <a:gd name="T17" fmla="*/ 1107 h 1107"/>
                  <a:gd name="T18" fmla="*/ 331 w 2744"/>
                  <a:gd name="T19" fmla="*/ 88 h 1107"/>
                  <a:gd name="T20" fmla="*/ 660 w 2744"/>
                  <a:gd name="T21" fmla="*/ 78 h 1107"/>
                  <a:gd name="T22" fmla="*/ 764 w 2744"/>
                  <a:gd name="T23" fmla="*/ 78 h 1107"/>
                  <a:gd name="T24" fmla="*/ 764 w 2744"/>
                  <a:gd name="T25" fmla="*/ 1107 h 1107"/>
                  <a:gd name="T26" fmla="*/ 660 w 2744"/>
                  <a:gd name="T27" fmla="*/ 1107 h 1107"/>
                  <a:gd name="T28" fmla="*/ 660 w 2744"/>
                  <a:gd name="T29" fmla="*/ 78 h 1107"/>
                  <a:gd name="T30" fmla="*/ 990 w 2744"/>
                  <a:gd name="T31" fmla="*/ 0 h 1107"/>
                  <a:gd name="T32" fmla="*/ 1094 w 2744"/>
                  <a:gd name="T33" fmla="*/ 0 h 1107"/>
                  <a:gd name="T34" fmla="*/ 1094 w 2744"/>
                  <a:gd name="T35" fmla="*/ 1107 h 1107"/>
                  <a:gd name="T36" fmla="*/ 990 w 2744"/>
                  <a:gd name="T37" fmla="*/ 1107 h 1107"/>
                  <a:gd name="T38" fmla="*/ 990 w 2744"/>
                  <a:gd name="T39" fmla="*/ 0 h 1107"/>
                  <a:gd name="T40" fmla="*/ 1321 w 2744"/>
                  <a:gd name="T41" fmla="*/ 123 h 1107"/>
                  <a:gd name="T42" fmla="*/ 1424 w 2744"/>
                  <a:gd name="T43" fmla="*/ 123 h 1107"/>
                  <a:gd name="T44" fmla="*/ 1424 w 2744"/>
                  <a:gd name="T45" fmla="*/ 1107 h 1107"/>
                  <a:gd name="T46" fmla="*/ 1321 w 2744"/>
                  <a:gd name="T47" fmla="*/ 1107 h 1107"/>
                  <a:gd name="T48" fmla="*/ 1321 w 2744"/>
                  <a:gd name="T49" fmla="*/ 123 h 1107"/>
                  <a:gd name="T50" fmla="*/ 1650 w 2744"/>
                  <a:gd name="T51" fmla="*/ 55 h 1107"/>
                  <a:gd name="T52" fmla="*/ 1754 w 2744"/>
                  <a:gd name="T53" fmla="*/ 55 h 1107"/>
                  <a:gd name="T54" fmla="*/ 1754 w 2744"/>
                  <a:gd name="T55" fmla="*/ 1107 h 1107"/>
                  <a:gd name="T56" fmla="*/ 1650 w 2744"/>
                  <a:gd name="T57" fmla="*/ 1107 h 1107"/>
                  <a:gd name="T58" fmla="*/ 1650 w 2744"/>
                  <a:gd name="T59" fmla="*/ 55 h 1107"/>
                  <a:gd name="T60" fmla="*/ 1981 w 2744"/>
                  <a:gd name="T61" fmla="*/ 20 h 1107"/>
                  <a:gd name="T62" fmla="*/ 2084 w 2744"/>
                  <a:gd name="T63" fmla="*/ 20 h 1107"/>
                  <a:gd name="T64" fmla="*/ 2084 w 2744"/>
                  <a:gd name="T65" fmla="*/ 1107 h 1107"/>
                  <a:gd name="T66" fmla="*/ 1981 w 2744"/>
                  <a:gd name="T67" fmla="*/ 1107 h 1107"/>
                  <a:gd name="T68" fmla="*/ 1981 w 2744"/>
                  <a:gd name="T69" fmla="*/ 20 h 1107"/>
                  <a:gd name="T70" fmla="*/ 2310 w 2744"/>
                  <a:gd name="T71" fmla="*/ 18 h 1107"/>
                  <a:gd name="T72" fmla="*/ 2414 w 2744"/>
                  <a:gd name="T73" fmla="*/ 18 h 1107"/>
                  <a:gd name="T74" fmla="*/ 2414 w 2744"/>
                  <a:gd name="T75" fmla="*/ 1107 h 1107"/>
                  <a:gd name="T76" fmla="*/ 2310 w 2744"/>
                  <a:gd name="T77" fmla="*/ 1107 h 1107"/>
                  <a:gd name="T78" fmla="*/ 2310 w 2744"/>
                  <a:gd name="T79" fmla="*/ 18 h 1107"/>
                  <a:gd name="T80" fmla="*/ 2640 w 2744"/>
                  <a:gd name="T81" fmla="*/ 108 h 1107"/>
                  <a:gd name="T82" fmla="*/ 2744 w 2744"/>
                  <a:gd name="T83" fmla="*/ 108 h 1107"/>
                  <a:gd name="T84" fmla="*/ 2744 w 2744"/>
                  <a:gd name="T85" fmla="*/ 1107 h 1107"/>
                  <a:gd name="T86" fmla="*/ 2640 w 2744"/>
                  <a:gd name="T87" fmla="*/ 1107 h 1107"/>
                  <a:gd name="T88" fmla="*/ 2640 w 2744"/>
                  <a:gd name="T89" fmla="*/ 108 h 11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2744" h="1107">
                    <a:moveTo>
                      <a:pt x="0" y="2"/>
                    </a:moveTo>
                    <a:lnTo>
                      <a:pt x="104" y="2"/>
                    </a:lnTo>
                    <a:lnTo>
                      <a:pt x="104" y="1107"/>
                    </a:lnTo>
                    <a:lnTo>
                      <a:pt x="0" y="1107"/>
                    </a:lnTo>
                    <a:lnTo>
                      <a:pt x="0" y="2"/>
                    </a:lnTo>
                    <a:close/>
                    <a:moveTo>
                      <a:pt x="331" y="88"/>
                    </a:moveTo>
                    <a:lnTo>
                      <a:pt x="433" y="88"/>
                    </a:lnTo>
                    <a:lnTo>
                      <a:pt x="433" y="1107"/>
                    </a:lnTo>
                    <a:lnTo>
                      <a:pt x="331" y="1107"/>
                    </a:lnTo>
                    <a:lnTo>
                      <a:pt x="331" y="88"/>
                    </a:lnTo>
                    <a:close/>
                    <a:moveTo>
                      <a:pt x="660" y="78"/>
                    </a:moveTo>
                    <a:lnTo>
                      <a:pt x="764" y="78"/>
                    </a:lnTo>
                    <a:lnTo>
                      <a:pt x="764" y="1107"/>
                    </a:lnTo>
                    <a:lnTo>
                      <a:pt x="660" y="1107"/>
                    </a:lnTo>
                    <a:lnTo>
                      <a:pt x="660" y="78"/>
                    </a:lnTo>
                    <a:close/>
                    <a:moveTo>
                      <a:pt x="990" y="0"/>
                    </a:moveTo>
                    <a:lnTo>
                      <a:pt x="1094" y="0"/>
                    </a:lnTo>
                    <a:lnTo>
                      <a:pt x="1094" y="1107"/>
                    </a:lnTo>
                    <a:lnTo>
                      <a:pt x="990" y="1107"/>
                    </a:lnTo>
                    <a:lnTo>
                      <a:pt x="990" y="0"/>
                    </a:lnTo>
                    <a:close/>
                    <a:moveTo>
                      <a:pt x="1321" y="123"/>
                    </a:moveTo>
                    <a:lnTo>
                      <a:pt x="1424" y="123"/>
                    </a:lnTo>
                    <a:lnTo>
                      <a:pt x="1424" y="1107"/>
                    </a:lnTo>
                    <a:lnTo>
                      <a:pt x="1321" y="1107"/>
                    </a:lnTo>
                    <a:lnTo>
                      <a:pt x="1321" y="123"/>
                    </a:lnTo>
                    <a:close/>
                    <a:moveTo>
                      <a:pt x="1650" y="55"/>
                    </a:moveTo>
                    <a:lnTo>
                      <a:pt x="1754" y="55"/>
                    </a:lnTo>
                    <a:lnTo>
                      <a:pt x="1754" y="1107"/>
                    </a:lnTo>
                    <a:lnTo>
                      <a:pt x="1650" y="1107"/>
                    </a:lnTo>
                    <a:lnTo>
                      <a:pt x="1650" y="55"/>
                    </a:lnTo>
                    <a:close/>
                    <a:moveTo>
                      <a:pt x="1981" y="20"/>
                    </a:moveTo>
                    <a:lnTo>
                      <a:pt x="2084" y="20"/>
                    </a:lnTo>
                    <a:lnTo>
                      <a:pt x="2084" y="1107"/>
                    </a:lnTo>
                    <a:lnTo>
                      <a:pt x="1981" y="1107"/>
                    </a:lnTo>
                    <a:lnTo>
                      <a:pt x="1981" y="20"/>
                    </a:lnTo>
                    <a:close/>
                    <a:moveTo>
                      <a:pt x="2310" y="18"/>
                    </a:moveTo>
                    <a:lnTo>
                      <a:pt x="2414" y="18"/>
                    </a:lnTo>
                    <a:lnTo>
                      <a:pt x="2414" y="1107"/>
                    </a:lnTo>
                    <a:lnTo>
                      <a:pt x="2310" y="1107"/>
                    </a:lnTo>
                    <a:lnTo>
                      <a:pt x="2310" y="18"/>
                    </a:lnTo>
                    <a:close/>
                    <a:moveTo>
                      <a:pt x="2640" y="108"/>
                    </a:moveTo>
                    <a:lnTo>
                      <a:pt x="2744" y="108"/>
                    </a:lnTo>
                    <a:lnTo>
                      <a:pt x="2744" y="1107"/>
                    </a:lnTo>
                    <a:lnTo>
                      <a:pt x="2640" y="1107"/>
                    </a:lnTo>
                    <a:lnTo>
                      <a:pt x="2640" y="108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" name="Freeform 49">
                <a:extLst>
                  <a:ext uri="{FF2B5EF4-FFF2-40B4-BE49-F238E27FC236}">
                    <a16:creationId xmlns:a16="http://schemas.microsoft.com/office/drawing/2014/main" id="{6BA6F1DD-3387-49B8-9F9A-A90460616B2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092575" y="8010525"/>
                <a:ext cx="58737" cy="525463"/>
              </a:xfrm>
              <a:custGeom>
                <a:avLst/>
                <a:gdLst>
                  <a:gd name="T0" fmla="*/ 18 w 37"/>
                  <a:gd name="T1" fmla="*/ 331 h 331"/>
                  <a:gd name="T2" fmla="*/ 18 w 37"/>
                  <a:gd name="T3" fmla="*/ 0 h 331"/>
                  <a:gd name="T4" fmla="*/ 0 w 37"/>
                  <a:gd name="T5" fmla="*/ 0 h 331"/>
                  <a:gd name="T6" fmla="*/ 37 w 37"/>
                  <a:gd name="T7" fmla="*/ 0 h 3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331">
                    <a:moveTo>
                      <a:pt x="18" y="331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9525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" name="Freeform 50">
                <a:extLst>
                  <a:ext uri="{FF2B5EF4-FFF2-40B4-BE49-F238E27FC236}">
                    <a16:creationId xmlns:a16="http://schemas.microsoft.com/office/drawing/2014/main" id="{5081593D-289A-4F28-A712-2B0351C09A3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616450" y="8213725"/>
                <a:ext cx="57150" cy="458788"/>
              </a:xfrm>
              <a:custGeom>
                <a:avLst/>
                <a:gdLst>
                  <a:gd name="T0" fmla="*/ 18 w 36"/>
                  <a:gd name="T1" fmla="*/ 289 h 289"/>
                  <a:gd name="T2" fmla="*/ 18 w 36"/>
                  <a:gd name="T3" fmla="*/ 0 h 289"/>
                  <a:gd name="T4" fmla="*/ 0 w 36"/>
                  <a:gd name="T5" fmla="*/ 0 h 289"/>
                  <a:gd name="T6" fmla="*/ 36 w 36"/>
                  <a:gd name="T7" fmla="*/ 0 h 2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289">
                    <a:moveTo>
                      <a:pt x="18" y="289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" name="Freeform 51">
                <a:extLst>
                  <a:ext uri="{FF2B5EF4-FFF2-40B4-BE49-F238E27FC236}">
                    <a16:creationId xmlns:a16="http://schemas.microsoft.com/office/drawing/2014/main" id="{34AE4FFC-3F3C-414E-96F9-CBBEFA1EB8F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140325" y="8069263"/>
                <a:ext cx="57150" cy="587375"/>
              </a:xfrm>
              <a:custGeom>
                <a:avLst/>
                <a:gdLst>
                  <a:gd name="T0" fmla="*/ 18 w 36"/>
                  <a:gd name="T1" fmla="*/ 370 h 370"/>
                  <a:gd name="T2" fmla="*/ 18 w 36"/>
                  <a:gd name="T3" fmla="*/ 0 h 370"/>
                  <a:gd name="T4" fmla="*/ 0 w 36"/>
                  <a:gd name="T5" fmla="*/ 0 h 370"/>
                  <a:gd name="T6" fmla="*/ 36 w 36"/>
                  <a:gd name="T7" fmla="*/ 0 h 3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70">
                    <a:moveTo>
                      <a:pt x="18" y="370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" name="Freeform 52">
                <a:extLst>
                  <a:ext uri="{FF2B5EF4-FFF2-40B4-BE49-F238E27FC236}">
                    <a16:creationId xmlns:a16="http://schemas.microsoft.com/office/drawing/2014/main" id="{B3683270-E6E1-487C-B9D6-A2D91ED889F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664200" y="8059738"/>
                <a:ext cx="57150" cy="473075"/>
              </a:xfrm>
              <a:custGeom>
                <a:avLst/>
                <a:gdLst>
                  <a:gd name="T0" fmla="*/ 18 w 36"/>
                  <a:gd name="T1" fmla="*/ 298 h 298"/>
                  <a:gd name="T2" fmla="*/ 18 w 36"/>
                  <a:gd name="T3" fmla="*/ 0 h 298"/>
                  <a:gd name="T4" fmla="*/ 0 w 36"/>
                  <a:gd name="T5" fmla="*/ 0 h 298"/>
                  <a:gd name="T6" fmla="*/ 36 w 36"/>
                  <a:gd name="T7" fmla="*/ 0 h 2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298">
                    <a:moveTo>
                      <a:pt x="18" y="298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" name="Freeform 53">
                <a:extLst>
                  <a:ext uri="{FF2B5EF4-FFF2-40B4-BE49-F238E27FC236}">
                    <a16:creationId xmlns:a16="http://schemas.microsoft.com/office/drawing/2014/main" id="{5CDA65CF-C0A9-4BFC-ACFB-4832F457641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188075" y="8318500"/>
                <a:ext cx="57150" cy="409575"/>
              </a:xfrm>
              <a:custGeom>
                <a:avLst/>
                <a:gdLst>
                  <a:gd name="T0" fmla="*/ 18 w 36"/>
                  <a:gd name="T1" fmla="*/ 258 h 258"/>
                  <a:gd name="T2" fmla="*/ 18 w 36"/>
                  <a:gd name="T3" fmla="*/ 0 h 258"/>
                  <a:gd name="T4" fmla="*/ 0 w 36"/>
                  <a:gd name="T5" fmla="*/ 0 h 258"/>
                  <a:gd name="T6" fmla="*/ 36 w 36"/>
                  <a:gd name="T7" fmla="*/ 0 h 2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258">
                    <a:moveTo>
                      <a:pt x="18" y="258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" name="Freeform 54">
                <a:extLst>
                  <a:ext uri="{FF2B5EF4-FFF2-40B4-BE49-F238E27FC236}">
                    <a16:creationId xmlns:a16="http://schemas.microsoft.com/office/drawing/2014/main" id="{B898AAEE-442D-43AF-825B-807CD304DE6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711950" y="8001000"/>
                <a:ext cx="57150" cy="619125"/>
              </a:xfrm>
              <a:custGeom>
                <a:avLst/>
                <a:gdLst>
                  <a:gd name="T0" fmla="*/ 18 w 36"/>
                  <a:gd name="T1" fmla="*/ 390 h 390"/>
                  <a:gd name="T2" fmla="*/ 18 w 36"/>
                  <a:gd name="T3" fmla="*/ 0 h 390"/>
                  <a:gd name="T4" fmla="*/ 0 w 36"/>
                  <a:gd name="T5" fmla="*/ 0 h 390"/>
                  <a:gd name="T6" fmla="*/ 36 w 36"/>
                  <a:gd name="T7" fmla="*/ 0 h 3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90">
                    <a:moveTo>
                      <a:pt x="18" y="390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" name="Freeform 55">
                <a:extLst>
                  <a:ext uri="{FF2B5EF4-FFF2-40B4-BE49-F238E27FC236}">
                    <a16:creationId xmlns:a16="http://schemas.microsoft.com/office/drawing/2014/main" id="{5427FCF9-C4F1-487B-85D5-34422C4DE80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235825" y="8016875"/>
                <a:ext cx="57150" cy="547688"/>
              </a:xfrm>
              <a:custGeom>
                <a:avLst/>
                <a:gdLst>
                  <a:gd name="T0" fmla="*/ 18 w 36"/>
                  <a:gd name="T1" fmla="*/ 345 h 345"/>
                  <a:gd name="T2" fmla="*/ 18 w 36"/>
                  <a:gd name="T3" fmla="*/ 0 h 345"/>
                  <a:gd name="T4" fmla="*/ 0 w 36"/>
                  <a:gd name="T5" fmla="*/ 0 h 345"/>
                  <a:gd name="T6" fmla="*/ 36 w 36"/>
                  <a:gd name="T7" fmla="*/ 0 h 3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45">
                    <a:moveTo>
                      <a:pt x="18" y="345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" name="Freeform 56">
                <a:extLst>
                  <a:ext uri="{FF2B5EF4-FFF2-40B4-BE49-F238E27FC236}">
                    <a16:creationId xmlns:a16="http://schemas.microsoft.com/office/drawing/2014/main" id="{53D4713A-53D9-44F7-A74C-FE27AA2C616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759700" y="7975600"/>
                <a:ext cx="57150" cy="585788"/>
              </a:xfrm>
              <a:custGeom>
                <a:avLst/>
                <a:gdLst>
                  <a:gd name="T0" fmla="*/ 18 w 36"/>
                  <a:gd name="T1" fmla="*/ 369 h 369"/>
                  <a:gd name="T2" fmla="*/ 18 w 36"/>
                  <a:gd name="T3" fmla="*/ 0 h 369"/>
                  <a:gd name="T4" fmla="*/ 0 w 36"/>
                  <a:gd name="T5" fmla="*/ 0 h 369"/>
                  <a:gd name="T6" fmla="*/ 36 w 36"/>
                  <a:gd name="T7" fmla="*/ 0 h 3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69">
                    <a:moveTo>
                      <a:pt x="18" y="369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3" name="Freeform 57">
                <a:extLst>
                  <a:ext uri="{FF2B5EF4-FFF2-40B4-BE49-F238E27FC236}">
                    <a16:creationId xmlns:a16="http://schemas.microsoft.com/office/drawing/2014/main" id="{E24F6DDD-BDBF-46B8-8A84-C1A62DBB241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283575" y="8428038"/>
                <a:ext cx="57150" cy="276225"/>
              </a:xfrm>
              <a:custGeom>
                <a:avLst/>
                <a:gdLst>
                  <a:gd name="T0" fmla="*/ 18 w 36"/>
                  <a:gd name="T1" fmla="*/ 174 h 174"/>
                  <a:gd name="T2" fmla="*/ 18 w 36"/>
                  <a:gd name="T3" fmla="*/ 0 h 174"/>
                  <a:gd name="T4" fmla="*/ 0 w 36"/>
                  <a:gd name="T5" fmla="*/ 0 h 174"/>
                  <a:gd name="T6" fmla="*/ 36 w 36"/>
                  <a:gd name="T7" fmla="*/ 0 h 1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174">
                    <a:moveTo>
                      <a:pt x="18" y="174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rgbClr val="59595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4" name="Line 58">
                <a:extLst>
                  <a:ext uri="{FF2B5EF4-FFF2-40B4-BE49-F238E27FC236}">
                    <a16:creationId xmlns:a16="http://schemas.microsoft.com/office/drawing/2014/main" id="{227EFABD-CB6E-4DCE-A181-602CBB85A4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59213" y="7723188"/>
                <a:ext cx="0" cy="256698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5" name="Freeform 59">
                <a:extLst>
                  <a:ext uri="{FF2B5EF4-FFF2-40B4-BE49-F238E27FC236}">
                    <a16:creationId xmlns:a16="http://schemas.microsoft.com/office/drawing/2014/main" id="{CA92CE7C-CB4B-40A5-B898-3CE34FD07FC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824288" y="7723188"/>
                <a:ext cx="34925" cy="2566988"/>
              </a:xfrm>
              <a:custGeom>
                <a:avLst/>
                <a:gdLst>
                  <a:gd name="T0" fmla="*/ 0 w 22"/>
                  <a:gd name="T1" fmla="*/ 1617 h 1617"/>
                  <a:gd name="T2" fmla="*/ 22 w 22"/>
                  <a:gd name="T3" fmla="*/ 1617 h 1617"/>
                  <a:gd name="T4" fmla="*/ 0 w 22"/>
                  <a:gd name="T5" fmla="*/ 1386 h 1617"/>
                  <a:gd name="T6" fmla="*/ 22 w 22"/>
                  <a:gd name="T7" fmla="*/ 1386 h 1617"/>
                  <a:gd name="T8" fmla="*/ 0 w 22"/>
                  <a:gd name="T9" fmla="*/ 1155 h 1617"/>
                  <a:gd name="T10" fmla="*/ 22 w 22"/>
                  <a:gd name="T11" fmla="*/ 1155 h 1617"/>
                  <a:gd name="T12" fmla="*/ 0 w 22"/>
                  <a:gd name="T13" fmla="*/ 924 h 1617"/>
                  <a:gd name="T14" fmla="*/ 22 w 22"/>
                  <a:gd name="T15" fmla="*/ 924 h 1617"/>
                  <a:gd name="T16" fmla="*/ 0 w 22"/>
                  <a:gd name="T17" fmla="*/ 693 h 1617"/>
                  <a:gd name="T18" fmla="*/ 22 w 22"/>
                  <a:gd name="T19" fmla="*/ 693 h 1617"/>
                  <a:gd name="T20" fmla="*/ 0 w 22"/>
                  <a:gd name="T21" fmla="*/ 462 h 1617"/>
                  <a:gd name="T22" fmla="*/ 22 w 22"/>
                  <a:gd name="T23" fmla="*/ 462 h 1617"/>
                  <a:gd name="T24" fmla="*/ 0 w 22"/>
                  <a:gd name="T25" fmla="*/ 231 h 1617"/>
                  <a:gd name="T26" fmla="*/ 22 w 22"/>
                  <a:gd name="T27" fmla="*/ 231 h 1617"/>
                  <a:gd name="T28" fmla="*/ 0 w 22"/>
                  <a:gd name="T29" fmla="*/ 0 h 1617"/>
                  <a:gd name="T30" fmla="*/ 22 w 22"/>
                  <a:gd name="T31" fmla="*/ 0 h 16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22" h="1617">
                    <a:moveTo>
                      <a:pt x="0" y="1617"/>
                    </a:moveTo>
                    <a:lnTo>
                      <a:pt x="22" y="1617"/>
                    </a:lnTo>
                    <a:moveTo>
                      <a:pt x="0" y="1386"/>
                    </a:moveTo>
                    <a:lnTo>
                      <a:pt x="22" y="1386"/>
                    </a:lnTo>
                    <a:moveTo>
                      <a:pt x="0" y="1155"/>
                    </a:moveTo>
                    <a:lnTo>
                      <a:pt x="22" y="1155"/>
                    </a:lnTo>
                    <a:moveTo>
                      <a:pt x="0" y="924"/>
                    </a:moveTo>
                    <a:lnTo>
                      <a:pt x="22" y="924"/>
                    </a:lnTo>
                    <a:moveTo>
                      <a:pt x="0" y="693"/>
                    </a:moveTo>
                    <a:lnTo>
                      <a:pt x="22" y="693"/>
                    </a:lnTo>
                    <a:moveTo>
                      <a:pt x="0" y="462"/>
                    </a:moveTo>
                    <a:lnTo>
                      <a:pt x="22" y="462"/>
                    </a:lnTo>
                    <a:moveTo>
                      <a:pt x="0" y="231"/>
                    </a:moveTo>
                    <a:lnTo>
                      <a:pt x="22" y="231"/>
                    </a:lnTo>
                    <a:moveTo>
                      <a:pt x="0" y="0"/>
                    </a:moveTo>
                    <a:lnTo>
                      <a:pt x="22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6" name="Line 60">
                <a:extLst>
                  <a:ext uri="{FF2B5EF4-FFF2-40B4-BE49-F238E27FC236}">
                    <a16:creationId xmlns:a16="http://schemas.microsoft.com/office/drawing/2014/main" id="{57289CBC-4C51-4AC7-8730-73BC10B12E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59213" y="10290175"/>
                <a:ext cx="471487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7" name="Freeform 61">
                <a:extLst>
                  <a:ext uri="{FF2B5EF4-FFF2-40B4-BE49-F238E27FC236}">
                    <a16:creationId xmlns:a16="http://schemas.microsoft.com/office/drawing/2014/main" id="{3B7A093D-7BF4-4075-BBDA-A1D72F03190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859213" y="10290175"/>
                <a:ext cx="4714875" cy="34925"/>
              </a:xfrm>
              <a:custGeom>
                <a:avLst/>
                <a:gdLst>
                  <a:gd name="T0" fmla="*/ 0 w 2970"/>
                  <a:gd name="T1" fmla="*/ 0 h 22"/>
                  <a:gd name="T2" fmla="*/ 0 w 2970"/>
                  <a:gd name="T3" fmla="*/ 22 h 22"/>
                  <a:gd name="T4" fmla="*/ 330 w 2970"/>
                  <a:gd name="T5" fmla="*/ 0 h 22"/>
                  <a:gd name="T6" fmla="*/ 330 w 2970"/>
                  <a:gd name="T7" fmla="*/ 22 h 22"/>
                  <a:gd name="T8" fmla="*/ 660 w 2970"/>
                  <a:gd name="T9" fmla="*/ 0 h 22"/>
                  <a:gd name="T10" fmla="*/ 660 w 2970"/>
                  <a:gd name="T11" fmla="*/ 22 h 22"/>
                  <a:gd name="T12" fmla="*/ 990 w 2970"/>
                  <a:gd name="T13" fmla="*/ 0 h 22"/>
                  <a:gd name="T14" fmla="*/ 990 w 2970"/>
                  <a:gd name="T15" fmla="*/ 22 h 22"/>
                  <a:gd name="T16" fmla="*/ 1320 w 2970"/>
                  <a:gd name="T17" fmla="*/ 0 h 22"/>
                  <a:gd name="T18" fmla="*/ 1320 w 2970"/>
                  <a:gd name="T19" fmla="*/ 22 h 22"/>
                  <a:gd name="T20" fmla="*/ 1650 w 2970"/>
                  <a:gd name="T21" fmla="*/ 0 h 22"/>
                  <a:gd name="T22" fmla="*/ 1650 w 2970"/>
                  <a:gd name="T23" fmla="*/ 22 h 22"/>
                  <a:gd name="T24" fmla="*/ 1980 w 2970"/>
                  <a:gd name="T25" fmla="*/ 0 h 22"/>
                  <a:gd name="T26" fmla="*/ 1980 w 2970"/>
                  <a:gd name="T27" fmla="*/ 22 h 22"/>
                  <a:gd name="T28" fmla="*/ 2311 w 2970"/>
                  <a:gd name="T29" fmla="*/ 0 h 22"/>
                  <a:gd name="T30" fmla="*/ 2311 w 2970"/>
                  <a:gd name="T31" fmla="*/ 22 h 22"/>
                  <a:gd name="T32" fmla="*/ 2640 w 2970"/>
                  <a:gd name="T33" fmla="*/ 0 h 22"/>
                  <a:gd name="T34" fmla="*/ 2640 w 2970"/>
                  <a:gd name="T35" fmla="*/ 22 h 22"/>
                  <a:gd name="T36" fmla="*/ 2970 w 2970"/>
                  <a:gd name="T37" fmla="*/ 0 h 22"/>
                  <a:gd name="T38" fmla="*/ 2970 w 2970"/>
                  <a:gd name="T39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2970" h="22">
                    <a:moveTo>
                      <a:pt x="0" y="0"/>
                    </a:moveTo>
                    <a:lnTo>
                      <a:pt x="0" y="22"/>
                    </a:lnTo>
                    <a:moveTo>
                      <a:pt x="330" y="0"/>
                    </a:moveTo>
                    <a:lnTo>
                      <a:pt x="330" y="22"/>
                    </a:lnTo>
                    <a:moveTo>
                      <a:pt x="660" y="0"/>
                    </a:moveTo>
                    <a:lnTo>
                      <a:pt x="660" y="22"/>
                    </a:lnTo>
                    <a:moveTo>
                      <a:pt x="990" y="0"/>
                    </a:moveTo>
                    <a:lnTo>
                      <a:pt x="990" y="22"/>
                    </a:lnTo>
                    <a:moveTo>
                      <a:pt x="1320" y="0"/>
                    </a:moveTo>
                    <a:lnTo>
                      <a:pt x="1320" y="22"/>
                    </a:lnTo>
                    <a:moveTo>
                      <a:pt x="1650" y="0"/>
                    </a:moveTo>
                    <a:lnTo>
                      <a:pt x="1650" y="22"/>
                    </a:lnTo>
                    <a:moveTo>
                      <a:pt x="1980" y="0"/>
                    </a:moveTo>
                    <a:lnTo>
                      <a:pt x="1980" y="22"/>
                    </a:lnTo>
                    <a:moveTo>
                      <a:pt x="2311" y="0"/>
                    </a:moveTo>
                    <a:lnTo>
                      <a:pt x="2311" y="22"/>
                    </a:lnTo>
                    <a:moveTo>
                      <a:pt x="2640" y="0"/>
                    </a:moveTo>
                    <a:lnTo>
                      <a:pt x="2640" y="22"/>
                    </a:lnTo>
                    <a:moveTo>
                      <a:pt x="2970" y="0"/>
                    </a:moveTo>
                    <a:lnTo>
                      <a:pt x="2970" y="22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grpSp>
          <p:nvGrpSpPr>
            <p:cNvPr id="217" name="Group 216">
              <a:extLst>
                <a:ext uri="{FF2B5EF4-FFF2-40B4-BE49-F238E27FC236}">
                  <a16:creationId xmlns:a16="http://schemas.microsoft.com/office/drawing/2014/main" id="{F0763598-31E4-4AB3-A851-12A22C62AFE2}"/>
                </a:ext>
              </a:extLst>
            </p:cNvPr>
            <p:cNvGrpSpPr/>
            <p:nvPr/>
          </p:nvGrpSpPr>
          <p:grpSpPr>
            <a:xfrm>
              <a:off x="3494723" y="6451182"/>
              <a:ext cx="211596" cy="2717700"/>
              <a:chOff x="3570288" y="7656513"/>
              <a:chExt cx="211596" cy="2717700"/>
            </a:xfrm>
          </p:grpSpPr>
          <p:sp>
            <p:nvSpPr>
              <p:cNvPr id="158" name="Rectangle 62">
                <a:extLst>
                  <a:ext uri="{FF2B5EF4-FFF2-40B4-BE49-F238E27FC236}">
                    <a16:creationId xmlns:a16="http://schemas.microsoft.com/office/drawing/2014/main" id="{9B58F3B7-65F5-49F4-81BB-19DAE5A8F8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11352" y="1022032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56" name="Rectangle 63">
                <a:extLst>
                  <a:ext uri="{FF2B5EF4-FFF2-40B4-BE49-F238E27FC236}">
                    <a16:creationId xmlns:a16="http://schemas.microsoft.com/office/drawing/2014/main" id="{FC5E751E-7BCF-4459-921B-6B05424ED8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0820" y="9853613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59" name="Rectangle 64">
                <a:extLst>
                  <a:ext uri="{FF2B5EF4-FFF2-40B4-BE49-F238E27FC236}">
                    <a16:creationId xmlns:a16="http://schemas.microsoft.com/office/drawing/2014/main" id="{9B92F9F4-1BB7-43AA-8244-A863AA251E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0820" y="9490075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62" name="Rectangle 65">
                <a:extLst>
                  <a:ext uri="{FF2B5EF4-FFF2-40B4-BE49-F238E27FC236}">
                    <a16:creationId xmlns:a16="http://schemas.microsoft.com/office/drawing/2014/main" id="{9561D524-20A3-494F-9613-7DF66F303D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0820" y="9123363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65" name="Rectangle 66">
                <a:extLst>
                  <a:ext uri="{FF2B5EF4-FFF2-40B4-BE49-F238E27FC236}">
                    <a16:creationId xmlns:a16="http://schemas.microsoft.com/office/drawing/2014/main" id="{8E1A032A-56A6-4F75-9DAC-33B95101A9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0820" y="8756650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68" name="Rectangle 67">
                <a:extLst>
                  <a:ext uri="{FF2B5EF4-FFF2-40B4-BE49-F238E27FC236}">
                    <a16:creationId xmlns:a16="http://schemas.microsoft.com/office/drawing/2014/main" id="{2D918A81-5F6A-4896-A9C2-493522E466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70288" y="8389938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71" name="Rectangle 68">
                <a:extLst>
                  <a:ext uri="{FF2B5EF4-FFF2-40B4-BE49-F238E27FC236}">
                    <a16:creationId xmlns:a16="http://schemas.microsoft.com/office/drawing/2014/main" id="{5EE37DC8-D2E3-465F-BA75-5658A3DB89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70288" y="8023225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74" name="Rectangle 69">
                <a:extLst>
                  <a:ext uri="{FF2B5EF4-FFF2-40B4-BE49-F238E27FC236}">
                    <a16:creationId xmlns:a16="http://schemas.microsoft.com/office/drawing/2014/main" id="{FC6F80F8-08F4-4325-AEEA-ABC23D4A08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70288" y="7656513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0</a:t>
                </a:r>
                <a:endPara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085" name="Rectangle 79">
              <a:extLst>
                <a:ext uri="{FF2B5EF4-FFF2-40B4-BE49-F238E27FC236}">
                  <a16:creationId xmlns:a16="http://schemas.microsoft.com/office/drawing/2014/main" id="{8ABD3D5B-3B8B-4D5E-802B-238B2DCFC85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83017" y="7717262"/>
              <a:ext cx="63799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% of </a:t>
              </a:r>
              <a:r>
                <a:rPr lang="en-US" altLang="en-US" sz="1000" dirty="0">
                  <a:solidFill>
                    <a:srgbClr val="000000"/>
                  </a:solidFill>
                </a:rPr>
                <a:t>time 0</a:t>
              </a:r>
              <a:endPara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7" name="Rectangle 81">
              <a:extLst>
                <a:ext uri="{FF2B5EF4-FFF2-40B4-BE49-F238E27FC236}">
                  <a16:creationId xmlns:a16="http://schemas.microsoft.com/office/drawing/2014/main" id="{28AB5264-7391-4AC5-9D2F-BCFE8C1761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7998" y="6138127"/>
              <a:ext cx="170719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) Heart ROS production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197" name="Group 196">
              <a:extLst>
                <a:ext uri="{FF2B5EF4-FFF2-40B4-BE49-F238E27FC236}">
                  <a16:creationId xmlns:a16="http://schemas.microsoft.com/office/drawing/2014/main" id="{DCEF53AC-EF79-4050-9098-C6B45E1866C7}"/>
                </a:ext>
              </a:extLst>
            </p:cNvPr>
            <p:cNvGrpSpPr/>
            <p:nvPr/>
          </p:nvGrpSpPr>
          <p:grpSpPr>
            <a:xfrm>
              <a:off x="4078852" y="9147600"/>
              <a:ext cx="4332746" cy="153888"/>
              <a:chOff x="4086225" y="5953125"/>
              <a:chExt cx="4332746" cy="153888"/>
            </a:xfrm>
          </p:grpSpPr>
          <p:sp>
            <p:nvSpPr>
              <p:cNvPr id="198" name="Rectangle 29">
                <a:extLst>
                  <a:ext uri="{FF2B5EF4-FFF2-40B4-BE49-F238E27FC236}">
                    <a16:creationId xmlns:a16="http://schemas.microsoft.com/office/drawing/2014/main" id="{7143DEBD-E1D8-452B-A11F-9C98151323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86225" y="595312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9" name="Rectangle 30">
                <a:extLst>
                  <a:ext uri="{FF2B5EF4-FFF2-40B4-BE49-F238E27FC236}">
                    <a16:creationId xmlns:a16="http://schemas.microsoft.com/office/drawing/2014/main" id="{CFB12009-7E8A-44DB-8FFA-9CAC087419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10100" y="595312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0" name="Rectangle 31">
                <a:extLst>
                  <a:ext uri="{FF2B5EF4-FFF2-40B4-BE49-F238E27FC236}">
                    <a16:creationId xmlns:a16="http://schemas.microsoft.com/office/drawing/2014/main" id="{CC43D0BE-C3FE-4454-9497-B21D62B763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81588" y="5953125"/>
                <a:ext cx="176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.5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1" name="Rectangle 32">
                <a:extLst>
                  <a:ext uri="{FF2B5EF4-FFF2-40B4-BE49-F238E27FC236}">
                    <a16:creationId xmlns:a16="http://schemas.microsoft.com/office/drawing/2014/main" id="{E02A9506-FB22-489C-8AE2-AB768531F2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57850" y="595312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2" name="Rectangle 33">
                <a:extLst>
                  <a:ext uri="{FF2B5EF4-FFF2-40B4-BE49-F238E27FC236}">
                    <a16:creationId xmlns:a16="http://schemas.microsoft.com/office/drawing/2014/main" id="{539BBF0C-791A-4CF3-AAEE-A2ED169D10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46800" y="5953125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5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3" name="Rectangle 34">
                <a:extLst>
                  <a:ext uri="{FF2B5EF4-FFF2-40B4-BE49-F238E27FC236}">
                    <a16:creationId xmlns:a16="http://schemas.microsoft.com/office/drawing/2014/main" id="{F68275F1-6E93-4EEC-86C1-9C102C8A02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70675" y="5953125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4" name="Rectangle 35">
                <a:extLst>
                  <a:ext uri="{FF2B5EF4-FFF2-40B4-BE49-F238E27FC236}">
                    <a16:creationId xmlns:a16="http://schemas.microsoft.com/office/drawing/2014/main" id="{67937153-A28F-48C9-BFA1-ADE39F4480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94550" y="5953125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5" name="Rectangle 36">
                <a:extLst>
                  <a:ext uri="{FF2B5EF4-FFF2-40B4-BE49-F238E27FC236}">
                    <a16:creationId xmlns:a16="http://schemas.microsoft.com/office/drawing/2014/main" id="{EDB12734-45A9-4F14-9952-1A4A9E64AE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83500" y="5953125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8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7" name="Rectangle 37">
                <a:extLst>
                  <a:ext uri="{FF2B5EF4-FFF2-40B4-BE49-F238E27FC236}">
                    <a16:creationId xmlns:a16="http://schemas.microsoft.com/office/drawing/2014/main" id="{A51FEE87-F422-4AF9-85A2-D6EE27EDCE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07375" y="5953125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6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5" name="Group 214">
              <a:extLst>
                <a:ext uri="{FF2B5EF4-FFF2-40B4-BE49-F238E27FC236}">
                  <a16:creationId xmlns:a16="http://schemas.microsoft.com/office/drawing/2014/main" id="{A6DB3737-B9C0-41A9-8DD7-91DAE24D6F43}"/>
                </a:ext>
              </a:extLst>
            </p:cNvPr>
            <p:cNvGrpSpPr/>
            <p:nvPr/>
          </p:nvGrpSpPr>
          <p:grpSpPr>
            <a:xfrm>
              <a:off x="3789363" y="10104654"/>
              <a:ext cx="4749800" cy="2619376"/>
              <a:chOff x="3789363" y="11591925"/>
              <a:chExt cx="4746625" cy="2479675"/>
            </a:xfrm>
          </p:grpSpPr>
          <p:sp>
            <p:nvSpPr>
              <p:cNvPr id="167" name="Freeform 87">
                <a:extLst>
                  <a:ext uri="{FF2B5EF4-FFF2-40B4-BE49-F238E27FC236}">
                    <a16:creationId xmlns:a16="http://schemas.microsoft.com/office/drawing/2014/main" id="{CC3063E7-9D17-4D44-B5CE-2B04BAB09FE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003675" y="12287250"/>
                <a:ext cx="4352925" cy="1749425"/>
              </a:xfrm>
              <a:custGeom>
                <a:avLst/>
                <a:gdLst>
                  <a:gd name="T0" fmla="*/ 0 w 2742"/>
                  <a:gd name="T1" fmla="*/ 0 h 1102"/>
                  <a:gd name="T2" fmla="*/ 103 w 2742"/>
                  <a:gd name="T3" fmla="*/ 0 h 1102"/>
                  <a:gd name="T4" fmla="*/ 103 w 2742"/>
                  <a:gd name="T5" fmla="*/ 1102 h 1102"/>
                  <a:gd name="T6" fmla="*/ 0 w 2742"/>
                  <a:gd name="T7" fmla="*/ 1102 h 1102"/>
                  <a:gd name="T8" fmla="*/ 0 w 2742"/>
                  <a:gd name="T9" fmla="*/ 0 h 1102"/>
                  <a:gd name="T10" fmla="*/ 330 w 2742"/>
                  <a:gd name="T11" fmla="*/ 36 h 1102"/>
                  <a:gd name="T12" fmla="*/ 434 w 2742"/>
                  <a:gd name="T13" fmla="*/ 36 h 1102"/>
                  <a:gd name="T14" fmla="*/ 434 w 2742"/>
                  <a:gd name="T15" fmla="*/ 1102 h 1102"/>
                  <a:gd name="T16" fmla="*/ 330 w 2742"/>
                  <a:gd name="T17" fmla="*/ 1102 h 1102"/>
                  <a:gd name="T18" fmla="*/ 330 w 2742"/>
                  <a:gd name="T19" fmla="*/ 36 h 1102"/>
                  <a:gd name="T20" fmla="*/ 660 w 2742"/>
                  <a:gd name="T21" fmla="*/ 74 h 1102"/>
                  <a:gd name="T22" fmla="*/ 763 w 2742"/>
                  <a:gd name="T23" fmla="*/ 74 h 1102"/>
                  <a:gd name="T24" fmla="*/ 763 w 2742"/>
                  <a:gd name="T25" fmla="*/ 1102 h 1102"/>
                  <a:gd name="T26" fmla="*/ 660 w 2742"/>
                  <a:gd name="T27" fmla="*/ 1102 h 1102"/>
                  <a:gd name="T28" fmla="*/ 660 w 2742"/>
                  <a:gd name="T29" fmla="*/ 74 h 1102"/>
                  <a:gd name="T30" fmla="*/ 990 w 2742"/>
                  <a:gd name="T31" fmla="*/ 12 h 1102"/>
                  <a:gd name="T32" fmla="*/ 1093 w 2742"/>
                  <a:gd name="T33" fmla="*/ 12 h 1102"/>
                  <a:gd name="T34" fmla="*/ 1093 w 2742"/>
                  <a:gd name="T35" fmla="*/ 1102 h 1102"/>
                  <a:gd name="T36" fmla="*/ 990 w 2742"/>
                  <a:gd name="T37" fmla="*/ 1102 h 1102"/>
                  <a:gd name="T38" fmla="*/ 990 w 2742"/>
                  <a:gd name="T39" fmla="*/ 12 h 1102"/>
                  <a:gd name="T40" fmla="*/ 1320 w 2742"/>
                  <a:gd name="T41" fmla="*/ 13 h 1102"/>
                  <a:gd name="T42" fmla="*/ 1423 w 2742"/>
                  <a:gd name="T43" fmla="*/ 13 h 1102"/>
                  <a:gd name="T44" fmla="*/ 1423 w 2742"/>
                  <a:gd name="T45" fmla="*/ 1102 h 1102"/>
                  <a:gd name="T46" fmla="*/ 1320 w 2742"/>
                  <a:gd name="T47" fmla="*/ 1102 h 1102"/>
                  <a:gd name="T48" fmla="*/ 1320 w 2742"/>
                  <a:gd name="T49" fmla="*/ 13 h 1102"/>
                  <a:gd name="T50" fmla="*/ 1649 w 2742"/>
                  <a:gd name="T51" fmla="*/ 75 h 1102"/>
                  <a:gd name="T52" fmla="*/ 1753 w 2742"/>
                  <a:gd name="T53" fmla="*/ 75 h 1102"/>
                  <a:gd name="T54" fmla="*/ 1753 w 2742"/>
                  <a:gd name="T55" fmla="*/ 1102 h 1102"/>
                  <a:gd name="T56" fmla="*/ 1649 w 2742"/>
                  <a:gd name="T57" fmla="*/ 1102 h 1102"/>
                  <a:gd name="T58" fmla="*/ 1649 w 2742"/>
                  <a:gd name="T59" fmla="*/ 75 h 1102"/>
                  <a:gd name="T60" fmla="*/ 1979 w 2742"/>
                  <a:gd name="T61" fmla="*/ 34 h 1102"/>
                  <a:gd name="T62" fmla="*/ 2082 w 2742"/>
                  <a:gd name="T63" fmla="*/ 34 h 1102"/>
                  <a:gd name="T64" fmla="*/ 2082 w 2742"/>
                  <a:gd name="T65" fmla="*/ 1102 h 1102"/>
                  <a:gd name="T66" fmla="*/ 1979 w 2742"/>
                  <a:gd name="T67" fmla="*/ 1102 h 1102"/>
                  <a:gd name="T68" fmla="*/ 1979 w 2742"/>
                  <a:gd name="T69" fmla="*/ 34 h 1102"/>
                  <a:gd name="T70" fmla="*/ 2309 w 2742"/>
                  <a:gd name="T71" fmla="*/ 42 h 1102"/>
                  <a:gd name="T72" fmla="*/ 2413 w 2742"/>
                  <a:gd name="T73" fmla="*/ 42 h 1102"/>
                  <a:gd name="T74" fmla="*/ 2413 w 2742"/>
                  <a:gd name="T75" fmla="*/ 1102 h 1102"/>
                  <a:gd name="T76" fmla="*/ 2309 w 2742"/>
                  <a:gd name="T77" fmla="*/ 1102 h 1102"/>
                  <a:gd name="T78" fmla="*/ 2309 w 2742"/>
                  <a:gd name="T79" fmla="*/ 42 h 1102"/>
                  <a:gd name="T80" fmla="*/ 2638 w 2742"/>
                  <a:gd name="T81" fmla="*/ 43 h 1102"/>
                  <a:gd name="T82" fmla="*/ 2742 w 2742"/>
                  <a:gd name="T83" fmla="*/ 43 h 1102"/>
                  <a:gd name="T84" fmla="*/ 2742 w 2742"/>
                  <a:gd name="T85" fmla="*/ 1102 h 1102"/>
                  <a:gd name="T86" fmla="*/ 2638 w 2742"/>
                  <a:gd name="T87" fmla="*/ 1102 h 1102"/>
                  <a:gd name="T88" fmla="*/ 2638 w 2742"/>
                  <a:gd name="T89" fmla="*/ 43 h 11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2742" h="1102">
                    <a:moveTo>
                      <a:pt x="0" y="0"/>
                    </a:moveTo>
                    <a:lnTo>
                      <a:pt x="103" y="0"/>
                    </a:lnTo>
                    <a:lnTo>
                      <a:pt x="103" y="1102"/>
                    </a:lnTo>
                    <a:lnTo>
                      <a:pt x="0" y="1102"/>
                    </a:lnTo>
                    <a:lnTo>
                      <a:pt x="0" y="0"/>
                    </a:lnTo>
                    <a:close/>
                    <a:moveTo>
                      <a:pt x="330" y="36"/>
                    </a:moveTo>
                    <a:lnTo>
                      <a:pt x="434" y="36"/>
                    </a:lnTo>
                    <a:lnTo>
                      <a:pt x="434" y="1102"/>
                    </a:lnTo>
                    <a:lnTo>
                      <a:pt x="330" y="1102"/>
                    </a:lnTo>
                    <a:lnTo>
                      <a:pt x="330" y="36"/>
                    </a:lnTo>
                    <a:close/>
                    <a:moveTo>
                      <a:pt x="660" y="74"/>
                    </a:moveTo>
                    <a:lnTo>
                      <a:pt x="763" y="74"/>
                    </a:lnTo>
                    <a:lnTo>
                      <a:pt x="763" y="1102"/>
                    </a:lnTo>
                    <a:lnTo>
                      <a:pt x="660" y="1102"/>
                    </a:lnTo>
                    <a:lnTo>
                      <a:pt x="660" y="74"/>
                    </a:lnTo>
                    <a:close/>
                    <a:moveTo>
                      <a:pt x="990" y="12"/>
                    </a:moveTo>
                    <a:lnTo>
                      <a:pt x="1093" y="12"/>
                    </a:lnTo>
                    <a:lnTo>
                      <a:pt x="1093" y="1102"/>
                    </a:lnTo>
                    <a:lnTo>
                      <a:pt x="990" y="1102"/>
                    </a:lnTo>
                    <a:lnTo>
                      <a:pt x="990" y="12"/>
                    </a:lnTo>
                    <a:close/>
                    <a:moveTo>
                      <a:pt x="1320" y="13"/>
                    </a:moveTo>
                    <a:lnTo>
                      <a:pt x="1423" y="13"/>
                    </a:lnTo>
                    <a:lnTo>
                      <a:pt x="1423" y="1102"/>
                    </a:lnTo>
                    <a:lnTo>
                      <a:pt x="1320" y="1102"/>
                    </a:lnTo>
                    <a:lnTo>
                      <a:pt x="1320" y="13"/>
                    </a:lnTo>
                    <a:close/>
                    <a:moveTo>
                      <a:pt x="1649" y="75"/>
                    </a:moveTo>
                    <a:lnTo>
                      <a:pt x="1753" y="75"/>
                    </a:lnTo>
                    <a:lnTo>
                      <a:pt x="1753" y="1102"/>
                    </a:lnTo>
                    <a:lnTo>
                      <a:pt x="1649" y="1102"/>
                    </a:lnTo>
                    <a:lnTo>
                      <a:pt x="1649" y="75"/>
                    </a:lnTo>
                    <a:close/>
                    <a:moveTo>
                      <a:pt x="1979" y="34"/>
                    </a:moveTo>
                    <a:lnTo>
                      <a:pt x="2082" y="34"/>
                    </a:lnTo>
                    <a:lnTo>
                      <a:pt x="2082" y="1102"/>
                    </a:lnTo>
                    <a:lnTo>
                      <a:pt x="1979" y="1102"/>
                    </a:lnTo>
                    <a:lnTo>
                      <a:pt x="1979" y="34"/>
                    </a:lnTo>
                    <a:close/>
                    <a:moveTo>
                      <a:pt x="2309" y="42"/>
                    </a:moveTo>
                    <a:lnTo>
                      <a:pt x="2413" y="42"/>
                    </a:lnTo>
                    <a:lnTo>
                      <a:pt x="2413" y="1102"/>
                    </a:lnTo>
                    <a:lnTo>
                      <a:pt x="2309" y="1102"/>
                    </a:lnTo>
                    <a:lnTo>
                      <a:pt x="2309" y="42"/>
                    </a:lnTo>
                    <a:close/>
                    <a:moveTo>
                      <a:pt x="2638" y="43"/>
                    </a:moveTo>
                    <a:lnTo>
                      <a:pt x="2742" y="43"/>
                    </a:lnTo>
                    <a:lnTo>
                      <a:pt x="2742" y="1102"/>
                    </a:lnTo>
                    <a:lnTo>
                      <a:pt x="2638" y="1102"/>
                    </a:lnTo>
                    <a:lnTo>
                      <a:pt x="2638" y="43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" name="Freeform 88">
                <a:extLst>
                  <a:ext uri="{FF2B5EF4-FFF2-40B4-BE49-F238E27FC236}">
                    <a16:creationId xmlns:a16="http://schemas.microsoft.com/office/drawing/2014/main" id="{22E3182D-F6DE-497A-B706-CF173EDD911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003675" y="12287250"/>
                <a:ext cx="4352925" cy="1749425"/>
              </a:xfrm>
              <a:custGeom>
                <a:avLst/>
                <a:gdLst>
                  <a:gd name="T0" fmla="*/ 0 w 2742"/>
                  <a:gd name="T1" fmla="*/ 0 h 1102"/>
                  <a:gd name="T2" fmla="*/ 103 w 2742"/>
                  <a:gd name="T3" fmla="*/ 0 h 1102"/>
                  <a:gd name="T4" fmla="*/ 103 w 2742"/>
                  <a:gd name="T5" fmla="*/ 1102 h 1102"/>
                  <a:gd name="T6" fmla="*/ 0 w 2742"/>
                  <a:gd name="T7" fmla="*/ 1102 h 1102"/>
                  <a:gd name="T8" fmla="*/ 0 w 2742"/>
                  <a:gd name="T9" fmla="*/ 0 h 1102"/>
                  <a:gd name="T10" fmla="*/ 330 w 2742"/>
                  <a:gd name="T11" fmla="*/ 36 h 1102"/>
                  <a:gd name="T12" fmla="*/ 434 w 2742"/>
                  <a:gd name="T13" fmla="*/ 36 h 1102"/>
                  <a:gd name="T14" fmla="*/ 434 w 2742"/>
                  <a:gd name="T15" fmla="*/ 1102 h 1102"/>
                  <a:gd name="T16" fmla="*/ 330 w 2742"/>
                  <a:gd name="T17" fmla="*/ 1102 h 1102"/>
                  <a:gd name="T18" fmla="*/ 330 w 2742"/>
                  <a:gd name="T19" fmla="*/ 36 h 1102"/>
                  <a:gd name="T20" fmla="*/ 660 w 2742"/>
                  <a:gd name="T21" fmla="*/ 74 h 1102"/>
                  <a:gd name="T22" fmla="*/ 763 w 2742"/>
                  <a:gd name="T23" fmla="*/ 74 h 1102"/>
                  <a:gd name="T24" fmla="*/ 763 w 2742"/>
                  <a:gd name="T25" fmla="*/ 1102 h 1102"/>
                  <a:gd name="T26" fmla="*/ 660 w 2742"/>
                  <a:gd name="T27" fmla="*/ 1102 h 1102"/>
                  <a:gd name="T28" fmla="*/ 660 w 2742"/>
                  <a:gd name="T29" fmla="*/ 74 h 1102"/>
                  <a:gd name="T30" fmla="*/ 990 w 2742"/>
                  <a:gd name="T31" fmla="*/ 12 h 1102"/>
                  <a:gd name="T32" fmla="*/ 1093 w 2742"/>
                  <a:gd name="T33" fmla="*/ 12 h 1102"/>
                  <a:gd name="T34" fmla="*/ 1093 w 2742"/>
                  <a:gd name="T35" fmla="*/ 1102 h 1102"/>
                  <a:gd name="T36" fmla="*/ 990 w 2742"/>
                  <a:gd name="T37" fmla="*/ 1102 h 1102"/>
                  <a:gd name="T38" fmla="*/ 990 w 2742"/>
                  <a:gd name="T39" fmla="*/ 12 h 1102"/>
                  <a:gd name="T40" fmla="*/ 1320 w 2742"/>
                  <a:gd name="T41" fmla="*/ 13 h 1102"/>
                  <a:gd name="T42" fmla="*/ 1423 w 2742"/>
                  <a:gd name="T43" fmla="*/ 13 h 1102"/>
                  <a:gd name="T44" fmla="*/ 1423 w 2742"/>
                  <a:gd name="T45" fmla="*/ 1102 h 1102"/>
                  <a:gd name="T46" fmla="*/ 1320 w 2742"/>
                  <a:gd name="T47" fmla="*/ 1102 h 1102"/>
                  <a:gd name="T48" fmla="*/ 1320 w 2742"/>
                  <a:gd name="T49" fmla="*/ 13 h 1102"/>
                  <a:gd name="T50" fmla="*/ 1649 w 2742"/>
                  <a:gd name="T51" fmla="*/ 75 h 1102"/>
                  <a:gd name="T52" fmla="*/ 1753 w 2742"/>
                  <a:gd name="T53" fmla="*/ 75 h 1102"/>
                  <a:gd name="T54" fmla="*/ 1753 w 2742"/>
                  <a:gd name="T55" fmla="*/ 1102 h 1102"/>
                  <a:gd name="T56" fmla="*/ 1649 w 2742"/>
                  <a:gd name="T57" fmla="*/ 1102 h 1102"/>
                  <a:gd name="T58" fmla="*/ 1649 w 2742"/>
                  <a:gd name="T59" fmla="*/ 75 h 1102"/>
                  <a:gd name="T60" fmla="*/ 1979 w 2742"/>
                  <a:gd name="T61" fmla="*/ 34 h 1102"/>
                  <a:gd name="T62" fmla="*/ 2082 w 2742"/>
                  <a:gd name="T63" fmla="*/ 34 h 1102"/>
                  <a:gd name="T64" fmla="*/ 2082 w 2742"/>
                  <a:gd name="T65" fmla="*/ 1102 h 1102"/>
                  <a:gd name="T66" fmla="*/ 1979 w 2742"/>
                  <a:gd name="T67" fmla="*/ 1102 h 1102"/>
                  <a:gd name="T68" fmla="*/ 1979 w 2742"/>
                  <a:gd name="T69" fmla="*/ 34 h 1102"/>
                  <a:gd name="T70" fmla="*/ 2309 w 2742"/>
                  <a:gd name="T71" fmla="*/ 42 h 1102"/>
                  <a:gd name="T72" fmla="*/ 2413 w 2742"/>
                  <a:gd name="T73" fmla="*/ 42 h 1102"/>
                  <a:gd name="T74" fmla="*/ 2413 w 2742"/>
                  <a:gd name="T75" fmla="*/ 1102 h 1102"/>
                  <a:gd name="T76" fmla="*/ 2309 w 2742"/>
                  <a:gd name="T77" fmla="*/ 1102 h 1102"/>
                  <a:gd name="T78" fmla="*/ 2309 w 2742"/>
                  <a:gd name="T79" fmla="*/ 42 h 1102"/>
                  <a:gd name="T80" fmla="*/ 2638 w 2742"/>
                  <a:gd name="T81" fmla="*/ 43 h 1102"/>
                  <a:gd name="T82" fmla="*/ 2742 w 2742"/>
                  <a:gd name="T83" fmla="*/ 43 h 1102"/>
                  <a:gd name="T84" fmla="*/ 2742 w 2742"/>
                  <a:gd name="T85" fmla="*/ 1102 h 1102"/>
                  <a:gd name="T86" fmla="*/ 2638 w 2742"/>
                  <a:gd name="T87" fmla="*/ 1102 h 1102"/>
                  <a:gd name="T88" fmla="*/ 2638 w 2742"/>
                  <a:gd name="T89" fmla="*/ 43 h 11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2742" h="1102">
                    <a:moveTo>
                      <a:pt x="0" y="0"/>
                    </a:moveTo>
                    <a:lnTo>
                      <a:pt x="103" y="0"/>
                    </a:lnTo>
                    <a:lnTo>
                      <a:pt x="103" y="1102"/>
                    </a:lnTo>
                    <a:lnTo>
                      <a:pt x="0" y="1102"/>
                    </a:lnTo>
                    <a:lnTo>
                      <a:pt x="0" y="0"/>
                    </a:lnTo>
                    <a:close/>
                    <a:moveTo>
                      <a:pt x="330" y="36"/>
                    </a:moveTo>
                    <a:lnTo>
                      <a:pt x="434" y="36"/>
                    </a:lnTo>
                    <a:lnTo>
                      <a:pt x="434" y="1102"/>
                    </a:lnTo>
                    <a:lnTo>
                      <a:pt x="330" y="1102"/>
                    </a:lnTo>
                    <a:lnTo>
                      <a:pt x="330" y="36"/>
                    </a:lnTo>
                    <a:close/>
                    <a:moveTo>
                      <a:pt x="660" y="74"/>
                    </a:moveTo>
                    <a:lnTo>
                      <a:pt x="763" y="74"/>
                    </a:lnTo>
                    <a:lnTo>
                      <a:pt x="763" y="1102"/>
                    </a:lnTo>
                    <a:lnTo>
                      <a:pt x="660" y="1102"/>
                    </a:lnTo>
                    <a:lnTo>
                      <a:pt x="660" y="74"/>
                    </a:lnTo>
                    <a:close/>
                    <a:moveTo>
                      <a:pt x="990" y="12"/>
                    </a:moveTo>
                    <a:lnTo>
                      <a:pt x="1093" y="12"/>
                    </a:lnTo>
                    <a:lnTo>
                      <a:pt x="1093" y="1102"/>
                    </a:lnTo>
                    <a:lnTo>
                      <a:pt x="990" y="1102"/>
                    </a:lnTo>
                    <a:lnTo>
                      <a:pt x="990" y="12"/>
                    </a:lnTo>
                    <a:close/>
                    <a:moveTo>
                      <a:pt x="1320" y="13"/>
                    </a:moveTo>
                    <a:lnTo>
                      <a:pt x="1423" y="13"/>
                    </a:lnTo>
                    <a:lnTo>
                      <a:pt x="1423" y="1102"/>
                    </a:lnTo>
                    <a:lnTo>
                      <a:pt x="1320" y="1102"/>
                    </a:lnTo>
                    <a:lnTo>
                      <a:pt x="1320" y="13"/>
                    </a:lnTo>
                    <a:close/>
                    <a:moveTo>
                      <a:pt x="1649" y="75"/>
                    </a:moveTo>
                    <a:lnTo>
                      <a:pt x="1753" y="75"/>
                    </a:lnTo>
                    <a:lnTo>
                      <a:pt x="1753" y="1102"/>
                    </a:lnTo>
                    <a:lnTo>
                      <a:pt x="1649" y="1102"/>
                    </a:lnTo>
                    <a:lnTo>
                      <a:pt x="1649" y="75"/>
                    </a:lnTo>
                    <a:close/>
                    <a:moveTo>
                      <a:pt x="1979" y="34"/>
                    </a:moveTo>
                    <a:lnTo>
                      <a:pt x="2082" y="34"/>
                    </a:lnTo>
                    <a:lnTo>
                      <a:pt x="2082" y="1102"/>
                    </a:lnTo>
                    <a:lnTo>
                      <a:pt x="1979" y="1102"/>
                    </a:lnTo>
                    <a:lnTo>
                      <a:pt x="1979" y="34"/>
                    </a:lnTo>
                    <a:close/>
                    <a:moveTo>
                      <a:pt x="2309" y="42"/>
                    </a:moveTo>
                    <a:lnTo>
                      <a:pt x="2413" y="42"/>
                    </a:lnTo>
                    <a:lnTo>
                      <a:pt x="2413" y="1102"/>
                    </a:lnTo>
                    <a:lnTo>
                      <a:pt x="2309" y="1102"/>
                    </a:lnTo>
                    <a:lnTo>
                      <a:pt x="2309" y="42"/>
                    </a:lnTo>
                    <a:close/>
                    <a:moveTo>
                      <a:pt x="2638" y="43"/>
                    </a:moveTo>
                    <a:lnTo>
                      <a:pt x="2742" y="43"/>
                    </a:lnTo>
                    <a:lnTo>
                      <a:pt x="2742" y="1102"/>
                    </a:lnTo>
                    <a:lnTo>
                      <a:pt x="2638" y="1102"/>
                    </a:lnTo>
                    <a:lnTo>
                      <a:pt x="2638" y="43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" name="Freeform 89">
                <a:extLst>
                  <a:ext uri="{FF2B5EF4-FFF2-40B4-BE49-F238E27FC236}">
                    <a16:creationId xmlns:a16="http://schemas.microsoft.com/office/drawing/2014/main" id="{4A234413-C4D0-46B7-ACDD-82C6A47D00C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057650" y="11893550"/>
                <a:ext cx="57150" cy="393700"/>
              </a:xfrm>
              <a:custGeom>
                <a:avLst/>
                <a:gdLst>
                  <a:gd name="T0" fmla="*/ 18 w 36"/>
                  <a:gd name="T1" fmla="*/ 248 h 248"/>
                  <a:gd name="T2" fmla="*/ 18 w 36"/>
                  <a:gd name="T3" fmla="*/ 0 h 248"/>
                  <a:gd name="T4" fmla="*/ 0 w 36"/>
                  <a:gd name="T5" fmla="*/ 0 h 248"/>
                  <a:gd name="T6" fmla="*/ 36 w 36"/>
                  <a:gd name="T7" fmla="*/ 0 h 2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248">
                    <a:moveTo>
                      <a:pt x="18" y="248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" name="Freeform 90">
                <a:extLst>
                  <a:ext uri="{FF2B5EF4-FFF2-40B4-BE49-F238E27FC236}">
                    <a16:creationId xmlns:a16="http://schemas.microsoft.com/office/drawing/2014/main" id="{55541DB6-D220-4027-AE83-6C95C89C6EC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579938" y="11872913"/>
                <a:ext cx="58738" cy="471488"/>
              </a:xfrm>
              <a:custGeom>
                <a:avLst/>
                <a:gdLst>
                  <a:gd name="T0" fmla="*/ 19 w 37"/>
                  <a:gd name="T1" fmla="*/ 297 h 297"/>
                  <a:gd name="T2" fmla="*/ 19 w 37"/>
                  <a:gd name="T3" fmla="*/ 0 h 297"/>
                  <a:gd name="T4" fmla="*/ 0 w 37"/>
                  <a:gd name="T5" fmla="*/ 0 h 297"/>
                  <a:gd name="T6" fmla="*/ 37 w 37"/>
                  <a:gd name="T7" fmla="*/ 0 h 2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297">
                    <a:moveTo>
                      <a:pt x="19" y="297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" name="Freeform 91">
                <a:extLst>
                  <a:ext uri="{FF2B5EF4-FFF2-40B4-BE49-F238E27FC236}">
                    <a16:creationId xmlns:a16="http://schemas.microsoft.com/office/drawing/2014/main" id="{555A4A48-83B6-431B-A6EB-AAA0BD24B6C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105400" y="11874500"/>
                <a:ext cx="55563" cy="530225"/>
              </a:xfrm>
              <a:custGeom>
                <a:avLst/>
                <a:gdLst>
                  <a:gd name="T0" fmla="*/ 17 w 35"/>
                  <a:gd name="T1" fmla="*/ 334 h 334"/>
                  <a:gd name="T2" fmla="*/ 17 w 35"/>
                  <a:gd name="T3" fmla="*/ 0 h 334"/>
                  <a:gd name="T4" fmla="*/ 0 w 35"/>
                  <a:gd name="T5" fmla="*/ 0 h 334"/>
                  <a:gd name="T6" fmla="*/ 35 w 35"/>
                  <a:gd name="T7" fmla="*/ 0 h 3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" h="334">
                    <a:moveTo>
                      <a:pt x="17" y="334"/>
                    </a:moveTo>
                    <a:lnTo>
                      <a:pt x="17" y="0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" name="Freeform 92">
                <a:extLst>
                  <a:ext uri="{FF2B5EF4-FFF2-40B4-BE49-F238E27FC236}">
                    <a16:creationId xmlns:a16="http://schemas.microsoft.com/office/drawing/2014/main" id="{32718D97-4416-4EAA-8925-0D619A4DC9D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627688" y="12031663"/>
                <a:ext cx="58738" cy="274638"/>
              </a:xfrm>
              <a:custGeom>
                <a:avLst/>
                <a:gdLst>
                  <a:gd name="T0" fmla="*/ 18 w 37"/>
                  <a:gd name="T1" fmla="*/ 173 h 173"/>
                  <a:gd name="T2" fmla="*/ 18 w 37"/>
                  <a:gd name="T3" fmla="*/ 0 h 173"/>
                  <a:gd name="T4" fmla="*/ 0 w 37"/>
                  <a:gd name="T5" fmla="*/ 0 h 173"/>
                  <a:gd name="T6" fmla="*/ 37 w 37"/>
                  <a:gd name="T7" fmla="*/ 0 h 1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173">
                    <a:moveTo>
                      <a:pt x="18" y="173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" name="Freeform 93">
                <a:extLst>
                  <a:ext uri="{FF2B5EF4-FFF2-40B4-BE49-F238E27FC236}">
                    <a16:creationId xmlns:a16="http://schemas.microsoft.com/office/drawing/2014/main" id="{20515C92-76C6-4556-93E9-BC720B57440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151563" y="11857038"/>
                <a:ext cx="57150" cy="450850"/>
              </a:xfrm>
              <a:custGeom>
                <a:avLst/>
                <a:gdLst>
                  <a:gd name="T0" fmla="*/ 18 w 36"/>
                  <a:gd name="T1" fmla="*/ 284 h 284"/>
                  <a:gd name="T2" fmla="*/ 18 w 36"/>
                  <a:gd name="T3" fmla="*/ 0 h 284"/>
                  <a:gd name="T4" fmla="*/ 0 w 36"/>
                  <a:gd name="T5" fmla="*/ 0 h 284"/>
                  <a:gd name="T6" fmla="*/ 36 w 36"/>
                  <a:gd name="T7" fmla="*/ 0 h 2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284">
                    <a:moveTo>
                      <a:pt x="18" y="284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" name="Freeform 94">
                <a:extLst>
                  <a:ext uri="{FF2B5EF4-FFF2-40B4-BE49-F238E27FC236}">
                    <a16:creationId xmlns:a16="http://schemas.microsoft.com/office/drawing/2014/main" id="{66EFA370-D7CB-46C5-BB10-D4C4DA73506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675438" y="11907838"/>
                <a:ext cx="57150" cy="498475"/>
              </a:xfrm>
              <a:custGeom>
                <a:avLst/>
                <a:gdLst>
                  <a:gd name="T0" fmla="*/ 18 w 36"/>
                  <a:gd name="T1" fmla="*/ 314 h 314"/>
                  <a:gd name="T2" fmla="*/ 18 w 36"/>
                  <a:gd name="T3" fmla="*/ 0 h 314"/>
                  <a:gd name="T4" fmla="*/ 0 w 36"/>
                  <a:gd name="T5" fmla="*/ 0 h 314"/>
                  <a:gd name="T6" fmla="*/ 36 w 36"/>
                  <a:gd name="T7" fmla="*/ 0 h 3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4">
                    <a:moveTo>
                      <a:pt x="18" y="314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" name="Freeform 95">
                <a:extLst>
                  <a:ext uri="{FF2B5EF4-FFF2-40B4-BE49-F238E27FC236}">
                    <a16:creationId xmlns:a16="http://schemas.microsoft.com/office/drawing/2014/main" id="{8FE69E60-A2F0-469A-A848-A9E1F06C3FD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197725" y="11993563"/>
                <a:ext cx="58738" cy="347663"/>
              </a:xfrm>
              <a:custGeom>
                <a:avLst/>
                <a:gdLst>
                  <a:gd name="T0" fmla="*/ 18 w 37"/>
                  <a:gd name="T1" fmla="*/ 219 h 219"/>
                  <a:gd name="T2" fmla="*/ 18 w 37"/>
                  <a:gd name="T3" fmla="*/ 0 h 219"/>
                  <a:gd name="T4" fmla="*/ 0 w 37"/>
                  <a:gd name="T5" fmla="*/ 0 h 219"/>
                  <a:gd name="T6" fmla="*/ 37 w 37"/>
                  <a:gd name="T7" fmla="*/ 0 h 2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219">
                    <a:moveTo>
                      <a:pt x="18" y="219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" name="Freeform 96">
                <a:extLst>
                  <a:ext uri="{FF2B5EF4-FFF2-40B4-BE49-F238E27FC236}">
                    <a16:creationId xmlns:a16="http://schemas.microsoft.com/office/drawing/2014/main" id="{96F0B837-8DF7-4F50-9BEE-C70166469F2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723188" y="11826875"/>
                <a:ext cx="55563" cy="527050"/>
              </a:xfrm>
              <a:custGeom>
                <a:avLst/>
                <a:gdLst>
                  <a:gd name="T0" fmla="*/ 18 w 35"/>
                  <a:gd name="T1" fmla="*/ 332 h 332"/>
                  <a:gd name="T2" fmla="*/ 18 w 35"/>
                  <a:gd name="T3" fmla="*/ 0 h 332"/>
                  <a:gd name="T4" fmla="*/ 0 w 35"/>
                  <a:gd name="T5" fmla="*/ 0 h 332"/>
                  <a:gd name="T6" fmla="*/ 35 w 35"/>
                  <a:gd name="T7" fmla="*/ 0 h 3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" h="332">
                    <a:moveTo>
                      <a:pt x="18" y="332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" name="Freeform 97">
                <a:extLst>
                  <a:ext uri="{FF2B5EF4-FFF2-40B4-BE49-F238E27FC236}">
                    <a16:creationId xmlns:a16="http://schemas.microsoft.com/office/drawing/2014/main" id="{19B4665D-8770-4766-A8EB-A59B2E5F0DD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245475" y="11890375"/>
                <a:ext cx="57150" cy="465138"/>
              </a:xfrm>
              <a:custGeom>
                <a:avLst/>
                <a:gdLst>
                  <a:gd name="T0" fmla="*/ 18 w 36"/>
                  <a:gd name="T1" fmla="*/ 293 h 293"/>
                  <a:gd name="T2" fmla="*/ 18 w 36"/>
                  <a:gd name="T3" fmla="*/ 0 h 293"/>
                  <a:gd name="T4" fmla="*/ 0 w 36"/>
                  <a:gd name="T5" fmla="*/ 0 h 293"/>
                  <a:gd name="T6" fmla="*/ 36 w 36"/>
                  <a:gd name="T7" fmla="*/ 0 h 2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293">
                    <a:moveTo>
                      <a:pt x="18" y="293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" name="Line 98">
                <a:extLst>
                  <a:ext uri="{FF2B5EF4-FFF2-40B4-BE49-F238E27FC236}">
                    <a16:creationId xmlns:a16="http://schemas.microsoft.com/office/drawing/2014/main" id="{0D39E154-40DC-4027-999A-E064B3F07A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24288" y="11591925"/>
                <a:ext cx="0" cy="244475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9" name="Freeform 99">
                <a:extLst>
                  <a:ext uri="{FF2B5EF4-FFF2-40B4-BE49-F238E27FC236}">
                    <a16:creationId xmlns:a16="http://schemas.microsoft.com/office/drawing/2014/main" id="{717172CE-36F2-4A61-B651-D1D9B85B135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789363" y="11591925"/>
                <a:ext cx="34925" cy="2444750"/>
              </a:xfrm>
              <a:custGeom>
                <a:avLst/>
                <a:gdLst>
                  <a:gd name="T0" fmla="*/ 0 w 22"/>
                  <a:gd name="T1" fmla="*/ 1540 h 1540"/>
                  <a:gd name="T2" fmla="*/ 22 w 22"/>
                  <a:gd name="T3" fmla="*/ 1540 h 1540"/>
                  <a:gd name="T4" fmla="*/ 0 w 22"/>
                  <a:gd name="T5" fmla="*/ 1320 h 1540"/>
                  <a:gd name="T6" fmla="*/ 22 w 22"/>
                  <a:gd name="T7" fmla="*/ 1320 h 1540"/>
                  <a:gd name="T8" fmla="*/ 0 w 22"/>
                  <a:gd name="T9" fmla="*/ 1100 h 1540"/>
                  <a:gd name="T10" fmla="*/ 22 w 22"/>
                  <a:gd name="T11" fmla="*/ 1100 h 1540"/>
                  <a:gd name="T12" fmla="*/ 0 w 22"/>
                  <a:gd name="T13" fmla="*/ 879 h 1540"/>
                  <a:gd name="T14" fmla="*/ 22 w 22"/>
                  <a:gd name="T15" fmla="*/ 879 h 1540"/>
                  <a:gd name="T16" fmla="*/ 0 w 22"/>
                  <a:gd name="T17" fmla="*/ 659 h 1540"/>
                  <a:gd name="T18" fmla="*/ 22 w 22"/>
                  <a:gd name="T19" fmla="*/ 659 h 1540"/>
                  <a:gd name="T20" fmla="*/ 0 w 22"/>
                  <a:gd name="T21" fmla="*/ 439 h 1540"/>
                  <a:gd name="T22" fmla="*/ 22 w 22"/>
                  <a:gd name="T23" fmla="*/ 439 h 1540"/>
                  <a:gd name="T24" fmla="*/ 0 w 22"/>
                  <a:gd name="T25" fmla="*/ 219 h 1540"/>
                  <a:gd name="T26" fmla="*/ 22 w 22"/>
                  <a:gd name="T27" fmla="*/ 219 h 1540"/>
                  <a:gd name="T28" fmla="*/ 0 w 22"/>
                  <a:gd name="T29" fmla="*/ 0 h 1540"/>
                  <a:gd name="T30" fmla="*/ 22 w 22"/>
                  <a:gd name="T31" fmla="*/ 0 h 15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22" h="1540">
                    <a:moveTo>
                      <a:pt x="0" y="1540"/>
                    </a:moveTo>
                    <a:lnTo>
                      <a:pt x="22" y="1540"/>
                    </a:lnTo>
                    <a:moveTo>
                      <a:pt x="0" y="1320"/>
                    </a:moveTo>
                    <a:lnTo>
                      <a:pt x="22" y="1320"/>
                    </a:lnTo>
                    <a:moveTo>
                      <a:pt x="0" y="1100"/>
                    </a:moveTo>
                    <a:lnTo>
                      <a:pt x="22" y="1100"/>
                    </a:lnTo>
                    <a:moveTo>
                      <a:pt x="0" y="879"/>
                    </a:moveTo>
                    <a:lnTo>
                      <a:pt x="22" y="879"/>
                    </a:lnTo>
                    <a:moveTo>
                      <a:pt x="0" y="659"/>
                    </a:moveTo>
                    <a:lnTo>
                      <a:pt x="22" y="659"/>
                    </a:lnTo>
                    <a:moveTo>
                      <a:pt x="0" y="439"/>
                    </a:moveTo>
                    <a:lnTo>
                      <a:pt x="22" y="439"/>
                    </a:lnTo>
                    <a:moveTo>
                      <a:pt x="0" y="219"/>
                    </a:moveTo>
                    <a:lnTo>
                      <a:pt x="22" y="219"/>
                    </a:lnTo>
                    <a:moveTo>
                      <a:pt x="0" y="0"/>
                    </a:moveTo>
                    <a:lnTo>
                      <a:pt x="22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" name="Line 100">
                <a:extLst>
                  <a:ext uri="{FF2B5EF4-FFF2-40B4-BE49-F238E27FC236}">
                    <a16:creationId xmlns:a16="http://schemas.microsoft.com/office/drawing/2014/main" id="{409F4D75-8E7B-4688-AEE7-A4490A691C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24288" y="14036675"/>
                <a:ext cx="4711700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1" name="Freeform 101">
                <a:extLst>
                  <a:ext uri="{FF2B5EF4-FFF2-40B4-BE49-F238E27FC236}">
                    <a16:creationId xmlns:a16="http://schemas.microsoft.com/office/drawing/2014/main" id="{C6DD1C18-D3F5-4BFE-8DA7-6EBA65CA5EB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824288" y="14036675"/>
                <a:ext cx="4711700" cy="34925"/>
              </a:xfrm>
              <a:custGeom>
                <a:avLst/>
                <a:gdLst>
                  <a:gd name="T0" fmla="*/ 0 w 2968"/>
                  <a:gd name="T1" fmla="*/ 0 h 22"/>
                  <a:gd name="T2" fmla="*/ 0 w 2968"/>
                  <a:gd name="T3" fmla="*/ 22 h 22"/>
                  <a:gd name="T4" fmla="*/ 329 w 2968"/>
                  <a:gd name="T5" fmla="*/ 0 h 22"/>
                  <a:gd name="T6" fmla="*/ 329 w 2968"/>
                  <a:gd name="T7" fmla="*/ 22 h 22"/>
                  <a:gd name="T8" fmla="*/ 660 w 2968"/>
                  <a:gd name="T9" fmla="*/ 0 h 22"/>
                  <a:gd name="T10" fmla="*/ 660 w 2968"/>
                  <a:gd name="T11" fmla="*/ 22 h 22"/>
                  <a:gd name="T12" fmla="*/ 989 w 2968"/>
                  <a:gd name="T13" fmla="*/ 0 h 22"/>
                  <a:gd name="T14" fmla="*/ 989 w 2968"/>
                  <a:gd name="T15" fmla="*/ 22 h 22"/>
                  <a:gd name="T16" fmla="*/ 1320 w 2968"/>
                  <a:gd name="T17" fmla="*/ 0 h 22"/>
                  <a:gd name="T18" fmla="*/ 1320 w 2968"/>
                  <a:gd name="T19" fmla="*/ 22 h 22"/>
                  <a:gd name="T20" fmla="*/ 1649 w 2968"/>
                  <a:gd name="T21" fmla="*/ 0 h 22"/>
                  <a:gd name="T22" fmla="*/ 1649 w 2968"/>
                  <a:gd name="T23" fmla="*/ 22 h 22"/>
                  <a:gd name="T24" fmla="*/ 1979 w 2968"/>
                  <a:gd name="T25" fmla="*/ 0 h 22"/>
                  <a:gd name="T26" fmla="*/ 1979 w 2968"/>
                  <a:gd name="T27" fmla="*/ 22 h 22"/>
                  <a:gd name="T28" fmla="*/ 2309 w 2968"/>
                  <a:gd name="T29" fmla="*/ 0 h 22"/>
                  <a:gd name="T30" fmla="*/ 2309 w 2968"/>
                  <a:gd name="T31" fmla="*/ 22 h 22"/>
                  <a:gd name="T32" fmla="*/ 2638 w 2968"/>
                  <a:gd name="T33" fmla="*/ 0 h 22"/>
                  <a:gd name="T34" fmla="*/ 2638 w 2968"/>
                  <a:gd name="T35" fmla="*/ 22 h 22"/>
                  <a:gd name="T36" fmla="*/ 2968 w 2968"/>
                  <a:gd name="T37" fmla="*/ 0 h 22"/>
                  <a:gd name="T38" fmla="*/ 2968 w 2968"/>
                  <a:gd name="T39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2968" h="22">
                    <a:moveTo>
                      <a:pt x="0" y="0"/>
                    </a:moveTo>
                    <a:lnTo>
                      <a:pt x="0" y="22"/>
                    </a:lnTo>
                    <a:moveTo>
                      <a:pt x="329" y="0"/>
                    </a:moveTo>
                    <a:lnTo>
                      <a:pt x="329" y="22"/>
                    </a:lnTo>
                    <a:moveTo>
                      <a:pt x="660" y="0"/>
                    </a:moveTo>
                    <a:lnTo>
                      <a:pt x="660" y="22"/>
                    </a:lnTo>
                    <a:moveTo>
                      <a:pt x="989" y="0"/>
                    </a:moveTo>
                    <a:lnTo>
                      <a:pt x="989" y="22"/>
                    </a:lnTo>
                    <a:moveTo>
                      <a:pt x="1320" y="0"/>
                    </a:moveTo>
                    <a:lnTo>
                      <a:pt x="1320" y="22"/>
                    </a:lnTo>
                    <a:moveTo>
                      <a:pt x="1649" y="0"/>
                    </a:moveTo>
                    <a:lnTo>
                      <a:pt x="1649" y="22"/>
                    </a:lnTo>
                    <a:moveTo>
                      <a:pt x="1979" y="0"/>
                    </a:moveTo>
                    <a:lnTo>
                      <a:pt x="1979" y="22"/>
                    </a:lnTo>
                    <a:moveTo>
                      <a:pt x="2309" y="0"/>
                    </a:moveTo>
                    <a:lnTo>
                      <a:pt x="2309" y="22"/>
                    </a:lnTo>
                    <a:moveTo>
                      <a:pt x="2638" y="0"/>
                    </a:moveTo>
                    <a:lnTo>
                      <a:pt x="2638" y="22"/>
                    </a:lnTo>
                    <a:moveTo>
                      <a:pt x="2968" y="0"/>
                    </a:moveTo>
                    <a:lnTo>
                      <a:pt x="2968" y="22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grpSp>
          <p:nvGrpSpPr>
            <p:cNvPr id="219" name="Group 218">
              <a:extLst>
                <a:ext uri="{FF2B5EF4-FFF2-40B4-BE49-F238E27FC236}">
                  <a16:creationId xmlns:a16="http://schemas.microsoft.com/office/drawing/2014/main" id="{637DC1B4-3D64-45F9-98B3-D722CB9F4B80}"/>
                </a:ext>
              </a:extLst>
            </p:cNvPr>
            <p:cNvGrpSpPr/>
            <p:nvPr/>
          </p:nvGrpSpPr>
          <p:grpSpPr>
            <a:xfrm>
              <a:off x="3494723" y="10053017"/>
              <a:ext cx="211596" cy="2723300"/>
              <a:chOff x="3535363" y="11525250"/>
              <a:chExt cx="211596" cy="2598638"/>
            </a:xfrm>
          </p:grpSpPr>
          <p:sp>
            <p:nvSpPr>
              <p:cNvPr id="182" name="Rectangle 102">
                <a:extLst>
                  <a:ext uri="{FF2B5EF4-FFF2-40B4-BE49-F238E27FC236}">
                    <a16:creationId xmlns:a16="http://schemas.microsoft.com/office/drawing/2014/main" id="{DBF90472-F7D7-49A9-A6A5-E5AA5B9415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76427" y="13970000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3" name="Rectangle 103">
                <a:extLst>
                  <a:ext uri="{FF2B5EF4-FFF2-40B4-BE49-F238E27FC236}">
                    <a16:creationId xmlns:a16="http://schemas.microsoft.com/office/drawing/2014/main" id="{BCA5E260-4395-4DCE-9981-845F179AB8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05895" y="13620750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4" name="Rectangle 104">
                <a:extLst>
                  <a:ext uri="{FF2B5EF4-FFF2-40B4-BE49-F238E27FC236}">
                    <a16:creationId xmlns:a16="http://schemas.microsoft.com/office/drawing/2014/main" id="{DD209BAF-CF80-40D7-9D3A-2FC110A998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05895" y="13271500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5" name="Rectangle 105">
                <a:extLst>
                  <a:ext uri="{FF2B5EF4-FFF2-40B4-BE49-F238E27FC236}">
                    <a16:creationId xmlns:a16="http://schemas.microsoft.com/office/drawing/2014/main" id="{B9B0EB58-8CCD-405C-8934-E0519C496D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05895" y="12922250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" name="Rectangle 106">
                <a:extLst>
                  <a:ext uri="{FF2B5EF4-FFF2-40B4-BE49-F238E27FC236}">
                    <a16:creationId xmlns:a16="http://schemas.microsoft.com/office/drawing/2014/main" id="{C54B5D48-261E-4C7C-A9A0-56AD184C60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05895" y="12573000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7" name="Rectangle 107">
                <a:extLst>
                  <a:ext uri="{FF2B5EF4-FFF2-40B4-BE49-F238E27FC236}">
                    <a16:creationId xmlns:a16="http://schemas.microsoft.com/office/drawing/2014/main" id="{A87E7925-BF1D-43F5-8A51-2882523C2C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35363" y="12223750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8" name="Rectangle 108">
                <a:extLst>
                  <a:ext uri="{FF2B5EF4-FFF2-40B4-BE49-F238E27FC236}">
                    <a16:creationId xmlns:a16="http://schemas.microsoft.com/office/drawing/2014/main" id="{743826B0-B48E-4184-B2A2-47AF7AE8EE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35363" y="11874500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0</a:t>
                </a:r>
                <a:endParaRPr kumimoji="0" lang="en-US" alt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9" name="Rectangle 109">
                <a:extLst>
                  <a:ext uri="{FF2B5EF4-FFF2-40B4-BE49-F238E27FC236}">
                    <a16:creationId xmlns:a16="http://schemas.microsoft.com/office/drawing/2014/main" id="{FB463468-CFAF-48EB-8D3B-3A4CFAC57D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35363" y="11525250"/>
                <a:ext cx="21159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0</a:t>
                </a:r>
                <a:endPara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91" name="Rectangle 110">
              <a:extLst>
                <a:ext uri="{FF2B5EF4-FFF2-40B4-BE49-F238E27FC236}">
                  <a16:creationId xmlns:a16="http://schemas.microsoft.com/office/drawing/2014/main" id="{6F62F861-D1A9-47F0-852F-5373EA0C0A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4475" y="12758954"/>
              <a:ext cx="11430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2" name="Rectangle 111">
              <a:extLst>
                <a:ext uri="{FF2B5EF4-FFF2-40B4-BE49-F238E27FC236}">
                  <a16:creationId xmlns:a16="http://schemas.microsoft.com/office/drawing/2014/main" id="{399A96D6-6214-49AD-8DC7-7DC759CA38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8350" y="12758954"/>
              <a:ext cx="11430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3" name="Rectangle 112">
              <a:extLst>
                <a:ext uri="{FF2B5EF4-FFF2-40B4-BE49-F238E27FC236}">
                  <a16:creationId xmlns:a16="http://schemas.microsoft.com/office/drawing/2014/main" id="{A647DEA5-427D-4CA2-87D2-819A260655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4600" y="12758954"/>
              <a:ext cx="207963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4" name="Rectangle 113">
              <a:extLst>
                <a:ext uri="{FF2B5EF4-FFF2-40B4-BE49-F238E27FC236}">
                  <a16:creationId xmlns:a16="http://schemas.microsoft.com/office/drawing/2014/main" id="{2993539B-AB01-403A-B794-A51695DD1F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26100" y="12758954"/>
              <a:ext cx="11430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5" name="Rectangle 114">
              <a:extLst>
                <a:ext uri="{FF2B5EF4-FFF2-40B4-BE49-F238E27FC236}">
                  <a16:creationId xmlns:a16="http://schemas.microsoft.com/office/drawing/2014/main" id="{9C1D2C08-7C59-437F-B8F8-2B87C0F823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8225" y="12758954"/>
              <a:ext cx="176213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6" name="Rectangle 115">
              <a:extLst>
                <a:ext uri="{FF2B5EF4-FFF2-40B4-BE49-F238E27FC236}">
                  <a16:creationId xmlns:a16="http://schemas.microsoft.com/office/drawing/2014/main" id="{10DF2B08-20A6-42C6-B1F7-4E0AD8D853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40513" y="12758954"/>
              <a:ext cx="17780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8" name="Rectangle 116">
              <a:extLst>
                <a:ext uri="{FF2B5EF4-FFF2-40B4-BE49-F238E27FC236}">
                  <a16:creationId xmlns:a16="http://schemas.microsoft.com/office/drawing/2014/main" id="{2E27D36B-F49E-45BB-9A55-8B6BD132EE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64388" y="12758954"/>
              <a:ext cx="17780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9" name="Rectangle 117">
              <a:extLst>
                <a:ext uri="{FF2B5EF4-FFF2-40B4-BE49-F238E27FC236}">
                  <a16:creationId xmlns:a16="http://schemas.microsoft.com/office/drawing/2014/main" id="{1DA9B969-7F3C-4835-B0EA-77AC1F0EC2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56513" y="12758954"/>
              <a:ext cx="24130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0" name="Rectangle 118">
              <a:extLst>
                <a:ext uri="{FF2B5EF4-FFF2-40B4-BE49-F238E27FC236}">
                  <a16:creationId xmlns:a16="http://schemas.microsoft.com/office/drawing/2014/main" id="{7DC4F9BB-4F37-4CF0-B8EC-FCB27B1506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80388" y="12758954"/>
              <a:ext cx="239713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1" name="Rectangle 119">
              <a:extLst>
                <a:ext uri="{FF2B5EF4-FFF2-40B4-BE49-F238E27FC236}">
                  <a16:creationId xmlns:a16="http://schemas.microsoft.com/office/drawing/2014/main" id="{E2219E9E-8D5F-42EC-AEEF-B0CEE32ADE6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02412" y="11331267"/>
              <a:ext cx="63799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% of </a:t>
              </a:r>
              <a:r>
                <a:rPr lang="en-US" altLang="en-US" sz="1000" dirty="0">
                  <a:solidFill>
                    <a:srgbClr val="000000"/>
                  </a:solidFill>
                </a:rPr>
                <a:t>time 0</a:t>
              </a:r>
              <a:endPara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3" name="Rectangle 121">
              <a:extLst>
                <a:ext uri="{FF2B5EF4-FFF2-40B4-BE49-F238E27FC236}">
                  <a16:creationId xmlns:a16="http://schemas.microsoft.com/office/drawing/2014/main" id="{BE375D98-125F-40B7-AF37-8370197631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7998" y="9683649"/>
              <a:ext cx="169758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) Brain ROS production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3" name="Rectangle 39">
              <a:extLst>
                <a:ext uri="{FF2B5EF4-FFF2-40B4-BE49-F238E27FC236}">
                  <a16:creationId xmlns:a16="http://schemas.microsoft.com/office/drawing/2014/main" id="{308BDC61-74F7-4710-97CA-9106B210C9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3031" y="9333764"/>
              <a:ext cx="4472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Minutes</a:t>
              </a:r>
              <a:endPara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4" name="Rectangle 39">
              <a:extLst>
                <a:ext uri="{FF2B5EF4-FFF2-40B4-BE49-F238E27FC236}">
                  <a16:creationId xmlns:a16="http://schemas.microsoft.com/office/drawing/2014/main" id="{1A0F674D-A79D-427A-A1D6-2846A3BD8D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8106" y="12978076"/>
              <a:ext cx="4472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Minutes</a:t>
              </a:r>
              <a:endPara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92663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503</TotalTime>
  <Words>339</Words>
  <Application>Microsoft Office PowerPoint</Application>
  <PresentationFormat>Custom</PresentationFormat>
  <Paragraphs>125</Paragraphs>
  <Slides>2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CS ChemDraw Drawing</vt:lpstr>
      <vt:lpstr>PowerPoint Presentation</vt:lpstr>
      <vt:lpstr>PowerPoint Presentation</vt:lpstr>
    </vt:vector>
  </TitlesOfParts>
  <Company>University of Readi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gfei Liu</dc:creator>
  <cp:lastModifiedBy>Jian-Mei Li</cp:lastModifiedBy>
  <cp:revision>324</cp:revision>
  <dcterms:created xsi:type="dcterms:W3CDTF">2017-11-14T10:08:21Z</dcterms:created>
  <dcterms:modified xsi:type="dcterms:W3CDTF">2020-07-08T15:32:22Z</dcterms:modified>
</cp:coreProperties>
</file>